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90EDB1-0B53-C5C6-897E-E4F87238ABB0}" name="Nicholas Skiados" initials="NS" userId="gyL5hJDrj+hZHFpDSneZU1h6zJeED3y/2O9IVXLr5ag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92"/>
    <p:restoredTop sz="93521" autoAdjust="0"/>
  </p:normalViewPr>
  <p:slideViewPr>
    <p:cSldViewPr snapToGrid="0" snapToObjects="1">
      <p:cViewPr varScale="1">
        <p:scale>
          <a:sx n="83" d="100"/>
          <a:sy n="83" d="100"/>
        </p:scale>
        <p:origin x="300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5" d="100"/>
        <a:sy n="8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04D8B9BF-69C7-CA41-BB06-68E512D2A60E}"/>
    <pc:docChg chg="modSld">
      <pc:chgData name="Wencai Zhang" userId="4a86a1d0-2108-4707-8228-1110f3c1be85" providerId="ADAL" clId="{04D8B9BF-69C7-CA41-BB06-68E512D2A60E}" dt="2021-09-13T20:46:18.988" v="23" actId="1076"/>
      <pc:docMkLst>
        <pc:docMk/>
      </pc:docMkLst>
      <pc:sldChg chg="addSp modSp">
        <pc:chgData name="Wencai Zhang" userId="4a86a1d0-2108-4707-8228-1110f3c1be85" providerId="ADAL" clId="{04D8B9BF-69C7-CA41-BB06-68E512D2A60E}" dt="2021-09-13T20:46:18.988" v="23" actId="1076"/>
        <pc:sldMkLst>
          <pc:docMk/>
          <pc:sldMk cId="3242017852" sldId="272"/>
        </pc:sldMkLst>
        <pc:grpChg chg="mod">
          <ac:chgData name="Wencai Zhang" userId="4a86a1d0-2108-4707-8228-1110f3c1be85" providerId="ADAL" clId="{04D8B9BF-69C7-CA41-BB06-68E512D2A60E}" dt="2021-09-13T20:46:07.575" v="5" actId="1076"/>
          <ac:grpSpMkLst>
            <pc:docMk/>
            <pc:sldMk cId="3242017852" sldId="272"/>
            <ac:grpSpMk id="3" creationId="{066BC804-6321-634F-887E-10DA31DF0490}"/>
          </ac:grpSpMkLst>
        </pc:grpChg>
        <pc:picChg chg="add mod modCrop">
          <ac:chgData name="Wencai Zhang" userId="4a86a1d0-2108-4707-8228-1110f3c1be85" providerId="ADAL" clId="{04D8B9BF-69C7-CA41-BB06-68E512D2A60E}" dt="2021-09-13T20:46:18.988" v="23" actId="1076"/>
          <ac:picMkLst>
            <pc:docMk/>
            <pc:sldMk cId="3242017852" sldId="272"/>
            <ac:picMk id="7" creationId="{D1FA5D13-4EDE-C142-A2DA-43A310FDCAD9}"/>
          </ac:picMkLst>
        </pc:picChg>
      </pc:sldChg>
    </pc:docChg>
  </pc:docChgLst>
  <pc:docChgLst>
    <pc:chgData name="Wencai Zhang" userId="4a86a1d0-2108-4707-8228-1110f3c1be85" providerId="ADAL" clId="{601397D5-CCEE-BD4B-BFE6-589CE3422873}"/>
    <pc:docChg chg="undo redo custSel addSld delSld modSld">
      <pc:chgData name="Wencai Zhang" userId="4a86a1d0-2108-4707-8228-1110f3c1be85" providerId="ADAL" clId="{601397D5-CCEE-BD4B-BFE6-589CE3422873}" dt="2022-05-24T12:53:14.823" v="5269" actId="1037"/>
      <pc:docMkLst>
        <pc:docMk/>
      </pc:docMkLst>
      <pc:sldChg chg="addSp delSp modSp mod">
        <pc:chgData name="Wencai Zhang" userId="4a86a1d0-2108-4707-8228-1110f3c1be85" providerId="ADAL" clId="{601397D5-CCEE-BD4B-BFE6-589CE3422873}" dt="2022-05-24T12:52:10.313" v="5259" actId="1037"/>
        <pc:sldMkLst>
          <pc:docMk/>
          <pc:sldMk cId="1245431894" sldId="274"/>
        </pc:sldMkLst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1" creationId="{8B1765C8-9FB9-4242-ACE4-959BEBC359FE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5-24T12:52:01.365" v="5233" actId="1076"/>
          <ac:spMkLst>
            <pc:docMk/>
            <pc:sldMk cId="1245431894" sldId="274"/>
            <ac:spMk id="17" creationId="{A1B94A96-93E3-5A44-AB8A-B4223D0CE1A9}"/>
          </ac:spMkLst>
        </pc:spChg>
        <pc:spChg chg="mod topLvl">
          <ac:chgData name="Wencai Zhang" userId="4a86a1d0-2108-4707-8228-1110f3c1be85" providerId="ADAL" clId="{601397D5-CCEE-BD4B-BFE6-589CE3422873}" dt="2022-04-30T09:39:05.967" v="780" actId="1037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09:38:58.188" v="777" actId="1037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34" creationId="{445C1720-EAE1-B045-A74A-D237858BD8E7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7" creationId="{3CE14412-679C-7841-A601-29DE430AFCDF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8" creationId="{7B6A9BEA-B854-D643-A7AA-44757418D712}"/>
          </ac:spMkLst>
        </pc:spChg>
        <pc:spChg chg="mod topLvl">
          <ac:chgData name="Wencai Zhang" userId="4a86a1d0-2108-4707-8228-1110f3c1be85" providerId="ADAL" clId="{601397D5-CCEE-BD4B-BFE6-589CE3422873}" dt="2022-04-30T09:44:44.631" v="1017" actId="1038"/>
          <ac:spMkLst>
            <pc:docMk/>
            <pc:sldMk cId="1245431894" sldId="274"/>
            <ac:spMk id="39" creationId="{FBCB02E0-C00F-2D46-B928-43D421827765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4" creationId="{01AB959A-CE73-6A44-A9DC-81DEE13DB7C0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5" creationId="{5185EF6F-CEA9-5A4A-B3B9-FF386C86AA3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6" creationId="{1EF11EF0-88B7-D74A-807A-3B9AE17E21A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7" creationId="{D14E0F2C-5FFF-FB4C-AEDD-26E79689B60D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8" creationId="{845E12EC-2976-054E-8539-8A9E6E46CA14}"/>
          </ac:spMkLst>
        </pc:spChg>
        <pc:spChg chg="del mod">
          <ac:chgData name="Wencai Zhang" userId="4a86a1d0-2108-4707-8228-1110f3c1be85" providerId="ADAL" clId="{601397D5-CCEE-BD4B-BFE6-589CE3422873}" dt="2022-04-30T09:57:29.905" v="1583" actId="478"/>
          <ac:spMkLst>
            <pc:docMk/>
            <pc:sldMk cId="1245431894" sldId="274"/>
            <ac:spMk id="49" creationId="{1A7E9299-ACF8-7340-8237-6E3D680EE9D1}"/>
          </ac:spMkLst>
        </pc:spChg>
        <pc:spChg chg="mod topLvl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50" creationId="{4FA919A5-8788-864E-800C-669A49A437BC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1" creationId="{B1CDE6C0-A2F5-3043-83F0-6E6CA4F4460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2" creationId="{B30B6DD3-7BB4-FD4B-896C-D912219DF98B}"/>
          </ac:spMkLst>
        </pc:spChg>
        <pc:spChg chg="del mod">
          <ac:chgData name="Wencai Zhang" userId="4a86a1d0-2108-4707-8228-1110f3c1be85" providerId="ADAL" clId="{601397D5-CCEE-BD4B-BFE6-589CE3422873}" dt="2022-04-30T09:41:02.573" v="880" actId="478"/>
          <ac:spMkLst>
            <pc:docMk/>
            <pc:sldMk cId="1245431894" sldId="274"/>
            <ac:spMk id="53" creationId="{56521FC2-1257-554C-888A-8BB8AE8FAF66}"/>
          </ac:spMkLst>
        </pc:spChg>
        <pc:spChg chg="del mod">
          <ac:chgData name="Wencai Zhang" userId="4a86a1d0-2108-4707-8228-1110f3c1be85" providerId="ADAL" clId="{601397D5-CCEE-BD4B-BFE6-589CE3422873}" dt="2022-04-30T09:41:17.729" v="886" actId="478"/>
          <ac:spMkLst>
            <pc:docMk/>
            <pc:sldMk cId="1245431894" sldId="274"/>
            <ac:spMk id="54" creationId="{EB4DEF75-AB8D-7841-93B1-95D1DF19A005}"/>
          </ac:spMkLst>
        </pc:spChg>
        <pc:spChg chg="del mod">
          <ac:chgData name="Wencai Zhang" userId="4a86a1d0-2108-4707-8228-1110f3c1be85" providerId="ADAL" clId="{601397D5-CCEE-BD4B-BFE6-589CE3422873}" dt="2022-04-30T09:40:49.905" v="872" actId="478"/>
          <ac:spMkLst>
            <pc:docMk/>
            <pc:sldMk cId="1245431894" sldId="274"/>
            <ac:spMk id="55" creationId="{2055D486-0270-6343-888B-C54177DDE6D7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6" creationId="{B66F0011-78BB-5747-8B97-B6CC71EF5766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7" creationId="{560E494D-624D-6D44-8472-8DC4AB0902F5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8" creationId="{B42A4FCB-9331-BD4D-AF92-932C012B05F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9" creationId="{4A93D9DD-52BA-8C46-8876-C994005005B1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0" creationId="{57212630-7408-0743-8C40-8031B4135912}"/>
          </ac:spMkLst>
        </pc:spChg>
        <pc:spChg chg="mod topLvl">
          <ac:chgData name="Wencai Zhang" userId="4a86a1d0-2108-4707-8228-1110f3c1be85" providerId="ADAL" clId="{601397D5-CCEE-BD4B-BFE6-589CE3422873}" dt="2022-04-30T09:38:37.837" v="750" actId="164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09:37:43.047" v="690" actId="165"/>
          <ac:spMkLst>
            <pc:docMk/>
            <pc:sldMk cId="1245431894" sldId="274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3" creationId="{CF4FDF92-59D0-224D-97CE-3C1471E5D0A5}"/>
          </ac:spMkLst>
        </pc:spChg>
        <pc:spChg chg="del">
          <ac:chgData name="Wencai Zhang" userId="4a86a1d0-2108-4707-8228-1110f3c1be85" providerId="ADAL" clId="{601397D5-CCEE-BD4B-BFE6-589CE3422873}" dt="2022-04-30T09:46:23.829" v="1161" actId="478"/>
          <ac:spMkLst>
            <pc:docMk/>
            <pc:sldMk cId="1245431894" sldId="274"/>
            <ac:spMk id="64" creationId="{FEFF3FC7-4F78-E84E-8DE0-BCA9EB3C79C0}"/>
          </ac:spMkLst>
        </pc:spChg>
        <pc:spChg chg="mod">
          <ac:chgData name="Wencai Zhang" userId="4a86a1d0-2108-4707-8228-1110f3c1be85" providerId="ADAL" clId="{601397D5-CCEE-BD4B-BFE6-589CE3422873}" dt="2022-04-30T09:43:11.619" v="957" actId="1037"/>
          <ac:spMkLst>
            <pc:docMk/>
            <pc:sldMk cId="1245431894" sldId="274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601397D5-CCEE-BD4B-BFE6-589CE3422873}" dt="2022-04-30T09:53:35.907" v="1412" actId="478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601397D5-CCEE-BD4B-BFE6-589CE3422873}" dt="2022-04-30T09:57:01.144" v="1581" actId="1037"/>
          <ac:spMkLst>
            <pc:docMk/>
            <pc:sldMk cId="1245431894" sldId="274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601397D5-CCEE-BD4B-BFE6-589CE3422873}" dt="2022-04-30T09:53:33.359" v="1411" actId="478"/>
          <ac:spMkLst>
            <pc:docMk/>
            <pc:sldMk cId="1245431894" sldId="274"/>
            <ac:spMk id="68" creationId="{E76224F7-D762-6B4A-8132-BE95ED59A120}"/>
          </ac:spMkLst>
        </pc:spChg>
        <pc:spChg chg="del">
          <ac:chgData name="Wencai Zhang" userId="4a86a1d0-2108-4707-8228-1110f3c1be85" providerId="ADAL" clId="{601397D5-CCEE-BD4B-BFE6-589CE3422873}" dt="2022-04-30T09:54:18.708" v="1491" actId="478"/>
          <ac:spMkLst>
            <pc:docMk/>
            <pc:sldMk cId="1245431894" sldId="274"/>
            <ac:spMk id="69" creationId="{1D3413AB-A5EB-3746-A3C6-4C49239A1C39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0" creationId="{57F3E927-7256-F14A-919C-C4E477AC08C9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1" creationId="{CEF8ED6B-E974-F744-8340-9B75D8DA0E1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2" creationId="{748316AF-EEE9-C647-8828-B610226D545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3" creationId="{D0955E5C-197D-6941-B62E-8856C146B342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4" creationId="{F553869F-FD05-2E4F-A272-51C23F24CA15}"/>
          </ac:spMkLst>
        </pc:spChg>
        <pc:spChg chg="mod">
          <ac:chgData name="Wencai Zhang" userId="4a86a1d0-2108-4707-8228-1110f3c1be85" providerId="ADAL" clId="{601397D5-CCEE-BD4B-BFE6-589CE3422873}" dt="2022-05-24T12:52:10.313" v="5259" actId="1037"/>
          <ac:spMkLst>
            <pc:docMk/>
            <pc:sldMk cId="1245431894" sldId="274"/>
            <ac:spMk id="75" creationId="{984D3048-D588-A64C-B806-8FCD9BD3A3ED}"/>
          </ac:spMkLst>
        </pc:spChg>
        <pc:spChg chg="add del mod topLvl">
          <ac:chgData name="Wencai Zhang" userId="4a86a1d0-2108-4707-8228-1110f3c1be85" providerId="ADAL" clId="{601397D5-CCEE-BD4B-BFE6-589CE3422873}" dt="2022-04-30T09:42:06.392" v="915" actId="478"/>
          <ac:spMkLst>
            <pc:docMk/>
            <pc:sldMk cId="1245431894" sldId="274"/>
            <ac:spMk id="76" creationId="{BF3E5FC6-9C0E-874C-A182-860CE4C1C66C}"/>
          </ac:spMkLst>
        </pc:spChg>
        <pc:spChg chg="add mod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77" creationId="{F62396F4-406F-094E-8B03-CCAD9B4D1912}"/>
          </ac:spMkLst>
        </pc:spChg>
        <pc:spChg chg="add del mod topLvl">
          <ac:chgData name="Wencai Zhang" userId="4a86a1d0-2108-4707-8228-1110f3c1be85" providerId="ADAL" clId="{601397D5-CCEE-BD4B-BFE6-589CE3422873}" dt="2022-04-30T09:37:52.360" v="692" actId="478"/>
          <ac:spMkLst>
            <pc:docMk/>
            <pc:sldMk cId="1245431894" sldId="274"/>
            <ac:spMk id="78" creationId="{5308B87A-D7B7-6244-AC93-A75A93DEBE59}"/>
          </ac:spMkLst>
        </pc:spChg>
        <pc:spChg chg="add del mod">
          <ac:chgData name="Wencai Zhang" userId="4a86a1d0-2108-4707-8228-1110f3c1be85" providerId="ADAL" clId="{601397D5-CCEE-BD4B-BFE6-589CE3422873}" dt="2022-04-30T09:54:39.163" v="1498" actId="478"/>
          <ac:spMkLst>
            <pc:docMk/>
            <pc:sldMk cId="1245431894" sldId="274"/>
            <ac:spMk id="79" creationId="{93CDA088-0809-0241-B2B8-8A781B8353FC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80" creationId="{96A58CB1-F200-6A4B-BE2C-ABA02B9E6C27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2" creationId="{7A7CC521-DE5A-F148-BBF3-62284527BD49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3" creationId="{D88C2E5B-FB39-2B44-9CB1-D6FEB76E2C4F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4" creationId="{8DD8AD64-71CF-604E-934C-DCA4B3D4B6E6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5" creationId="{E3448973-791A-6C43-8EFF-21F6D8C13A45}"/>
          </ac:spMkLst>
        </pc:spChg>
        <pc:spChg chg="mod">
          <ac:chgData name="Wencai Zhang" userId="4a86a1d0-2108-4707-8228-1110f3c1be85" providerId="ADAL" clId="{601397D5-CCEE-BD4B-BFE6-589CE3422873}" dt="2022-04-30T09:42:13.846" v="917" actId="20577"/>
          <ac:spMkLst>
            <pc:docMk/>
            <pc:sldMk cId="1245431894" sldId="274"/>
            <ac:spMk id="88" creationId="{A10106DF-4C0D-ED44-A3E4-7C701A3EF735}"/>
          </ac:spMkLst>
        </pc:spChg>
        <pc:spChg chg="mod">
          <ac:chgData name="Wencai Zhang" userId="4a86a1d0-2108-4707-8228-1110f3c1be85" providerId="ADAL" clId="{601397D5-CCEE-BD4B-BFE6-589CE3422873}" dt="2022-04-30T09:41:25.244" v="893" actId="1035"/>
          <ac:spMkLst>
            <pc:docMk/>
            <pc:sldMk cId="1245431894" sldId="274"/>
            <ac:spMk id="89" creationId="{E2687387-6EC9-9547-A178-D512C3B8783A}"/>
          </ac:spMkLst>
        </pc:spChg>
        <pc:spChg chg="mod">
          <ac:chgData name="Wencai Zhang" userId="4a86a1d0-2108-4707-8228-1110f3c1be85" providerId="ADAL" clId="{601397D5-CCEE-BD4B-BFE6-589CE3422873}" dt="2022-04-30T09:44:02.304" v="1005" actId="1037"/>
          <ac:spMkLst>
            <pc:docMk/>
            <pc:sldMk cId="1245431894" sldId="274"/>
            <ac:spMk id="90" creationId="{818B608E-4304-754D-8CE6-2FE1CAFB6C10}"/>
          </ac:spMkLst>
        </pc:spChg>
        <pc:spChg chg="mod">
          <ac:chgData name="Wencai Zhang" userId="4a86a1d0-2108-4707-8228-1110f3c1be85" providerId="ADAL" clId="{601397D5-CCEE-BD4B-BFE6-589CE3422873}" dt="2022-04-30T09:40:07.635" v="785"/>
          <ac:spMkLst>
            <pc:docMk/>
            <pc:sldMk cId="1245431894" sldId="274"/>
            <ac:spMk id="91" creationId="{418F03D5-004A-0243-9C3D-65DDDD553847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3" creationId="{42820192-ED4B-CD4C-BB05-931FA8BC37EC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4" creationId="{F632FB9E-1A65-2741-85A0-FEF7F2FDA5B2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5" creationId="{4A8CFE0B-4B18-D647-9290-9044282161F8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6" creationId="{407A5FE7-9BFB-4943-B0DE-6AB7F513F205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97" creationId="{0C0FEB0D-15FE-D24A-BB56-ADA4DB2F3CE4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99" creationId="{30F4C6CD-545F-4F47-978C-AFCF938323FA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100" creationId="{C0141150-0609-D54F-BE09-9E3B775C878B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3" creationId="{CD7A72C2-289A-F14E-AB05-A9ECBD10093C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4" creationId="{36AC5DFD-CE8C-C94E-AA40-888DB10DBDE7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5" creationId="{A3302C64-3F17-A244-8FF5-7C3D8C7CB650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6" creationId="{64B625FC-1280-9346-858D-4A6D71B0CB43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1" creationId="{39440CC8-4B0B-5144-827A-86EAD60FE552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2" creationId="{3C8BDC4A-2710-DC49-BDC6-F6FFCA5D9A74}"/>
          </ac:spMkLst>
        </pc:spChg>
        <pc:spChg chg="add mod">
          <ac:chgData name="Wencai Zhang" userId="4a86a1d0-2108-4707-8228-1110f3c1be85" providerId="ADAL" clId="{601397D5-CCEE-BD4B-BFE6-589CE3422873}" dt="2022-04-30T10:18:33.929" v="2148" actId="1037"/>
          <ac:spMkLst>
            <pc:docMk/>
            <pc:sldMk cId="1245431894" sldId="274"/>
            <ac:spMk id="114" creationId="{BFBC01FB-184C-C244-8E1A-8915CE4B560F}"/>
          </ac:spMkLst>
        </pc:spChg>
        <pc:spChg chg="mod">
          <ac:chgData name="Wencai Zhang" userId="4a86a1d0-2108-4707-8228-1110f3c1be85" providerId="ADAL" clId="{601397D5-CCEE-BD4B-BFE6-589CE3422873}" dt="2022-04-30T10:15:20.352" v="2061" actId="1038"/>
          <ac:spMkLst>
            <pc:docMk/>
            <pc:sldMk cId="1245431894" sldId="274"/>
            <ac:spMk id="116" creationId="{FEF5075E-877E-DE42-A757-D92E9C5DE320}"/>
          </ac:spMkLst>
        </pc:spChg>
        <pc:spChg chg="mod">
          <ac:chgData name="Wencai Zhang" userId="4a86a1d0-2108-4707-8228-1110f3c1be85" providerId="ADAL" clId="{601397D5-CCEE-BD4B-BFE6-589CE3422873}" dt="2022-04-30T10:15:28.636" v="2064" actId="1038"/>
          <ac:spMkLst>
            <pc:docMk/>
            <pc:sldMk cId="1245431894" sldId="274"/>
            <ac:spMk id="117" creationId="{EC920844-0D81-0D4E-ACFA-AAE1815BF753}"/>
          </ac:spMkLst>
        </pc:spChg>
        <pc:spChg chg="mod">
          <ac:chgData name="Wencai Zhang" userId="4a86a1d0-2108-4707-8228-1110f3c1be85" providerId="ADAL" clId="{601397D5-CCEE-BD4B-BFE6-589CE3422873}" dt="2022-05-01T00:28:27.208" v="3981" actId="1038"/>
          <ac:spMkLst>
            <pc:docMk/>
            <pc:sldMk cId="1245431894" sldId="274"/>
            <ac:spMk id="118" creationId="{42D4C04B-69CB-F94E-B426-25E39BB18BDF}"/>
          </ac:spMkLst>
        </pc:spChg>
        <pc:spChg chg="mod">
          <ac:chgData name="Wencai Zhang" userId="4a86a1d0-2108-4707-8228-1110f3c1be85" providerId="ADAL" clId="{601397D5-CCEE-BD4B-BFE6-589CE3422873}" dt="2022-04-30T10:16:41.406" v="2078" actId="1037"/>
          <ac:spMkLst>
            <pc:docMk/>
            <pc:sldMk cId="1245431894" sldId="274"/>
            <ac:spMk id="119" creationId="{F284AD4B-C620-1B47-8915-C1EEECCB957A}"/>
          </ac:spMkLst>
        </pc:spChg>
        <pc:spChg chg="add mod">
          <ac:chgData name="Wencai Zhang" userId="4a86a1d0-2108-4707-8228-1110f3c1be85" providerId="ADAL" clId="{601397D5-CCEE-BD4B-BFE6-589CE3422873}" dt="2022-04-30T10:00:22.621" v="1768" actId="164"/>
          <ac:spMkLst>
            <pc:docMk/>
            <pc:sldMk cId="1245431894" sldId="274"/>
            <ac:spMk id="120" creationId="{163911B3-F2DA-4446-80EC-E53B5F7D8455}"/>
          </ac:spMkLst>
        </pc:spChg>
        <pc:spChg chg="add mod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121" creationId="{E73CA776-1522-CF44-AD0D-0F932A7EAF62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3" creationId="{4AD92260-1D42-9F4B-B1DA-A81356B097B5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4" creationId="{76CEEC2D-3CDE-9346-A99A-8CF795A303CF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5" creationId="{18DB0EB5-37E1-4945-B800-E71336936C19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6" creationId="{F7BBE626-25B4-2049-9BA5-1B9CA65E328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29" creationId="{080ED678-C39A-8646-95FA-598619FA1FD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0" creationId="{41A9BF00-DE33-CA4F-A6BC-7E7A7C4C727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1" creationId="{0CF6C572-F76F-694E-8B40-F4F04D015D84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2" creationId="{D8F7F326-47EB-C947-8DF9-7C232F78C15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3" creationId="{96BF3511-70E6-1D4B-951F-4A24B74DF950}"/>
          </ac:spMkLst>
        </pc:spChg>
        <pc:spChg chg="add mod">
          <ac:chgData name="Wencai Zhang" userId="4a86a1d0-2108-4707-8228-1110f3c1be85" providerId="ADAL" clId="{601397D5-CCEE-BD4B-BFE6-589CE3422873}" dt="2022-04-30T10:03:33.812" v="1966" actId="20577"/>
          <ac:spMkLst>
            <pc:docMk/>
            <pc:sldMk cId="1245431894" sldId="274"/>
            <ac:spMk id="134" creationId="{DD1BA8CE-77A7-2E42-871C-132411D01489}"/>
          </ac:spMkLst>
        </pc:spChg>
        <pc:spChg chg="mod">
          <ac:chgData name="Wencai Zhang" userId="4a86a1d0-2108-4707-8228-1110f3c1be85" providerId="ADAL" clId="{601397D5-CCEE-BD4B-BFE6-589CE3422873}" dt="2022-04-30T10:01:05.350" v="1837"/>
          <ac:spMkLst>
            <pc:docMk/>
            <pc:sldMk cId="1245431894" sldId="274"/>
            <ac:spMk id="137" creationId="{D4E6B25F-7D95-2745-8091-4B19C7D72C90}"/>
          </ac:spMkLst>
        </pc:spChg>
        <pc:spChg chg="mod">
          <ac:chgData name="Wencai Zhang" userId="4a86a1d0-2108-4707-8228-1110f3c1be85" providerId="ADAL" clId="{601397D5-CCEE-BD4B-BFE6-589CE3422873}" dt="2022-04-30T10:15:45.875" v="2074" actId="1038"/>
          <ac:spMkLst>
            <pc:docMk/>
            <pc:sldMk cId="1245431894" sldId="274"/>
            <ac:spMk id="138" creationId="{39FEDF6B-CC9C-DC4E-96B7-5AE7E10C04F6}"/>
          </ac:spMkLst>
        </pc:spChg>
        <pc:spChg chg="mod">
          <ac:chgData name="Wencai Zhang" userId="4a86a1d0-2108-4707-8228-1110f3c1be85" providerId="ADAL" clId="{601397D5-CCEE-BD4B-BFE6-589CE3422873}" dt="2022-04-30T10:15:38.853" v="2067" actId="1038"/>
          <ac:spMkLst>
            <pc:docMk/>
            <pc:sldMk cId="1245431894" sldId="274"/>
            <ac:spMk id="139" creationId="{224B57D6-7DFF-2E40-BAE2-58122CB26FCD}"/>
          </ac:spMkLst>
        </pc:spChg>
        <pc:spChg chg="mod">
          <ac:chgData name="Wencai Zhang" userId="4a86a1d0-2108-4707-8228-1110f3c1be85" providerId="ADAL" clId="{601397D5-CCEE-BD4B-BFE6-589CE3422873}" dt="2022-05-01T00:28:32.728" v="3991" actId="1038"/>
          <ac:spMkLst>
            <pc:docMk/>
            <pc:sldMk cId="1245431894" sldId="274"/>
            <ac:spMk id="140" creationId="{205B4B3F-0BED-4147-AA76-05C239618D4E}"/>
          </ac:spMkLst>
        </pc:spChg>
        <pc:spChg chg="mod">
          <ac:chgData name="Wencai Zhang" userId="4a86a1d0-2108-4707-8228-1110f3c1be85" providerId="ADAL" clId="{601397D5-CCEE-BD4B-BFE6-589CE3422873}" dt="2022-04-30T10:16:50.124" v="2082" actId="1037"/>
          <ac:spMkLst>
            <pc:docMk/>
            <pc:sldMk cId="1245431894" sldId="274"/>
            <ac:spMk id="141" creationId="{92792615-2C13-AC40-9377-6DFA17DD4637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4" creationId="{11FC017C-2B06-F649-A48B-3BCFBB28B8C0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6" creationId="{10866B5D-B945-DA4B-86F9-8452F652725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8" creationId="{D7071482-5688-234A-AEDC-FA2832E54D9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9" creationId="{DD6815FB-DAD6-974F-AD33-918B077A48DA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0" creationId="{D4B885CB-56DF-B741-8379-8AB8DA643364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1" creationId="{607865BB-E6DF-D146-8C18-2C90CCEC53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2" creationId="{3ACE166F-E9FD-6342-93E9-DF5CBC1BA1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3" creationId="{ACF085E6-BE95-054C-A9B0-EAFCD4B37C9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4" creationId="{91826A4D-AE81-EC41-94D0-5B8F0C4171A5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5" creationId="{F6DD9DF9-4519-D044-A5D5-17D88225ACD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59" creationId="{36ECC5DD-C69A-1C43-8329-7B57275E4B6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1" creationId="{EAEC4CC2-D2B7-9F45-801D-450CEB9EE052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3" creationId="{C4B4789A-6529-EE4E-893E-292FACA87EAA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4" creationId="{3013D939-6B9E-5042-B77D-28E7904A3DCB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5" creationId="{854064DB-55DF-B642-8476-995AF3EAC13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6" creationId="{88CBE085-FEDF-DC46-937C-EECC6C4783F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7" creationId="{BA814A65-E707-B249-9DDF-9886977131C5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8" creationId="{799DBCC8-42B6-7544-88F6-4374B2A93B6C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9" creationId="{8790FFCC-00BD-114E-B34C-187818483AC9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70" creationId="{DC8B4A1F-4443-814B-8390-00FEE3075D15}"/>
          </ac:spMkLst>
        </pc:spChg>
        <pc:grpChg chg="mod topLvl">
          <ac:chgData name="Wencai Zhang" userId="4a86a1d0-2108-4707-8228-1110f3c1be85" providerId="ADAL" clId="{601397D5-CCEE-BD4B-BFE6-589CE3422873}" dt="2022-04-30T09:38:21.250" v="711" actId="164"/>
          <ac:grpSpMkLst>
            <pc:docMk/>
            <pc:sldMk cId="1245431894" sldId="274"/>
            <ac:grpSpMk id="2" creationId="{23522517-C292-8C40-8C84-B30913B1168A}"/>
          </ac:grpSpMkLst>
        </pc:grpChg>
        <pc:grpChg chg="del mod">
          <ac:chgData name="Wencai Zhang" userId="4a86a1d0-2108-4707-8228-1110f3c1be85" providerId="ADAL" clId="{601397D5-CCEE-BD4B-BFE6-589CE3422873}" dt="2022-04-30T09:57:45.729" v="1585" actId="165"/>
          <ac:grpSpMkLst>
            <pc:docMk/>
            <pc:sldMk cId="1245431894" sldId="274"/>
            <ac:grpSpMk id="6" creationId="{3207817F-35DA-984B-9C13-DE719ECE44BE}"/>
          </ac:grpSpMkLst>
        </pc:grpChg>
        <pc:grpChg chg="del mod">
          <ac:chgData name="Wencai Zhang" userId="4a86a1d0-2108-4707-8228-1110f3c1be85" providerId="ADAL" clId="{601397D5-CCEE-BD4B-BFE6-589CE3422873}" dt="2022-04-30T10:02:44.027" v="1957" actId="165"/>
          <ac:grpSpMkLst>
            <pc:docMk/>
            <pc:sldMk cId="1245431894" sldId="274"/>
            <ac:grpSpMk id="7" creationId="{552740C5-D09D-F144-B878-0D860851BFA2}"/>
          </ac:grpSpMkLst>
        </pc:grpChg>
        <pc:grpChg chg="del">
          <ac:chgData name="Wencai Zhang" userId="4a86a1d0-2108-4707-8228-1110f3c1be85" providerId="ADAL" clId="{601397D5-CCEE-BD4B-BFE6-589CE3422873}" dt="2022-04-30T09:36:48.223" v="605" actId="165"/>
          <ac:grpSpMkLst>
            <pc:docMk/>
            <pc:sldMk cId="1245431894" sldId="274"/>
            <ac:grpSpMk id="13" creationId="{9FF85789-FF0D-5543-A59A-7B51408D6A7C}"/>
          </ac:grpSpMkLst>
        </pc:grpChg>
        <pc:grpChg chg="del mod topLvl">
          <ac:chgData name="Wencai Zhang" userId="4a86a1d0-2108-4707-8228-1110f3c1be85" providerId="ADAL" clId="{601397D5-CCEE-BD4B-BFE6-589CE3422873}" dt="2022-04-30T09:37:43.047" v="690" actId="165"/>
          <ac:grpSpMkLst>
            <pc:docMk/>
            <pc:sldMk cId="1245431894" sldId="274"/>
            <ac:grpSpMk id="14" creationId="{F95F3D6A-65D7-9E44-96E9-20491945A591}"/>
          </ac:grpSpMkLst>
        </pc:grpChg>
        <pc:grpChg chg="del mod">
          <ac:chgData name="Wencai Zhang" userId="4a86a1d0-2108-4707-8228-1110f3c1be85" providerId="ADAL" clId="{601397D5-CCEE-BD4B-BFE6-589CE3422873}" dt="2022-04-30T09:50:13.091" v="1316" actId="165"/>
          <ac:grpSpMkLst>
            <pc:docMk/>
            <pc:sldMk cId="1245431894" sldId="274"/>
            <ac:grpSpMk id="15" creationId="{C3887E10-3A55-7B47-A45C-5B4C27CE1721}"/>
          </ac:grpSpMkLst>
        </pc:grpChg>
        <pc:grpChg chg="mod topLvl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6" creationId="{44F590F2-CA20-0245-AE8C-00C96D6C7E38}"/>
          </ac:grpSpMkLst>
        </pc:grpChg>
        <pc:grpChg chg="add del mod">
          <ac:chgData name="Wencai Zhang" userId="4a86a1d0-2108-4707-8228-1110f3c1be85" providerId="ADAL" clId="{601397D5-CCEE-BD4B-BFE6-589CE3422873}" dt="2022-04-30T09:37:37.185" v="689" actId="165"/>
          <ac:grpSpMkLst>
            <pc:docMk/>
            <pc:sldMk cId="1245431894" sldId="274"/>
            <ac:grpSpMk id="18" creationId="{0A12C264-61FB-D044-9C64-8162ACF50E8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9" creationId="{CB7F0928-B175-B546-8964-DBF603323D4B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20" creationId="{CC182A8A-D2AE-9F4F-AB69-5D67ED331764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21" creationId="{DC1D7515-7C96-AE4A-8076-558810533C0A}"/>
          </ac:grpSpMkLst>
        </pc:grpChg>
        <pc:grpChg chg="add del mod">
          <ac:chgData name="Wencai Zhang" userId="4a86a1d0-2108-4707-8228-1110f3c1be85" providerId="ADAL" clId="{601397D5-CCEE-BD4B-BFE6-589CE3422873}" dt="2022-04-30T09:41:48.454" v="894" actId="165"/>
          <ac:grpSpMkLst>
            <pc:docMk/>
            <pc:sldMk cId="1245431894" sldId="274"/>
            <ac:grpSpMk id="23" creationId="{04DF7197-8EA6-BB4A-BD75-E251BF3F1659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4" creationId="{2507B683-4FC2-1645-BE77-6E6F9066980B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5" creationId="{A5396756-1CE3-0C48-8687-6C44C66EF2AD}"/>
          </ac:grpSpMkLst>
        </pc:grpChg>
        <pc:grpChg chg="add mod">
          <ac:chgData name="Wencai Zhang" userId="4a86a1d0-2108-4707-8228-1110f3c1be85" providerId="ADAL" clId="{601397D5-CCEE-BD4B-BFE6-589CE3422873}" dt="2022-05-01T00:29:21.502" v="3992" actId="164"/>
          <ac:grpSpMkLst>
            <pc:docMk/>
            <pc:sldMk cId="1245431894" sldId="274"/>
            <ac:grpSpMk id="27" creationId="{3814D77D-2902-F147-9EB7-FD45851C3E8C}"/>
          </ac:grpSpMkLst>
        </pc:grpChg>
        <pc:grpChg chg="add del mod">
          <ac:chgData name="Wencai Zhang" userId="4a86a1d0-2108-4707-8228-1110f3c1be85" providerId="ADAL" clId="{601397D5-CCEE-BD4B-BFE6-589CE3422873}" dt="2022-05-01T00:29:48.714" v="3994" actId="165"/>
          <ac:grpSpMkLst>
            <pc:docMk/>
            <pc:sldMk cId="1245431894" sldId="274"/>
            <ac:grpSpMk id="28" creationId="{694186BE-BDCB-BE4F-AEC4-7724D3C142ED}"/>
          </ac:grpSpMkLst>
        </pc:grpChg>
        <pc:grpChg chg="add del mod">
          <ac:chgData name="Wencai Zhang" userId="4a86a1d0-2108-4707-8228-1110f3c1be85" providerId="ADAL" clId="{601397D5-CCEE-BD4B-BFE6-589CE3422873}" dt="2022-04-30T09:45:36.243" v="1043" actId="478"/>
          <ac:grpSpMkLst>
            <pc:docMk/>
            <pc:sldMk cId="1245431894" sldId="274"/>
            <ac:grpSpMk id="81" creationId="{536F7360-551B-A549-A48F-A5D5A1AEA2A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87" creationId="{C85B12F6-EE77-F143-A342-8C0F8357941D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92" creationId="{CB98DB7A-0394-0F41-8949-312B90C7D875}"/>
          </ac:grpSpMkLst>
        </pc:grpChg>
        <pc:grpChg chg="add del mod">
          <ac:chgData name="Wencai Zhang" userId="4a86a1d0-2108-4707-8228-1110f3c1be85" providerId="ADAL" clId="{601397D5-CCEE-BD4B-BFE6-589CE3422873}" dt="2022-04-30T09:50:53.975" v="1318" actId="165"/>
          <ac:grpSpMkLst>
            <pc:docMk/>
            <pc:sldMk cId="1245431894" sldId="274"/>
            <ac:grpSpMk id="98" creationId="{9FD5B3C4-24E8-954C-A396-1E629071D9DA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2" creationId="{8EA92509-1294-3647-8701-C2F8F63C157C}"/>
          </ac:grpSpMkLst>
        </pc:grpChg>
        <pc:grpChg chg="add del mod">
          <ac:chgData name="Wencai Zhang" userId="4a86a1d0-2108-4707-8228-1110f3c1be85" providerId="ADAL" clId="{601397D5-CCEE-BD4B-BFE6-589CE3422873}" dt="2022-04-30T09:52:01.548" v="1385" actId="478"/>
          <ac:grpSpMkLst>
            <pc:docMk/>
            <pc:sldMk cId="1245431894" sldId="274"/>
            <ac:grpSpMk id="108" creationId="{834423DE-3B16-5446-BA38-B3B7B886853B}"/>
          </ac:grpSpMkLst>
        </pc:grpChg>
        <pc:grpChg chg="mod topLvl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9" creationId="{AE123F98-275F-CB4B-9A4E-CD5A91653574}"/>
          </ac:grpSpMkLst>
        </pc:grpChg>
        <pc:grpChg chg="add mod">
          <ac:chgData name="Wencai Zhang" userId="4a86a1d0-2108-4707-8228-1110f3c1be85" providerId="ADAL" clId="{601397D5-CCEE-BD4B-BFE6-589CE3422873}" dt="2022-04-30T10:00:22.621" v="1768" actId="164"/>
          <ac:grpSpMkLst>
            <pc:docMk/>
            <pc:sldMk cId="1245431894" sldId="274"/>
            <ac:grpSpMk id="115" creationId="{BC6E8D0A-0CF3-4B46-BFFC-F88451C3C8DF}"/>
          </ac:grpSpMkLst>
        </pc:grpChg>
        <pc:grpChg chg="add del mod">
          <ac:chgData name="Wencai Zhang" userId="4a86a1d0-2108-4707-8228-1110f3c1be85" providerId="ADAL" clId="{601397D5-CCEE-BD4B-BFE6-589CE3422873}" dt="2022-04-30T10:00:03.702" v="1762"/>
          <ac:grpSpMkLst>
            <pc:docMk/>
            <pc:sldMk cId="1245431894" sldId="274"/>
            <ac:grpSpMk id="122" creationId="{1816ABAC-CF5A-7C49-8AF7-3769C7ED6B3C}"/>
          </ac:grpSpMkLst>
        </pc:grpChg>
        <pc:grpChg chg="add del mod">
          <ac:chgData name="Wencai Zhang" userId="4a86a1d0-2108-4707-8228-1110f3c1be85" providerId="ADAL" clId="{601397D5-CCEE-BD4B-BFE6-589CE3422873}" dt="2022-04-30T10:01:23.441" v="1896" actId="478"/>
          <ac:grpSpMkLst>
            <pc:docMk/>
            <pc:sldMk cId="1245431894" sldId="274"/>
            <ac:grpSpMk id="127" creationId="{441047AB-573D-2E40-B842-9B5AC0FB0851}"/>
          </ac:grpSpMkLst>
        </pc:grpChg>
        <pc:grpChg chg="mod">
          <ac:chgData name="Wencai Zhang" userId="4a86a1d0-2108-4707-8228-1110f3c1be85" providerId="ADAL" clId="{601397D5-CCEE-BD4B-BFE6-589CE3422873}" dt="2022-04-30T10:00:24.014" v="1769"/>
          <ac:grpSpMkLst>
            <pc:docMk/>
            <pc:sldMk cId="1245431894" sldId="274"/>
            <ac:grpSpMk id="128" creationId="{0998EA91-8E48-694D-A61F-E85EF94EC20F}"/>
          </ac:grpSpMkLst>
        </pc:grpChg>
        <pc:grpChg chg="add mod">
          <ac:chgData name="Wencai Zhang" userId="4a86a1d0-2108-4707-8228-1110f3c1be85" providerId="ADAL" clId="{601397D5-CCEE-BD4B-BFE6-589CE3422873}" dt="2022-04-30T10:01:21.118" v="1895" actId="164"/>
          <ac:grpSpMkLst>
            <pc:docMk/>
            <pc:sldMk cId="1245431894" sldId="274"/>
            <ac:grpSpMk id="135" creationId="{321C8A31-490D-5445-B190-2D01932F7EB9}"/>
          </ac:grpSpMkLst>
        </pc:grpChg>
        <pc:grpChg chg="mod">
          <ac:chgData name="Wencai Zhang" userId="4a86a1d0-2108-4707-8228-1110f3c1be85" providerId="ADAL" clId="{601397D5-CCEE-BD4B-BFE6-589CE3422873}" dt="2022-04-30T10:01:05.350" v="1837"/>
          <ac:grpSpMkLst>
            <pc:docMk/>
            <pc:sldMk cId="1245431894" sldId="274"/>
            <ac:grpSpMk id="136" creationId="{72FD0C54-3AE8-9040-A3C2-E3D389A5159F}"/>
          </ac:grpSpMkLst>
        </pc:grpChg>
        <pc:grpChg chg="add del mod">
          <ac:chgData name="Wencai Zhang" userId="4a86a1d0-2108-4707-8228-1110f3c1be85" providerId="ADAL" clId="{601397D5-CCEE-BD4B-BFE6-589CE3422873}" dt="2022-05-01T00:30:48.616" v="4000"/>
          <ac:grpSpMkLst>
            <pc:docMk/>
            <pc:sldMk cId="1245431894" sldId="274"/>
            <ac:grpSpMk id="143" creationId="{E45301DB-CE95-9C45-90FC-C7295E484541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5" creationId="{DB331214-DA2E-6644-B472-5A9A027F78CA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7" creationId="{A6B498F3-F034-3644-A3AA-3C1D648DB9E6}"/>
          </ac:grpSpMkLst>
        </pc:grpChg>
        <pc:grpChg chg="add del mod">
          <ac:chgData name="Wencai Zhang" userId="4a86a1d0-2108-4707-8228-1110f3c1be85" providerId="ADAL" clId="{601397D5-CCEE-BD4B-BFE6-589CE3422873}" dt="2022-05-01T00:32:01.051" v="4006"/>
          <ac:grpSpMkLst>
            <pc:docMk/>
            <pc:sldMk cId="1245431894" sldId="274"/>
            <ac:grpSpMk id="158" creationId="{F6CED7D0-E08E-2F40-815D-E1765FA41F9C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0" creationId="{3143BDD4-3225-BF42-AB37-5D4A41C3E397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2" creationId="{4B8B5E30-BD16-6D4E-BDC1-87D00230290A}"/>
          </ac:grpSpMkLst>
        </pc:grpChg>
        <pc:picChg chg="mod topLvl modCrop">
          <ac:chgData name="Wencai Zhang" userId="4a86a1d0-2108-4707-8228-1110f3c1be85" providerId="ADAL" clId="{601397D5-CCEE-BD4B-BFE6-589CE3422873}" dt="2022-04-30T09:38:37.837" v="750" actId="164"/>
          <ac:picMkLst>
            <pc:docMk/>
            <pc:sldMk cId="1245431894" sldId="274"/>
            <ac:picMk id="3" creationId="{687E3D84-6344-4328-9010-DABD465265A4}"/>
          </ac:picMkLst>
        </pc:picChg>
        <pc:picChg chg="mod topLvl modCrop">
          <ac:chgData name="Wencai Zhang" userId="4a86a1d0-2108-4707-8228-1110f3c1be85" providerId="ADAL" clId="{601397D5-CCEE-BD4B-BFE6-589CE3422873}" dt="2022-04-30T09:38:21.250" v="711" actId="164"/>
          <ac:picMkLst>
            <pc:docMk/>
            <pc:sldMk cId="1245431894" sldId="274"/>
            <ac:picMk id="4" creationId="{2EEDDA25-1F2E-406D-8861-DFE3770F42DF}"/>
          </ac:picMkLst>
        </pc:picChg>
        <pc:picChg chg="mod topLvl modCrop">
          <ac:chgData name="Wencai Zhang" userId="4a86a1d0-2108-4707-8228-1110f3c1be85" providerId="ADAL" clId="{601397D5-CCEE-BD4B-BFE6-589CE3422873}" dt="2022-04-30T10:18:14.774" v="2141" actId="1035"/>
          <ac:picMkLst>
            <pc:docMk/>
            <pc:sldMk cId="1245431894" sldId="274"/>
            <ac:picMk id="5" creationId="{D552F245-96BD-44EF-962D-5D885EF72528}"/>
          </ac:picMkLst>
        </pc:picChg>
        <pc:picChg chg="mod modCrop">
          <ac:chgData name="Wencai Zhang" userId="4a86a1d0-2108-4707-8228-1110f3c1be85" providerId="ADAL" clId="{601397D5-CCEE-BD4B-BFE6-589CE3422873}" dt="2022-04-30T09:41:48.454" v="894" actId="165"/>
          <ac:picMkLst>
            <pc:docMk/>
            <pc:sldMk cId="1245431894" sldId="274"/>
            <ac:picMk id="9" creationId="{BE4F643D-BC53-4E47-925A-9949972331C6}"/>
          </ac:picMkLst>
        </pc:picChg>
        <pc:picChg chg="mod modCrop">
          <ac:chgData name="Wencai Zhang" userId="4a86a1d0-2108-4707-8228-1110f3c1be85" providerId="ADAL" clId="{601397D5-CCEE-BD4B-BFE6-589CE3422873}" dt="2022-04-30T10:18:33.929" v="2148" actId="1037"/>
          <ac:picMkLst>
            <pc:docMk/>
            <pc:sldMk cId="1245431894" sldId="274"/>
            <ac:picMk id="40" creationId="{60338076-8AA4-E149-AB1D-585C351977FE}"/>
          </ac:picMkLst>
        </pc:picChg>
        <pc:picChg chg="mod topLvl modCrop">
          <ac:chgData name="Wencai Zhang" userId="4a86a1d0-2108-4707-8228-1110f3c1be85" providerId="ADAL" clId="{601397D5-CCEE-BD4B-BFE6-589CE3422873}" dt="2022-05-01T00:29:21.502" v="3992" actId="164"/>
          <ac:picMkLst>
            <pc:docMk/>
            <pc:sldMk cId="1245431894" sldId="274"/>
            <ac:picMk id="41" creationId="{FD52F038-05A1-3645-8977-3867CCB3BF16}"/>
          </ac:picMkLst>
        </pc:picChg>
        <pc:picChg chg="del mod topLvl">
          <ac:chgData name="Wencai Zhang" userId="4a86a1d0-2108-4707-8228-1110f3c1be85" providerId="ADAL" clId="{601397D5-CCEE-BD4B-BFE6-589CE3422873}" dt="2022-04-30T09:50:58.035" v="1319" actId="478"/>
          <ac:picMkLst>
            <pc:docMk/>
            <pc:sldMk cId="1245431894" sldId="274"/>
            <ac:picMk id="101" creationId="{0FD0CAEB-3ACE-CC43-A6BA-E96DA897AE6B}"/>
          </ac:picMkLst>
        </pc:picChg>
        <pc:picChg chg="del mod topLvl">
          <ac:chgData name="Wencai Zhang" userId="4a86a1d0-2108-4707-8228-1110f3c1be85" providerId="ADAL" clId="{601397D5-CCEE-BD4B-BFE6-589CE3422873}" dt="2022-04-30T09:52:01.548" v="1385" actId="478"/>
          <ac:picMkLst>
            <pc:docMk/>
            <pc:sldMk cId="1245431894" sldId="274"/>
            <ac:picMk id="110" creationId="{0E2245FA-56C0-1340-B0F7-5DBAD6E36EA0}"/>
          </ac:picMkLst>
        </pc:picChg>
        <pc:picChg chg="add del mod">
          <ac:chgData name="Wencai Zhang" userId="4a86a1d0-2108-4707-8228-1110f3c1be85" providerId="ADAL" clId="{601397D5-CCEE-BD4B-BFE6-589CE3422873}" dt="2022-04-30T10:08:25.188" v="1987" actId="478"/>
          <ac:picMkLst>
            <pc:docMk/>
            <pc:sldMk cId="1245431894" sldId="274"/>
            <ac:picMk id="142" creationId="{8AA450D9-3D00-C044-A162-1A8E364653D4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6" creationId="{17B1435F-F637-7D49-A9E4-08E784810E07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7" creationId="{CDBC6666-96CF-084E-A9EB-A290FEEFCD92}"/>
          </ac:picMkLst>
        </pc:picChg>
        <pc:cxnChg chg="add del mod">
          <ac:chgData name="Wencai Zhang" userId="4a86a1d0-2108-4707-8228-1110f3c1be85" providerId="ADAL" clId="{601397D5-CCEE-BD4B-BFE6-589CE3422873}" dt="2022-04-30T10:16:56.568" v="2084" actId="478"/>
          <ac:cxnSpMkLst>
            <pc:docMk/>
            <pc:sldMk cId="1245431894" sldId="274"/>
            <ac:cxnSpMk id="10" creationId="{1E32A983-8972-5240-BA8E-B5680C755189}"/>
          </ac:cxnSpMkLst>
        </pc:cxnChg>
        <pc:cxnChg chg="add del mod">
          <ac:chgData name="Wencai Zhang" userId="4a86a1d0-2108-4707-8228-1110f3c1be85" providerId="ADAL" clId="{601397D5-CCEE-BD4B-BFE6-589CE3422873}" dt="2022-04-30T09:50:25.189" v="1317" actId="478"/>
          <ac:cxnSpMkLst>
            <pc:docMk/>
            <pc:sldMk cId="1245431894" sldId="274"/>
            <ac:cxnSpMk id="107" creationId="{843797BE-DFEF-BF4A-85B8-1120010B5576}"/>
          </ac:cxnSpMkLst>
        </pc:cxnChg>
        <pc:cxnChg chg="add del mod">
          <ac:chgData name="Wencai Zhang" userId="4a86a1d0-2108-4707-8228-1110f3c1be85" providerId="ADAL" clId="{601397D5-CCEE-BD4B-BFE6-589CE3422873}" dt="2022-04-30T10:16:54.366" v="2083" actId="478"/>
          <ac:cxnSpMkLst>
            <pc:docMk/>
            <pc:sldMk cId="1245431894" sldId="274"/>
            <ac:cxnSpMk id="113" creationId="{1817209B-7300-F848-AC14-FA0090E1F56D}"/>
          </ac:cxnSpMkLst>
        </pc:cxnChg>
      </pc:sldChg>
      <pc:sldChg chg="addSp delSp modSp mod">
        <pc:chgData name="Wencai Zhang" userId="4a86a1d0-2108-4707-8228-1110f3c1be85" providerId="ADAL" clId="{601397D5-CCEE-BD4B-BFE6-589CE3422873}" dt="2022-05-24T12:52:27.818" v="5262" actId="113"/>
        <pc:sldMkLst>
          <pc:docMk/>
          <pc:sldMk cId="933386568" sldId="284"/>
        </pc:sldMkLst>
        <pc:spChg chg="add mod">
          <ac:chgData name="Wencai Zhang" userId="4a86a1d0-2108-4707-8228-1110f3c1be85" providerId="ADAL" clId="{601397D5-CCEE-BD4B-BFE6-589CE3422873}" dt="2022-05-15T01:08:34.647" v="5232" actId="1037"/>
          <ac:spMkLst>
            <pc:docMk/>
            <pc:sldMk cId="933386568" sldId="284"/>
            <ac:spMk id="3" creationId="{3219B98B-D17F-79CC-201B-392AFE1D677C}"/>
          </ac:spMkLst>
        </pc:spChg>
        <pc:spChg chg="add del mod">
          <ac:chgData name="Wencai Zhang" userId="4a86a1d0-2108-4707-8228-1110f3c1be85" providerId="ADAL" clId="{601397D5-CCEE-BD4B-BFE6-589CE3422873}" dt="2022-05-01T01:04:54.190" v="4942" actId="478"/>
          <ac:spMkLst>
            <pc:docMk/>
            <pc:sldMk cId="933386568" sldId="284"/>
            <ac:spMk id="3" creationId="{A1408ABA-A6A7-9B40-929C-CDE72C0D04CA}"/>
          </ac:spMkLst>
        </pc:spChg>
        <pc:spChg chg="mod">
          <ac:chgData name="Wencai Zhang" userId="4a86a1d0-2108-4707-8228-1110f3c1be85" providerId="ADAL" clId="{601397D5-CCEE-BD4B-BFE6-589CE3422873}" dt="2022-05-24T12:52:27.818" v="5262" actId="113"/>
          <ac:spMkLst>
            <pc:docMk/>
            <pc:sldMk cId="933386568" sldId="284"/>
            <ac:spMk id="30" creationId="{1C0380E3-79BE-1446-AEC3-0CB660E7272B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2" creationId="{5BE10FF6-B4A7-6B4D-83C6-447971D5328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5" creationId="{D7E77E64-EC48-4F4B-8DC5-3AFFAB8EB1F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6" creationId="{9B2B69CC-916B-2144-AD42-5A9D61D7EC7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7" creationId="{D1ABBB74-402B-0048-8DAA-2A9959B58A1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8" creationId="{47A1E29C-0FFE-424B-A01F-6A4419A47F1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9" creationId="{15E7D893-CE20-704C-A46E-5152C5C4399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1" creationId="{2A3DCC62-A131-0341-A8F3-4C96BBC620AC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4" creationId="{7E8A5C9D-CB32-FE43-8B5E-27F935036DE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5" creationId="{3883C1AE-492D-2646-A002-F0569859BB10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6" creationId="{DA6D6170-BA4D-E543-8E90-D6BCDAF26AD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7" creationId="{F6BCE345-A704-E141-9C4A-8D38D90F952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8" creationId="{A5E0B651-E3ED-8647-BA37-1DFE7A43B19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0" creationId="{D492429E-105D-9A47-A243-1A1673255C4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3" creationId="{1FC0A510-1F1B-2646-908D-8753EED97BB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4" creationId="{42F2F4AC-8469-4444-983C-9BAC247EB35B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5" creationId="{00AA4233-AA45-B64F-9EBF-EF370EC44AC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6" creationId="{125FCD0B-0409-7F48-A4F3-64396F4E9815}"/>
          </ac:spMkLst>
        </pc:spChg>
        <pc:spChg chg="del mod topLvl">
          <ac:chgData name="Wencai Zhang" userId="4a86a1d0-2108-4707-8228-1110f3c1be85" providerId="ADAL" clId="{601397D5-CCEE-BD4B-BFE6-589CE3422873}" dt="2022-05-14T01:39:32.523" v="5104" actId="478"/>
          <ac:spMkLst>
            <pc:docMk/>
            <pc:sldMk cId="933386568" sldId="284"/>
            <ac:spMk id="56" creationId="{6F11A542-35C8-2100-3187-82D1E0BDA548}"/>
          </ac:spMkLst>
        </pc:spChg>
        <pc:spChg chg="del mod">
          <ac:chgData name="Wencai Zhang" userId="4a86a1d0-2108-4707-8228-1110f3c1be85" providerId="ADAL" clId="{601397D5-CCEE-BD4B-BFE6-589CE3422873}" dt="2022-05-14T01:39:29.092" v="5103" actId="478"/>
          <ac:spMkLst>
            <pc:docMk/>
            <pc:sldMk cId="933386568" sldId="284"/>
            <ac:spMk id="57" creationId="{6DCE1D51-4DFB-0B58-5FB8-09FB23FB716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8" creationId="{08066992-84B7-E849-9870-CE9C12A482AF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0" creationId="{51AFD3D6-F906-0140-8AB8-EDCE24E8DB2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1" creationId="{2DF77823-E401-1C44-96BA-593F2816448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4" creationId="{D7035750-4CB6-9B44-9859-52A2BEE5EB3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5" creationId="{380A9ED4-660D-0041-AB98-857A5699902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9" creationId="{80C2A820-6801-A24C-86B7-DC204DE63E5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0" creationId="{08CEE753-B37D-964B-9EB9-B0982D3E002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2" creationId="{759E9196-7AC0-0A42-9940-2F16E76A0551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3" creationId="{6F2F7002-D3EA-2141-85CB-86583D5F73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4" creationId="{A8096333-9BF7-D44B-B93E-BA2E862283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5" creationId="{6A033E92-B838-6E42-84DB-EC6641C663C1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6" creationId="{BCAEBD8F-F713-8D49-9AC8-953B48D97D4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7" creationId="{A047E042-33D1-6645-A534-E0484C44B8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8" creationId="{5C587FF2-9011-CB4B-8C28-A2273ABD7176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9" creationId="{7268AD19-D365-7748-AFA6-22B40E19116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0" creationId="{5572FD54-E417-3440-8645-2397F5AC21C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1" creationId="{EA996649-7FB4-9B44-A816-835219717AB2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2" creationId="{ADBDE68F-5F79-444E-9418-8FB5403A3C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3" creationId="{7BEBA0B0-606C-BC45-B582-A1EFD332DF4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4" creationId="{0B163ACD-F721-644A-B3E7-E92293A97B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5" creationId="{4D4450C7-B24D-4243-A6DF-EE96FF7DE398}"/>
          </ac:spMkLst>
        </pc:spChg>
        <pc:spChg chg="mod">
          <ac:chgData name="Wencai Zhang" userId="4a86a1d0-2108-4707-8228-1110f3c1be85" providerId="ADAL" clId="{601397D5-CCEE-BD4B-BFE6-589CE3422873}" dt="2022-05-24T12:52:24.643" v="5261" actId="1076"/>
          <ac:spMkLst>
            <pc:docMk/>
            <pc:sldMk cId="933386568" sldId="284"/>
            <ac:spMk id="108" creationId="{D7F17C28-EEFC-4046-8657-4171497F3A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9" creationId="{4E2B74CA-C218-3B40-9CB4-8A69A7E118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0" creationId="{5CFC2C34-5EFA-CA4A-90CD-BACA96070EDA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1" creationId="{79AAECAE-E619-524D-990B-981AF887755E}"/>
          </ac:spMkLst>
        </pc:s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2" creationId="{0AA23D8D-6AEC-8D30-1CED-D2B3D306F1D7}"/>
          </ac:grpSpMkLst>
        </pc:grpChg>
        <pc:grpChg chg="del">
          <ac:chgData name="Wencai Zhang" userId="4a86a1d0-2108-4707-8228-1110f3c1be85" providerId="ADAL" clId="{601397D5-CCEE-BD4B-BFE6-589CE3422873}" dt="2022-05-01T01:04:51.648" v="4941" actId="478"/>
          <ac:grpSpMkLst>
            <pc:docMk/>
            <pc:sldMk cId="933386568" sldId="284"/>
            <ac:grpSpMk id="17" creationId="{B0D4D876-8BEA-904A-AD5D-7D02415EFBA1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31" creationId="{2D75EAF4-15CA-DD4D-96BC-AFB09E6532E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3" creationId="{D6575CD8-B078-AC4B-B097-ECBCC4F4216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4" creationId="{51034CA5-4B0E-5348-8F19-ADE574A34144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0" creationId="{25B00ECD-F120-074D-B02B-3C9F6E3ACFC7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2" creationId="{C1A519FE-7D32-AC40-8D6C-C91D29E2D8F8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3" creationId="{D4F3A4A4-441E-EB4B-A3EE-B16A850EC36C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9" creationId="{73B0DDA1-777C-BA4A-B425-94E6AE91810E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1" creationId="{55F4185F-F203-8D46-8024-5A50107A976C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2" creationId="{012815A1-CD9E-1345-BBBF-8D0F8E65D1A9}"/>
          </ac:grpSpMkLst>
        </pc:grpChg>
        <pc:grpChg chg="add del mod">
          <ac:chgData name="Wencai Zhang" userId="4a86a1d0-2108-4707-8228-1110f3c1be85" providerId="ADAL" clId="{601397D5-CCEE-BD4B-BFE6-589CE3422873}" dt="2022-05-14T01:39:32.523" v="5104" actId="478"/>
          <ac:grpSpMkLst>
            <pc:docMk/>
            <pc:sldMk cId="933386568" sldId="284"/>
            <ac:grpSpMk id="55" creationId="{B3922988-5BD5-A3DD-0BB2-59D704814258}"/>
          </ac:grpSpMkLst>
        </pc:gr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63" creationId="{A712FC03-C691-1D4B-B345-D8A394EB6A7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68" creationId="{405099F5-AC4D-EC41-97AE-517F7E19203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71" creationId="{C05EA403-1681-9D4A-B256-6A6D8D124AC0}"/>
          </ac:grpSpMkLst>
        </pc:grp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15" creationId="{8418AF89-C222-A543-8A1D-BE70982101BB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7" creationId="{99463D46-60F5-5C45-9D54-F484E8BF5458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9" creationId="{500FEB85-B127-754A-A556-799D01B8C9DC}"/>
          </ac:picMkLst>
        </pc:picChg>
        <pc:picChg chg="mod topLvl modCrop">
          <ac:chgData name="Wencai Zhang" userId="4a86a1d0-2108-4707-8228-1110f3c1be85" providerId="ADAL" clId="{601397D5-CCEE-BD4B-BFE6-589CE3422873}" dt="2022-05-15T01:04:51.047" v="5109" actId="732"/>
          <ac:picMkLst>
            <pc:docMk/>
            <pc:sldMk cId="933386568" sldId="284"/>
            <ac:picMk id="59" creationId="{5B228306-92E2-7295-5BFE-3CFD896E463C}"/>
          </ac:picMkLst>
        </pc:picChg>
        <pc:picChg chg="add mod">
          <ac:chgData name="Wencai Zhang" userId="4a86a1d0-2108-4707-8228-1110f3c1be85" providerId="ADAL" clId="{601397D5-CCEE-BD4B-BFE6-589CE3422873}" dt="2022-05-14T01:39:17.164" v="5101" actId="1076"/>
          <ac:picMkLst>
            <pc:docMk/>
            <pc:sldMk cId="933386568" sldId="284"/>
            <ac:picMk id="62" creationId="{24EA8D65-DF3B-FF43-AAB7-1709AE354ED8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6" creationId="{EEE591E5-4DA0-EF49-B42F-9AB7D72EF951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7" creationId="{9D5D6913-F5BD-384E-B900-1D81D2DEE4AA}"/>
          </ac:picMkLst>
        </pc:picChg>
      </pc:sldChg>
      <pc:sldChg chg="addSp delSp modSp mod">
        <pc:chgData name="Wencai Zhang" userId="4a86a1d0-2108-4707-8228-1110f3c1be85" providerId="ADAL" clId="{601397D5-CCEE-BD4B-BFE6-589CE3422873}" dt="2022-05-24T12:53:14.823" v="5269" actId="1037"/>
        <pc:sldMkLst>
          <pc:docMk/>
          <pc:sldMk cId="1149708096" sldId="285"/>
        </pc:sldMkLst>
        <pc:spChg chg="del">
          <ac:chgData name="Wencai Zhang" userId="4a86a1d0-2108-4707-8228-1110f3c1be85" providerId="ADAL" clId="{601397D5-CCEE-BD4B-BFE6-589CE3422873}" dt="2022-04-30T10:27:56.854" v="2209" actId="478"/>
          <ac:spMkLst>
            <pc:docMk/>
            <pc:sldMk cId="1149708096" sldId="285"/>
            <ac:spMk id="11" creationId="{8B1765C8-9FB9-4242-ACE4-959BEBC359FE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4-30T17:43:50.435" v="2776" actId="1038"/>
          <ac:spMkLst>
            <pc:docMk/>
            <pc:sldMk cId="1149708096" sldId="285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10:37:35.462" v="2610" actId="1037"/>
          <ac:spMkLst>
            <pc:docMk/>
            <pc:sldMk cId="1149708096" sldId="285"/>
            <ac:spMk id="26" creationId="{C4308320-9356-44DD-9CD7-D86A1D1F07E5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44" creationId="{1F682268-4461-BD4E-8D8E-720C57FF2ED2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47" creationId="{65BDBD14-8EDC-FF43-ACEC-7B2892235D53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1" creationId="{D6168116-A21A-4547-A3A6-874E4F2FC8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2" creationId="{58BD06B3-A6AC-3946-81BB-D7DB344761C7}"/>
          </ac:spMkLst>
        </pc:spChg>
        <pc:spChg chg="mod">
          <ac:chgData name="Wencai Zhang" userId="4a86a1d0-2108-4707-8228-1110f3c1be85" providerId="ADAL" clId="{601397D5-CCEE-BD4B-BFE6-589CE3422873}" dt="2022-04-30T17:43:41.136" v="2756" actId="20577"/>
          <ac:spMkLst>
            <pc:docMk/>
            <pc:sldMk cId="1149708096" sldId="285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10:38:57.057" v="2665" actId="1035"/>
          <ac:spMkLst>
            <pc:docMk/>
            <pc:sldMk cId="1149708096" sldId="285"/>
            <ac:spMk id="62" creationId="{1E261997-15B1-5B47-9CD8-5196E34E590B}"/>
          </ac:spMkLst>
        </pc:spChg>
        <pc:spChg chg="mod">
          <ac:chgData name="Wencai Zhang" userId="4a86a1d0-2108-4707-8228-1110f3c1be85" providerId="ADAL" clId="{601397D5-CCEE-BD4B-BFE6-589CE3422873}" dt="2022-05-24T12:53:14.823" v="5269" actId="1037"/>
          <ac:spMkLst>
            <pc:docMk/>
            <pc:sldMk cId="1149708096" sldId="285"/>
            <ac:spMk id="67" creationId="{AAF7166A-E9B7-7F4B-88D9-37A6AF8189F8}"/>
          </ac:spMkLst>
        </pc:spChg>
        <pc:spChg chg="add mod">
          <ac:chgData name="Wencai Zhang" userId="4a86a1d0-2108-4707-8228-1110f3c1be85" providerId="ADAL" clId="{601397D5-CCEE-BD4B-BFE6-589CE3422873}" dt="2022-04-30T10:28:58.843" v="2283" actId="164"/>
          <ac:spMkLst>
            <pc:docMk/>
            <pc:sldMk cId="1149708096" sldId="285"/>
            <ac:spMk id="68" creationId="{6266BB3B-480D-2849-9A8F-96232A8FBFA0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17:44:28.179" v="2816" actId="1038"/>
          <ac:spMkLst>
            <pc:docMk/>
            <pc:sldMk cId="1149708096" sldId="285"/>
            <ac:spMk id="72" creationId="{01E6CBBD-975D-684C-8F3B-F6E617F4614D}"/>
          </ac:spMkLst>
        </pc:spChg>
        <pc:spChg chg="mod">
          <ac:chgData name="Wencai Zhang" userId="4a86a1d0-2108-4707-8228-1110f3c1be85" providerId="ADAL" clId="{601397D5-CCEE-BD4B-BFE6-589CE3422873}" dt="2022-04-30T17:44:22.545" v="2802" actId="20577"/>
          <ac:spMkLst>
            <pc:docMk/>
            <pc:sldMk cId="1149708096" sldId="285"/>
            <ac:spMk id="73" creationId="{682628A6-CA67-524D-B834-77C4B1F2480D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10:31:37.638" v="2515" actId="20577"/>
          <ac:spMkLst>
            <pc:docMk/>
            <pc:sldMk cId="1149708096" sldId="285"/>
            <ac:spMk id="80" creationId="{893C71A0-423B-AB46-B937-EE0408D5528E}"/>
          </ac:spMkLst>
        </pc:spChg>
        <pc:spChg chg="mod">
          <ac:chgData name="Wencai Zhang" userId="4a86a1d0-2108-4707-8228-1110f3c1be85" providerId="ADAL" clId="{601397D5-CCEE-BD4B-BFE6-589CE3422873}" dt="2022-04-30T10:31:10.876" v="2513" actId="1037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4-30T10:30:58.756" v="2492" actId="20577"/>
          <ac:spMkLst>
            <pc:docMk/>
            <pc:sldMk cId="1149708096" sldId="285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7" creationId="{0C58621E-C652-7241-BADB-38CDFDA4174D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4-30T10:31:44.204" v="2519" actId="20577"/>
          <ac:spMkLst>
            <pc:docMk/>
            <pc:sldMk cId="1149708096" sldId="285"/>
            <ac:spMk id="90" creationId="{76E54392-E5F4-4645-8CA7-400EF8273A5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2" creationId="{B5E7AF1F-577F-D74D-9FE8-6CFB54FB3E2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4" creationId="{530A02B4-D6D2-7E4C-9FB6-BA27AE9134B2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6" creationId="{2B8C5462-DFB0-2F48-8E36-438B07DFB1D3}"/>
          </ac:spMkLst>
        </pc:spChg>
        <pc:spChg chg="mod">
          <ac:chgData name="Wencai Zhang" userId="4a86a1d0-2108-4707-8228-1110f3c1be85" providerId="ADAL" clId="{601397D5-CCEE-BD4B-BFE6-589CE3422873}" dt="2022-04-30T17:44:12.696" v="2797" actId="1038"/>
          <ac:spMkLst>
            <pc:docMk/>
            <pc:sldMk cId="1149708096" sldId="285"/>
            <ac:spMk id="97" creationId="{274E4200-55E5-7041-8D4B-3EAC2573EA7F}"/>
          </ac:spMkLst>
        </pc:spChg>
        <pc:spChg chg="mod">
          <ac:chgData name="Wencai Zhang" userId="4a86a1d0-2108-4707-8228-1110f3c1be85" providerId="ADAL" clId="{601397D5-CCEE-BD4B-BFE6-589CE3422873}" dt="2022-04-30T17:44:06.027" v="2782" actId="20577"/>
          <ac:spMkLst>
            <pc:docMk/>
            <pc:sldMk cId="1149708096" sldId="285"/>
            <ac:spMk id="98" creationId="{E17D2348-CFEC-6240-984F-7853BD0A9B90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9" creationId="{3AA52D08-B985-DC4E-BE31-C8983C079CA6}"/>
          </ac:spMkLst>
        </pc:spChg>
        <pc:spChg chg="mod">
          <ac:chgData name="Wencai Zhang" userId="4a86a1d0-2108-4707-8228-1110f3c1be85" providerId="ADAL" clId="{601397D5-CCEE-BD4B-BFE6-589CE3422873}" dt="2022-04-30T10:31:41.149" v="2517" actId="20577"/>
          <ac:spMkLst>
            <pc:docMk/>
            <pc:sldMk cId="1149708096" sldId="285"/>
            <ac:spMk id="101" creationId="{E2D90543-19C2-E349-AAEC-959C0BDBFC5C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04" creationId="{7BA34DF9-067C-6B4B-AACA-65693B8C63E4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5" creationId="{D42D7F3F-5D47-6847-A943-9A68F3E87B29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6" creationId="{C4486F64-D921-ED40-BA8C-16E7C2240B46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7" creationId="{DB8184A8-894D-F949-977C-E39BE2E1A71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9" creationId="{80C7A311-F52F-5243-BB1A-902862AB078F}"/>
          </ac:spMkLst>
        </pc:spChg>
        <pc:spChg chg="mod">
          <ac:chgData name="Wencai Zhang" userId="4a86a1d0-2108-4707-8228-1110f3c1be85" providerId="ADAL" clId="{601397D5-CCEE-BD4B-BFE6-589CE3422873}" dt="2022-04-30T10:41:10.928" v="2721" actId="20577"/>
          <ac:spMkLst>
            <pc:docMk/>
            <pc:sldMk cId="1149708096" sldId="285"/>
            <ac:spMk id="112" creationId="{19408F6A-8B6D-A44F-96BA-24EB3760ED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4" creationId="{BE57D0A7-08B2-014B-8D98-4FC6B0C4E9D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5" creationId="{DC0A7D60-8BB8-744F-96D3-68FFF7ABCBB0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6" creationId="{662FD4E4-F54A-8E47-A01A-CD07321F8323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7" creationId="{2E1280DB-6E2B-1742-8866-937296F68BC7}"/>
          </ac:spMkLst>
        </pc:spChg>
        <pc:spChg chg="mod">
          <ac:chgData name="Wencai Zhang" userId="4a86a1d0-2108-4707-8228-1110f3c1be85" providerId="ADAL" clId="{601397D5-CCEE-BD4B-BFE6-589CE3422873}" dt="2022-04-30T10:41:14.659" v="2723" actId="20577"/>
          <ac:spMkLst>
            <pc:docMk/>
            <pc:sldMk cId="1149708096" sldId="285"/>
            <ac:spMk id="119" creationId="{B5084B10-5E22-6245-A805-2E279313D6D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1" creationId="{A513FBF5-3F76-B240-ACE6-7B964C47516D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2" creationId="{4799A3EE-D38B-5F49-908A-C79A241B616F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3" creationId="{F47570FD-F324-EB4C-8CB8-8C16A2037A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4" creationId="{8EAFB36F-E5D5-E841-A42D-C1E49A65DC32}"/>
          </ac:spMkLst>
        </pc:spChg>
        <pc:spChg chg="mod">
          <ac:chgData name="Wencai Zhang" userId="4a86a1d0-2108-4707-8228-1110f3c1be85" providerId="ADAL" clId="{601397D5-CCEE-BD4B-BFE6-589CE3422873}" dt="2022-04-30T10:41:18.674" v="2725" actId="20577"/>
          <ac:spMkLst>
            <pc:docMk/>
            <pc:sldMk cId="1149708096" sldId="285"/>
            <ac:spMk id="126" creationId="{44909DF1-E740-E84D-9BC8-407C831D9789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8" creationId="{6CC8B625-7C65-6B40-96A2-CF3E275EAD82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9" creationId="{B69C0BEE-EA4A-D14D-A319-F1EB61A2591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0" creationId="{D9787B59-62D9-CF49-8ED0-762FAA870278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1" creationId="{EDD27A20-C796-484D-82B7-93DBAF304608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6" creationId="{DF4F88E1-C1DF-F448-A2D1-6FABC046069E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7" creationId="{63F4150B-9E1F-A14A-9DAC-13E2BD56D36C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0" creationId="{E9F04F84-393B-0247-803A-04757BBB74E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1" creationId="{F1C77AE5-7664-D34B-92FE-7D5FD3E24ED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2" creationId="{7F5F3805-1D7F-904F-B5F4-ADC3AA1D62B2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3" creationId="{891B76C6-8205-2646-9293-D1EAD73A86E8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7" creationId="{7AA92CD7-1053-324E-9D1D-7B95CB2DD04B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8" creationId="{ABAFA949-0F1B-A44C-9888-3B2AFFA4AD9D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49" creationId="{34367095-710D-314C-8E99-FF96D27BC83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0" creationId="{B7BD24F0-83FB-9840-B0B4-B6771AF03FE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1" creationId="{68062BAA-BE4C-E640-A53C-66D6F9C4C3F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2" creationId="{C168F9AF-73EB-D641-86A4-30171970E7C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3" creationId="{44ED3698-0567-FE40-A624-97C0A7C9832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4" creationId="{1BE62DEE-DBFF-DC41-A305-956602962F50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5" creationId="{BFE9E317-DD50-B142-A1C6-DB60C6C6ECA7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6" creationId="{DAB32B2A-6D33-C840-ABD6-A0291A5B416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7" creationId="{C22BE35C-824F-0647-8B3A-1864253D8C4A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60" creationId="{0FD73DFB-B926-5944-82E8-25E92E6FA2E7}"/>
          </ac:spMkLst>
        </pc:spChg>
        <pc:spChg chg="mod">
          <ac:chgData name="Wencai Zhang" userId="4a86a1d0-2108-4707-8228-1110f3c1be85" providerId="ADAL" clId="{601397D5-CCEE-BD4B-BFE6-589CE3422873}" dt="2022-04-30T10:37:46.703" v="2629" actId="1038"/>
          <ac:spMkLst>
            <pc:docMk/>
            <pc:sldMk cId="1149708096" sldId="285"/>
            <ac:spMk id="162" creationId="{3132ABAA-2286-6B43-90FC-7CA0493620CD}"/>
          </ac:spMkLst>
        </pc:spChg>
        <pc:spChg chg="mod">
          <ac:chgData name="Wencai Zhang" userId="4a86a1d0-2108-4707-8228-1110f3c1be85" providerId="ADAL" clId="{601397D5-CCEE-BD4B-BFE6-589CE3422873}" dt="2022-04-30T10:37:41.231" v="2619" actId="1037"/>
          <ac:spMkLst>
            <pc:docMk/>
            <pc:sldMk cId="1149708096" sldId="285"/>
            <ac:spMk id="163" creationId="{B67E019A-039C-034B-8010-0F30EAF5EC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69" creationId="{2DABBA40-3290-D949-87B8-28F2DBF8ABD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0" creationId="{7A83050F-F391-6F44-9CC0-A90B62A53A1E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1" creationId="{F66C24FC-4A99-BE42-8BAC-DEBF3DF32E81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2" creationId="{D1AFC6A5-D6A9-9B4C-A20F-B7CF8FC02950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3" creationId="{2612389C-A1E3-1E49-9A7B-3CAD621E5262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4" creationId="{D7F8C79D-9FD2-6547-A6AB-6351ADC5480F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5" creationId="{F3240188-6BB1-D64A-AA18-F9C2EF42899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6" creationId="{9D9FC8EC-451D-B944-AF33-395CF43DB7F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7" creationId="{31CF7B47-2D9F-0542-9CE5-F7360F618C46}"/>
          </ac:spMkLst>
        </pc:spChg>
        <pc:spChg chg="mod">
          <ac:chgData name="Wencai Zhang" userId="4a86a1d0-2108-4707-8228-1110f3c1be85" providerId="ADAL" clId="{601397D5-CCEE-BD4B-BFE6-589CE3422873}" dt="2022-05-24T12:53:05.002" v="5267" actId="1076"/>
          <ac:spMkLst>
            <pc:docMk/>
            <pc:sldMk cId="1149708096" sldId="285"/>
            <ac:spMk id="178" creationId="{9B8AA01D-55A8-C748-86FD-9C8CB6ED50E0}"/>
          </ac:spMkLst>
        </pc:spChg>
        <pc:grpChg chg="del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4" creationId="{CE98C840-45C2-214F-82F0-40DA913A6490}"/>
          </ac:grpSpMkLst>
        </pc:grpChg>
        <pc:grpChg chg="del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6" creationId="{14AF42AC-F8BA-034D-917A-DCADE1B36D5D}"/>
          </ac:grpSpMkLst>
        </pc:grpChg>
        <pc:grpChg chg="mod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7" creationId="{2655B5AC-157E-D44E-8BAF-1F9F9C5FBBF4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8" creationId="{ED9CD213-3DB1-9548-A745-76AB59B7390C}"/>
          </ac:grpSpMkLst>
        </pc:grpChg>
        <pc:grpChg chg="mod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15" creationId="{E278F67A-D9C4-CA4E-9338-EBAE27291E00}"/>
          </ac:grpSpMkLst>
        </pc:grpChg>
        <pc:grpChg chg="mod">
          <ac:chgData name="Wencai Zhang" userId="4a86a1d0-2108-4707-8228-1110f3c1be85" providerId="ADAL" clId="{601397D5-CCEE-BD4B-BFE6-589CE3422873}" dt="2022-04-30T17:47:37.659" v="3003" actId="1035"/>
          <ac:grpSpMkLst>
            <pc:docMk/>
            <pc:sldMk cId="1149708096" sldId="285"/>
            <ac:grpSpMk id="17" creationId="{CC64A505-9742-AA47-B25B-E2657D796EF2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0" creationId="{A6DAA4FE-2820-2041-A490-E3491E68F991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70" creationId="{A1F87E1B-DDF0-A245-8738-0A761E2F0B0F}"/>
          </ac:grpSpMkLst>
        </pc:grpChg>
        <pc:grpChg chg="add mod">
          <ac:chgData name="Wencai Zhang" userId="4a86a1d0-2108-4707-8228-1110f3c1be85" providerId="ADAL" clId="{601397D5-CCEE-BD4B-BFE6-589CE3422873}" dt="2022-04-30T10:29:42.662" v="2469" actId="1038"/>
          <ac:grpSpMkLst>
            <pc:docMk/>
            <pc:sldMk cId="1149708096" sldId="285"/>
            <ac:grpSpMk id="78" creationId="{3A678556-DC02-1C43-9DA7-3F2D30A20CFD}"/>
          </ac:grpSpMkLst>
        </pc:grpChg>
        <pc:grpChg chg="mod">
          <ac:chgData name="Wencai Zhang" userId="4a86a1d0-2108-4707-8228-1110f3c1be85" providerId="ADAL" clId="{601397D5-CCEE-BD4B-BFE6-589CE3422873}" dt="2022-04-30T10:28:59.639" v="2284"/>
          <ac:grpSpMkLst>
            <pc:docMk/>
            <pc:sldMk cId="1149708096" sldId="285"/>
            <ac:grpSpMk id="83" creationId="{711E2424-9101-BB44-A202-3C522B47FEF5}"/>
          </ac:grpSpMkLst>
        </pc:grpChg>
        <pc:grpChg chg="add mod">
          <ac:chgData name="Wencai Zhang" userId="4a86a1d0-2108-4707-8228-1110f3c1be85" providerId="ADAL" clId="{601397D5-CCEE-BD4B-BFE6-589CE3422873}" dt="2022-04-30T10:30:04.847" v="2488" actId="1038"/>
          <ac:grpSpMkLst>
            <pc:docMk/>
            <pc:sldMk cId="1149708096" sldId="285"/>
            <ac:grpSpMk id="89" creationId="{D05A730E-3C5D-2748-A96F-CD563F5B13C4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91" creationId="{5950188A-14B1-DA4E-9369-7165366CBE43}"/>
          </ac:grpSpMkLst>
        </pc:grpChg>
        <pc:grpChg chg="mod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95" creationId="{5AA2CBDC-65C0-7B40-85C9-DB0CFAB62EC0}"/>
          </ac:grpSpMkLst>
        </pc:grpChg>
        <pc:grpChg chg="add mod">
          <ac:chgData name="Wencai Zhang" userId="4a86a1d0-2108-4707-8228-1110f3c1be85" providerId="ADAL" clId="{601397D5-CCEE-BD4B-BFE6-589CE3422873}" dt="2022-04-30T10:29:34.920" v="2434" actId="1037"/>
          <ac:grpSpMkLst>
            <pc:docMk/>
            <pc:sldMk cId="1149708096" sldId="285"/>
            <ac:grpSpMk id="100" creationId="{36414AE8-2647-4847-8AEC-CF3094F6BFED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102" creationId="{2F3B59D4-2406-1844-9896-F06B056D0708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1" creationId="{B7AA0579-FD80-ED49-89AF-1E08226F2FD0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13" creationId="{A4790209-5A0A-BF41-BC00-6984AD406683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8" creationId="{DFF0F105-8999-F044-A146-0AD784150901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0" creationId="{8EC1334B-51EF-2742-8377-5348343304ED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25" creationId="{F3F27909-B93C-F945-9A43-A3E9668151A5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7" creationId="{23EE3D68-0462-1B4A-8925-FF3B59E2B5D1}"/>
          </ac:grpSpMkLst>
        </pc:grpChg>
        <pc:grpChg chg="add del mod">
          <ac:chgData name="Wencai Zhang" userId="4a86a1d0-2108-4707-8228-1110f3c1be85" providerId="ADAL" clId="{601397D5-CCEE-BD4B-BFE6-589CE3422873}" dt="2022-04-30T23:22:09.152" v="3080" actId="478"/>
          <ac:grpSpMkLst>
            <pc:docMk/>
            <pc:sldMk cId="1149708096" sldId="285"/>
            <ac:grpSpMk id="133" creationId="{1A696CD4-F485-6442-ADB4-A2C7F7F1AE5D}"/>
          </ac:grpSpMkLst>
        </pc:grpChg>
        <pc:grpChg chg="mod">
          <ac:chgData name="Wencai Zhang" userId="4a86a1d0-2108-4707-8228-1110f3c1be85" providerId="ADAL" clId="{601397D5-CCEE-BD4B-BFE6-589CE3422873}" dt="2022-04-30T17:48:59.075" v="3008"/>
          <ac:grpSpMkLst>
            <pc:docMk/>
            <pc:sldMk cId="1149708096" sldId="285"/>
            <ac:grpSpMk id="135" creationId="{7FE65C5F-9F4D-6847-881B-DDEA34688CB7}"/>
          </ac:grpSpMkLst>
        </pc:grpChg>
        <pc:grpChg chg="add del mod">
          <ac:chgData name="Wencai Zhang" userId="4a86a1d0-2108-4707-8228-1110f3c1be85" providerId="ADAL" clId="{601397D5-CCEE-BD4B-BFE6-589CE3422873}" dt="2022-04-30T23:27:06.079" v="3112"/>
          <ac:grpSpMkLst>
            <pc:docMk/>
            <pc:sldMk cId="1149708096" sldId="285"/>
            <ac:grpSpMk id="138" creationId="{4C28A422-4225-FD4A-ADC8-5C478C58A35F}"/>
          </ac:grpSpMkLst>
        </pc:grpChg>
        <pc:grpChg chg="mod">
          <ac:chgData name="Wencai Zhang" userId="4a86a1d0-2108-4707-8228-1110f3c1be85" providerId="ADAL" clId="{601397D5-CCEE-BD4B-BFE6-589CE3422873}" dt="2022-04-30T23:26:59.312" v="3111"/>
          <ac:grpSpMkLst>
            <pc:docMk/>
            <pc:sldMk cId="1149708096" sldId="285"/>
            <ac:grpSpMk id="139" creationId="{D8D38B5C-7A94-EF43-95A9-B6AB2D64FBE8}"/>
          </ac:grpSpMkLst>
        </pc:grpChg>
        <pc:picChg chg="mod modCrop">
          <ac:chgData name="Wencai Zhang" userId="4a86a1d0-2108-4707-8228-1110f3c1be85" providerId="ADAL" clId="{601397D5-CCEE-BD4B-BFE6-589CE3422873}" dt="2022-04-30T23:17:53.496" v="3057" actId="732"/>
          <ac:picMkLst>
            <pc:docMk/>
            <pc:sldMk cId="1149708096" sldId="285"/>
            <ac:picMk id="35" creationId="{DAB56067-C9D8-544A-8F0D-3D5A77A0C7B1}"/>
          </ac:picMkLst>
        </pc:picChg>
        <pc:picChg chg="mod modCrop">
          <ac:chgData name="Wencai Zhang" userId="4a86a1d0-2108-4707-8228-1110f3c1be85" providerId="ADAL" clId="{601397D5-CCEE-BD4B-BFE6-589CE3422873}" dt="2022-04-30T17:48:20.609" v="3007" actId="732"/>
          <ac:picMkLst>
            <pc:docMk/>
            <pc:sldMk cId="1149708096" sldId="285"/>
            <ac:picMk id="37" creationId="{5733B46C-0A78-6E47-9CA7-D72DE37C5B5B}"/>
          </ac:picMkLst>
        </pc:picChg>
        <pc:picChg chg="mod modCrop">
          <ac:chgData name="Wencai Zhang" userId="4a86a1d0-2108-4707-8228-1110f3c1be85" providerId="ADAL" clId="{601397D5-CCEE-BD4B-BFE6-589CE3422873}" dt="2022-04-30T23:22:08.510" v="3079" actId="732"/>
          <ac:picMkLst>
            <pc:docMk/>
            <pc:sldMk cId="1149708096" sldId="285"/>
            <ac:picMk id="69" creationId="{72B762D0-D956-2545-B9FE-55271B7E715D}"/>
          </ac:picMkLst>
        </pc:picChg>
        <pc:picChg chg="mod modCrop">
          <ac:chgData name="Wencai Zhang" userId="4a86a1d0-2108-4707-8228-1110f3c1be85" providerId="ADAL" clId="{601397D5-CCEE-BD4B-BFE6-589CE3422873}" dt="2022-04-30T23:21:49.476" v="3072" actId="732"/>
          <ac:picMkLst>
            <pc:docMk/>
            <pc:sldMk cId="1149708096" sldId="285"/>
            <ac:picMk id="77" creationId="{044309F2-5B00-714A-91B7-DBDFA966F19F}"/>
          </ac:picMkLst>
        </pc:picChg>
        <pc:picChg chg="mod modCrop">
          <ac:chgData name="Wencai Zhang" userId="4a86a1d0-2108-4707-8228-1110f3c1be85" providerId="ADAL" clId="{601397D5-CCEE-BD4B-BFE6-589CE3422873}" dt="2022-04-30T23:22:07.228" v="3077" actId="732"/>
          <ac:picMkLst>
            <pc:docMk/>
            <pc:sldMk cId="1149708096" sldId="285"/>
            <ac:picMk id="93" creationId="{2E2022A4-2B4E-B149-92D3-14BE7FB3152D}"/>
          </ac:picMkLst>
        </pc:picChg>
        <pc:picChg chg="add del mod modCrop">
          <ac:chgData name="Wencai Zhang" userId="4a86a1d0-2108-4707-8228-1110f3c1be85" providerId="ADAL" clId="{601397D5-CCEE-BD4B-BFE6-589CE3422873}" dt="2022-04-30T10:36:35.317" v="2578" actId="478"/>
          <ac:picMkLst>
            <pc:docMk/>
            <pc:sldMk cId="1149708096" sldId="285"/>
            <ac:picMk id="110" creationId="{ED32DF17-EE29-264E-BCDE-B02B42C1CD83}"/>
          </ac:picMkLst>
        </pc:picChg>
        <pc:picChg chg="mod">
          <ac:chgData name="Wencai Zhang" userId="4a86a1d0-2108-4707-8228-1110f3c1be85" providerId="ADAL" clId="{601397D5-CCEE-BD4B-BFE6-589CE3422873}" dt="2022-04-30T17:48:59.075" v="3008"/>
          <ac:picMkLst>
            <pc:docMk/>
            <pc:sldMk cId="1149708096" sldId="285"/>
            <ac:picMk id="134" creationId="{761B6B86-BA08-2E42-A9D4-0D29ECF5DC6F}"/>
          </ac:picMkLst>
        </pc:picChg>
        <pc:picChg chg="mod modCrop">
          <ac:chgData name="Wencai Zhang" userId="4a86a1d0-2108-4707-8228-1110f3c1be85" providerId="ADAL" clId="{601397D5-CCEE-BD4B-BFE6-589CE3422873}" dt="2022-04-30T10:38:15.896" v="2662" actId="1038"/>
          <ac:picMkLst>
            <pc:docMk/>
            <pc:sldMk cId="1149708096" sldId="285"/>
            <ac:picMk id="161" creationId="{EE9D0FF9-6168-D046-8990-141B7FF9567F}"/>
          </ac:picMkLst>
        </pc:picChg>
        <pc:picChg chg="mod modCrop">
          <ac:chgData name="Wencai Zhang" userId="4a86a1d0-2108-4707-8228-1110f3c1be85" providerId="ADAL" clId="{601397D5-CCEE-BD4B-BFE6-589CE3422873}" dt="2022-04-30T10:36:48.319" v="2579"/>
          <ac:picMkLst>
            <pc:docMk/>
            <pc:sldMk cId="1149708096" sldId="285"/>
            <ac:picMk id="164" creationId="{5FF19B2E-7158-7145-984D-7A0D9678071A}"/>
          </ac:picMkLst>
        </pc:picChg>
        <pc:cxnChg chg="del mod">
          <ac:chgData name="Wencai Zhang" userId="4a86a1d0-2108-4707-8228-1110f3c1be85" providerId="ADAL" clId="{601397D5-CCEE-BD4B-BFE6-589CE3422873}" dt="2022-04-30T23:22:38.244" v="3082" actId="478"/>
          <ac:cxnSpMkLst>
            <pc:docMk/>
            <pc:sldMk cId="1149708096" sldId="285"/>
            <ac:cxnSpMk id="103" creationId="{50567C17-0019-DC4A-BAE1-AC93BEDE10E3}"/>
          </ac:cxnSpMkLst>
        </pc:cxnChg>
        <pc:cxnChg chg="add del mod">
          <ac:chgData name="Wencai Zhang" userId="4a86a1d0-2108-4707-8228-1110f3c1be85" providerId="ADAL" clId="{601397D5-CCEE-BD4B-BFE6-589CE3422873}" dt="2022-04-30T23:22:36.420" v="3081" actId="478"/>
          <ac:cxnSpMkLst>
            <pc:docMk/>
            <pc:sldMk cId="1149708096" sldId="285"/>
            <ac:cxnSpMk id="132" creationId="{15AA0296-7ABE-C84B-8BCA-02C46338F8AE}"/>
          </ac:cxnSpMkLst>
        </pc:cxnChg>
      </pc:sldChg>
      <pc:sldChg chg="addSp delSp modSp del mod">
        <pc:chgData name="Wencai Zhang" userId="4a86a1d0-2108-4707-8228-1110f3c1be85" providerId="ADAL" clId="{601397D5-CCEE-BD4B-BFE6-589CE3422873}" dt="2022-05-01T00:05:23.117" v="3905" actId="2696"/>
        <pc:sldMkLst>
          <pc:docMk/>
          <pc:sldMk cId="797336377" sldId="287"/>
        </pc:sldMkLst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1" creationId="{496A500F-F502-CB41-A422-56AF7FEBC53D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2" creationId="{7CA12471-F3DE-834C-A0B9-D69ECC6A5124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93" creationId="{DEFE97B5-9F42-0B43-9F7F-79F784336BD5}"/>
          </ac:spMkLst>
        </pc:spChg>
        <pc:spChg chg="mod">
          <ac:chgData name="Wencai Zhang" userId="4a86a1d0-2108-4707-8228-1110f3c1be85" providerId="ADAL" clId="{601397D5-CCEE-BD4B-BFE6-589CE3422873}" dt="2022-04-30T23:26:35.581" v="3110" actId="1035"/>
          <ac:spMkLst>
            <pc:docMk/>
            <pc:sldMk cId="797336377" sldId="287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113" creationId="{F6CB6D27-412B-0540-BD67-90FAE236ACE7}"/>
          </ac:spMkLst>
        </pc:spChg>
        <pc:spChg chg="del">
          <ac:chgData name="Wencai Zhang" userId="4a86a1d0-2108-4707-8228-1110f3c1be85" providerId="ADAL" clId="{601397D5-CCEE-BD4B-BFE6-589CE3422873}" dt="2022-05-01T00:04:54.909" v="3902" actId="21"/>
          <ac:spMkLst>
            <pc:docMk/>
            <pc:sldMk cId="797336377" sldId="287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4-30T23:26:04.031" v="3108" actId="1076"/>
          <ac:grpSpMkLst>
            <pc:docMk/>
            <pc:sldMk cId="797336377" sldId="287"/>
            <ac:grpSpMk id="77" creationId="{03D8C2BF-7956-F84C-8080-8DCEE101002F}"/>
          </ac:grpSpMkLst>
        </pc:grpChg>
        <pc:grpChg chg="mod">
          <ac:chgData name="Wencai Zhang" userId="4a86a1d0-2108-4707-8228-1110f3c1be85" providerId="ADAL" clId="{601397D5-CCEE-BD4B-BFE6-589CE3422873}" dt="2022-04-30T23:25:58.848" v="3107"/>
          <ac:grpSpMkLst>
            <pc:docMk/>
            <pc:sldMk cId="797336377" sldId="287"/>
            <ac:grpSpMk id="79" creationId="{6CB11493-4062-9E45-A07D-AFCE959525F9}"/>
          </ac:grpSpMkLst>
        </pc:grpChg>
      </pc:sldChg>
      <pc:sldChg chg="addSp delSp modSp del mod">
        <pc:chgData name="Wencai Zhang" userId="4a86a1d0-2108-4707-8228-1110f3c1be85" providerId="ADAL" clId="{601397D5-CCEE-BD4B-BFE6-589CE3422873}" dt="2022-05-01T01:00:32.843" v="4928" actId="2696"/>
        <pc:sldMkLst>
          <pc:docMk/>
          <pc:sldMk cId="1912379916" sldId="288"/>
        </pc:sldMkLst>
        <pc:spChg chg="del">
          <ac:chgData name="Wencai Zhang" userId="4a86a1d0-2108-4707-8228-1110f3c1be85" providerId="ADAL" clId="{601397D5-CCEE-BD4B-BFE6-589CE3422873}" dt="2022-05-01T01:00:07.621" v="4925" actId="21"/>
          <ac:spMkLst>
            <pc:docMk/>
            <pc:sldMk cId="1912379916" sldId="288"/>
            <ac:spMk id="3" creationId="{E57E89A8-149F-F444-868C-E3F689DB43A1}"/>
          </ac:spMkLst>
        </pc:spChg>
        <pc:spChg chg="add del mod">
          <ac:chgData name="Wencai Zhang" userId="4a86a1d0-2108-4707-8228-1110f3c1be85" providerId="ADAL" clId="{601397D5-CCEE-BD4B-BFE6-589CE3422873}" dt="2022-05-01T00:59:52.447" v="4923" actId="21"/>
          <ac:spMkLst>
            <pc:docMk/>
            <pc:sldMk cId="1912379916" sldId="288"/>
            <ac:spMk id="72" creationId="{68D5EF45-EF4C-3543-9492-6A1BB14DC42B}"/>
          </ac:spMkLst>
        </pc:spChg>
        <pc:spChg chg="add mod">
          <ac:chgData name="Wencai Zhang" userId="4a86a1d0-2108-4707-8228-1110f3c1be85" providerId="ADAL" clId="{601397D5-CCEE-BD4B-BFE6-589CE3422873}" dt="2022-05-01T01:00:11.011" v="4926"/>
          <ac:spMkLst>
            <pc:docMk/>
            <pc:sldMk cId="1912379916" sldId="288"/>
            <ac:spMk id="83" creationId="{E699E075-1256-CF4A-90F2-C9DC87E28953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0" creationId="{0724B1FD-98C0-E543-B80E-42E42628C165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1" creationId="{D92F082E-408D-2140-8A61-97B603C35023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4" creationId="{75A4291E-31EB-1948-8650-B6A91E0B3B70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5" creationId="{B4A5F239-DE78-A947-B47A-B526E60BD5DB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6" creationId="{29FF29C8-D352-E349-9FCE-4DD07B22B449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7" creationId="{BF331F05-92FF-224B-8A97-59F3D69636A3}"/>
          </ac:spMkLst>
        </pc:spChg>
        <pc:spChg chg="del">
          <ac:chgData name="Wencai Zhang" userId="4a86a1d0-2108-4707-8228-1110f3c1be85" providerId="ADAL" clId="{601397D5-CCEE-BD4B-BFE6-589CE3422873}" dt="2022-05-01T00:59:34.851" v="4921" actId="21"/>
          <ac:spMkLst>
            <pc:docMk/>
            <pc:sldMk cId="1912379916" sldId="288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5-01T00:55:13.057" v="4718" actId="164"/>
          <ac:grpSpMkLst>
            <pc:docMk/>
            <pc:sldMk cId="1912379916" sldId="288"/>
            <ac:grpSpMk id="6" creationId="{EB8DD054-3AE9-A347-BB20-3B93A9350E0D}"/>
          </ac:grpSpMkLst>
        </pc:grpChg>
        <pc:grpChg chg="add mod">
          <ac:chgData name="Wencai Zhang" userId="4a86a1d0-2108-4707-8228-1110f3c1be85" providerId="ADAL" clId="{601397D5-CCEE-BD4B-BFE6-589CE3422873}" dt="2022-05-01T00:55:25.057" v="4719" actId="164"/>
          <ac:grpSpMkLst>
            <pc:docMk/>
            <pc:sldMk cId="1912379916" sldId="288"/>
            <ac:grpSpMk id="7" creationId="{68FD2353-F6ED-B046-BBCB-BA39C50E9936}"/>
          </ac:grpSpMkLst>
        </pc:grpChg>
        <pc:grpChg chg="add mod">
          <ac:chgData name="Wencai Zhang" userId="4a86a1d0-2108-4707-8228-1110f3c1be85" providerId="ADAL" clId="{601397D5-CCEE-BD4B-BFE6-589CE3422873}" dt="2022-05-01T00:55:33.141" v="4720" actId="164"/>
          <ac:grpSpMkLst>
            <pc:docMk/>
            <pc:sldMk cId="1912379916" sldId="288"/>
            <ac:grpSpMk id="8" creationId="{417433C8-28F0-DB4E-8C25-1C708E8E07F4}"/>
          </ac:grpSpMkLst>
        </pc:grpChg>
        <pc:graphicFrameChg chg="del">
          <ac:chgData name="Wencai Zhang" userId="4a86a1d0-2108-4707-8228-1110f3c1be85" providerId="ADAL" clId="{601397D5-CCEE-BD4B-BFE6-589CE3422873}" dt="2022-05-01T01:00:07.621" v="4925" actId="21"/>
          <ac:graphicFrameMkLst>
            <pc:docMk/>
            <pc:sldMk cId="1912379916" sldId="288"/>
            <ac:graphicFrameMk id="2" creationId="{02A0B3AD-96A0-1340-BB53-74771DCE2FB8}"/>
          </ac:graphicFrameMkLst>
        </pc:graphicFrameChg>
        <pc:graphicFrameChg chg="add mod">
          <ac:chgData name="Wencai Zhang" userId="4a86a1d0-2108-4707-8228-1110f3c1be85" providerId="ADAL" clId="{601397D5-CCEE-BD4B-BFE6-589CE3422873}" dt="2022-05-01T01:00:11.011" v="4926"/>
          <ac:graphicFrameMkLst>
            <pc:docMk/>
            <pc:sldMk cId="1912379916" sldId="288"/>
            <ac:graphicFrameMk id="77" creationId="{B9162564-8B0A-4C48-94C4-54555B098D55}"/>
          </ac:graphicFrameMkLst>
        </pc:graphicFrameChg>
        <pc:picChg chg="mod modCrop">
          <ac:chgData name="Wencai Zhang" userId="4a86a1d0-2108-4707-8228-1110f3c1be85" providerId="ADAL" clId="{601397D5-CCEE-BD4B-BFE6-589CE3422873}" dt="2022-05-01T00:44:14.007" v="4231" actId="732"/>
          <ac:picMkLst>
            <pc:docMk/>
            <pc:sldMk cId="1912379916" sldId="288"/>
            <ac:picMk id="63" creationId="{AC982787-C19D-8545-A1F1-0F57A37833E6}"/>
          </ac:picMkLst>
        </pc:picChg>
        <pc:picChg chg="mod modCrop">
          <ac:chgData name="Wencai Zhang" userId="4a86a1d0-2108-4707-8228-1110f3c1be85" providerId="ADAL" clId="{601397D5-CCEE-BD4B-BFE6-589CE3422873}" dt="2022-05-01T00:44:04.133" v="4230" actId="732"/>
          <ac:picMkLst>
            <pc:docMk/>
            <pc:sldMk cId="1912379916" sldId="288"/>
            <ac:picMk id="64" creationId="{EF3D6C60-8D43-8245-A65E-2874389C4BAF}"/>
          </ac:picMkLst>
        </pc:picChg>
        <pc:picChg chg="mod modCrop">
          <ac:chgData name="Wencai Zhang" userId="4a86a1d0-2108-4707-8228-1110f3c1be85" providerId="ADAL" clId="{601397D5-CCEE-BD4B-BFE6-589CE3422873}" dt="2022-05-01T00:44:51.882" v="4234" actId="732"/>
          <ac:picMkLst>
            <pc:docMk/>
            <pc:sldMk cId="1912379916" sldId="288"/>
            <ac:picMk id="80" creationId="{34C69AC7-E529-E44F-A2DF-51DF0CC31B89}"/>
          </ac:picMkLst>
        </pc:picChg>
        <pc:picChg chg="mod modCrop">
          <ac:chgData name="Wencai Zhang" userId="4a86a1d0-2108-4707-8228-1110f3c1be85" providerId="ADAL" clId="{601397D5-CCEE-BD4B-BFE6-589CE3422873}" dt="2022-05-01T00:43:47.889" v="4229" actId="732"/>
          <ac:picMkLst>
            <pc:docMk/>
            <pc:sldMk cId="1912379916" sldId="288"/>
            <ac:picMk id="118" creationId="{E33DAA03-BB54-5D44-AA9E-E3552140CDB7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55.117" v="5266" actId="113"/>
        <pc:sldMkLst>
          <pc:docMk/>
          <pc:sldMk cId="1407856934" sldId="289"/>
        </pc:sldMkLst>
        <pc:spChg chg="mod">
          <ac:chgData name="Wencai Zhang" userId="4a86a1d0-2108-4707-8228-1110f3c1be85" providerId="ADAL" clId="{601397D5-CCEE-BD4B-BFE6-589CE3422873}" dt="2022-05-24T12:52:55.117" v="5266" actId="113"/>
          <ac:spMkLst>
            <pc:docMk/>
            <pc:sldMk cId="1407856934" sldId="289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23:29:10.723" v="3138" actId="20577"/>
          <ac:spMkLst>
            <pc:docMk/>
            <pc:sldMk cId="1407856934" sldId="289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23:29:29.988" v="3163" actId="20577"/>
          <ac:spMkLst>
            <pc:docMk/>
            <pc:sldMk cId="1407856934" sldId="289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08" creationId="{70C767CA-8362-E846-995F-325FA8E3022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10" creationId="{D82CB67E-8622-754E-97D2-1959EFE8199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2" creationId="{F75C7E26-49E5-8F4B-81FE-2642E576543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3" creationId="{6C10D26F-07E1-FB48-92E9-9350FD3E8F8D}"/>
          </ac:spMkLst>
        </pc:spChg>
        <pc:spChg chg="mod">
          <ac:chgData name="Wencai Zhang" userId="4a86a1d0-2108-4707-8228-1110f3c1be85" providerId="ADAL" clId="{601397D5-CCEE-BD4B-BFE6-589CE3422873}" dt="2022-04-30T23:31:57.820" v="3285" actId="20577"/>
          <ac:spMkLst>
            <pc:docMk/>
            <pc:sldMk cId="1407856934" sldId="289"/>
            <ac:spMk id="135" creationId="{D715092B-1735-CC41-BA9D-DFCD1AC14C54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7" creationId="{DCBC9871-974C-FF4C-8DCA-5A8218D6194A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8" creationId="{20F05B7B-347A-A449-AA64-A6F4527AA65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9" creationId="{C5F90E82-897E-A041-BC2C-66C9060BB3D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40" creationId="{6FE32478-553C-D541-9B59-F9F8173F67E4}"/>
          </ac:spMkLst>
        </pc:spChg>
        <pc:spChg chg="mod">
          <ac:chgData name="Wencai Zhang" userId="4a86a1d0-2108-4707-8228-1110f3c1be85" providerId="ADAL" clId="{601397D5-CCEE-BD4B-BFE6-589CE3422873}" dt="2022-04-30T23:33:17.740" v="3405" actId="20577"/>
          <ac:spMkLst>
            <pc:docMk/>
            <pc:sldMk cId="1407856934" sldId="289"/>
            <ac:spMk id="142" creationId="{9FE5CB05-037C-5644-ABC7-F6A1FE1675E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4" creationId="{CCEF2AC3-0B3F-6843-A922-FFFB79A2EF7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5" creationId="{F1A2B842-5A1B-C34B-9B54-3367EB29D301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6" creationId="{1E84548F-F7F3-564A-BCEA-385AB5C5C8D7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7" creationId="{E530FEA3-30A7-4243-A436-EFF61202A7CD}"/>
          </ac:spMkLst>
        </pc:spChg>
        <pc:spChg chg="mod">
          <ac:chgData name="Wencai Zhang" userId="4a86a1d0-2108-4707-8228-1110f3c1be85" providerId="ADAL" clId="{601397D5-CCEE-BD4B-BFE6-589CE3422873}" dt="2022-04-30T23:33:14.435" v="3403" actId="20577"/>
          <ac:spMkLst>
            <pc:docMk/>
            <pc:sldMk cId="1407856934" sldId="289"/>
            <ac:spMk id="149" creationId="{60D32DFA-6497-7346-9C28-9ED5DF2B9D43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1" creationId="{DE41B9DC-51D8-804B-8421-D85418DF9E22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2" creationId="{C701D05A-1FB6-3B41-B86E-2BA96830EAE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3" creationId="{84C39668-52DB-A34C-A241-45CD6DFFDD8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4" creationId="{F66A00ED-30C9-FE4C-8740-1F7038533600}"/>
          </ac:spMkLst>
        </pc:spChg>
        <pc:spChg chg="mod">
          <ac:chgData name="Wencai Zhang" userId="4a86a1d0-2108-4707-8228-1110f3c1be85" providerId="ADAL" clId="{601397D5-CCEE-BD4B-BFE6-589CE3422873}" dt="2022-04-30T23:34:37.136" v="3512" actId="20577"/>
          <ac:spMkLst>
            <pc:docMk/>
            <pc:sldMk cId="1407856934" sldId="289"/>
            <ac:spMk id="156" creationId="{19173C30-C645-724E-BCD0-3C97BB3C196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58" creationId="{83C8F045-1688-9343-980E-D988F6BC35C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5" creationId="{EC67B775-6E2F-B648-9BAF-1A604CD2B91A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6" creationId="{D7601504-4869-7E4A-B0B3-E39B0C2935F1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7" creationId="{093A8EAF-D547-5E43-AC30-FB03BC273602}"/>
          </ac:spMkLst>
        </pc:spChg>
        <pc:spChg chg="mod">
          <ac:chgData name="Wencai Zhang" userId="4a86a1d0-2108-4707-8228-1110f3c1be85" providerId="ADAL" clId="{601397D5-CCEE-BD4B-BFE6-589CE3422873}" dt="2022-04-30T23:34:34.165" v="3510" actId="20577"/>
          <ac:spMkLst>
            <pc:docMk/>
            <pc:sldMk cId="1407856934" sldId="289"/>
            <ac:spMk id="169" creationId="{AB7919FD-A39D-FB4B-9EB3-1797E27961E8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1" creationId="{97336412-D1D1-9844-9C9F-04811FA2458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2" creationId="{B93FC1FD-E0F5-4340-9C3C-EB0F2BFAFEBB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3" creationId="{FE77E810-A8AF-FB40-B1B3-B81F50EF2D8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4" creationId="{96CAECD1-BA31-5545-A3E8-83EA207D3DD6}"/>
          </ac:spMkLst>
        </pc:spChg>
        <pc:spChg chg="mod">
          <ac:chgData name="Wencai Zhang" userId="4a86a1d0-2108-4707-8228-1110f3c1be85" providerId="ADAL" clId="{601397D5-CCEE-BD4B-BFE6-589CE3422873}" dt="2022-04-30T23:34:39.888" v="3514" actId="20577"/>
          <ac:spMkLst>
            <pc:docMk/>
            <pc:sldMk cId="1407856934" sldId="289"/>
            <ac:spMk id="176" creationId="{F96898F6-84E7-6843-8260-F837DE252D71}"/>
          </ac:spMkLst>
        </pc:spChg>
        <pc:spChg chg="del">
          <ac:chgData name="Wencai Zhang" userId="4a86a1d0-2108-4707-8228-1110f3c1be85" providerId="ADAL" clId="{601397D5-CCEE-BD4B-BFE6-589CE3422873}" dt="2022-05-01T00:05:00.885" v="3903" actId="478"/>
          <ac:spMkLst>
            <pc:docMk/>
            <pc:sldMk cId="1407856934" sldId="289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9" creationId="{63542515-3A0A-B849-B10B-F3763C78483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0" creationId="{B1C1D200-6903-3341-8780-D99338BB423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1" creationId="{F6310896-C60B-484E-A415-91FD13B10AE3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2" creationId="{7403F486-0C32-0241-B664-CC7C84C2FC72}"/>
          </ac:spMkLst>
        </pc:spChg>
        <pc:spChg chg="add mod">
          <ac:chgData name="Wencai Zhang" userId="4a86a1d0-2108-4707-8228-1110f3c1be85" providerId="ADAL" clId="{601397D5-CCEE-BD4B-BFE6-589CE3422873}" dt="2022-05-24T12:52:51.318" v="5265" actId="1076"/>
          <ac:spMkLst>
            <pc:docMk/>
            <pc:sldMk cId="1407856934" sldId="289"/>
            <ac:spMk id="190" creationId="{D935C8CE-1EE1-A64F-ACA1-5580D3854AF2}"/>
          </ac:spMkLst>
        </pc:spChg>
        <pc:grpChg chg="topLv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2" creationId="{23522517-C292-8C40-8C84-B30913B1168A}"/>
          </ac:grpSpMkLst>
        </pc:grpChg>
        <pc:grpChg chg="topLv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3" creationId="{B836CDE8-D276-B14C-8317-FF755C7FD67B}"/>
          </ac:grpSpMkLst>
        </pc:grpChg>
        <pc:grpChg chg="de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7" creationId="{2655B5AC-157E-D44E-8BAF-1F9F9C5FBBF4}"/>
          </ac:grpSpMkLst>
        </pc:grpChg>
        <pc:grpChg chg="topLv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21" creationId="{A08E21AA-65D0-904C-A117-A07CC56DBB2D}"/>
          </ac:grpSpMkLst>
        </pc:grpChg>
        <pc:grpChg chg="del">
          <ac:chgData name="Wencai Zhang" userId="4a86a1d0-2108-4707-8228-1110f3c1be85" providerId="ADAL" clId="{601397D5-CCEE-BD4B-BFE6-589CE3422873}" dt="2022-04-30T23:31:50.503" v="3283" actId="478"/>
          <ac:grpSpMkLst>
            <pc:docMk/>
            <pc:sldMk cId="1407856934" sldId="289"/>
            <ac:grpSpMk id="78" creationId="{3A678556-DC02-1C43-9DA7-3F2D30A20CFD}"/>
          </ac:grpSpMkLst>
        </pc:grpChg>
        <pc:grpChg chg="topLv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79" creationId="{BCAD6698-7ABF-9143-B78D-400EA289BEFB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89" creationId="{D05A730E-3C5D-2748-A96F-CD563F5B13C4}"/>
          </ac:grpSpMkLst>
        </pc:grpChg>
        <pc:grpChg chg="topLv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95" creationId="{5AA2CBDC-65C0-7B40-85C9-DB0CFAB62EC0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100" creationId="{36414AE8-2647-4847-8AEC-CF3094F6BFED}"/>
          </ac:grpSpMkLst>
        </pc:grpChg>
        <pc:grpChg chg="add del mod">
          <ac:chgData name="Wencai Zhang" userId="4a86a1d0-2108-4707-8228-1110f3c1be85" providerId="ADAL" clId="{601397D5-CCEE-BD4B-BFE6-589CE3422873}" dt="2022-04-30T23:53:45.770" v="3873" actId="478"/>
          <ac:grpSpMkLst>
            <pc:docMk/>
            <pc:sldMk cId="1407856934" sldId="289"/>
            <ac:grpSpMk id="103" creationId="{C7D43C47-5CD4-2244-8DC8-222616EFFB2D}"/>
          </ac:grpSpMkLst>
        </pc:grpChg>
        <pc:grpChg chg="mod">
          <ac:chgData name="Wencai Zhang" userId="4a86a1d0-2108-4707-8228-1110f3c1be85" providerId="ADAL" clId="{601397D5-CCEE-BD4B-BFE6-589CE3422873}" dt="2022-04-30T23:28:19.263" v="3116"/>
          <ac:grpSpMkLst>
            <pc:docMk/>
            <pc:sldMk cId="1407856934" sldId="289"/>
            <ac:grpSpMk id="104" creationId="{D6EBF83F-25DC-9641-AB60-12A65B3DA13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4-30T23:31:45.939" v="3282" actId="167"/>
          <ac:grpSpMkLst>
            <pc:docMk/>
            <pc:sldMk cId="1407856934" sldId="289"/>
            <ac:grpSpMk id="134" creationId="{162F8122-6771-ED44-9C6F-7137950C8C9E}"/>
          </ac:grpSpMkLst>
        </pc:grpChg>
        <pc:grpChg chg="mod">
          <ac:chgData name="Wencai Zhang" userId="4a86a1d0-2108-4707-8228-1110f3c1be85" providerId="ADAL" clId="{601397D5-CCEE-BD4B-BFE6-589CE3422873}" dt="2022-04-30T23:31:20.769" v="3179"/>
          <ac:grpSpMkLst>
            <pc:docMk/>
            <pc:sldMk cId="1407856934" sldId="289"/>
            <ac:grpSpMk id="136" creationId="{52684B29-9FC9-F647-9922-88BE21BA1C60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1" creationId="{B6D402F1-EF29-2445-B776-4323F8FFA11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43" creationId="{0F97778A-C3DB-7342-BDCA-19DCB0C4FE7C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8" creationId="{06093D73-035D-9143-9074-4FFB9E1C8E0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50" creationId="{7CA76CFA-AC89-754D-906B-10B7EC2CECB5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55" creationId="{390F5643-AD11-934E-B66C-F9E0138F20A2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57" creationId="{FBE21514-BB4D-DD41-8F00-1A8606883AE2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68" creationId="{8067A426-6CF7-B648-90EA-4F6DD170B88B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0" creationId="{B66B16C5-B4E0-5741-B4B3-38CBE7FED8CA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75" creationId="{D2800C9E-DF50-6F4A-AC39-B7325F39B013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7" creationId="{AFEA0C03-A481-D143-A7FA-124439AB8C79}"/>
          </ac:grpSpMkLst>
        </pc:grpChg>
        <pc:picChg chg="del topLvl">
          <ac:chgData name="Wencai Zhang" userId="4a86a1d0-2108-4707-8228-1110f3c1be85" providerId="ADAL" clId="{601397D5-CCEE-BD4B-BFE6-589CE3422873}" dt="2022-04-30T23:30:48.810" v="3176" actId="478"/>
          <ac:picMkLst>
            <pc:docMk/>
            <pc:sldMk cId="1407856934" sldId="289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4-30T23:30:42.919" v="3175" actId="478"/>
          <ac:picMkLst>
            <pc:docMk/>
            <pc:sldMk cId="1407856934" sldId="289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4-30T23:30:54.506" v="3178" actId="478"/>
          <ac:picMkLst>
            <pc:docMk/>
            <pc:sldMk cId="1407856934" sldId="289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4-30T23:30:34.297" v="3172" actId="478"/>
          <ac:picMkLst>
            <pc:docMk/>
            <pc:sldMk cId="1407856934" sldId="289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4-30T23:30:51.679" v="3177" actId="478"/>
          <ac:picMkLst>
            <pc:docMk/>
            <pc:sldMk cId="1407856934" sldId="289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4-30T23:30:37.184" v="3173" actId="478"/>
          <ac:picMkLst>
            <pc:docMk/>
            <pc:sldMk cId="1407856934" sldId="289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4-30T23:30:39.175" v="3174" actId="478"/>
          <ac:picMkLst>
            <pc:docMk/>
            <pc:sldMk cId="1407856934" sldId="289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4-30T23:43:02.900" v="3791" actId="1038"/>
          <ac:picMkLst>
            <pc:docMk/>
            <pc:sldMk cId="1407856934" sldId="289"/>
            <ac:picMk id="183" creationId="{6DF655EF-B227-7246-9802-B11D2C6A19A2}"/>
          </ac:picMkLst>
        </pc:picChg>
        <pc:picChg chg="add mod modCrop">
          <ac:chgData name="Wencai Zhang" userId="4a86a1d0-2108-4707-8228-1110f3c1be85" providerId="ADAL" clId="{601397D5-CCEE-BD4B-BFE6-589CE3422873}" dt="2022-04-30T23:43:26.332" v="3795" actId="732"/>
          <ac:picMkLst>
            <pc:docMk/>
            <pc:sldMk cId="1407856934" sldId="289"/>
            <ac:picMk id="184" creationId="{84CC4829-81DE-944B-8AE3-EEC56F9CF746}"/>
          </ac:picMkLst>
        </pc:picChg>
        <pc:picChg chg="add mod modCrop">
          <ac:chgData name="Wencai Zhang" userId="4a86a1d0-2108-4707-8228-1110f3c1be85" providerId="ADAL" clId="{601397D5-CCEE-BD4B-BFE6-589CE3422873}" dt="2022-04-30T23:44:55.394" v="3825"/>
          <ac:picMkLst>
            <pc:docMk/>
            <pc:sldMk cId="1407856934" sldId="289"/>
            <ac:picMk id="185" creationId="{467884D8-44B7-B145-BE58-4FF193FE4393}"/>
          </ac:picMkLst>
        </pc:picChg>
        <pc:picChg chg="add mod modCrop">
          <ac:chgData name="Wencai Zhang" userId="4a86a1d0-2108-4707-8228-1110f3c1be85" providerId="ADAL" clId="{601397D5-CCEE-BD4B-BFE6-589CE3422873}" dt="2022-04-30T23:59:13.775" v="3895" actId="732"/>
          <ac:picMkLst>
            <pc:docMk/>
            <pc:sldMk cId="1407856934" sldId="289"/>
            <ac:picMk id="186" creationId="{D185AFC2-AEB4-EE46-9C5D-CBD93F7836FC}"/>
          </ac:picMkLst>
        </pc:picChg>
        <pc:picChg chg="add mod modCrop">
          <ac:chgData name="Wencai Zhang" userId="4a86a1d0-2108-4707-8228-1110f3c1be85" providerId="ADAL" clId="{601397D5-CCEE-BD4B-BFE6-589CE3422873}" dt="2022-05-01T00:00:42.111" v="3901" actId="732"/>
          <ac:picMkLst>
            <pc:docMk/>
            <pc:sldMk cId="1407856934" sldId="289"/>
            <ac:picMk id="187" creationId="{82502955-AF95-494A-A5C3-FC25D3384C5B}"/>
          </ac:picMkLst>
        </pc:picChg>
        <pc:picChg chg="add mod modCrop">
          <ac:chgData name="Wencai Zhang" userId="4a86a1d0-2108-4707-8228-1110f3c1be85" providerId="ADAL" clId="{601397D5-CCEE-BD4B-BFE6-589CE3422873}" dt="2022-04-30T23:52:40.896" v="3864" actId="732"/>
          <ac:picMkLst>
            <pc:docMk/>
            <pc:sldMk cId="1407856934" sldId="289"/>
            <ac:picMk id="188" creationId="{E28F2C99-FFAC-E640-BD6E-657D5A82A8C4}"/>
          </ac:picMkLst>
        </pc:picChg>
        <pc:picChg chg="add mod modCrop">
          <ac:chgData name="Wencai Zhang" userId="4a86a1d0-2108-4707-8228-1110f3c1be85" providerId="ADAL" clId="{601397D5-CCEE-BD4B-BFE6-589CE3422873}" dt="2022-04-30T23:55:55.279" v="3884" actId="732"/>
          <ac:picMkLst>
            <pc:docMk/>
            <pc:sldMk cId="1407856934" sldId="289"/>
            <ac:picMk id="189" creationId="{71B3C6A2-BAE0-C246-9E07-A5C558F382A9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42.185" v="5264" actId="1076"/>
        <pc:sldMkLst>
          <pc:docMk/>
          <pc:sldMk cId="3037230208" sldId="290"/>
        </pc:sldMkLst>
        <pc:spChg chg="add del mod">
          <ac:chgData name="Wencai Zhang" userId="4a86a1d0-2108-4707-8228-1110f3c1be85" providerId="ADAL" clId="{601397D5-CCEE-BD4B-BFE6-589CE3422873}" dt="2022-05-01T01:03:44.641" v="4930" actId="478"/>
          <ac:spMkLst>
            <pc:docMk/>
            <pc:sldMk cId="3037230208" sldId="290"/>
            <ac:spMk id="9" creationId="{D5DE88EC-61B3-C549-A5C3-4CE8D9EC50CD}"/>
          </ac:spMkLst>
        </pc:spChg>
        <pc:spChg chg="add del mod">
          <ac:chgData name="Wencai Zhang" userId="4a86a1d0-2108-4707-8228-1110f3c1be85" providerId="ADAL" clId="{601397D5-CCEE-BD4B-BFE6-589CE3422873}" dt="2022-05-01T01:05:24.353" v="4995" actId="478"/>
          <ac:spMkLst>
            <pc:docMk/>
            <pc:sldMk cId="3037230208" sldId="290"/>
            <ac:spMk id="11" creationId="{B46E44DC-FC65-4D4F-A2FC-5B387C047FB4}"/>
          </ac:spMkLst>
        </pc:spChg>
        <pc:spChg chg="mod">
          <ac:chgData name="Wencai Zhang" userId="4a86a1d0-2108-4707-8228-1110f3c1be85" providerId="ADAL" clId="{601397D5-CCEE-BD4B-BFE6-589CE3422873}" dt="2022-05-24T12:52:35.203" v="5263" actId="113"/>
          <ac:spMkLst>
            <pc:docMk/>
            <pc:sldMk cId="3037230208" sldId="290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5-02T00:16:31.494" v="5022" actId="1038"/>
          <ac:spMkLst>
            <pc:docMk/>
            <pc:sldMk cId="3037230208" sldId="290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5-01T00:35:55.368" v="4208" actId="20577"/>
          <ac:spMkLst>
            <pc:docMk/>
            <pc:sldMk cId="3037230208" sldId="290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5-01T00:46:11.578" v="4278" actId="1038"/>
          <ac:spMkLst>
            <pc:docMk/>
            <pc:sldMk cId="3037230208" sldId="290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5-02T00:16:38.966" v="5040" actId="1038"/>
          <ac:spMkLst>
            <pc:docMk/>
            <pc:sldMk cId="3037230208" sldId="290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04" creationId="{298F8962-F801-A04D-A8F0-6D2B903D7BFB}"/>
          </ac:spMkLst>
        </pc:spChg>
        <pc:spChg chg="mod">
          <ac:chgData name="Wencai Zhang" userId="4a86a1d0-2108-4707-8228-1110f3c1be85" providerId="ADAL" clId="{601397D5-CCEE-BD4B-BFE6-589CE3422873}" dt="2022-05-02T00:16:58.174" v="5065" actId="1037"/>
          <ac:spMkLst>
            <pc:docMk/>
            <pc:sldMk cId="3037230208" sldId="290"/>
            <ac:spMk id="110" creationId="{653E06BB-652D-CE4F-A75A-F56B1EB7A476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2" creationId="{C16836BF-FA7A-3941-A92D-C23AFBE18A95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3" creationId="{01954A24-241C-424E-AB11-04C536F86FE2}"/>
          </ac:spMkLst>
        </pc:spChg>
        <pc:spChg chg="mod">
          <ac:chgData name="Wencai Zhang" userId="4a86a1d0-2108-4707-8228-1110f3c1be85" providerId="ADAL" clId="{601397D5-CCEE-BD4B-BFE6-589CE3422873}" dt="2022-05-02T00:16:51.339" v="5058" actId="1038"/>
          <ac:spMkLst>
            <pc:docMk/>
            <pc:sldMk cId="3037230208" sldId="290"/>
            <ac:spMk id="134" creationId="{F036179A-2126-CC4B-8FE6-BDA22A67C62C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6" creationId="{DE990937-14B8-3247-A320-3923A3115E1A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8" creationId="{7DB4CB67-90E2-AD48-BD55-25F9E8C970A2}"/>
          </ac:spMkLst>
        </pc:spChg>
        <pc:spChg chg="mod">
          <ac:chgData name="Wencai Zhang" userId="4a86a1d0-2108-4707-8228-1110f3c1be85" providerId="ADAL" clId="{601397D5-CCEE-BD4B-BFE6-589CE3422873}" dt="2022-05-02T00:17:04.584" v="5070" actId="1038"/>
          <ac:spMkLst>
            <pc:docMk/>
            <pc:sldMk cId="3037230208" sldId="290"/>
            <ac:spMk id="139" creationId="{5CCA8D0C-4B0A-184A-8D55-F237FEE5AB3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40" creationId="{FAF47AB8-0169-6D49-AD2C-629993CBFE51}"/>
          </ac:spMkLst>
        </pc:spChg>
        <pc:spChg chg="mod">
          <ac:chgData name="Wencai Zhang" userId="4a86a1d0-2108-4707-8228-1110f3c1be85" providerId="ADAL" clId="{601397D5-CCEE-BD4B-BFE6-589CE3422873}" dt="2022-05-02T00:16:45.845" v="5054" actId="1038"/>
          <ac:spMkLst>
            <pc:docMk/>
            <pc:sldMk cId="3037230208" sldId="290"/>
            <ac:spMk id="141" creationId="{4E5429D9-D950-6042-8EE7-90326C8B9F49}"/>
          </ac:spMkLst>
        </pc:spChg>
        <pc:spChg chg="mod">
          <ac:chgData name="Wencai Zhang" userId="4a86a1d0-2108-4707-8228-1110f3c1be85" providerId="ADAL" clId="{601397D5-CCEE-BD4B-BFE6-589CE3422873}" dt="2022-05-01T00:35:21.981" v="4193" actId="20577"/>
          <ac:spMkLst>
            <pc:docMk/>
            <pc:sldMk cId="3037230208" sldId="290"/>
            <ac:spMk id="143" creationId="{FF4A83B0-81A9-9F41-9D30-6F9FFE51B669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6" creationId="{B4381B19-6B8B-1B43-89E9-1626AD3375D1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7" creationId="{97C697A2-1F49-E945-9123-76DF5A6F809A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8" creationId="{08FACD22-1757-E348-89CC-11459FA0E245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9" creationId="{8D2D8B9D-762A-4F44-84A7-1263C90A94DD}"/>
          </ac:spMkLst>
        </pc:spChg>
        <pc:spChg chg="mod">
          <ac:chgData name="Wencai Zhang" userId="4a86a1d0-2108-4707-8228-1110f3c1be85" providerId="ADAL" clId="{601397D5-CCEE-BD4B-BFE6-589CE3422873}" dt="2022-05-01T00:59:06.549" v="4920" actId="1038"/>
          <ac:spMkLst>
            <pc:docMk/>
            <pc:sldMk cId="3037230208" sldId="290"/>
            <ac:spMk id="150" creationId="{F7788C95-779E-B642-B1BE-C1DB4378A3EC}"/>
          </ac:spMkLst>
        </pc:spChg>
        <pc:spChg chg="mod">
          <ac:chgData name="Wencai Zhang" userId="4a86a1d0-2108-4707-8228-1110f3c1be85" providerId="ADAL" clId="{601397D5-CCEE-BD4B-BFE6-589CE3422873}" dt="2022-05-01T00:35:17.794" v="4192" actId="20577"/>
          <ac:spMkLst>
            <pc:docMk/>
            <pc:sldMk cId="3037230208" sldId="290"/>
            <ac:spMk id="152" creationId="{1D4C253C-977F-B446-ADF7-B794ED0C63ED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5" creationId="{2DD4F50B-2E58-AC4A-9599-810B8C9FB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6" creationId="{3B2DC62D-5138-D64C-93B3-DC3F0663199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7" creationId="{76B20CE5-7839-F848-BEAC-71BCCE5C0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8" creationId="{43F1178C-A296-FA4D-A41F-6210A141B6D7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60" creationId="{0FD73DFB-B926-5944-82E8-25E92E6FA2E7}"/>
          </ac:spMkLst>
        </pc:spChg>
        <pc:spChg chg="del">
          <ac:chgData name="Wencai Zhang" userId="4a86a1d0-2108-4707-8228-1110f3c1be85" providerId="ADAL" clId="{601397D5-CCEE-BD4B-BFE6-589CE3422873}" dt="2022-05-01T00:49:55.785" v="4451" actId="478"/>
          <ac:spMkLst>
            <pc:docMk/>
            <pc:sldMk cId="3037230208" sldId="290"/>
            <ac:spMk id="162" creationId="{3132ABAA-2286-6B43-90FC-7CA0493620CD}"/>
          </ac:spMkLst>
        </pc:spChg>
        <pc:spChg chg="del">
          <ac:chgData name="Wencai Zhang" userId="4a86a1d0-2108-4707-8228-1110f3c1be85" providerId="ADAL" clId="{601397D5-CCEE-BD4B-BFE6-589CE3422873}" dt="2022-05-01T00:49:52.621" v="4450" actId="478"/>
          <ac:spMkLst>
            <pc:docMk/>
            <pc:sldMk cId="3037230208" sldId="290"/>
            <ac:spMk id="163" creationId="{B67E019A-039C-034B-8010-0F30EAF5ECF6}"/>
          </ac:spMkLst>
        </pc:spChg>
        <pc:spChg chg="mod">
          <ac:chgData name="Wencai Zhang" userId="4a86a1d0-2108-4707-8228-1110f3c1be85" providerId="ADAL" clId="{601397D5-CCEE-BD4B-BFE6-589CE3422873}" dt="2022-05-01T00:58:52.508" v="4894" actId="1038"/>
          <ac:spMkLst>
            <pc:docMk/>
            <pc:sldMk cId="3037230208" sldId="290"/>
            <ac:spMk id="165" creationId="{20B367B1-DEEE-AC4F-B69A-38668B74760A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67" creationId="{4C4B642B-CD79-8B47-A89A-FDEB015A1A2C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0" creationId="{0BBC5EE7-1D3D-2348-AF5D-3CA7AD5D256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1" creationId="{1337F171-F500-7240-94FD-F0E48DAC0E5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2" creationId="{B0642554-4B0C-3144-B536-8E96421F6579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3" creationId="{5ED886CA-5BE8-D446-8CF2-52D9FFF2881E}"/>
          </ac:spMkLst>
        </pc:spChg>
        <pc:spChg chg="mod">
          <ac:chgData name="Wencai Zhang" userId="4a86a1d0-2108-4707-8228-1110f3c1be85" providerId="ADAL" clId="{601397D5-CCEE-BD4B-BFE6-589CE3422873}" dt="2022-05-01T00:58:59.476" v="4907" actId="1038"/>
          <ac:spMkLst>
            <pc:docMk/>
            <pc:sldMk cId="3037230208" sldId="290"/>
            <ac:spMk id="174" creationId="{6FA88D74-DD27-F643-8FB8-18F2EBB25342}"/>
          </ac:spMkLst>
        </pc:spChg>
        <pc:spChg chg="del">
          <ac:chgData name="Wencai Zhang" userId="4a86a1d0-2108-4707-8228-1110f3c1be85" providerId="ADAL" clId="{601397D5-CCEE-BD4B-BFE6-589CE3422873}" dt="2022-05-01T00:54:28.272" v="4717" actId="478"/>
          <ac:spMkLst>
            <pc:docMk/>
            <pc:sldMk cId="3037230208" sldId="290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0" creationId="{FDF39AC3-88B1-5D4D-A551-2AEA1A0E018E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1" creationId="{5E3B0886-67A9-8448-BA3E-F496B1677016}"/>
          </ac:spMkLst>
        </pc:spChg>
        <pc:spChg chg="mod">
          <ac:chgData name="Wencai Zhang" userId="4a86a1d0-2108-4707-8228-1110f3c1be85" providerId="ADAL" clId="{601397D5-CCEE-BD4B-BFE6-589CE3422873}" dt="2022-05-02T00:16:10.659" v="4999" actId="1037"/>
          <ac:spMkLst>
            <pc:docMk/>
            <pc:sldMk cId="3037230208" sldId="290"/>
            <ac:spMk id="184" creationId="{DD136694-6F06-2840-B4AF-E4820016AAE3}"/>
          </ac:spMkLst>
        </pc:spChg>
        <pc:spChg chg="mod">
          <ac:chgData name="Wencai Zhang" userId="4a86a1d0-2108-4707-8228-1110f3c1be85" providerId="ADAL" clId="{601397D5-CCEE-BD4B-BFE6-589CE3422873}" dt="2022-05-01T00:51:03.055" v="4594"/>
          <ac:spMkLst>
            <pc:docMk/>
            <pc:sldMk cId="3037230208" sldId="290"/>
            <ac:spMk id="185" creationId="{F0F1B4BF-9A83-A14D-B5C4-58B5397FC0F3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88" creationId="{EA98BF7D-5022-294D-9979-2AA00AE2A29F}"/>
          </ac:spMkLst>
        </pc:spChg>
        <pc:spChg chg="mod">
          <ac:chgData name="Wencai Zhang" userId="4a86a1d0-2108-4707-8228-1110f3c1be85" providerId="ADAL" clId="{601397D5-CCEE-BD4B-BFE6-589CE3422873}" dt="2022-05-01T00:57:04.817" v="4767" actId="14100"/>
          <ac:spMkLst>
            <pc:docMk/>
            <pc:sldMk cId="3037230208" sldId="290"/>
            <ac:spMk id="189" creationId="{E6FAD05A-EDB2-FC4E-BDB7-90E3D66468C4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3" creationId="{3D90DAA1-D2A6-474C-8B5A-DA10B9FCA4DE}"/>
          </ac:spMkLst>
        </pc:spChg>
        <pc:spChg chg="mod">
          <ac:chgData name="Wencai Zhang" userId="4a86a1d0-2108-4707-8228-1110f3c1be85" providerId="ADAL" clId="{601397D5-CCEE-BD4B-BFE6-589CE3422873}" dt="2022-05-01T00:57:28.055" v="4779" actId="14100"/>
          <ac:spMkLst>
            <pc:docMk/>
            <pc:sldMk cId="3037230208" sldId="290"/>
            <ac:spMk id="194" creationId="{BE5FAC78-74B6-E746-B2FC-6B34A2094A19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6" creationId="{AF116BBB-35C8-9543-A0E4-B8A545394A7C}"/>
          </ac:spMkLst>
        </pc:spChg>
        <pc:spChg chg="mod">
          <ac:chgData name="Wencai Zhang" userId="4a86a1d0-2108-4707-8228-1110f3c1be85" providerId="ADAL" clId="{601397D5-CCEE-BD4B-BFE6-589CE3422873}" dt="2022-05-01T00:57:23.127" v="4776" actId="14100"/>
          <ac:spMkLst>
            <pc:docMk/>
            <pc:sldMk cId="3037230208" sldId="290"/>
            <ac:spMk id="197" creationId="{900E993E-0E9A-B040-994B-547E11086EEE}"/>
          </ac:spMkLst>
        </pc:spChg>
        <pc:spChg chg="add mod">
          <ac:chgData name="Wencai Zhang" userId="4a86a1d0-2108-4707-8228-1110f3c1be85" providerId="ADAL" clId="{601397D5-CCEE-BD4B-BFE6-589CE3422873}" dt="2022-05-24T12:52:42.185" v="5264" actId="1076"/>
          <ac:spMkLst>
            <pc:docMk/>
            <pc:sldMk cId="3037230208" sldId="290"/>
            <ac:spMk id="198" creationId="{CAAA600C-C9C5-5F44-81A7-2B1615AB35F1}"/>
          </ac:spMkLst>
        </pc:spChg>
        <pc:spChg chg="add mod">
          <ac:chgData name="Wencai Zhang" userId="4a86a1d0-2108-4707-8228-1110f3c1be85" providerId="ADAL" clId="{601397D5-CCEE-BD4B-BFE6-589CE3422873}" dt="2022-05-01T01:00:17.086" v="4927"/>
          <ac:spMkLst>
            <pc:docMk/>
            <pc:sldMk cId="3037230208" sldId="290"/>
            <ac:spMk id="200" creationId="{960AA1A2-471B-9643-B356-0D8D28ED6195}"/>
          </ac:spMkLst>
        </pc:spChg>
        <pc:spChg chg="mod">
          <ac:chgData name="Wencai Zhang" userId="4a86a1d0-2108-4707-8228-1110f3c1be85" providerId="ADAL" clId="{601397D5-CCEE-BD4B-BFE6-589CE3422873}" dt="2022-05-01T01:04:12.942" v="4937" actId="20577"/>
          <ac:spMkLst>
            <pc:docMk/>
            <pc:sldMk cId="3037230208" sldId="290"/>
            <ac:spMk id="202" creationId="{1E19ED15-3BED-B548-8A4D-C14C1869A25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5" creationId="{33BF01E5-D2CE-3040-84EA-0A67C1F490E6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6" creationId="{FB267545-F58F-FB47-B24A-D2440A662C2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7" creationId="{0AA46335-218F-084E-8B1C-C17D43130CE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8" creationId="{A19FC4AB-77FE-BA46-963C-8BEBF202EC9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9" creationId="{E54711CA-3A46-0746-8CA5-8FE361234351}"/>
          </ac:spMkLst>
        </pc:spChg>
        <pc:spChg chg="mod">
          <ac:chgData name="Wencai Zhang" userId="4a86a1d0-2108-4707-8228-1110f3c1be85" providerId="ADAL" clId="{601397D5-CCEE-BD4B-BFE6-589CE3422873}" dt="2022-05-01T01:04:06.094" v="4933" actId="20577"/>
          <ac:spMkLst>
            <pc:docMk/>
            <pc:sldMk cId="3037230208" sldId="290"/>
            <ac:spMk id="211" creationId="{A0EE488A-E1BA-2A47-86E5-A3DE2722F1F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4" creationId="{8BC1E247-1296-7246-A27B-A78D0EA7273E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5" creationId="{CD3BA7B7-53DC-D44A-916E-A4C5AA2AEEE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6" creationId="{F677B40F-E379-0345-AB1B-ECBFB2B169F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7" creationId="{A1C86BF0-72A8-1A41-A545-2C4A497D8B6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8" creationId="{7493F6C8-6C33-4447-BB3C-E67ABA007BDD}"/>
          </ac:spMkLst>
        </pc:spChg>
        <pc:spChg chg="mod">
          <ac:chgData name="Wencai Zhang" userId="4a86a1d0-2108-4707-8228-1110f3c1be85" providerId="ADAL" clId="{601397D5-CCEE-BD4B-BFE6-589CE3422873}" dt="2022-05-01T01:04:09.724" v="4935" actId="20577"/>
          <ac:spMkLst>
            <pc:docMk/>
            <pc:sldMk cId="3037230208" sldId="290"/>
            <ac:spMk id="220" creationId="{2916B63A-40A4-6D43-B1BC-929C910FBD7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3" creationId="{84EBBDFB-8036-A54F-831C-E4AFC080FF4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4" creationId="{A82D9D98-B019-0A4F-96E5-4320195ACAD2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5" creationId="{36E908C0-5156-274B-BCC0-F8581BC9DE6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6" creationId="{0887E4A8-00EB-0A4D-940A-A8390B323B7A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7" creationId="{084B4E61-5C8C-F644-93FC-6954EE72B00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0" creationId="{42FC1453-4C90-4F47-84E8-B84422A0C34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1" creationId="{919473DA-BA35-1F4C-BDB9-4F1FC4105EE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5" creationId="{EA8FF81C-41D4-0F45-94D2-CC527CE92D5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6" creationId="{39AA6ED0-1A7F-7C4D-9E67-6BC8E605F31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8" creationId="{4DC16834-32E0-9949-880E-38859036367B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9" creationId="{465DD361-BEEE-9C4D-B818-736BDDFA83A6}"/>
          </ac:spMkLst>
        </pc:spChg>
        <pc:grpChg chg="del topLvl">
          <ac:chgData name="Wencai Zhang" userId="4a86a1d0-2108-4707-8228-1110f3c1be85" providerId="ADAL" clId="{601397D5-CCEE-BD4B-BFE6-589CE3422873}" dt="2022-05-01T00:50:47.735" v="4570" actId="478"/>
          <ac:grpSpMkLst>
            <pc:docMk/>
            <pc:sldMk cId="3037230208" sldId="290"/>
            <ac:grpSpMk id="2" creationId="{23522517-C292-8C40-8C84-B30913B1168A}"/>
          </ac:grpSpMkLst>
        </pc:grpChg>
        <pc:grpChg chg="del topLvl">
          <ac:chgData name="Wencai Zhang" userId="4a86a1d0-2108-4707-8228-1110f3c1be85" providerId="ADAL" clId="{601397D5-CCEE-BD4B-BFE6-589CE3422873}" dt="2022-05-01T00:54:15.981" v="4714" actId="478"/>
          <ac:grpSpMkLst>
            <pc:docMk/>
            <pc:sldMk cId="3037230208" sldId="290"/>
            <ac:grpSpMk id="3" creationId="{B836CDE8-D276-B14C-8317-FF755C7FD67B}"/>
          </ac:grpSpMkLst>
        </pc:grpChg>
        <pc:grpChg chg="add mod">
          <ac:chgData name="Wencai Zhang" userId="4a86a1d0-2108-4707-8228-1110f3c1be85" providerId="ADAL" clId="{601397D5-CCEE-BD4B-BFE6-589CE3422873}" dt="2022-05-01T00:48:20.699" v="4419" actId="1036"/>
          <ac:grpSpMkLst>
            <pc:docMk/>
            <pc:sldMk cId="3037230208" sldId="290"/>
            <ac:grpSpMk id="4" creationId="{EEA0505E-A23D-884B-92D7-B239BA911068}"/>
          </ac:grpSpMkLst>
        </pc:grpChg>
        <pc:grpChg chg="del">
          <ac:chgData name="Wencai Zhang" userId="4a86a1d0-2108-4707-8228-1110f3c1be85" providerId="ADAL" clId="{601397D5-CCEE-BD4B-BFE6-589CE3422873}" dt="2022-05-01T00:33:33.294" v="4010" actId="478"/>
          <ac:grpSpMkLst>
            <pc:docMk/>
            <pc:sldMk cId="3037230208" sldId="290"/>
            <ac:grpSpMk id="7" creationId="{2655B5AC-157E-D44E-8BAF-1F9F9C5FBBF4}"/>
          </ac:grpSpMkLst>
        </pc:grpChg>
        <pc:grpChg chg="del topLvl">
          <ac:chgData name="Wencai Zhang" userId="4a86a1d0-2108-4707-8228-1110f3c1be85" providerId="ADAL" clId="{601397D5-CCEE-BD4B-BFE6-589CE3422873}" dt="2022-05-01T00:54:21.558" v="4716" actId="478"/>
          <ac:grpSpMkLst>
            <pc:docMk/>
            <pc:sldMk cId="3037230208" sldId="290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5-01T00:10:21.674" v="3909" actId="478"/>
          <ac:grpSpMkLst>
            <pc:docMk/>
            <pc:sldMk cId="3037230208" sldId="290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5-01T00:10:34.445" v="3912" actId="478"/>
          <ac:grpSpMkLst>
            <pc:docMk/>
            <pc:sldMk cId="3037230208" sldId="290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5-01T00:33:37.958" v="4011" actId="478"/>
          <ac:grpSpMkLst>
            <pc:docMk/>
            <pc:sldMk cId="3037230208" sldId="290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5-01T00:33:30.970" v="4009" actId="478"/>
          <ac:grpSpMkLst>
            <pc:docMk/>
            <pc:sldMk cId="3037230208" sldId="290"/>
            <ac:grpSpMk id="21" creationId="{A08E21AA-65D0-904C-A117-A07CC56DBB2D}"/>
          </ac:grpSpMkLst>
        </pc:grpChg>
        <pc:grpChg chg="mod topLvl">
          <ac:chgData name="Wencai Zhang" userId="4a86a1d0-2108-4707-8228-1110f3c1be85" providerId="ADAL" clId="{601397D5-CCEE-BD4B-BFE6-589CE3422873}" dt="2022-05-01T00:46:01.518" v="4264" actId="1038"/>
          <ac:grpSpMkLst>
            <pc:docMk/>
            <pc:sldMk cId="3037230208" sldId="290"/>
            <ac:grpSpMk id="79" creationId="{BCAD6698-7ABF-9143-B78D-400EA289BEFB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89" creationId="{D05A730E-3C5D-2748-A96F-CD563F5B13C4}"/>
          </ac:grpSpMkLst>
        </pc:grpChg>
        <pc:grpChg chg="del topLvl">
          <ac:chgData name="Wencai Zhang" userId="4a86a1d0-2108-4707-8228-1110f3c1be85" providerId="ADAL" clId="{601397D5-CCEE-BD4B-BFE6-589CE3422873}" dt="2022-05-01T00:54:18.768" v="4715" actId="478"/>
          <ac:grpSpMkLst>
            <pc:docMk/>
            <pc:sldMk cId="3037230208" sldId="290"/>
            <ac:grpSpMk id="95" creationId="{5AA2CBDC-65C0-7B40-85C9-DB0CFAB62EC0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100" creationId="{36414AE8-2647-4847-8AEC-CF3094F6BFED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3" creationId="{77F3B635-0E98-434D-A139-1A470F830EA4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8" creationId="{0E8241FF-5E0B-9C40-97C6-A8A8565FE5C9}"/>
          </ac:grpSpMkLst>
        </pc:grpChg>
        <pc:grpChg chg="del">
          <ac:chgData name="Wencai Zhang" userId="4a86a1d0-2108-4707-8228-1110f3c1be85" providerId="ADAL" clId="{601397D5-CCEE-BD4B-BFE6-589CE3422873}" dt="2022-05-01T00:33:55.721" v="4014" actId="478"/>
          <ac:grpSpMkLst>
            <pc:docMk/>
            <pc:sldMk cId="3037230208" sldId="290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5-01T00:33:50.901" v="4013" actId="478"/>
          <ac:grpSpMkLst>
            <pc:docMk/>
            <pc:sldMk cId="3037230208" sldId="290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5-01T00:33:43.721" v="4012" actId="478"/>
          <ac:grpSpMkLst>
            <pc:docMk/>
            <pc:sldMk cId="3037230208" sldId="290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5" creationId="{0FB6D560-63A7-0045-A71F-C5709F18C6FE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7" creationId="{2F6A066E-C8C2-AD45-815B-9D422DA698FF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42" creationId="{BBCFCF12-92BD-6D4D-B468-D9EE22D3F18D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4" creationId="{02A9521D-9532-3140-A5B5-55493F16E205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5" creationId="{67DE2C29-3A52-A04D-ADE9-BF673F9E2A86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51" creationId="{0EFAEB64-1462-B147-A719-7A4393052284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3" creationId="{3EBE2FBD-E4D3-294E-953E-646A79A1D445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4" creationId="{CBDD24B9-42E8-C143-8410-20421B117D6B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66" creationId="{91F0F827-E9B1-6148-A7CD-84EDB31FEAAC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8" creationId="{DFBA3DF6-A616-7847-8D05-80CD6988406F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9" creationId="{F4DA4FB0-D520-2445-BADD-EAE0A57950CC}"/>
          </ac:grpSpMkLst>
        </pc:grpChg>
        <pc:grpChg chg="add mod">
          <ac:chgData name="Wencai Zhang" userId="4a86a1d0-2108-4707-8228-1110f3c1be85" providerId="ADAL" clId="{601397D5-CCEE-BD4B-BFE6-589CE3422873}" dt="2022-05-01T00:50:13.777" v="4569" actId="1037"/>
          <ac:grpSpMkLst>
            <pc:docMk/>
            <pc:sldMk cId="3037230208" sldId="290"/>
            <ac:grpSpMk id="179" creationId="{72BEDB68-3FCD-D642-B29B-8E55B1BBE595}"/>
          </ac:grpSpMkLst>
        </pc:grpChg>
        <pc:grpChg chg="add mod">
          <ac:chgData name="Wencai Zhang" userId="4a86a1d0-2108-4707-8228-1110f3c1be85" providerId="ADAL" clId="{601397D5-CCEE-BD4B-BFE6-589CE3422873}" dt="2022-05-01T00:51:18.253" v="4700" actId="1038"/>
          <ac:grpSpMkLst>
            <pc:docMk/>
            <pc:sldMk cId="3037230208" sldId="290"/>
            <ac:grpSpMk id="183" creationId="{FEA016EC-C43A-C244-9242-564B7A2BA890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87" creationId="{5DEB43C3-049E-A046-BB83-894BD2CC04CE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2" creationId="{014FB606-EFD1-A64D-BA0B-730B23022C31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5" creationId="{8231A601-9B41-3342-BF06-C51AEEDE32FA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01" creationId="{398A8C5E-F70C-9B4A-A356-8DC51BA6A1E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3" creationId="{2B79809F-5490-A940-9F9D-AD913D6EF379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4" creationId="{34A9A84D-3C92-E642-ABBD-129BF607DDA4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0" creationId="{B2A8BA90-0D57-AC41-91A2-3E71DF5C07C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2" creationId="{F086E9F0-42D0-464F-A11F-71F34C3A83C2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3" creationId="{BC193584-D235-6942-BD35-B43290A8F03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9" creationId="{AA2D3B33-FEFD-B946-A819-CA8255729B7C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1" creationId="{79748524-5ECF-B049-A970-11E7B0D3245B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2" creationId="{FC3AE8B7-4A5B-6948-8D76-FAC5F6D79CDD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29" creationId="{4502CFA8-73B4-3E43-A75E-73467E67D08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4" creationId="{6BF24D3A-0D1E-CE46-82CE-7D18B6F671E5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7" creationId="{C68AEF8E-0A21-D64E-BC7F-E5CF27EF28A2}"/>
          </ac:grpSpMkLst>
        </pc:grpChg>
        <pc:graphicFrameChg chg="add mod">
          <ac:chgData name="Wencai Zhang" userId="4a86a1d0-2108-4707-8228-1110f3c1be85" providerId="ADAL" clId="{601397D5-CCEE-BD4B-BFE6-589CE3422873}" dt="2022-05-01T01:00:17.086" v="4927"/>
          <ac:graphicFrameMkLst>
            <pc:docMk/>
            <pc:sldMk cId="3037230208" sldId="290"/>
            <ac:graphicFrameMk id="199" creationId="{C6646175-759A-8245-9096-ED0062CA70F1}"/>
          </ac:graphicFrameMkLst>
        </pc:graphicFrameChg>
        <pc:picChg chg="del topLvl">
          <ac:chgData name="Wencai Zhang" userId="4a86a1d0-2108-4707-8228-1110f3c1be85" providerId="ADAL" clId="{601397D5-CCEE-BD4B-BFE6-589CE3422873}" dt="2022-05-01T00:33:33.294" v="4010" actId="478"/>
          <ac:picMkLst>
            <pc:docMk/>
            <pc:sldMk cId="3037230208" sldId="290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5-01T00:10:34.445" v="3912" actId="478"/>
          <ac:picMkLst>
            <pc:docMk/>
            <pc:sldMk cId="3037230208" sldId="290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5-01T00:33:37.958" v="4011" actId="478"/>
          <ac:picMkLst>
            <pc:docMk/>
            <pc:sldMk cId="3037230208" sldId="290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5-01T00:10:21.674" v="3909" actId="478"/>
          <ac:picMkLst>
            <pc:docMk/>
            <pc:sldMk cId="3037230208" sldId="290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5-01T00:33:30.970" v="4009" actId="478"/>
          <ac:picMkLst>
            <pc:docMk/>
            <pc:sldMk cId="3037230208" sldId="290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5-01T00:10:24.605" v="3910" actId="478"/>
          <ac:picMkLst>
            <pc:docMk/>
            <pc:sldMk cId="3037230208" sldId="290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5-01T00:10:31.703" v="3911" actId="478"/>
          <ac:picMkLst>
            <pc:docMk/>
            <pc:sldMk cId="3037230208" sldId="290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5-01T00:53:13.964" v="4713" actId="732"/>
          <ac:picMkLst>
            <pc:docMk/>
            <pc:sldMk cId="3037230208" sldId="290"/>
            <ac:picMk id="175" creationId="{D336C030-5E72-4D4D-B9FE-8A39C3816C71}"/>
          </ac:picMkLst>
        </pc:picChg>
        <pc:picChg chg="add mod modCrop">
          <ac:chgData name="Wencai Zhang" userId="4a86a1d0-2108-4707-8228-1110f3c1be85" providerId="ADAL" clId="{601397D5-CCEE-BD4B-BFE6-589CE3422873}" dt="2022-05-01T00:52:59.622" v="4711" actId="732"/>
          <ac:picMkLst>
            <pc:docMk/>
            <pc:sldMk cId="3037230208" sldId="290"/>
            <ac:picMk id="176" creationId="{1EA9737B-972E-5642-889F-75906420EB23}"/>
          </ac:picMkLst>
        </pc:picChg>
        <pc:picChg chg="add mod modCrop">
          <ac:chgData name="Wencai Zhang" userId="4a86a1d0-2108-4707-8228-1110f3c1be85" providerId="ADAL" clId="{601397D5-CCEE-BD4B-BFE6-589CE3422873}" dt="2022-05-01T00:52:37.301" v="4709" actId="732"/>
          <ac:picMkLst>
            <pc:docMk/>
            <pc:sldMk cId="3037230208" sldId="290"/>
            <ac:picMk id="177" creationId="{20206D92-C081-BE4A-9BAE-C7185327118C}"/>
          </ac:picMkLst>
        </pc:picChg>
        <pc:picChg chg="add mod modCrop">
          <ac:chgData name="Wencai Zhang" userId="4a86a1d0-2108-4707-8228-1110f3c1be85" providerId="ADAL" clId="{601397D5-CCEE-BD4B-BFE6-589CE3422873}" dt="2022-05-01T00:51:50.735" v="4706" actId="732"/>
          <ac:picMkLst>
            <pc:docMk/>
            <pc:sldMk cId="3037230208" sldId="290"/>
            <ac:picMk id="182" creationId="{DE60C6FF-64FE-F845-B344-6D1F65498BD2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86" creationId="{2D01C11A-C461-B44D-A35F-D9DF2F2DD030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0" creationId="{F38F2B52-1B82-BF4A-9458-7AF4527C7B1B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1" creationId="{186D8013-B1C8-C444-A9B3-377EAF8482F4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28" creationId="{CC9D1DD8-BAF8-234E-97EA-B3125226F850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2" creationId="{A615F78E-33DF-6449-A440-307870AD5773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3" creationId="{131FBFA1-1267-A84C-AB74-F68069DB76AF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8T21:24:35.856" v="7121" actId="164"/>
      <pc:docMkLst>
        <pc:docMk/>
      </pc:docMkLst>
      <pc:sldChg chg="addSp delSp modSp mod">
        <pc:chgData name="Wencai Zhang" userId="4a86a1d0-2108-4707-8228-1110f3c1be85" providerId="ADAL" clId="{0E9FBDE7-7504-E948-96F8-38AF79E2A691}" dt="2021-06-08T21:24:35.856" v="7121" actId="164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8:51:43.308" v="6988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spChg chg="add mod">
          <ac:chgData name="Wencai Zhang" userId="4a86a1d0-2108-4707-8228-1110f3c1be85" providerId="ADAL" clId="{0E9FBDE7-7504-E948-96F8-38AF79E2A691}" dt="2021-06-08T21:13:06.705" v="7116" actId="207"/>
          <ac:spMkLst>
            <pc:docMk/>
            <pc:sldMk cId="3242017852" sldId="272"/>
            <ac:spMk id="240" creationId="{E9C8D369-5F8D-E54A-AF65-476407FD0AD1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1" creationId="{9FCC0C5D-D6A9-164C-8964-401099D7F9F9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2" creationId="{58BF14D6-FC81-CA47-8833-2926CE44CE6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3" creationId="{2BE5FD5F-9D67-4C49-9CA4-E1DE27758C2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4" creationId="{9883A24A-5A7C-EC4C-B6EF-924938B59F28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5" creationId="{3F6C5F80-5C86-194C-B267-8C2B7027B07A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6" creationId="{CC32910A-38D6-C84A-B308-3FBD60C2D445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mod">
          <ac:chgData name="Wencai Zhang" userId="4a86a1d0-2108-4707-8228-1110f3c1be85" providerId="ADAL" clId="{0E9FBDE7-7504-E948-96F8-38AF79E2A691}" dt="2021-06-08T21:24:35.856" v="7121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add mod modCrop">
          <ac:chgData name="Wencai Zhang" userId="4a86a1d0-2108-4707-8228-1110f3c1be85" providerId="ADAL" clId="{0E9FBDE7-7504-E948-96F8-38AF79E2A691}" dt="2021-06-08T21:12:14.556" v="7063" actId="732"/>
          <ac:picMkLst>
            <pc:docMk/>
            <pc:sldMk cId="3242017852" sldId="272"/>
            <ac:picMk id="192" creationId="{71CCA731-AEC4-324C-B904-1CFC513A08F9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0F41D4EE-7ED7-A54E-AEED-93519C447CFC}"/>
    <pc:docChg chg="delSld">
      <pc:chgData name="Wencai Zhang" userId="4a86a1d0-2108-4707-8228-1110f3c1be85" providerId="ADAL" clId="{0F41D4EE-7ED7-A54E-AEED-93519C447CFC}" dt="2022-06-23T12:12:05.618" v="1" actId="2696"/>
      <pc:docMkLst>
        <pc:docMk/>
      </pc:docMkLst>
      <pc:sldChg chg="del">
        <pc:chgData name="Wencai Zhang" userId="4a86a1d0-2108-4707-8228-1110f3c1be85" providerId="ADAL" clId="{0F41D4EE-7ED7-A54E-AEED-93519C447CFC}" dt="2022-06-23T12:12:04.111" v="0" actId="2696"/>
        <pc:sldMkLst>
          <pc:docMk/>
          <pc:sldMk cId="1245431894" sldId="274"/>
        </pc:sldMkLst>
      </pc:sldChg>
      <pc:sldChg chg="del">
        <pc:chgData name="Wencai Zhang" userId="4a86a1d0-2108-4707-8228-1110f3c1be85" providerId="ADAL" clId="{0F41D4EE-7ED7-A54E-AEED-93519C447CFC}" dt="2022-06-23T12:12:05.618" v="1" actId="2696"/>
        <pc:sldMkLst>
          <pc:docMk/>
          <pc:sldMk cId="933386568" sldId="284"/>
        </pc:sldMkLst>
      </pc:sldChg>
      <pc:sldChg chg="del">
        <pc:chgData name="Wencai Zhang" userId="4a86a1d0-2108-4707-8228-1110f3c1be85" providerId="ADAL" clId="{0F41D4EE-7ED7-A54E-AEED-93519C447CFC}" dt="2022-06-23T12:12:04.111" v="0" actId="2696"/>
        <pc:sldMkLst>
          <pc:docMk/>
          <pc:sldMk cId="1149708096" sldId="285"/>
        </pc:sldMkLst>
      </pc:sldChg>
      <pc:sldChg chg="del">
        <pc:chgData name="Wencai Zhang" userId="4a86a1d0-2108-4707-8228-1110f3c1be85" providerId="ADAL" clId="{0F41D4EE-7ED7-A54E-AEED-93519C447CFC}" dt="2022-06-23T12:12:04.111" v="0" actId="2696"/>
        <pc:sldMkLst>
          <pc:docMk/>
          <pc:sldMk cId="1407856934" sldId="289"/>
        </pc:sldMkLst>
      </pc:sldChg>
    </pc:docChg>
  </pc:docChgLst>
  <pc:docChgLst>
    <pc:chgData name="Wencai Zhang" userId="4a86a1d0-2108-4707-8228-1110f3c1be85" providerId="ADAL" clId="{46594FD8-AF25-D846-9BAA-39E14A4662C6}"/>
    <pc:docChg chg="undo redo custSel addSld modSld">
      <pc:chgData name="Wencai Zhang" userId="4a86a1d0-2108-4707-8228-1110f3c1be85" providerId="ADAL" clId="{46594FD8-AF25-D846-9BAA-39E14A4662C6}" dt="2021-09-14T20:36:10.978" v="3363" actId="1035"/>
      <pc:docMkLst>
        <pc:docMk/>
      </pc:docMkLst>
      <pc:sldChg chg="modSp mod">
        <pc:chgData name="Wencai Zhang" userId="4a86a1d0-2108-4707-8228-1110f3c1be85" providerId="ADAL" clId="{46594FD8-AF25-D846-9BAA-39E14A4662C6}" dt="2021-09-13T21:18:41.172" v="41" actId="20577"/>
        <pc:sldMkLst>
          <pc:docMk/>
          <pc:sldMk cId="3242017852" sldId="272"/>
        </pc:sldMkLst>
        <pc:spChg chg="mod">
          <ac:chgData name="Wencai Zhang" userId="4a86a1d0-2108-4707-8228-1110f3c1be85" providerId="ADAL" clId="{46594FD8-AF25-D846-9BAA-39E14A4662C6}" dt="2021-09-13T21:17:47.493" v="26" actId="1037"/>
          <ac:spMkLst>
            <pc:docMk/>
            <pc:sldMk cId="3242017852" sldId="272"/>
            <ac:spMk id="33" creationId="{AD8D757C-C30A-EB43-B121-3175844E2FA4}"/>
          </ac:spMkLst>
        </pc:spChg>
        <pc:spChg chg="mod">
          <ac:chgData name="Wencai Zhang" userId="4a86a1d0-2108-4707-8228-1110f3c1be85" providerId="ADAL" clId="{46594FD8-AF25-D846-9BAA-39E14A4662C6}" dt="2021-09-13T21:18:09.444" v="27" actId="20577"/>
          <ac:spMkLst>
            <pc:docMk/>
            <pc:sldMk cId="3242017852" sldId="272"/>
            <ac:spMk id="135" creationId="{B48D9B35-7E39-2E49-8EE5-821BFC4661C9}"/>
          </ac:spMkLst>
        </pc:spChg>
        <pc:spChg chg="mod">
          <ac:chgData name="Wencai Zhang" userId="4a86a1d0-2108-4707-8228-1110f3c1be85" providerId="ADAL" clId="{46594FD8-AF25-D846-9BAA-39E14A4662C6}" dt="2021-09-13T21:18:12.377" v="28" actId="20577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46594FD8-AF25-D846-9BAA-39E14A4662C6}" dt="2021-09-13T21:18:29.549" v="34" actId="20577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3T21:18:41.172" v="41" actId="20577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3T21:18:16.966" v="29" actId="20577"/>
          <ac:spMkLst>
            <pc:docMk/>
            <pc:sldMk cId="3242017852" sldId="272"/>
            <ac:spMk id="172" creationId="{ED09868F-F3BC-F748-82C8-DE2537285D17}"/>
          </ac:spMkLst>
        </pc:spChg>
      </pc:sldChg>
      <pc:sldChg chg="addSp delSp modSp add mod">
        <pc:chgData name="Wencai Zhang" userId="4a86a1d0-2108-4707-8228-1110f3c1be85" providerId="ADAL" clId="{46594FD8-AF25-D846-9BAA-39E14A4662C6}" dt="2021-09-14T20:36:10.978" v="3363" actId="1035"/>
        <pc:sldMkLst>
          <pc:docMk/>
          <pc:sldMk cId="3998775946" sldId="283"/>
        </pc:sldMkLst>
        <pc:spChg chg="mod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5" creationId="{C9676FCD-1B75-674C-B612-D1EA39A39093}"/>
          </ac:spMkLst>
        </pc:spChg>
        <pc:spChg chg="mod topLvl">
          <ac:chgData name="Wencai Zhang" userId="4a86a1d0-2108-4707-8228-1110f3c1be85" providerId="ADAL" clId="{46594FD8-AF25-D846-9BAA-39E14A4662C6}" dt="2021-09-13T23:05:06.562" v="353" actId="1035"/>
          <ac:spMkLst>
            <pc:docMk/>
            <pc:sldMk cId="3998775946" sldId="283"/>
            <ac:spMk id="11" creationId="{61353381-AC7D-E848-A714-0811467522BE}"/>
          </ac:spMkLst>
        </pc:spChg>
        <pc:spChg chg="mod topLvl">
          <ac:chgData name="Wencai Zhang" userId="4a86a1d0-2108-4707-8228-1110f3c1be85" providerId="ADAL" clId="{46594FD8-AF25-D846-9BAA-39E14A4662C6}" dt="2021-09-14T20:21:21.527" v="2900" actId="20577"/>
          <ac:spMkLst>
            <pc:docMk/>
            <pc:sldMk cId="3998775946" sldId="283"/>
            <ac:spMk id="15" creationId="{73A0757A-AC74-43FC-BBB2-E91DD12F5CD5}"/>
          </ac:spMkLst>
        </pc:spChg>
        <pc:spChg chg="mod topLvl">
          <ac:chgData name="Wencai Zhang" userId="4a86a1d0-2108-4707-8228-1110f3c1be85" providerId="ADAL" clId="{46594FD8-AF25-D846-9BAA-39E14A4662C6}" dt="2021-09-14T14:29:25.383" v="2486" actId="14100"/>
          <ac:spMkLst>
            <pc:docMk/>
            <pc:sldMk cId="3998775946" sldId="283"/>
            <ac:spMk id="17" creationId="{F7169A32-322E-B048-8904-C6E23785AA6B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2" creationId="{119C059E-C733-4742-A0D4-D02B0A0755A1}"/>
          </ac:spMkLst>
        </pc:spChg>
        <pc:spChg chg="mod">
          <ac:chgData name="Wencai Zhang" userId="4a86a1d0-2108-4707-8228-1110f3c1be85" providerId="ADAL" clId="{46594FD8-AF25-D846-9BAA-39E14A4662C6}" dt="2021-09-13T21:26:09.821" v="184" actId="20577"/>
          <ac:spMkLst>
            <pc:docMk/>
            <pc:sldMk cId="3998775946" sldId="283"/>
            <ac:spMk id="23" creationId="{19318E2F-9580-484A-A2E4-97CB1BA629D3}"/>
          </ac:spMkLst>
        </pc:spChg>
        <pc:spChg chg="mod">
          <ac:chgData name="Wencai Zhang" userId="4a86a1d0-2108-4707-8228-1110f3c1be85" providerId="ADAL" clId="{46594FD8-AF25-D846-9BAA-39E14A4662C6}" dt="2021-09-13T21:26:17.829" v="190" actId="20577"/>
          <ac:spMkLst>
            <pc:docMk/>
            <pc:sldMk cId="3998775946" sldId="283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6" creationId="{C4308320-9356-44DD-9CD7-D86A1D1F07E5}"/>
          </ac:spMkLst>
        </pc:spChg>
        <pc:spChg chg="add mod">
          <ac:chgData name="Wencai Zhang" userId="4a86a1d0-2108-4707-8228-1110f3c1be85" providerId="ADAL" clId="{46594FD8-AF25-D846-9BAA-39E14A4662C6}" dt="2021-09-13T23:57:46.029" v="1003" actId="164"/>
          <ac:spMkLst>
            <pc:docMk/>
            <pc:sldMk cId="3998775946" sldId="283"/>
            <ac:spMk id="29" creationId="{7A4FB25F-67C1-0043-8C0C-65E2542B6AD4}"/>
          </ac:spMkLst>
        </pc:spChg>
        <pc:spChg chg="add del mod">
          <ac:chgData name="Wencai Zhang" userId="4a86a1d0-2108-4707-8228-1110f3c1be85" providerId="ADAL" clId="{46594FD8-AF25-D846-9BAA-39E14A4662C6}" dt="2021-09-14T00:09:18.877" v="1135" actId="478"/>
          <ac:spMkLst>
            <pc:docMk/>
            <pc:sldMk cId="3998775946" sldId="283"/>
            <ac:spMk id="31" creationId="{205F49D8-2186-664B-AA26-BA967BBF5F5D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3" creationId="{AD8D757C-C30A-EB43-B121-3175844E2FA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1" creationId="{05C57CC4-2015-234E-8A6B-3FD17DD61D9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2" creationId="{B6BBFF1F-DD97-8A45-A1BE-EFFC7A1DBE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6" creationId="{2FD6981F-D417-BF40-B127-245C841203C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7" creationId="{7573BBB2-B64F-A649-A186-CB45101E4CA4}"/>
          </ac:spMkLst>
        </pc:spChg>
        <pc:spChg chg="add del mod">
          <ac:chgData name="Wencai Zhang" userId="4a86a1d0-2108-4707-8228-1110f3c1be85" providerId="ADAL" clId="{46594FD8-AF25-D846-9BAA-39E14A4662C6}" dt="2021-09-14T14:12:22.991" v="2183"/>
          <ac:spMkLst>
            <pc:docMk/>
            <pc:sldMk cId="3998775946" sldId="283"/>
            <ac:spMk id="48" creationId="{2AF6279E-40EB-784F-9881-C05B1D7FFCA8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1" creationId="{009F4F04-6D19-564F-9123-4184998AE4C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2" creationId="{4EBE9D99-D109-1544-BFB0-DCDC5827BCC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4" creationId="{85EE4A3E-131F-154D-A684-CD6E595E2ADB}"/>
          </ac:spMkLst>
        </pc:spChg>
        <pc:spChg chg="mod topLvl">
          <ac:chgData name="Wencai Zhang" userId="4a86a1d0-2108-4707-8228-1110f3c1be85" providerId="ADAL" clId="{46594FD8-AF25-D846-9BAA-39E14A4662C6}" dt="2021-09-13T23:31:57.576" v="885" actId="20577"/>
          <ac:spMkLst>
            <pc:docMk/>
            <pc:sldMk cId="3998775946" sldId="283"/>
            <ac:spMk id="59" creationId="{EB44D005-E90D-074C-AD4E-F55FC9DDD341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61" creationId="{83D4EDD7-402D-C44E-8C12-80E5C60B6F18}"/>
          </ac:spMkLst>
        </pc:spChg>
        <pc:spChg chg="mod topLvl">
          <ac:chgData name="Wencai Zhang" userId="4a86a1d0-2108-4707-8228-1110f3c1be85" providerId="ADAL" clId="{46594FD8-AF25-D846-9BAA-39E14A4662C6}" dt="2021-09-13T23:02:28.680" v="336" actId="1037"/>
          <ac:spMkLst>
            <pc:docMk/>
            <pc:sldMk cId="3998775946" sldId="283"/>
            <ac:spMk id="62" creationId="{1E261997-15B1-5B47-9CD8-5196E34E590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4" creationId="{B4837D33-AA29-F44E-B82F-CF018DE447A1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5" creationId="{3DFB711B-8B90-1240-B6A8-D19F09136C23}"/>
          </ac:spMkLst>
        </pc:spChg>
        <pc:spChg chg="mod topLvl">
          <ac:chgData name="Wencai Zhang" userId="4a86a1d0-2108-4707-8228-1110f3c1be85" providerId="ADAL" clId="{46594FD8-AF25-D846-9BAA-39E14A4662C6}" dt="2021-09-13T23:02:32.205" v="338" actId="1037"/>
          <ac:spMkLst>
            <pc:docMk/>
            <pc:sldMk cId="3998775946" sldId="283"/>
            <ac:spMk id="66" creationId="{FF517956-7D11-5045-BAB3-D0FBDAA68E18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7" creationId="{5A88E887-9896-2742-9FBE-A90372B280F9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8" creationId="{E76224F7-D762-6B4A-8132-BE95ED59A120}"/>
          </ac:spMkLst>
        </pc:spChg>
        <pc:spChg chg="mod topLvl">
          <ac:chgData name="Wencai Zhang" userId="4a86a1d0-2108-4707-8228-1110f3c1be85" providerId="ADAL" clId="{46594FD8-AF25-D846-9BAA-39E14A4662C6}" dt="2021-09-13T23:32:01.259" v="886" actId="20577"/>
          <ac:spMkLst>
            <pc:docMk/>
            <pc:sldMk cId="3998775946" sldId="283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46594FD8-AF25-D846-9BAA-39E14A4662C6}" dt="2021-09-14T20:21:24.065" v="2902" actId="20577"/>
          <ac:spMkLst>
            <pc:docMk/>
            <pc:sldMk cId="3998775946" sldId="283"/>
            <ac:spMk id="71" creationId="{9B63982C-9423-B641-9499-4AB2C87BF98E}"/>
          </ac:spMkLst>
        </pc:spChg>
        <pc:spChg chg="mod topLvl">
          <ac:chgData name="Wencai Zhang" userId="4a86a1d0-2108-4707-8228-1110f3c1be85" providerId="ADAL" clId="{46594FD8-AF25-D846-9BAA-39E14A4662C6}" dt="2021-09-14T20:21:32.671" v="2906" actId="20577"/>
          <ac:spMkLst>
            <pc:docMk/>
            <pc:sldMk cId="3998775946" sldId="283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46594FD8-AF25-D846-9BAA-39E14A4662C6}" dt="2021-09-13T21:25:22.665" v="172" actId="1035"/>
          <ac:spMkLst>
            <pc:docMk/>
            <pc:sldMk cId="3998775946" sldId="283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5" creationId="{08BD4463-344C-AD42-BFF9-D2126DB12D85}"/>
          </ac:spMkLst>
        </pc:spChg>
        <pc:spChg chg="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46594FD8-AF25-D846-9BAA-39E14A4662C6}" dt="2021-09-14T00:00:33.577" v="1024" actId="478"/>
          <ac:spMkLst>
            <pc:docMk/>
            <pc:sldMk cId="3998775946" sldId="283"/>
            <ac:spMk id="103" creationId="{49A8B912-C125-EB4C-9D89-4E536C209009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4" creationId="{560F9739-AE91-E14F-A72C-229CB273C2CF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5" creationId="{CF6CD96D-1E3B-2648-B127-72770E0C05BE}"/>
          </ac:spMkLst>
        </pc:spChg>
        <pc:spChg chg="del mod">
          <ac:chgData name="Wencai Zhang" userId="4a86a1d0-2108-4707-8228-1110f3c1be85" providerId="ADAL" clId="{46594FD8-AF25-D846-9BAA-39E14A4662C6}" dt="2021-09-14T13:33:08.726" v="1667" actId="478"/>
          <ac:spMkLst>
            <pc:docMk/>
            <pc:sldMk cId="3998775946" sldId="283"/>
            <ac:spMk id="117" creationId="{7486C78F-C24F-9246-A8D3-C3B4808B817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9" creationId="{6AF6553F-3C31-EE44-8578-7CFE050FF54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20" creationId="{2C4FD043-317B-A949-B9FD-AFD5D529F261}"/>
          </ac:spMkLst>
        </pc:spChg>
        <pc:spChg chg="del mod">
          <ac:chgData name="Wencai Zhang" userId="4a86a1d0-2108-4707-8228-1110f3c1be85" providerId="ADAL" clId="{46594FD8-AF25-D846-9BAA-39E14A4662C6}" dt="2021-09-14T13:45:49.899" v="1829" actId="478"/>
          <ac:spMkLst>
            <pc:docMk/>
            <pc:sldMk cId="3998775946" sldId="283"/>
            <ac:spMk id="122" creationId="{F099C031-F70A-3145-90B0-B55867E59E35}"/>
          </ac:spMkLst>
        </pc:spChg>
        <pc:spChg chg="mod">
          <ac:chgData name="Wencai Zhang" userId="4a86a1d0-2108-4707-8228-1110f3c1be85" providerId="ADAL" clId="{46594FD8-AF25-D846-9BAA-39E14A4662C6}" dt="2021-09-14T13:20:13.704" v="1526" actId="1076"/>
          <ac:spMkLst>
            <pc:docMk/>
            <pc:sldMk cId="3998775946" sldId="283"/>
            <ac:spMk id="125" creationId="{B8241A98-BD3C-2B44-B42F-E00E91B351C9}"/>
          </ac:spMkLst>
        </pc:spChg>
        <pc:spChg chg="mod">
          <ac:chgData name="Wencai Zhang" userId="4a86a1d0-2108-4707-8228-1110f3c1be85" providerId="ADAL" clId="{46594FD8-AF25-D846-9BAA-39E14A4662C6}" dt="2021-09-14T12:22:07.022" v="1270" actId="1037"/>
          <ac:spMkLst>
            <pc:docMk/>
            <pc:sldMk cId="3998775946" sldId="283"/>
            <ac:spMk id="126" creationId="{3B37581F-4FE7-2044-848A-A0B20CF5AF9F}"/>
          </ac:spMkLst>
        </pc:spChg>
        <pc:spChg chg="mod">
          <ac:chgData name="Wencai Zhang" userId="4a86a1d0-2108-4707-8228-1110f3c1be85" providerId="ADAL" clId="{46594FD8-AF25-D846-9BAA-39E14A4662C6}" dt="2021-09-14T12:55:03.345" v="1337" actId="20577"/>
          <ac:spMkLst>
            <pc:docMk/>
            <pc:sldMk cId="3998775946" sldId="283"/>
            <ac:spMk id="128" creationId="{5E907FC5-52AF-4643-9EC3-69405E989E4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1" creationId="{550FE903-1811-EF48-A1B8-FF735FB9F49C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2" creationId="{3DF5FE96-AD62-ED4E-91F2-27C62CC21035}"/>
          </ac:spMkLst>
        </pc:spChg>
        <pc:spChg chg="del mod">
          <ac:chgData name="Wencai Zhang" userId="4a86a1d0-2108-4707-8228-1110f3c1be85" providerId="ADAL" clId="{46594FD8-AF25-D846-9BAA-39E14A4662C6}" dt="2021-09-14T13:41:41.890" v="1767" actId="478"/>
          <ac:spMkLst>
            <pc:docMk/>
            <pc:sldMk cId="3998775946" sldId="283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6" creationId="{9346785B-AFE6-2144-BA16-D060A7E0DE3A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4" creationId="{26E32EED-1551-7448-A92A-85AE4FD33D86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5" creationId="{1C6065E1-6EF7-5D47-9010-FBAD30FA814D}"/>
          </ac:spMkLst>
        </pc:spChg>
        <pc:spChg chg="del mod topLvl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6" creationId="{0143FAEC-2918-7642-B01E-B1C62000098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49" creationId="{BDE54864-131E-C449-B5C3-100A2A0DD68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1" creationId="{8D588FF3-C5B7-EB4C-92AF-E20C07CDDD4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2" creationId="{B2996674-BD81-A944-A187-6112C872B32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4" creationId="{19BDB247-BCE1-DD40-8FDE-8E727BFCA7C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5" creationId="{A98A02D4-5713-B941-9FEC-ED4FF54BD66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7" creationId="{2CDE7BEB-9ED7-B64B-AFE7-6473F16F45F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9" creationId="{84AFAC13-E366-DE4C-AB5B-9B492483659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0" creationId="{F4B28066-6EC4-4F4B-BEDE-E392D7F685D9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2" creationId="{21D2D76C-1D04-C947-BDD6-0B1A2EDD76DD}"/>
          </ac:spMkLst>
        </pc:spChg>
        <pc:spChg chg="mod">
          <ac:chgData name="Wencai Zhang" userId="4a86a1d0-2108-4707-8228-1110f3c1be85" providerId="ADAL" clId="{46594FD8-AF25-D846-9BAA-39E14A4662C6}" dt="2021-09-14T13:21:59.870" v="1550" actId="1076"/>
          <ac:spMkLst>
            <pc:docMk/>
            <pc:sldMk cId="3998775946" sldId="283"/>
            <ac:spMk id="164" creationId="{82DBD88E-2361-4D44-B048-37A892383F0A}"/>
          </ac:spMkLst>
        </pc:spChg>
        <pc:spChg chg="mod">
          <ac:chgData name="Wencai Zhang" userId="4a86a1d0-2108-4707-8228-1110f3c1be85" providerId="ADAL" clId="{46594FD8-AF25-D846-9BAA-39E14A4662C6}" dt="2021-09-14T13:22:06.183" v="1551" actId="1076"/>
          <ac:spMkLst>
            <pc:docMk/>
            <pc:sldMk cId="3998775946" sldId="283"/>
            <ac:spMk id="165" creationId="{73FD3E4E-E4E8-454A-BCEB-B1A1CDF3702F}"/>
          </ac:spMkLst>
        </pc:spChg>
        <pc:spChg chg="del mod">
          <ac:chgData name="Wencai Zhang" userId="4a86a1d0-2108-4707-8228-1110f3c1be85" providerId="ADAL" clId="{46594FD8-AF25-D846-9BAA-39E14A4662C6}" dt="2021-09-14T13:22:17.144" v="1552" actId="478"/>
          <ac:spMkLst>
            <pc:docMk/>
            <pc:sldMk cId="3998775946" sldId="283"/>
            <ac:spMk id="167" creationId="{A4CCA9F6-B1D3-0544-8359-DF7ABA905F4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2" creationId="{ED09868F-F3BC-F748-82C8-DE2537285D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3" creationId="{E6F050D7-3FB5-B84C-A0A4-13CC5032B4BD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174" creationId="{772C2F64-D0CB-794D-A688-AE5D87C04FC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46594FD8-AF25-D846-9BAA-39E14A4662C6}" dt="2021-09-13T23:04:02.811" v="339" actId="478"/>
          <ac:spMkLst>
            <pc:docMk/>
            <pc:sldMk cId="3998775946" sldId="283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46594FD8-AF25-D846-9BAA-39E14A4662C6}" dt="2021-09-13T23:04:09.840" v="341" actId="478"/>
          <ac:spMkLst>
            <pc:docMk/>
            <pc:sldMk cId="3998775946" sldId="283"/>
            <ac:spMk id="177" creationId="{7B9A2A0A-A737-8249-8285-20EEE828D37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0" creationId="{65144C8B-EE53-1E4C-ABB8-FCFC397D08F8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46594FD8-AF25-D846-9BAA-39E14A4662C6}" dt="2021-09-14T13:37:25.547" v="1713" actId="478"/>
          <ac:spMkLst>
            <pc:docMk/>
            <pc:sldMk cId="3998775946" sldId="283"/>
            <ac:spMk id="182" creationId="{3E61F479-3743-E445-8731-64B72FBA76CD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46594FD8-AF25-D846-9BAA-39E14A4662C6}" dt="2021-09-14T14:35:06.281" v="2617" actId="1036"/>
          <ac:spMkLst>
            <pc:docMk/>
            <pc:sldMk cId="3998775946" sldId="283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46594FD8-AF25-D846-9BAA-39E14A4662C6}" dt="2021-09-14T14:35:39.728" v="2660" actId="1036"/>
          <ac:spMkLst>
            <pc:docMk/>
            <pc:sldMk cId="3998775946" sldId="283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46594FD8-AF25-D846-9BAA-39E14A4662C6}" dt="2021-09-14T14:37:33.707" v="2668" actId="1037"/>
          <ac:spMkLst>
            <pc:docMk/>
            <pc:sldMk cId="3998775946" sldId="283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4" creationId="{8DD94CE5-3FDF-8D49-B907-928FD99BAC7E}"/>
          </ac:spMkLst>
        </pc:spChg>
        <pc:spChg chg="del mod topLvl">
          <ac:chgData name="Wencai Zhang" userId="4a86a1d0-2108-4707-8228-1110f3c1be85" providerId="ADAL" clId="{46594FD8-AF25-D846-9BAA-39E14A4662C6}" dt="2021-09-14T14:26:45.466" v="2481" actId="478"/>
          <ac:spMkLst>
            <pc:docMk/>
            <pc:sldMk cId="3998775946" sldId="283"/>
            <ac:spMk id="205" creationId="{888FCFE7-5505-4741-8BB8-A84C1F3CB558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09" creationId="{5016763D-2A7E-EC45-A36D-27C149ECF8D6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13" creationId="{F00BDF11-FD76-9E4D-92DD-65342E85E5EE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19" creationId="{4DFFC7C1-C262-D84B-B37D-D418CC2B44D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0" creationId="{C753CA9A-24DE-1448-8C84-5FBCD56DA6A2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1" creationId="{2F98D0C5-1C90-A948-AEBD-807BB9C093AA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2" creationId="{3F3FBA2E-6E41-494A-B4AA-433133A70710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4" creationId="{73A922F8-B8F6-0E49-87B5-BE3FC4BA48C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6" creationId="{F628E4D9-F7A3-3241-AA59-0B4702E3F498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7" creationId="{6834918A-E009-BD4A-BA9A-DF084F1CE0EE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0" creationId="{CCF939D2-A404-3D4A-8F4A-5AF08A395C1F}"/>
          </ac:spMkLst>
        </pc:spChg>
        <pc:spChg chg="del mod">
          <ac:chgData name="Wencai Zhang" userId="4a86a1d0-2108-4707-8228-1110f3c1be85" providerId="ADAL" clId="{46594FD8-AF25-D846-9BAA-39E14A4662C6}" dt="2021-09-14T20:28:59.805" v="3024" actId="478"/>
          <ac:spMkLst>
            <pc:docMk/>
            <pc:sldMk cId="3998775946" sldId="283"/>
            <ac:spMk id="232" creationId="{FD920D99-A7D1-AA4B-A83B-34CF13351773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3" creationId="{00C045AB-36C3-6743-86B8-8EBBC7E7A178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4" creationId="{1F39223C-EE50-0E43-BAE0-84D214654983}"/>
          </ac:spMkLst>
        </pc:spChg>
        <pc:spChg chg="del mod">
          <ac:chgData name="Wencai Zhang" userId="4a86a1d0-2108-4707-8228-1110f3c1be85" providerId="ADAL" clId="{46594FD8-AF25-D846-9BAA-39E14A4662C6}" dt="2021-09-14T20:27:16.799" v="3012" actId="478"/>
          <ac:spMkLst>
            <pc:docMk/>
            <pc:sldMk cId="3998775946" sldId="283"/>
            <ac:spMk id="235" creationId="{EA10B2EF-CACD-FB43-A830-753F266192DC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6" creationId="{6600A3DD-2531-D849-AF84-78DC1C920A61}"/>
          </ac:spMkLst>
        </pc:spChg>
        <pc:spChg chg="del mod topLvl">
          <ac:chgData name="Wencai Zhang" userId="4a86a1d0-2108-4707-8228-1110f3c1be85" providerId="ADAL" clId="{46594FD8-AF25-D846-9BAA-39E14A4662C6}" dt="2021-09-14T20:31:25.077" v="3074" actId="478"/>
          <ac:spMkLst>
            <pc:docMk/>
            <pc:sldMk cId="3998775946" sldId="283"/>
            <ac:spMk id="237" creationId="{EDCFD7CC-11F9-934C-BC9A-B9EA0F24D49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8" creationId="{464C8492-EDEF-994E-83AC-252A679BC9C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9" creationId="{57252B6C-EA1C-2849-A41E-B14B57B362DA}"/>
          </ac:spMkLst>
        </pc:spChg>
        <pc:spChg chg="del mod topLvl">
          <ac:chgData name="Wencai Zhang" userId="4a86a1d0-2108-4707-8228-1110f3c1be85" providerId="ADAL" clId="{46594FD8-AF25-D846-9BAA-39E14A4662C6}" dt="2021-09-14T20:29:17.712" v="3035" actId="478"/>
          <ac:spMkLst>
            <pc:docMk/>
            <pc:sldMk cId="3998775946" sldId="283"/>
            <ac:spMk id="240" creationId="{E9C8D369-5F8D-E54A-AF65-476407FD0AD1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1" creationId="{9FCC0C5D-D6A9-164C-8964-401099D7F9F9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2" creationId="{58BF14D6-FC81-CA47-8833-2926CE44CE61}"/>
          </ac:spMkLst>
        </pc:spChg>
        <pc:spChg chg="mod">
          <ac:chgData name="Wencai Zhang" userId="4a86a1d0-2108-4707-8228-1110f3c1be85" providerId="ADAL" clId="{46594FD8-AF25-D846-9BAA-39E14A4662C6}" dt="2021-09-14T20:26:58.173" v="3010" actId="1036"/>
          <ac:spMkLst>
            <pc:docMk/>
            <pc:sldMk cId="3998775946" sldId="283"/>
            <ac:spMk id="243" creationId="{2BE5FD5F-9D67-4C49-9CA4-E1DE27758C21}"/>
          </ac:spMkLst>
        </pc:spChg>
        <pc:spChg chg="mod">
          <ac:chgData name="Wencai Zhang" userId="4a86a1d0-2108-4707-8228-1110f3c1be85" providerId="ADAL" clId="{46594FD8-AF25-D846-9BAA-39E14A4662C6}" dt="2021-09-14T20:27:03.988" v="3011" actId="1036"/>
          <ac:spMkLst>
            <pc:docMk/>
            <pc:sldMk cId="3998775946" sldId="283"/>
            <ac:spMk id="244" creationId="{9883A24A-5A7C-EC4C-B6EF-924938B59F28}"/>
          </ac:spMkLst>
        </pc:spChg>
        <pc:spChg chg="mod">
          <ac:chgData name="Wencai Zhang" userId="4a86a1d0-2108-4707-8228-1110f3c1be85" providerId="ADAL" clId="{46594FD8-AF25-D846-9BAA-39E14A4662C6}" dt="2021-09-14T20:26:37.963" v="2999" actId="1035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46594FD8-AF25-D846-9BAA-39E14A4662C6}" dt="2021-09-14T20:26:52.896" v="3006" actId="1037"/>
          <ac:spMkLst>
            <pc:docMk/>
            <pc:sldMk cId="3998775946" sldId="283"/>
            <ac:spMk id="246" creationId="{CC32910A-38D6-C84A-B308-3FBD60C2D445}"/>
          </ac:spMkLst>
        </pc:spChg>
        <pc:spChg chg="del mod topLvl">
          <ac:chgData name="Wencai Zhang" userId="4a86a1d0-2108-4707-8228-1110f3c1be85" providerId="ADAL" clId="{46594FD8-AF25-D846-9BAA-39E14A4662C6}" dt="2021-09-14T20:25:51.945" v="2945" actId="478"/>
          <ac:spMkLst>
            <pc:docMk/>
            <pc:sldMk cId="3998775946" sldId="283"/>
            <ac:spMk id="249" creationId="{C8230297-1475-3444-AE6A-DA7A58BA0B75}"/>
          </ac:spMkLst>
        </pc:spChg>
        <pc:spChg chg="del mod topLvl">
          <ac:chgData name="Wencai Zhang" userId="4a86a1d0-2108-4707-8228-1110f3c1be85" providerId="ADAL" clId="{46594FD8-AF25-D846-9BAA-39E14A4662C6}" dt="2021-09-14T20:26:32.537" v="2989" actId="478"/>
          <ac:spMkLst>
            <pc:docMk/>
            <pc:sldMk cId="3998775946" sldId="283"/>
            <ac:spMk id="250" creationId="{122C8E5F-0692-274A-A75F-0CF5B51070DC}"/>
          </ac:spMkLst>
        </pc:spChg>
        <pc:spChg chg="add mod">
          <ac:chgData name="Wencai Zhang" userId="4a86a1d0-2108-4707-8228-1110f3c1be85" providerId="ADAL" clId="{46594FD8-AF25-D846-9BAA-39E14A4662C6}" dt="2021-09-13T23:05:14.041" v="362" actId="1035"/>
          <ac:spMkLst>
            <pc:docMk/>
            <pc:sldMk cId="3998775946" sldId="283"/>
            <ac:spMk id="252" creationId="{9E7A4822-5BB5-5E4B-8079-2A2D614459E1}"/>
          </ac:spMkLst>
        </pc:spChg>
        <pc:spChg chg="add mod">
          <ac:chgData name="Wencai Zhang" userId="4a86a1d0-2108-4707-8228-1110f3c1be85" providerId="ADAL" clId="{46594FD8-AF25-D846-9BAA-39E14A4662C6}" dt="2021-09-13T23:25:03.834" v="761" actId="1036"/>
          <ac:spMkLst>
            <pc:docMk/>
            <pc:sldMk cId="3998775946" sldId="283"/>
            <ac:spMk id="253" creationId="{9F3D2978-3FA5-1F46-B7BB-B2A1D2C70654}"/>
          </ac:spMkLst>
        </pc:spChg>
        <pc:spChg chg="add mod">
          <ac:chgData name="Wencai Zhang" userId="4a86a1d0-2108-4707-8228-1110f3c1be85" providerId="ADAL" clId="{46594FD8-AF25-D846-9BAA-39E14A4662C6}" dt="2021-09-13T23:25:11.440" v="768" actId="1038"/>
          <ac:spMkLst>
            <pc:docMk/>
            <pc:sldMk cId="3998775946" sldId="283"/>
            <ac:spMk id="254" creationId="{FFD005C4-C00B-2949-823A-A186C32EC442}"/>
          </ac:spMkLst>
        </pc:spChg>
        <pc:spChg chg="add mod">
          <ac:chgData name="Wencai Zhang" userId="4a86a1d0-2108-4707-8228-1110f3c1be85" providerId="ADAL" clId="{46594FD8-AF25-D846-9BAA-39E14A4662C6}" dt="2021-09-13T23:25:16.269" v="769" actId="1038"/>
          <ac:spMkLst>
            <pc:docMk/>
            <pc:sldMk cId="3998775946" sldId="283"/>
            <ac:spMk id="256" creationId="{3D8708BD-48FC-544C-97E2-913EADBF8C8D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7" creationId="{4D7D491B-105C-3644-A0BA-ADE10712D27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8" creationId="{C43F6F12-416D-1945-B6E0-107443CCDF46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9" creationId="{A42F0D0B-74D9-E94C-91E7-AD51A2B55DD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0" creationId="{954D13E6-38B5-734A-A1A7-6C11C73CF015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3" creationId="{70A610C3-9E97-D94F-80DE-3E3920EB3BAA}"/>
          </ac:spMkLst>
        </pc:spChg>
        <pc:spChg chg="add mod">
          <ac:chgData name="Wencai Zhang" userId="4a86a1d0-2108-4707-8228-1110f3c1be85" providerId="ADAL" clId="{46594FD8-AF25-D846-9BAA-39E14A4662C6}" dt="2021-09-14T20:21:19.038" v="2898" actId="20577"/>
          <ac:spMkLst>
            <pc:docMk/>
            <pc:sldMk cId="3998775946" sldId="283"/>
            <ac:spMk id="264" creationId="{B3B59ED4-62D1-6A4C-AEEB-3D91A6797AAC}"/>
          </ac:spMkLst>
        </pc:spChg>
        <pc:spChg chg="add mod">
          <ac:chgData name="Wencai Zhang" userId="4a86a1d0-2108-4707-8228-1110f3c1be85" providerId="ADAL" clId="{46594FD8-AF25-D846-9BAA-39E14A4662C6}" dt="2021-09-14T20:21:29.971" v="2904" actId="20577"/>
          <ac:spMkLst>
            <pc:docMk/>
            <pc:sldMk cId="3998775946" sldId="283"/>
            <ac:spMk id="265" creationId="{8D326B54-6FC1-6B43-B24F-103C48CE56A4}"/>
          </ac:spMkLst>
        </pc:spChg>
        <pc:spChg chg="add mod">
          <ac:chgData name="Wencai Zhang" userId="4a86a1d0-2108-4707-8228-1110f3c1be85" providerId="ADAL" clId="{46594FD8-AF25-D846-9BAA-39E14A4662C6}" dt="2021-09-13T23:30:52.600" v="857" actId="1037"/>
          <ac:spMkLst>
            <pc:docMk/>
            <pc:sldMk cId="3998775946" sldId="283"/>
            <ac:spMk id="266" creationId="{962912CF-932F-3B4E-A328-17538F9CB7A9}"/>
          </ac:spMkLst>
        </pc:spChg>
        <pc:spChg chg="add mod">
          <ac:chgData name="Wencai Zhang" userId="4a86a1d0-2108-4707-8228-1110f3c1be85" providerId="ADAL" clId="{46594FD8-AF25-D846-9BAA-39E14A4662C6}" dt="2021-09-13T23:58:39.685" v="1009" actId="14100"/>
          <ac:spMkLst>
            <pc:docMk/>
            <pc:sldMk cId="3998775946" sldId="283"/>
            <ac:spMk id="267" creationId="{C370FCB8-C987-9B42-AE42-115DACF9850A}"/>
          </ac:spMkLst>
        </pc:spChg>
        <pc:spChg chg="add mod">
          <ac:chgData name="Wencai Zhang" userId="4a86a1d0-2108-4707-8228-1110f3c1be85" providerId="ADAL" clId="{46594FD8-AF25-D846-9BAA-39E14A4662C6}" dt="2021-09-13T23:58:34.871" v="1008" actId="14100"/>
          <ac:spMkLst>
            <pc:docMk/>
            <pc:sldMk cId="3998775946" sldId="283"/>
            <ac:spMk id="268" creationId="{A91F5993-B4E5-B14A-A335-0BF55F5DD358}"/>
          </ac:spMkLst>
        </pc:spChg>
        <pc:spChg chg="mod">
          <ac:chgData name="Wencai Zhang" userId="4a86a1d0-2108-4707-8228-1110f3c1be85" providerId="ADAL" clId="{46594FD8-AF25-D846-9BAA-39E14A4662C6}" dt="2021-09-14T12:05:13.077" v="1173" actId="14100"/>
          <ac:spMkLst>
            <pc:docMk/>
            <pc:sldMk cId="3998775946" sldId="283"/>
            <ac:spMk id="270" creationId="{06F013AE-6355-124D-9518-0B7AD063914C}"/>
          </ac:spMkLst>
        </pc:spChg>
        <pc:spChg chg="mod">
          <ac:chgData name="Wencai Zhang" userId="4a86a1d0-2108-4707-8228-1110f3c1be85" providerId="ADAL" clId="{46594FD8-AF25-D846-9BAA-39E14A4662C6}" dt="2021-09-14T12:04:50.336" v="1172" actId="14100"/>
          <ac:spMkLst>
            <pc:docMk/>
            <pc:sldMk cId="3998775946" sldId="283"/>
            <ac:spMk id="271" creationId="{F8989B0B-AAC2-C545-A53A-5638D11A272F}"/>
          </ac:spMkLst>
        </pc:spChg>
        <pc:spChg chg="mod">
          <ac:chgData name="Wencai Zhang" userId="4a86a1d0-2108-4707-8228-1110f3c1be85" providerId="ADAL" clId="{46594FD8-AF25-D846-9BAA-39E14A4662C6}" dt="2021-09-14T00:07:43.790" v="1114" actId="14100"/>
          <ac:spMkLst>
            <pc:docMk/>
            <pc:sldMk cId="3998775946" sldId="283"/>
            <ac:spMk id="272" creationId="{6FC4A1E5-0DC2-CF41-8E78-DAB763F1221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4" creationId="{4B2B0F80-6662-FE42-A3FF-AC45C71EDD6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5" creationId="{2B7EE132-3F4B-3243-8D2B-7662957346DF}"/>
          </ac:spMkLst>
        </pc:spChg>
        <pc:spChg chg="add mod">
          <ac:chgData name="Wencai Zhang" userId="4a86a1d0-2108-4707-8228-1110f3c1be85" providerId="ADAL" clId="{46594FD8-AF25-D846-9BAA-39E14A4662C6}" dt="2021-09-14T12:22:46.292" v="1283" actId="164"/>
          <ac:spMkLst>
            <pc:docMk/>
            <pc:sldMk cId="3998775946" sldId="283"/>
            <ac:spMk id="276" creationId="{F46EE642-428B-C243-BE49-52CE3E37AC07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7" creationId="{056AEB35-6CD1-854E-9F57-E131C2E4DB99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8" creationId="{2F51DBAE-15F0-8940-9FF5-E2FD05424FFE}"/>
          </ac:spMkLst>
        </pc:spChg>
        <pc:spChg chg="add mod">
          <ac:chgData name="Wencai Zhang" userId="4a86a1d0-2108-4707-8228-1110f3c1be85" providerId="ADAL" clId="{46594FD8-AF25-D846-9BAA-39E14A4662C6}" dt="2021-09-14T12:21:41.634" v="1252" actId="164"/>
          <ac:spMkLst>
            <pc:docMk/>
            <pc:sldMk cId="3998775946" sldId="283"/>
            <ac:spMk id="279" creationId="{8E7B3E58-D522-CD4C-88FF-8419878B1277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0" creationId="{35680868-7F4D-014E-996E-5D90D7928454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1" creationId="{AD2B9D23-35D4-A542-A327-C5D0DED648DD}"/>
          </ac:spMkLst>
        </pc:spChg>
        <pc:spChg chg="add del mod">
          <ac:chgData name="Wencai Zhang" userId="4a86a1d0-2108-4707-8228-1110f3c1be85" providerId="ADAL" clId="{46594FD8-AF25-D846-9BAA-39E14A4662C6}" dt="2021-09-14T12:57:01.008" v="1377" actId="478"/>
          <ac:spMkLst>
            <pc:docMk/>
            <pc:sldMk cId="3998775946" sldId="283"/>
            <ac:spMk id="283" creationId="{077079B6-879B-364D-8923-DAF9B17F5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4" creationId="{FD36D9F5-0AC5-C643-8D26-298DE0F99D50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5" creationId="{A92A19F7-BAB0-7E4F-A263-4555C5BD8FF0}"/>
          </ac:spMkLst>
        </pc:spChg>
        <pc:spChg chg="add del mod">
          <ac:chgData name="Wencai Zhang" userId="4a86a1d0-2108-4707-8228-1110f3c1be85" providerId="ADAL" clId="{46594FD8-AF25-D846-9BAA-39E14A4662C6}" dt="2021-09-14T12:58:59.480" v="1394" actId="478"/>
          <ac:spMkLst>
            <pc:docMk/>
            <pc:sldMk cId="3998775946" sldId="283"/>
            <ac:spMk id="286" creationId="{2E5778EA-EA68-B240-BEF8-8A02BC59EB21}"/>
          </ac:spMkLst>
        </pc:spChg>
        <pc:spChg chg="add del mod">
          <ac:chgData name="Wencai Zhang" userId="4a86a1d0-2108-4707-8228-1110f3c1be85" providerId="ADAL" clId="{46594FD8-AF25-D846-9BAA-39E14A4662C6}" dt="2021-09-14T13:27:40.449" v="1636" actId="478"/>
          <ac:spMkLst>
            <pc:docMk/>
            <pc:sldMk cId="3998775946" sldId="283"/>
            <ac:spMk id="288" creationId="{9169C486-C907-EB4C-921B-9C9ACD16C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9" creationId="{E59D94A3-A775-B24F-8FC5-035B9DB0D9FB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0" creationId="{36EA0914-858A-304F-802F-F908CE0D12EB}"/>
          </ac:spMkLst>
        </pc:spChg>
        <pc:spChg chg="add del mod">
          <ac:chgData name="Wencai Zhang" userId="4a86a1d0-2108-4707-8228-1110f3c1be85" providerId="ADAL" clId="{46594FD8-AF25-D846-9BAA-39E14A4662C6}" dt="2021-09-14T13:28:35.311" v="1640" actId="478"/>
          <ac:spMkLst>
            <pc:docMk/>
            <pc:sldMk cId="3998775946" sldId="283"/>
            <ac:spMk id="291" creationId="{CFE0FD2A-0BD5-8548-8AED-3BB7C87226B4}"/>
          </ac:spMkLst>
        </pc:spChg>
        <pc:spChg chg="add del mod">
          <ac:chgData name="Wencai Zhang" userId="4a86a1d0-2108-4707-8228-1110f3c1be85" providerId="ADAL" clId="{46594FD8-AF25-D846-9BAA-39E14A4662C6}" dt="2021-09-14T13:28:31.558" v="1639" actId="478"/>
          <ac:spMkLst>
            <pc:docMk/>
            <pc:sldMk cId="3998775946" sldId="283"/>
            <ac:spMk id="293" creationId="{AD15D494-D343-D542-B6FA-A9FFB279A8CA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4" creationId="{1E2DD64C-2FB0-E749-8A1F-E4F1608160EE}"/>
          </ac:spMkLst>
        </pc:spChg>
        <pc:spChg chg="add del mod">
          <ac:chgData name="Wencai Zhang" userId="4a86a1d0-2108-4707-8228-1110f3c1be85" providerId="ADAL" clId="{46594FD8-AF25-D846-9BAA-39E14A4662C6}" dt="2021-09-14T13:22:55.157" v="1561" actId="478"/>
          <ac:spMkLst>
            <pc:docMk/>
            <pc:sldMk cId="3998775946" sldId="283"/>
            <ac:spMk id="296" creationId="{D0D4B759-9CF8-D64C-BD3E-84E6071B9175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7" creationId="{273F7130-EE75-1A49-BAF7-6FB6602B489F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8" creationId="{57BE9F52-ABCE-C34E-A683-6907FEF1DEB4}"/>
          </ac:spMkLst>
        </pc:spChg>
        <pc:spChg chg="add del mod">
          <ac:chgData name="Wencai Zhang" userId="4a86a1d0-2108-4707-8228-1110f3c1be85" providerId="ADAL" clId="{46594FD8-AF25-D846-9BAA-39E14A4662C6}" dt="2021-09-14T13:24:59.148" v="1596" actId="478"/>
          <ac:spMkLst>
            <pc:docMk/>
            <pc:sldMk cId="3998775946" sldId="283"/>
            <ac:spMk id="299" creationId="{D7FF1A76-EA74-114A-820D-FFE93E7EE697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0" creationId="{5EFEA7F4-8CCB-9B49-9C0D-DD160F828755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1" creationId="{47AF706E-6473-7D48-9E88-CB4346B5D1C9}"/>
          </ac:spMkLst>
        </pc:spChg>
        <pc:spChg chg="add mod">
          <ac:chgData name="Wencai Zhang" userId="4a86a1d0-2108-4707-8228-1110f3c1be85" providerId="ADAL" clId="{46594FD8-AF25-D846-9BAA-39E14A4662C6}" dt="2021-09-14T13:21:26.808" v="1548" actId="20577"/>
          <ac:spMkLst>
            <pc:docMk/>
            <pc:sldMk cId="3998775946" sldId="283"/>
            <ac:spMk id="302" creationId="{86DB98B1-BDFC-0942-8FBA-F054AB42CC42}"/>
          </ac:spMkLst>
        </pc:spChg>
        <pc:spChg chg="add mod">
          <ac:chgData name="Wencai Zhang" userId="4a86a1d0-2108-4707-8228-1110f3c1be85" providerId="ADAL" clId="{46594FD8-AF25-D846-9BAA-39E14A4662C6}" dt="2021-09-14T13:22:32.881" v="1557" actId="164"/>
          <ac:spMkLst>
            <pc:docMk/>
            <pc:sldMk cId="3998775946" sldId="283"/>
            <ac:spMk id="303" creationId="{7A8A4964-A4E5-8F4B-862F-F928D5BEB80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4" creationId="{A0363A2F-D7BB-5A4D-95EE-8656CE5F066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5" creationId="{B5D84BCF-4062-5640-8BF4-C47DEFF63F4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6" creationId="{0AC37BEE-9FEE-C748-A708-C96BAD624187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7" creationId="{46E052C2-EEDD-6D49-AD8B-F416350080F6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8" creationId="{F6A252C6-8E9F-9A40-81E1-4658575D1D93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9" creationId="{723145C1-38D6-D347-89A4-F6A68BCDA1D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0" creationId="{3E97819B-7389-414D-8D3D-77FF352CA8A4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1" creationId="{0C676772-4386-A542-B4E3-EAB0ADF2C293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2" creationId="{280D227E-C83A-0441-B8A4-E7F897E7A06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3" creationId="{9E00FB9E-D923-004E-A59E-4406B1183C42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4" creationId="{0412498F-4F4D-8640-BE4A-3E10228E23F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5" creationId="{99F4BB11-D596-1545-8161-A9CF4F97D8EE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6" creationId="{BFDC8C24-2E7C-C54C-B7B1-363556E699D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7" creationId="{D3CC6593-FC19-284E-8B73-DD53FA2CE544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9" creationId="{3DA8A3D2-6FE0-734F-9FAA-25640EF09677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0" creationId="{6AFAA2A5-BAAD-E44D-AFE9-912EF181750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1" creationId="{9D8AE43B-7056-2C42-B504-6B4D46E835B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2" creationId="{DC9E1A87-B772-5B48-B326-C782BC67476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24" creationId="{90DAC876-2700-F647-98B9-8D9775682A6C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5" creationId="{A52F1DE5-28A6-4549-A26C-4DE511E67175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6" creationId="{E273EACB-801F-434F-900C-C49A4E8B1F2F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7" creationId="{E8C132DF-C4EB-BA44-BD97-1660DCE1A422}"/>
          </ac:spMkLst>
        </pc:spChg>
        <pc:spChg chg="add del mod">
          <ac:chgData name="Wencai Zhang" userId="4a86a1d0-2108-4707-8228-1110f3c1be85" providerId="ADAL" clId="{46594FD8-AF25-D846-9BAA-39E14A4662C6}" dt="2021-09-14T14:14:40.729" v="2199" actId="478"/>
          <ac:spMkLst>
            <pc:docMk/>
            <pc:sldMk cId="3998775946" sldId="283"/>
            <ac:spMk id="329" creationId="{1B967B23-2BF1-734C-8A6B-5141CA0146A2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1" creationId="{B0CDCD81-2FEB-E64C-A1E3-A0C78EDFF80E}"/>
          </ac:spMkLst>
        </pc:spChg>
        <pc:spChg chg="add del mod">
          <ac:chgData name="Wencai Zhang" userId="4a86a1d0-2108-4707-8228-1110f3c1be85" providerId="ADAL" clId="{46594FD8-AF25-D846-9BAA-39E14A4662C6}" dt="2021-09-14T14:09:58.731" v="2181" actId="478"/>
          <ac:spMkLst>
            <pc:docMk/>
            <pc:sldMk cId="3998775946" sldId="283"/>
            <ac:spMk id="333" creationId="{2829901E-78BA-6B48-80A0-98346E9D8333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4" creationId="{6904F76C-14D2-654F-9A1B-59DB924065EA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5" creationId="{A07DD7A4-501D-6C49-87C5-93BA6681ACA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6" creationId="{4AB94D3F-29D0-1840-A8DD-7B01A9F447DC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7" creationId="{139155A5-464A-DF4F-8942-BC5AB524A156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8" creationId="{D9652BCF-79CA-D946-A6AD-845AA4100A69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9" creationId="{030B6B7E-1238-7947-90F6-12786847EF1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0" creationId="{41EA6193-130E-4B48-A4E5-56699D0ADAD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1" creationId="{134DF9EB-9B2B-3A49-A658-506CD3323A52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2" creationId="{7FD554B4-6867-A54D-A7A4-18F63894D04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3" creationId="{88B2F9DF-0690-D54A-BA49-E303FFC16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4" creationId="{BAF454D1-2531-4649-A27F-D46ED0DFB8FD}"/>
          </ac:spMkLst>
        </pc:spChg>
        <pc:spChg chg="add del mod">
          <ac:chgData name="Wencai Zhang" userId="4a86a1d0-2108-4707-8228-1110f3c1be85" providerId="ADAL" clId="{46594FD8-AF25-D846-9BAA-39E14A4662C6}" dt="2021-09-14T14:25:08.686" v="2433" actId="478"/>
          <ac:spMkLst>
            <pc:docMk/>
            <pc:sldMk cId="3998775946" sldId="283"/>
            <ac:spMk id="345" creationId="{F8E01990-4AB6-A74F-A15B-E15193BF8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7" creationId="{D63D19DE-919C-B14F-9765-AB87B8ABF63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8" creationId="{170DC328-F7D8-D747-871D-D6A4078F1AA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9" creationId="{67FAAC8F-F84F-7C47-878B-19D85F1FE035}"/>
          </ac:spMkLst>
        </pc:spChg>
        <pc:spChg chg="add mod">
          <ac:chgData name="Wencai Zhang" userId="4a86a1d0-2108-4707-8228-1110f3c1be85" providerId="ADAL" clId="{46594FD8-AF25-D846-9BAA-39E14A4662C6}" dt="2021-09-14T20:21:16.858" v="2896" actId="20577"/>
          <ac:spMkLst>
            <pc:docMk/>
            <pc:sldMk cId="3998775946" sldId="283"/>
            <ac:spMk id="350" creationId="{829AC08B-4779-2E4C-9CDD-BE6631EC42D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1" creationId="{A3AED6B8-3A07-D847-8288-D8BECCD3CB2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2" creationId="{092266A2-BC6F-8B42-B1F6-2793B87939A5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3" creationId="{5715180B-47B2-7A40-8448-B41A943EEB93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4" creationId="{3861B9CF-2048-7647-AB06-A556E8430B6F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5" creationId="{A5C27DAF-3031-864C-9C37-112CC070FCC4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6" creationId="{A1D7723D-0C3E-D548-BCC7-B7D44C3588B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7" creationId="{463C2D55-EFCB-1D40-A3BF-EA5D75F7633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8" creationId="{B1802351-4668-D242-920B-36BE5B67400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9" creationId="{0429DC9A-7DCC-3E49-87E8-05C7839D2E9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0" creationId="{5D008AD1-3239-394E-9325-5A53B29078DC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1" creationId="{3E021C58-547C-7347-B3CF-ED94F6CFD05E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2" creationId="{9D5AFDC7-44F6-D14F-BD91-A183F0487EDA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3" creationId="{80DE4503-1D68-4242-B457-61BB8F040E84}"/>
          </ac:spMkLst>
        </pc:spChg>
        <pc:spChg chg="add mod">
          <ac:chgData name="Wencai Zhang" userId="4a86a1d0-2108-4707-8228-1110f3c1be85" providerId="ADAL" clId="{46594FD8-AF25-D846-9BAA-39E14A4662C6}" dt="2021-09-14T20:35:48.619" v="3264" actId="20577"/>
          <ac:spMkLst>
            <pc:docMk/>
            <pc:sldMk cId="3998775946" sldId="283"/>
            <ac:spMk id="364" creationId="{5032542A-D0F1-7F4B-910B-DCBD1CFA9EEB}"/>
          </ac:spMkLst>
        </pc:spChg>
        <pc:grpChg chg="del mod topLvl">
          <ac:chgData name="Wencai Zhang" userId="4a86a1d0-2108-4707-8228-1110f3c1be85" providerId="ADAL" clId="{46594FD8-AF25-D846-9BAA-39E14A4662C6}" dt="2021-09-13T23:04:11.970" v="342" actId="478"/>
          <ac:grpSpMkLst>
            <pc:docMk/>
            <pc:sldMk cId="3998775946" sldId="283"/>
            <ac:grpSpMk id="2" creationId="{96451E40-1371-C64D-9BFA-6472B2ABF063}"/>
          </ac:grpSpMkLst>
        </pc:grpChg>
        <pc:grpChg chg="del">
          <ac:chgData name="Wencai Zhang" userId="4a86a1d0-2108-4707-8228-1110f3c1be85" providerId="ADAL" clId="{46594FD8-AF25-D846-9BAA-39E14A4662C6}" dt="2021-09-13T21:20:48.414" v="43" actId="165"/>
          <ac:grpSpMkLst>
            <pc:docMk/>
            <pc:sldMk cId="3998775946" sldId="283"/>
            <ac:grpSpMk id="3" creationId="{066BC804-6321-634F-887E-10DA31DF0490}"/>
          </ac:grpSpMkLst>
        </pc:grpChg>
        <pc:grpChg chg="mod topLvl">
          <ac:chgData name="Wencai Zhang" userId="4a86a1d0-2108-4707-8228-1110f3c1be85" providerId="ADAL" clId="{46594FD8-AF25-D846-9BAA-39E14A4662C6}" dt="2021-09-14T20:23:15.210" v="2920" actId="164"/>
          <ac:grpSpMkLst>
            <pc:docMk/>
            <pc:sldMk cId="3998775946" sldId="283"/>
            <ac:grpSpMk id="4" creationId="{7D7F32F4-005D-484E-B856-F6EAA80159E7}"/>
          </ac:grpSpMkLst>
        </pc:grpChg>
        <pc:grpChg chg="del mod topLvl">
          <ac:chgData name="Wencai Zhang" userId="4a86a1d0-2108-4707-8228-1110f3c1be85" providerId="ADAL" clId="{46594FD8-AF25-D846-9BAA-39E14A4662C6}" dt="2021-09-13T21:21:04.922" v="45" actId="165"/>
          <ac:grpSpMkLst>
            <pc:docMk/>
            <pc:sldMk cId="3998775946" sldId="283"/>
            <ac:grpSpMk id="6" creationId="{581344F7-D56B-B94B-9DB8-92E65EDBA18E}"/>
          </ac:grpSpMkLst>
        </pc:grpChg>
        <pc:grpChg chg="del mod topLvl">
          <ac:chgData name="Wencai Zhang" userId="4a86a1d0-2108-4707-8228-1110f3c1be85" providerId="ADAL" clId="{46594FD8-AF25-D846-9BAA-39E14A4662C6}" dt="2021-09-14T12:21:20.342" v="1249" actId="478"/>
          <ac:grpSpMkLst>
            <pc:docMk/>
            <pc:sldMk cId="3998775946" sldId="283"/>
            <ac:grpSpMk id="8" creationId="{63650F43-37FA-564D-A530-06A0FD37A9AC}"/>
          </ac:grpSpMkLst>
        </pc:grpChg>
        <pc:grpChg chg="del mod topLvl">
          <ac:chgData name="Wencai Zhang" userId="4a86a1d0-2108-4707-8228-1110f3c1be85" providerId="ADAL" clId="{46594FD8-AF25-D846-9BAA-39E14A4662C6}" dt="2021-09-13T21:20:55.826" v="44" actId="165"/>
          <ac:grpSpMkLst>
            <pc:docMk/>
            <pc:sldMk cId="3998775946" sldId="283"/>
            <ac:grpSpMk id="9" creationId="{20D61725-C418-9046-9B50-C136B0964C04}"/>
          </ac:grpSpMkLst>
        </pc:grpChg>
        <pc:grpChg chg="mod topLvl">
          <ac:chgData name="Wencai Zhang" userId="4a86a1d0-2108-4707-8228-1110f3c1be85" providerId="ADAL" clId="{46594FD8-AF25-D846-9BAA-39E14A4662C6}" dt="2021-09-13T21:26:30.569" v="218" actId="1038"/>
          <ac:grpSpMkLst>
            <pc:docMk/>
            <pc:sldMk cId="3998775946" sldId="283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46594FD8-AF25-D846-9BAA-39E14A4662C6}" dt="2021-09-13T21:32:22.291" v="332" actId="1038"/>
          <ac:grpSpMkLst>
            <pc:docMk/>
            <pc:sldMk cId="3998775946" sldId="283"/>
            <ac:grpSpMk id="12" creationId="{9375FF98-CCE2-AF4B-93D1-850D44D144F7}"/>
          </ac:grpSpMkLst>
        </pc:grpChg>
        <pc:grpChg chg="del mod topLvl">
          <ac:chgData name="Wencai Zhang" userId="4a86a1d0-2108-4707-8228-1110f3c1be85" providerId="ADAL" clId="{46594FD8-AF25-D846-9BAA-39E14A4662C6}" dt="2021-09-13T21:21:39.052" v="77" actId="165"/>
          <ac:grpSpMkLst>
            <pc:docMk/>
            <pc:sldMk cId="3998775946" sldId="283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46594FD8-AF25-D846-9BAA-39E14A4662C6}" dt="2021-09-14T14:09:05.190" v="2157" actId="165"/>
          <ac:grpSpMkLst>
            <pc:docMk/>
            <pc:sldMk cId="3998775946" sldId="283"/>
            <ac:grpSpMk id="14" creationId="{B76D2E34-8BE1-BB4B-BBC3-A4CE0308B2DC}"/>
          </ac:grpSpMkLst>
        </pc:grpChg>
        <pc:grpChg chg="add del mod topLvl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6" creationId="{41EF3202-F853-1A42-837D-3B57913EE75D}"/>
          </ac:grpSpMkLst>
        </pc:grpChg>
        <pc:grpChg chg="add del mod">
          <ac:chgData name="Wencai Zhang" userId="4a86a1d0-2108-4707-8228-1110f3c1be85" providerId="ADAL" clId="{46594FD8-AF25-D846-9BAA-39E14A4662C6}" dt="2021-09-14T00:09:09.634" v="1132" actId="165"/>
          <ac:grpSpMkLst>
            <pc:docMk/>
            <pc:sldMk cId="3998775946" sldId="283"/>
            <ac:grpSpMk id="18" creationId="{8ACB21F1-4F70-3947-A9EC-179FA174FF75}"/>
          </ac:grpSpMkLst>
        </pc:grpChg>
        <pc:grpChg chg="del mod topLvl">
          <ac:chgData name="Wencai Zhang" userId="4a86a1d0-2108-4707-8228-1110f3c1be85" providerId="ADAL" clId="{46594FD8-AF25-D846-9BAA-39E14A4662C6}" dt="2021-09-14T20:29:42.370" v="3046" actId="165"/>
          <ac:grpSpMkLst>
            <pc:docMk/>
            <pc:sldMk cId="3998775946" sldId="283"/>
            <ac:grpSpMk id="20" creationId="{321DAD19-E9D0-234C-821C-5E044A313399}"/>
          </ac:grpSpMkLst>
        </pc:grpChg>
        <pc:grpChg chg="del mod topLvl">
          <ac:chgData name="Wencai Zhang" userId="4a86a1d0-2108-4707-8228-1110f3c1be85" providerId="ADAL" clId="{46594FD8-AF25-D846-9BAA-39E14A4662C6}" dt="2021-09-14T14:26:37.581" v="2479" actId="165"/>
          <ac:grpSpMkLst>
            <pc:docMk/>
            <pc:sldMk cId="3998775946" sldId="283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46594FD8-AF25-D846-9BAA-39E14A4662C6}" dt="2021-09-14T00:09:14.051" v="1133" actId="1076"/>
          <ac:grpSpMkLst>
            <pc:docMk/>
            <pc:sldMk cId="3998775946" sldId="283"/>
            <ac:grpSpMk id="30" creationId="{99050ACA-3440-604E-B0E3-794FAF5D459B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4" creationId="{B1A190EF-8208-214C-AA74-D041DE9849E0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5" creationId="{9F37A052-8D50-BC4D-A4DC-069BFC6A39F3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7" creationId="{27B8616D-59C5-5349-A558-778965C429EA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8" creationId="{06D7A987-CF2A-D24A-B247-60B248C57C3A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53" creationId="{086B17DE-7EDC-534D-8BD5-66196B103598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60" creationId="{224B13FA-B34C-854B-BE94-EE22CC7CA3B4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70" creationId="{75B0705B-E19E-E34D-B58E-0C1D0C1A2D17}"/>
          </ac:grpSpMkLst>
        </pc:grpChg>
        <pc:grpChg chg="mod topLvl">
          <ac:chgData name="Wencai Zhang" userId="4a86a1d0-2108-4707-8228-1110f3c1be85" providerId="ADAL" clId="{46594FD8-AF25-D846-9BAA-39E14A4662C6}" dt="2021-09-14T20:34:08.976" v="3245" actId="1037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46594FD8-AF25-D846-9BAA-39E14A4662C6}" dt="2021-09-14T20:35:14.883" v="3252" actId="1076"/>
          <ac:grpSpMkLst>
            <pc:docMk/>
            <pc:sldMk cId="3998775946" sldId="283"/>
            <ac:grpSpMk id="104" creationId="{845CF3A1-794D-6D47-88E7-29FB95D0CEE6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5" creationId="{0C41E2B1-A353-A340-89D5-A68350C569DC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6" creationId="{345CB9A9-5784-A24E-9572-7BEA17A9C6A1}"/>
          </ac:grpSpMkLst>
        </pc:grpChg>
        <pc:grpChg chg="del mod topLvl">
          <ac:chgData name="Wencai Zhang" userId="4a86a1d0-2108-4707-8228-1110f3c1be85" providerId="ADAL" clId="{46594FD8-AF25-D846-9BAA-39E14A4662C6}" dt="2021-09-14T13:33:34.528" v="1675" actId="165"/>
          <ac:grpSpMkLst>
            <pc:docMk/>
            <pc:sldMk cId="3998775946" sldId="283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46594FD8-AF25-D846-9BAA-39E14A4662C6}" dt="2021-09-14T13:46:01.828" v="1830" actId="165"/>
          <ac:grpSpMkLst>
            <pc:docMk/>
            <pc:sldMk cId="3998775946" sldId="283"/>
            <ac:grpSpMk id="118" creationId="{C1E4D236-88F6-DB40-85DC-62A33FB83DA5}"/>
          </ac:grpSpMkLst>
        </pc:grpChg>
        <pc:grpChg chg="mod topLvl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46594FD8-AF25-D846-9BAA-39E14A4662C6}" dt="2021-09-14T13:41:52.486" v="1768" actId="165"/>
          <ac:grpSpMkLst>
            <pc:docMk/>
            <pc:sldMk cId="3998775946" sldId="283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46594FD8-AF25-D846-9BAA-39E14A4662C6}" dt="2021-09-14T13:34:23.810" v="1687" actId="478"/>
          <ac:grpSpMkLst>
            <pc:docMk/>
            <pc:sldMk cId="3998775946" sldId="283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46594FD8-AF25-D846-9BAA-39E14A4662C6}" dt="2021-09-14T13:46:43.574" v="1843" actId="478"/>
          <ac:grpSpMkLst>
            <pc:docMk/>
            <pc:sldMk cId="3998775946" sldId="283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46594FD8-AF25-D846-9BAA-39E14A4662C6}" dt="2021-09-14T13:40:11.686" v="1751" actId="478"/>
          <ac:grpSpMkLst>
            <pc:docMk/>
            <pc:sldMk cId="3998775946" sldId="283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46594FD8-AF25-D846-9BAA-39E14A4662C6}" dt="2021-09-14T13:44:01.967" v="1787" actId="478"/>
          <ac:grpSpMkLst>
            <pc:docMk/>
            <pc:sldMk cId="3998775946" sldId="283"/>
            <ac:grpSpMk id="158" creationId="{A27194E5-D149-6A41-8DF8-77D640F31ED1}"/>
          </ac:grpSpMkLst>
        </pc:grpChg>
        <pc:grpChg chg="mod topLvl">
          <ac:chgData name="Wencai Zhang" userId="4a86a1d0-2108-4707-8228-1110f3c1be85" providerId="ADAL" clId="{46594FD8-AF25-D846-9BAA-39E14A4662C6}" dt="2021-09-14T13:22:32.881" v="1557" actId="164"/>
          <ac:grpSpMkLst>
            <pc:docMk/>
            <pc:sldMk cId="3998775946" sldId="283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46594FD8-AF25-D846-9BAA-39E14A4662C6}" dt="2021-09-13T23:04:06.224" v="340" actId="478"/>
          <ac:grpSpMkLst>
            <pc:docMk/>
            <pc:sldMk cId="3998775946" sldId="283"/>
            <ac:grpSpMk id="168" creationId="{A09C9EB4-CD43-1043-8733-F82B55937457}"/>
          </ac:grpSpMkLst>
        </pc:grpChg>
        <pc:grpChg chg="del mod topLvl">
          <ac:chgData name="Wencai Zhang" userId="4a86a1d0-2108-4707-8228-1110f3c1be85" providerId="ADAL" clId="{46594FD8-AF25-D846-9BAA-39E14A4662C6}" dt="2021-09-14T14:27:07.500" v="2482" actId="478"/>
          <ac:grpSpMkLst>
            <pc:docMk/>
            <pc:sldMk cId="3998775946" sldId="283"/>
            <ac:grpSpMk id="193" creationId="{B28A1FD1-A220-654D-A3D3-A59446D3E45C}"/>
          </ac:grpSpMkLst>
        </pc:grpChg>
        <pc:grpChg chg="del mod topLvl">
          <ac:chgData name="Wencai Zhang" userId="4a86a1d0-2108-4707-8228-1110f3c1be85" providerId="ADAL" clId="{46594FD8-AF25-D846-9BAA-39E14A4662C6}" dt="2021-09-14T14:26:45.466" v="2481" actId="478"/>
          <ac:grpSpMkLst>
            <pc:docMk/>
            <pc:sldMk cId="3998775946" sldId="283"/>
            <ac:grpSpMk id="206" creationId="{1AE4CE81-DAC5-224C-8545-40891CE139FC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7" creationId="{AD9B821E-C422-E04A-A103-D3A5ED9BAAED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8" creationId="{73C4B178-CF0D-5C47-9FAC-E0CA86EFB7CA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0" creationId="{88DCF839-11FB-4343-BE18-49AD2DB34376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4" creationId="{7B7A8594-ADCC-6C45-AB93-BE6A34224418}"/>
          </ac:grpSpMkLst>
        </pc:grpChg>
        <pc:grpChg chg="del mod topLvl">
          <ac:chgData name="Wencai Zhang" userId="4a86a1d0-2108-4707-8228-1110f3c1be85" providerId="ADAL" clId="{46594FD8-AF25-D846-9BAA-39E14A4662C6}" dt="2021-09-14T20:29:49.723" v="3047" actId="165"/>
          <ac:grpSpMkLst>
            <pc:docMk/>
            <pc:sldMk cId="3998775946" sldId="283"/>
            <ac:grpSpMk id="229" creationId="{081F240A-0520-F947-946F-1B69E677B2E7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269" creationId="{FD380891-B898-D543-8E6E-B3F3612DA5EC}"/>
          </ac:grpSpMkLst>
        </pc:grpChg>
        <pc:grpChg chg="add mod">
          <ac:chgData name="Wencai Zhang" userId="4a86a1d0-2108-4707-8228-1110f3c1be85" providerId="ADAL" clId="{46594FD8-AF25-D846-9BAA-39E14A4662C6}" dt="2021-09-14T12:22:46.292" v="1283" actId="164"/>
          <ac:grpSpMkLst>
            <pc:docMk/>
            <pc:sldMk cId="3998775946" sldId="283"/>
            <ac:grpSpMk id="273" creationId="{0EBE9469-EE49-8B40-8266-360D1920018B}"/>
          </ac:grpSpMkLst>
        </pc:grpChg>
        <pc:graphicFrameChg chg="add del mod modGraphic">
          <ac:chgData name="Wencai Zhang" userId="4a86a1d0-2108-4707-8228-1110f3c1be85" providerId="ADAL" clId="{46594FD8-AF25-D846-9BAA-39E14A4662C6}" dt="2021-09-13T23:54:13.220" v="986" actId="478"/>
          <ac:graphicFrameMkLst>
            <pc:docMk/>
            <pc:sldMk cId="3998775946" sldId="283"/>
            <ac:graphicFrameMk id="28" creationId="{38E2C02C-E641-4C40-B52C-F397E33923F7}"/>
          </ac:graphicFrameMkLst>
        </pc:graphicFrameChg>
        <pc:picChg chg="mod">
          <ac:chgData name="Wencai Zhang" userId="4a86a1d0-2108-4707-8228-1110f3c1be85" providerId="ADAL" clId="{46594FD8-AF25-D846-9BAA-39E14A4662C6}" dt="2021-09-13T23:26:04.652" v="800" actId="1038"/>
          <ac:picMkLst>
            <pc:docMk/>
            <pc:sldMk cId="3998775946" sldId="283"/>
            <ac:picMk id="7" creationId="{D1FA5D13-4EDE-C142-A2DA-43A310FDCAD9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40" creationId="{5CFBCABC-16A3-9847-9416-3CD86F952992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5" creationId="{63F65AE1-44E9-354E-BE26-AA103449E57C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6" creationId="{BDB44C3F-FDD4-FE45-AC56-0381B726E574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7" creationId="{2CAC91D8-819A-3A43-9836-57CCE57CEE92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8" creationId="{35932F72-055A-784A-B589-B30EEFC75F1A}"/>
          </ac:picMkLst>
        </pc:picChg>
        <pc:picChg chg="mod">
          <ac:chgData name="Wencai Zhang" userId="4a86a1d0-2108-4707-8228-1110f3c1be85" providerId="ADAL" clId="{46594FD8-AF25-D846-9BAA-39E14A4662C6}" dt="2021-09-13T23:40:25.084" v="897" actId="1076"/>
          <ac:picMkLst>
            <pc:docMk/>
            <pc:sldMk cId="3998775946" sldId="283"/>
            <ac:picMk id="73" creationId="{FF18B9C0-2944-D04A-B17E-A6B77D598E85}"/>
          </ac:picMkLst>
        </pc:picChg>
        <pc:picChg chg="mod">
          <ac:chgData name="Wencai Zhang" userId="4a86a1d0-2108-4707-8228-1110f3c1be85" providerId="ADAL" clId="{46594FD8-AF25-D846-9BAA-39E14A4662C6}" dt="2021-09-13T23:40:33.023" v="898" actId="1076"/>
          <ac:picMkLst>
            <pc:docMk/>
            <pc:sldMk cId="3998775946" sldId="283"/>
            <ac:picMk id="74" creationId="{93A14D80-062C-FE40-8EA0-7EC5D5756F26}"/>
          </ac:picMkLst>
        </pc:picChg>
        <pc:picChg chg="mod">
          <ac:chgData name="Wencai Zhang" userId="4a86a1d0-2108-4707-8228-1110f3c1be85" providerId="ADAL" clId="{46594FD8-AF25-D846-9BAA-39E14A4662C6}" dt="2021-09-13T21:21:39.052" v="77" actId="165"/>
          <ac:picMkLst>
            <pc:docMk/>
            <pc:sldMk cId="3998775946" sldId="283"/>
            <ac:picMk id="75" creationId="{E62CEEFD-4CA1-864B-8692-4445BAA180CE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16" creationId="{842C16C1-2569-2B41-9BE7-A76C8801DE2F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46594FD8-AF25-D846-9BAA-39E14A4662C6}" dt="2021-09-14T13:13:37.137" v="1448" actId="732"/>
          <ac:picMkLst>
            <pc:docMk/>
            <pc:sldMk cId="3998775946" sldId="283"/>
            <ac:picMk id="124" creationId="{EE43A61C-6170-E24B-8AF5-77D6B46599E2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30" creationId="{65980DD0-A155-014F-ACE3-B39C7F3E2B32}"/>
          </ac:picMkLst>
        </pc:picChg>
        <pc:picChg chg="mod topLvl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143" creationId="{B4693310-C7E5-024B-8516-9417A988DDAB}"/>
          </ac:picMkLst>
        </pc:picChg>
        <pc:picChg chg="mod modCrop">
          <ac:chgData name="Wencai Zhang" userId="4a86a1d0-2108-4707-8228-1110f3c1be85" providerId="ADAL" clId="{46594FD8-AF25-D846-9BAA-39E14A4662C6}" dt="2021-09-14T13:44:20.776" v="1794" actId="732"/>
          <ac:picMkLst>
            <pc:docMk/>
            <pc:sldMk cId="3998775946" sldId="283"/>
            <ac:picMk id="150" creationId="{D5AB19CC-3D12-E641-AD09-16D58ADAEE64}"/>
          </ac:picMkLst>
        </pc:picChg>
        <pc:picChg chg="mod modCrop">
          <ac:chgData name="Wencai Zhang" userId="4a86a1d0-2108-4707-8228-1110f3c1be85" providerId="ADAL" clId="{46594FD8-AF25-D846-9BAA-39E14A4662C6}" dt="2021-09-14T13:36:55.682" v="1708" actId="732"/>
          <ac:picMkLst>
            <pc:docMk/>
            <pc:sldMk cId="3998775946" sldId="283"/>
            <ac:picMk id="156" creationId="{AFC9541E-22AC-6247-87F3-F8023E249043}"/>
          </ac:picMkLst>
        </pc:picChg>
        <pc:picChg chg="mod">
          <ac:chgData name="Wencai Zhang" userId="4a86a1d0-2108-4707-8228-1110f3c1be85" providerId="ADAL" clId="{46594FD8-AF25-D846-9BAA-39E14A4662C6}" dt="2021-09-14T00:09:26.713" v="1136" actId="165"/>
          <ac:picMkLst>
            <pc:docMk/>
            <pc:sldMk cId="3998775946" sldId="283"/>
            <ac:picMk id="161" creationId="{C2C57B83-5DBB-9C44-8647-89191A234E61}"/>
          </ac:picMkLst>
        </pc:picChg>
        <pc:picChg chg="mod modCrop">
          <ac:chgData name="Wencai Zhang" userId="4a86a1d0-2108-4707-8228-1110f3c1be85" providerId="ADAL" clId="{46594FD8-AF25-D846-9BAA-39E14A4662C6}" dt="2021-09-14T13:21:53.041" v="1549" actId="1076"/>
          <ac:picMkLst>
            <pc:docMk/>
            <pc:sldMk cId="3998775946" sldId="283"/>
            <ac:picMk id="166" creationId="{5DE39962-B321-8847-83CF-4797A1FEFE2C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192" creationId="{71CCA731-AEC4-324C-B904-1CFC513A08F9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231" creationId="{F554A9D2-829E-5A40-AE3F-524E7DA73D43}"/>
          </ac:picMkLst>
        </pc:picChg>
        <pc:picChg chg="mod topLvl modCrop">
          <ac:chgData name="Wencai Zhang" userId="4a86a1d0-2108-4707-8228-1110f3c1be85" providerId="ADAL" clId="{46594FD8-AF25-D846-9BAA-39E14A4662C6}" dt="2021-09-14T20:25:36.048" v="2935" actId="1076"/>
          <ac:picMkLst>
            <pc:docMk/>
            <pc:sldMk cId="3998775946" sldId="283"/>
            <ac:picMk id="247" creationId="{69702E48-531B-3148-BF07-B925212EC571}"/>
          </ac:picMkLst>
        </pc:picChg>
        <pc:picChg chg="mod topLvl modCrop">
          <ac:chgData name="Wencai Zhang" userId="4a86a1d0-2108-4707-8228-1110f3c1be85" providerId="ADAL" clId="{46594FD8-AF25-D846-9BAA-39E14A4662C6}" dt="2021-09-14T20:26:16.784" v="2969" actId="1076"/>
          <ac:picMkLst>
            <pc:docMk/>
            <pc:sldMk cId="3998775946" sldId="283"/>
            <ac:picMk id="248" creationId="{B98E97CD-7D34-9D42-8BF2-E7E62C9D628D}"/>
          </ac:picMkLst>
        </pc:picChg>
        <pc:picChg chg="mod topLvl">
          <ac:chgData name="Wencai Zhang" userId="4a86a1d0-2108-4707-8228-1110f3c1be85" providerId="ADAL" clId="{46594FD8-AF25-D846-9BAA-39E14A4662C6}" dt="2021-09-13T23:26:23.448" v="802" actId="1076"/>
          <ac:picMkLst>
            <pc:docMk/>
            <pc:sldMk cId="3998775946" sldId="283"/>
            <ac:picMk id="251" creationId="{F76FC1D9-9EC6-F64F-94E4-D200B2207C2B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55" creationId="{6C620D77-00EC-B64C-8F91-2C86BE3F5E02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1" creationId="{75DDD74C-06B1-914F-95C5-0D495A06B57C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2" creationId="{4BD3F89D-5639-6A41-ACBE-74033AE2CD4B}"/>
          </ac:picMkLst>
        </pc:picChg>
        <pc:picChg chg="add mod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82" creationId="{18DA0EF1-2FF2-7E4F-BC2F-2D99611BBAE6}"/>
          </ac:picMkLst>
        </pc:picChg>
        <pc:picChg chg="add mod modCrop">
          <ac:chgData name="Wencai Zhang" userId="4a86a1d0-2108-4707-8228-1110f3c1be85" providerId="ADAL" clId="{46594FD8-AF25-D846-9BAA-39E14A4662C6}" dt="2021-09-14T13:22:44.410" v="1558" actId="164"/>
          <ac:picMkLst>
            <pc:docMk/>
            <pc:sldMk cId="3998775946" sldId="283"/>
            <ac:picMk id="287" creationId="{14376114-6756-8944-B63C-82DAE34734B6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292" creationId="{A1795917-6CAB-294C-9F2B-310E5BA86DE7}"/>
          </ac:picMkLst>
        </pc:picChg>
        <pc:picChg chg="add mod modCrop">
          <ac:chgData name="Wencai Zhang" userId="4a86a1d0-2108-4707-8228-1110f3c1be85" providerId="ADAL" clId="{46594FD8-AF25-D846-9BAA-39E14A4662C6}" dt="2021-09-14T13:24:44.301" v="1595" actId="1076"/>
          <ac:picMkLst>
            <pc:docMk/>
            <pc:sldMk cId="3998775946" sldId="283"/>
            <ac:picMk id="295" creationId="{251A0F80-8D82-2245-9504-A3FA76583FEC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18" creationId="{37AA4BFA-EF24-B240-B9DD-1675C3688EE3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3" creationId="{EE36942F-7CEC-DD41-BE75-CCDD77DF75DB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8" creationId="{0B58CBAA-3E9F-6140-8558-409BCB7DFAC6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0" creationId="{838D67ED-3CFF-0145-9C1D-AF09670DB68A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2" creationId="{A1680779-27D2-E74B-B95A-4C0856377508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46" creationId="{63DE2182-CB52-B448-8FA7-2E6A4B6547BD}"/>
          </ac:picMkLst>
        </pc:picChg>
        <pc:cxnChg chg="add del mod">
          <ac:chgData name="Wencai Zhang" userId="4a86a1d0-2108-4707-8228-1110f3c1be85" providerId="ADAL" clId="{46594FD8-AF25-D846-9BAA-39E14A4662C6}" dt="2021-09-13T23:52:52.258" v="980" actId="478"/>
          <ac:cxnSpMkLst>
            <pc:docMk/>
            <pc:sldMk cId="3998775946" sldId="283"/>
            <ac:cxnSpMk id="27" creationId="{9DF6DD43-A991-2440-A044-4F6E2AE86676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46594FD8-AF25-D846-9BAA-39E14A4662C6}" dt="2021-09-14T00:02:35.441" v="1033" actId="478"/>
          <ac:cxnSpMkLst>
            <pc:docMk/>
            <pc:sldMk cId="3998775946" sldId="283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46594FD8-AF25-D846-9BAA-39E14A4662C6}" dt="2021-09-14T00:00:28.757" v="1022" actId="478"/>
          <ac:cxnSpMkLst>
            <pc:docMk/>
            <pc:sldMk cId="3998775946" sldId="283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46594FD8-AF25-D846-9BAA-39E14A4662C6}" dt="2021-09-14T00:00:36.257" v="1025" actId="478"/>
          <ac:cxnSpMkLst>
            <pc:docMk/>
            <pc:sldMk cId="3998775946" sldId="283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46594FD8-AF25-D846-9BAA-39E14A4662C6}" dt="2021-09-14T14:35:35.286" v="2648" actId="1036"/>
          <ac:cxnSpMkLst>
            <pc:docMk/>
            <pc:sldMk cId="3998775946" sldId="283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46594FD8-AF25-D846-9BAA-39E14A4662C6}" dt="2021-09-14T14:27:25.159" v="2483" actId="164"/>
          <ac:cxnSpMkLst>
            <pc:docMk/>
            <pc:sldMk cId="3998775946" sldId="283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46594FD8-AF25-D846-9BAA-39E14A4662C6}" dt="2021-09-14T14:32:53.376" v="2550" actId="1037"/>
          <ac:cxnSpMkLst>
            <pc:docMk/>
            <pc:sldMk cId="3998775946" sldId="283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8" creationId="{258DFB78-793C-854F-877B-B462DDCB44FD}"/>
          </ac:cxnSpMkLst>
        </pc:cxnChg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Wencai Zhang" userId="4a86a1d0-2108-4707-8228-1110f3c1be85" providerId="ADAL" clId="{466F9609-92B5-CA44-9207-17EC6325917A}"/>
    <pc:docChg chg="custSel modSld">
      <pc:chgData name="Wencai Zhang" userId="4a86a1d0-2108-4707-8228-1110f3c1be85" providerId="ADAL" clId="{466F9609-92B5-CA44-9207-17EC6325917A}" dt="2022-04-19T19:51:07.877" v="28" actId="478"/>
      <pc:docMkLst>
        <pc:docMk/>
      </pc:docMkLst>
      <pc:sldChg chg="addSp delSp modSp">
        <pc:chgData name="Wencai Zhang" userId="4a86a1d0-2108-4707-8228-1110f3c1be85" providerId="ADAL" clId="{466F9609-92B5-CA44-9207-17EC6325917A}" dt="2022-04-19T19:51:07.877" v="28" actId="478"/>
        <pc:sldMkLst>
          <pc:docMk/>
          <pc:sldMk cId="3998775946" sldId="283"/>
        </pc:sldMkLst>
        <pc:spChg chg="del">
          <ac:chgData name="Wencai Zhang" userId="4a86a1d0-2108-4707-8228-1110f3c1be85" providerId="ADAL" clId="{466F9609-92B5-CA44-9207-17EC6325917A}" dt="2022-04-19T19:51:07.877" v="28" actId="478"/>
          <ac:spMkLst>
            <pc:docMk/>
            <pc:sldMk cId="3998775946" sldId="283"/>
            <ac:spMk id="69" creationId="{1B56E517-81CF-064C-95B9-BB828A0B3D29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71" creationId="{9B63982C-9423-B641-9499-4AB2C87BF98E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7" creationId="{4D7D491B-105C-3644-A0BA-ADE10712D27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9" creationId="{A42F0D0B-74D9-E94C-91E7-AD51A2B55DD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0" creationId="{954D13E6-38B5-734A-A1A7-6C11C73CF015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5" creationId="{8D326B54-6FC1-6B43-B24F-103C48CE56A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6" creationId="{962912CF-932F-3B4E-A328-17538F9CB7A9}"/>
          </ac:spMkLst>
        </pc:spChg>
        <pc:grpChg chg="mod">
          <ac:chgData name="Wencai Zhang" userId="4a86a1d0-2108-4707-8228-1110f3c1be85" providerId="ADAL" clId="{466F9609-92B5-CA44-9207-17EC6325917A}" dt="2022-04-14T18:12:41.715" v="26" actId="1038"/>
          <ac:grpSpMkLst>
            <pc:docMk/>
            <pc:sldMk cId="3998775946" sldId="283"/>
            <ac:grpSpMk id="12" creationId="{9375FF98-CCE2-AF4B-93D1-850D44D144F7}"/>
          </ac:grpSpMkLst>
        </pc:grpChg>
        <pc:picChg chg="add mod">
          <ac:chgData name="Wencai Zhang" userId="4a86a1d0-2108-4707-8228-1110f3c1be85" providerId="ADAL" clId="{466F9609-92B5-CA44-9207-17EC6325917A}" dt="2022-04-14T18:12:48.690" v="27" actId="1076"/>
          <ac:picMkLst>
            <pc:docMk/>
            <pc:sldMk cId="3998775946" sldId="283"/>
            <ac:picMk id="7" creationId="{4E9CACB6-C4AB-7740-BBFF-7B28DE099420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3" creationId="{3F3452F0-C951-384B-AB8D-7B41DE8D0F93}"/>
          </ac:picMkLst>
        </pc:picChg>
      </pc:sldChg>
    </pc:docChg>
  </pc:docChgLst>
  <pc:docChgLst>
    <pc:chgData name="Wencai Zhang" userId="4a86a1d0-2108-4707-8228-1110f3c1be85" providerId="ADAL" clId="{1BBB9177-4005-5540-B885-43DD27640C07}"/>
    <pc:docChg chg="undo custSel addSld modSld sldOrd">
      <pc:chgData name="Wencai Zhang" userId="4a86a1d0-2108-4707-8228-1110f3c1be85" providerId="ADAL" clId="{1BBB9177-4005-5540-B885-43DD27640C07}" dt="2022-04-21T00:48:43.328" v="3132" actId="20578"/>
      <pc:docMkLst>
        <pc:docMk/>
      </pc:docMkLst>
      <pc:sldChg chg="addSp delSp modSp mod">
        <pc:chgData name="Wencai Zhang" userId="4a86a1d0-2108-4707-8228-1110f3c1be85" providerId="ADAL" clId="{1BBB9177-4005-5540-B885-43DD27640C07}" dt="2022-04-21T00:30:35.519" v="2131" actId="1035"/>
        <pc:sldMkLst>
          <pc:docMk/>
          <pc:sldMk cId="3998775946" sldId="283"/>
        </pc:sldMkLst>
        <pc:spChg chg="mod">
          <ac:chgData name="Wencai Zhang" userId="4a86a1d0-2108-4707-8228-1110f3c1be85" providerId="ADAL" clId="{1BBB9177-4005-5540-B885-43DD27640C07}" dt="2022-04-20T23:41:28.741" v="236" actId="1038"/>
          <ac:spMkLst>
            <pc:docMk/>
            <pc:sldMk cId="3998775946" sldId="283"/>
            <ac:spMk id="11" creationId="{61353381-AC7D-E848-A714-0811467522BE}"/>
          </ac:spMkLst>
        </pc:spChg>
        <pc:spChg chg="mod">
          <ac:chgData name="Wencai Zhang" userId="4a86a1d0-2108-4707-8228-1110f3c1be85" providerId="ADAL" clId="{1BBB9177-4005-5540-B885-43DD27640C07}" dt="2022-04-20T23:47:40.913" v="680" actId="1037"/>
          <ac:spMkLst>
            <pc:docMk/>
            <pc:sldMk cId="3998775946" sldId="283"/>
            <ac:spMk id="24" creationId="{0743C9DB-C2C3-4D68-9AC6-CC11265D5C66}"/>
          </ac:spMkLst>
        </pc:spChg>
        <pc:spChg chg="mod">
          <ac:chgData name="Wencai Zhang" userId="4a86a1d0-2108-4707-8228-1110f3c1be85" providerId="ADAL" clId="{1BBB9177-4005-5540-B885-43DD27640C07}" dt="2022-04-20T23:47:13.500" v="678" actId="1037"/>
          <ac:spMkLst>
            <pc:docMk/>
            <pc:sldMk cId="3998775946" sldId="283"/>
            <ac:spMk id="32" creationId="{E7D8A89C-5DD3-434D-B0F9-4FFE362E8493}"/>
          </ac:spMkLst>
        </pc:spChg>
        <pc:spChg chg="mod">
          <ac:chgData name="Wencai Zhang" userId="4a86a1d0-2108-4707-8228-1110f3c1be85" providerId="ADAL" clId="{1BBB9177-4005-5540-B885-43DD27640C07}" dt="2022-04-20T23:47:08.465" v="674" actId="1037"/>
          <ac:spMkLst>
            <pc:docMk/>
            <pc:sldMk cId="3998775946" sldId="283"/>
            <ac:spMk id="33" creationId="{AD8D757C-C30A-EB43-B121-3175844E2FA4}"/>
          </ac:spMkLst>
        </pc:spChg>
        <pc:spChg chg="del">
          <ac:chgData name="Wencai Zhang" userId="4a86a1d0-2108-4707-8228-1110f3c1be85" providerId="ADAL" clId="{1BBB9177-4005-5540-B885-43DD27640C07}" dt="2022-04-20T23:48:36.352" v="703" actId="478"/>
          <ac:spMkLst>
            <pc:docMk/>
            <pc:sldMk cId="3998775946" sldId="283"/>
            <ac:spMk id="59" creationId="{EB44D005-E90D-074C-AD4E-F55FC9DDD341}"/>
          </ac:spMkLst>
        </pc:spChg>
        <pc:spChg chg="del">
          <ac:chgData name="Wencai Zhang" userId="4a86a1d0-2108-4707-8228-1110f3c1be85" providerId="ADAL" clId="{1BBB9177-4005-5540-B885-43DD27640C07}" dt="2022-04-20T23:44:52.289" v="389" actId="478"/>
          <ac:spMkLst>
            <pc:docMk/>
            <pc:sldMk cId="3998775946" sldId="283"/>
            <ac:spMk id="61" creationId="{83D4EDD7-402D-C44E-8C12-80E5C60B6F18}"/>
          </ac:spMkLst>
        </pc:spChg>
        <pc:spChg chg="del">
          <ac:chgData name="Wencai Zhang" userId="4a86a1d0-2108-4707-8228-1110f3c1be85" providerId="ADAL" clId="{1BBB9177-4005-5540-B885-43DD27640C07}" dt="2022-04-20T23:44:39.359" v="370" actId="478"/>
          <ac:spMkLst>
            <pc:docMk/>
            <pc:sldMk cId="3998775946" sldId="283"/>
            <ac:spMk id="62" creationId="{1E261997-15B1-5B47-9CD8-5196E34E590B}"/>
          </ac:spMkLst>
        </pc:spChg>
        <pc:spChg chg="del">
          <ac:chgData name="Wencai Zhang" userId="4a86a1d0-2108-4707-8228-1110f3c1be85" providerId="ADAL" clId="{1BBB9177-4005-5540-B885-43DD27640C07}" dt="2022-04-20T23:45:25.772" v="466" actId="478"/>
          <ac:spMkLst>
            <pc:docMk/>
            <pc:sldMk cId="3998775946" sldId="283"/>
            <ac:spMk id="65" creationId="{3DFB711B-8B90-1240-B6A8-D19F09136C23}"/>
          </ac:spMkLst>
        </pc:spChg>
        <pc:spChg chg="del mod">
          <ac:chgData name="Wencai Zhang" userId="4a86a1d0-2108-4707-8228-1110f3c1be85" providerId="ADAL" clId="{1BBB9177-4005-5540-B885-43DD27640C07}" dt="2022-04-20T23:45:31.649" v="469" actId="478"/>
          <ac:spMkLst>
            <pc:docMk/>
            <pc:sldMk cId="3998775946" sldId="283"/>
            <ac:spMk id="66" creationId="{FF517956-7D11-5045-BAB3-D0FBDAA68E18}"/>
          </ac:spMkLst>
        </pc:spChg>
        <pc:spChg chg="mod">
          <ac:chgData name="Wencai Zhang" userId="4a86a1d0-2108-4707-8228-1110f3c1be85" providerId="ADAL" clId="{1BBB9177-4005-5540-B885-43DD27640C07}" dt="2022-04-20T23:42:23.762" v="291" actId="1037"/>
          <ac:spMkLst>
            <pc:docMk/>
            <pc:sldMk cId="3998775946" sldId="283"/>
            <ac:spMk id="71" creationId="{9B63982C-9423-B641-9499-4AB2C87BF98E}"/>
          </ac:spMkLst>
        </pc:spChg>
        <pc:spChg chg="add del mod">
          <ac:chgData name="Wencai Zhang" userId="4a86a1d0-2108-4707-8228-1110f3c1be85" providerId="ADAL" clId="{1BBB9177-4005-5540-B885-43DD27640C07}" dt="2022-04-21T00:17:16.288" v="1562" actId="478"/>
          <ac:spMkLst>
            <pc:docMk/>
            <pc:sldMk cId="3998775946" sldId="283"/>
            <ac:spMk id="108" creationId="{6FAEC1F7-A983-A54A-AE8F-94753F3B62FF}"/>
          </ac:spMkLst>
        </pc:spChg>
        <pc:spChg chg="del">
          <ac:chgData name="Wencai Zhang" userId="4a86a1d0-2108-4707-8228-1110f3c1be85" providerId="ADAL" clId="{1BBB9177-4005-5540-B885-43DD27640C07}" dt="2022-04-21T00:13:50.580" v="1391" actId="478"/>
          <ac:spMkLst>
            <pc:docMk/>
            <pc:sldMk cId="3998775946" sldId="283"/>
            <ac:spMk id="115" creationId="{CF6CD96D-1E3B-2648-B127-72770E0C05BE}"/>
          </ac:spMkLst>
        </pc:spChg>
        <pc:spChg chg="del">
          <ac:chgData name="Wencai Zhang" userId="4a86a1d0-2108-4707-8228-1110f3c1be85" providerId="ADAL" clId="{1BBB9177-4005-5540-B885-43DD27640C07}" dt="2022-04-21T00:13:57.525" v="1394" actId="478"/>
          <ac:spMkLst>
            <pc:docMk/>
            <pc:sldMk cId="3998775946" sldId="283"/>
            <ac:spMk id="120" creationId="{2C4FD043-317B-A949-B9FD-AFD5D529F261}"/>
          </ac:spMkLst>
        </pc:spChg>
        <pc:spChg chg="del">
          <ac:chgData name="Wencai Zhang" userId="4a86a1d0-2108-4707-8228-1110f3c1be85" providerId="ADAL" clId="{1BBB9177-4005-5540-B885-43DD27640C07}" dt="2022-04-21T00:13:43.177" v="1388" actId="478"/>
          <ac:spMkLst>
            <pc:docMk/>
            <pc:sldMk cId="3998775946" sldId="283"/>
            <ac:spMk id="126" creationId="{3B37581F-4FE7-2044-848A-A0B20CF5AF9F}"/>
          </ac:spMkLst>
        </pc:spChg>
        <pc:spChg chg="del mod">
          <ac:chgData name="Wencai Zhang" userId="4a86a1d0-2108-4707-8228-1110f3c1be85" providerId="ADAL" clId="{1BBB9177-4005-5540-B885-43DD27640C07}" dt="2022-04-21T00:14:39.457" v="1462" actId="478"/>
          <ac:spMkLst>
            <pc:docMk/>
            <pc:sldMk cId="3998775946" sldId="283"/>
            <ac:spMk id="128" creationId="{5E907FC5-52AF-4643-9EC3-69405E989E4E}"/>
          </ac:spMkLst>
        </pc:spChg>
        <pc:spChg chg="del">
          <ac:chgData name="Wencai Zhang" userId="4a86a1d0-2108-4707-8228-1110f3c1be85" providerId="ADAL" clId="{1BBB9177-4005-5540-B885-43DD27640C07}" dt="2022-04-21T00:13:55.328" v="1393" actId="478"/>
          <ac:spMkLst>
            <pc:docMk/>
            <pc:sldMk cId="3998775946" sldId="283"/>
            <ac:spMk id="132" creationId="{3DF5FE96-AD62-ED4E-91F2-27C62CC21035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164" creationId="{82DBD88E-2361-4D44-B048-37A892383F0A}"/>
          </ac:spMkLst>
        </pc:spChg>
        <pc:spChg chg="del">
          <ac:chgData name="Wencai Zhang" userId="4a86a1d0-2108-4707-8228-1110f3c1be85" providerId="ADAL" clId="{1BBB9177-4005-5540-B885-43DD27640C07}" dt="2022-04-21T00:08:10.421" v="1252" actId="478"/>
          <ac:spMkLst>
            <pc:docMk/>
            <pc:sldMk cId="3998775946" sldId="283"/>
            <ac:spMk id="165" creationId="{73FD3E4E-E4E8-454A-BCEB-B1A1CDF3702F}"/>
          </ac:spMkLst>
        </pc:spChg>
        <pc:spChg chg="mod">
          <ac:chgData name="Wencai Zhang" userId="4a86a1d0-2108-4707-8228-1110f3c1be85" providerId="ADAL" clId="{1BBB9177-4005-5540-B885-43DD27640C07}" dt="2022-04-21T00:18:48.989" v="1645" actId="1038"/>
          <ac:spMkLst>
            <pc:docMk/>
            <pc:sldMk cId="3998775946" sldId="283"/>
            <ac:spMk id="173" creationId="{E6F050D7-3FB5-B84C-A0A4-13CC5032B4BD}"/>
          </ac:spMkLst>
        </pc:spChg>
        <pc:spChg chg="mod">
          <ac:chgData name="Wencai Zhang" userId="4a86a1d0-2108-4707-8228-1110f3c1be85" providerId="ADAL" clId="{1BBB9177-4005-5540-B885-43DD27640C07}" dt="2022-04-21T00:19:10.582" v="1662" actId="1037"/>
          <ac:spMkLst>
            <pc:docMk/>
            <pc:sldMk cId="3998775946" sldId="283"/>
            <ac:spMk id="174" creationId="{772C2F64-D0CB-794D-A688-AE5D87C04FC4}"/>
          </ac:spMkLst>
        </pc:spChg>
        <pc:spChg chg="del">
          <ac:chgData name="Wencai Zhang" userId="4a86a1d0-2108-4707-8228-1110f3c1be85" providerId="ADAL" clId="{1BBB9177-4005-5540-B885-43DD27640C07}" dt="2022-04-21T00:13:52.875" v="1392" actId="478"/>
          <ac:spMkLst>
            <pc:docMk/>
            <pc:sldMk cId="3998775946" sldId="283"/>
            <ac:spMk id="181" creationId="{4A10CFC8-E628-1345-9CC9-1E154CC7592B}"/>
          </ac:spMkLst>
        </pc:spChg>
        <pc:spChg chg="del">
          <ac:chgData name="Wencai Zhang" userId="4a86a1d0-2108-4707-8228-1110f3c1be85" providerId="ADAL" clId="{1BBB9177-4005-5540-B885-43DD27640C07}" dt="2022-04-21T00:25:50.793" v="1892" actId="478"/>
          <ac:spMkLst>
            <pc:docMk/>
            <pc:sldMk cId="3998775946" sldId="283"/>
            <ac:spMk id="230" creationId="{CCF939D2-A404-3D4A-8F4A-5AF08A395C1F}"/>
          </ac:spMkLst>
        </pc:spChg>
        <pc:spChg chg="mod">
          <ac:chgData name="Wencai Zhang" userId="4a86a1d0-2108-4707-8228-1110f3c1be85" providerId="ADAL" clId="{1BBB9177-4005-5540-B885-43DD27640C07}" dt="2022-04-21T00:27:01.345" v="1989" actId="1035"/>
          <ac:spMkLst>
            <pc:docMk/>
            <pc:sldMk cId="3998775946" sldId="283"/>
            <ac:spMk id="236" creationId="{6600A3DD-2531-D849-AF84-78DC1C920A61}"/>
          </ac:spMkLst>
        </pc:spChg>
        <pc:spChg chg="del">
          <ac:chgData name="Wencai Zhang" userId="4a86a1d0-2108-4707-8228-1110f3c1be85" providerId="ADAL" clId="{1BBB9177-4005-5540-B885-43DD27640C07}" dt="2022-04-21T00:25:53.360" v="1893" actId="478"/>
          <ac:spMkLst>
            <pc:docMk/>
            <pc:sldMk cId="3998775946" sldId="283"/>
            <ac:spMk id="238" creationId="{464C8492-EDEF-994E-83AC-252A679BC9CB}"/>
          </ac:spMkLst>
        </pc:spChg>
        <pc:spChg chg="mod">
          <ac:chgData name="Wencai Zhang" userId="4a86a1d0-2108-4707-8228-1110f3c1be85" providerId="ADAL" clId="{1BBB9177-4005-5540-B885-43DD27640C07}" dt="2022-04-21T00:26:55.304" v="1985" actId="1035"/>
          <ac:spMkLst>
            <pc:docMk/>
            <pc:sldMk cId="3998775946" sldId="283"/>
            <ac:spMk id="239" creationId="{57252B6C-EA1C-2849-A41E-B14B57B362DA}"/>
          </ac:spMkLst>
        </pc:spChg>
        <pc:spChg chg="del">
          <ac:chgData name="Wencai Zhang" userId="4a86a1d0-2108-4707-8228-1110f3c1be85" providerId="ADAL" clId="{1BBB9177-4005-5540-B885-43DD27640C07}" dt="2022-04-21T00:24:16.714" v="1830" actId="478"/>
          <ac:spMkLst>
            <pc:docMk/>
            <pc:sldMk cId="3998775946" sldId="283"/>
            <ac:spMk id="243" creationId="{2BE5FD5F-9D67-4C49-9CA4-E1DE27758C21}"/>
          </ac:spMkLst>
        </pc:spChg>
        <pc:spChg chg="del">
          <ac:chgData name="Wencai Zhang" userId="4a86a1d0-2108-4707-8228-1110f3c1be85" providerId="ADAL" clId="{1BBB9177-4005-5540-B885-43DD27640C07}" dt="2022-04-21T00:24:14.204" v="1829" actId="478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1BBB9177-4005-5540-B885-43DD27640C07}" dt="2022-04-21T00:25:45.306" v="1891" actId="1036"/>
          <ac:spMkLst>
            <pc:docMk/>
            <pc:sldMk cId="3998775946" sldId="283"/>
            <ac:spMk id="246" creationId="{CC32910A-38D6-C84A-B308-3FBD60C2D445}"/>
          </ac:spMkLst>
        </pc:spChg>
        <pc:spChg chg="add mod">
          <ac:chgData name="Wencai Zhang" userId="4a86a1d0-2108-4707-8228-1110f3c1be85" providerId="ADAL" clId="{1BBB9177-4005-5540-B885-43DD27640C07}" dt="2022-04-20T23:40:14.800" v="149" actId="1076"/>
          <ac:spMkLst>
            <pc:docMk/>
            <pc:sldMk cId="3998775946" sldId="283"/>
            <ac:spMk id="248" creationId="{68F4B79A-B9D0-DE43-BCE3-4BCA7B21BF8B}"/>
          </ac:spMkLst>
        </pc:spChg>
        <pc:spChg chg="del">
          <ac:chgData name="Wencai Zhang" userId="4a86a1d0-2108-4707-8228-1110f3c1be85" providerId="ADAL" clId="{1BBB9177-4005-5540-B885-43DD27640C07}" dt="2022-04-20T23:52:12.708" v="742" actId="478"/>
          <ac:spMkLst>
            <pc:docMk/>
            <pc:sldMk cId="3998775946" sldId="283"/>
            <ac:spMk id="249" creationId="{0D04BF5E-F2F2-BF4E-9DA9-CA33764EBD18}"/>
          </ac:spMkLst>
        </pc:spChg>
        <pc:spChg chg="del">
          <ac:chgData name="Wencai Zhang" userId="4a86a1d0-2108-4707-8228-1110f3c1be85" providerId="ADAL" clId="{1BBB9177-4005-5540-B885-43DD27640C07}" dt="2022-04-20T23:51:43.336" v="718" actId="478"/>
          <ac:spMkLst>
            <pc:docMk/>
            <pc:sldMk cId="3998775946" sldId="283"/>
            <ac:spMk id="250" creationId="{1B0541EF-233E-7449-BC03-18AE62F15A5A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1BBB9177-4005-5540-B885-43DD27640C07}" dt="2022-04-20T23:46:48.848" v="656" actId="1037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7" creationId="{4D7D491B-105C-3644-A0BA-ADE10712D27F}"/>
          </ac:spMkLst>
        </pc:spChg>
        <pc:spChg chg="del mod">
          <ac:chgData name="Wencai Zhang" userId="4a86a1d0-2108-4707-8228-1110f3c1be85" providerId="ADAL" clId="{1BBB9177-4005-5540-B885-43DD27640C07}" dt="2022-04-20T23:45:53.852" v="496" actId="47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1BBB9177-4005-5540-B885-43DD27640C07}" dt="2022-04-20T23:46:36.207" v="650" actId="1035"/>
          <ac:spMkLst>
            <pc:docMk/>
            <pc:sldMk cId="3998775946" sldId="283"/>
            <ac:spMk id="259" creationId="{A42F0D0B-74D9-E94C-91E7-AD51A2B55DDF}"/>
          </ac:spMkLst>
        </pc:spChg>
        <pc:spChg chg="del mod">
          <ac:chgData name="Wencai Zhang" userId="4a86a1d0-2108-4707-8228-1110f3c1be85" providerId="ADAL" clId="{1BBB9177-4005-5540-B885-43DD27640C07}" dt="2022-04-20T23:45:56.872" v="497" actId="478"/>
          <ac:spMkLst>
            <pc:docMk/>
            <pc:sldMk cId="3998775946" sldId="283"/>
            <ac:spMk id="260" creationId="{954D13E6-38B5-734A-A1A7-6C11C73CF015}"/>
          </ac:spMkLst>
        </pc:spChg>
        <pc:spChg chg="del">
          <ac:chgData name="Wencai Zhang" userId="4a86a1d0-2108-4707-8228-1110f3c1be85" providerId="ADAL" clId="{1BBB9177-4005-5540-B885-43DD27640C07}" dt="2022-04-20T23:52:10.218" v="741" actId="478"/>
          <ac:spMkLst>
            <pc:docMk/>
            <pc:sldMk cId="3998775946" sldId="283"/>
            <ac:spMk id="261" creationId="{98F5C952-E2B9-0D48-AD1C-D1C114FAF6F8}"/>
          </ac:spMkLst>
        </pc:spChg>
        <pc:spChg chg="del">
          <ac:chgData name="Wencai Zhang" userId="4a86a1d0-2108-4707-8228-1110f3c1be85" providerId="ADAL" clId="{1BBB9177-4005-5540-B885-43DD27640C07}" dt="2022-04-20T23:51:46.391" v="719" actId="478"/>
          <ac:spMkLst>
            <pc:docMk/>
            <pc:sldMk cId="3998775946" sldId="283"/>
            <ac:spMk id="262" creationId="{E7FC0D5A-10ED-1648-9EC1-AB84F340CFC8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0T23:41:58.757" v="268" actId="1038"/>
          <ac:spMkLst>
            <pc:docMk/>
            <pc:sldMk cId="3998775946" sldId="283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5" creationId="{8D326B54-6FC1-6B43-B24F-103C48CE56A4}"/>
          </ac:spMkLst>
        </pc:spChg>
        <pc:spChg chg="del mod">
          <ac:chgData name="Wencai Zhang" userId="4a86a1d0-2108-4707-8228-1110f3c1be85" providerId="ADAL" clId="{1BBB9177-4005-5540-B885-43DD27640C07}" dt="2022-04-20T23:40:09.462" v="147" actId="21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7" creationId="{056AEB35-6CD1-854E-9F57-E131C2E4DB9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8" creationId="{2F51DBAE-15F0-8940-9FF5-E2FD05424FFE}"/>
          </ac:spMkLst>
        </pc:spChg>
        <pc:spChg chg="mod">
          <ac:chgData name="Wencai Zhang" userId="4a86a1d0-2108-4707-8228-1110f3c1be85" providerId="ADAL" clId="{1BBB9177-4005-5540-B885-43DD27640C07}" dt="2022-04-21T00:18:14.615" v="1606" actId="1038"/>
          <ac:spMkLst>
            <pc:docMk/>
            <pc:sldMk cId="3998775946" sldId="283"/>
            <ac:spMk id="279" creationId="{8E7B3E58-D522-CD4C-88FF-8419878B1277}"/>
          </ac:spMkLst>
        </pc:spChg>
        <pc:spChg chg="mod">
          <ac:chgData name="Wencai Zhang" userId="4a86a1d0-2108-4707-8228-1110f3c1be85" providerId="ADAL" clId="{1BBB9177-4005-5540-B885-43DD27640C07}" dt="2022-04-20T23:53:36.844" v="783" actId="1037"/>
          <ac:spMkLst>
            <pc:docMk/>
            <pc:sldMk cId="3998775946" sldId="283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0T23:53:28.826" v="776" actId="1037"/>
          <ac:spMkLst>
            <pc:docMk/>
            <pc:sldMk cId="3998775946" sldId="283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0T23:53:33.028" v="780" actId="1037"/>
          <ac:spMkLst>
            <pc:docMk/>
            <pc:sldMk cId="3998775946" sldId="283"/>
            <ac:spMk id="283" creationId="{B5314342-C516-DC41-BC08-CBFC2A6AEDC5}"/>
          </ac:spMkLst>
        </pc:spChg>
        <pc:spChg chg="del">
          <ac:chgData name="Wencai Zhang" userId="4a86a1d0-2108-4707-8228-1110f3c1be85" providerId="ADAL" clId="{1BBB9177-4005-5540-B885-43DD27640C07}" dt="2022-04-21T00:13:45.293" v="1389" actId="478"/>
          <ac:spMkLst>
            <pc:docMk/>
            <pc:sldMk cId="3998775946" sldId="283"/>
            <ac:spMk id="285" creationId="{A92A19F7-BAB0-7E4F-A263-4555C5BD8FF0}"/>
          </ac:spMkLst>
        </pc:spChg>
        <pc:spChg chg="mod">
          <ac:chgData name="Wencai Zhang" userId="4a86a1d0-2108-4707-8228-1110f3c1be85" providerId="ADAL" clId="{1BBB9177-4005-5540-B885-43DD27640C07}" dt="2022-04-20T23:54:27.359" v="841" actId="1037"/>
          <ac:spMkLst>
            <pc:docMk/>
            <pc:sldMk cId="3998775946" sldId="283"/>
            <ac:spMk id="286" creationId="{5A0F809E-FEC4-1F49-8973-FC476EE7A8CE}"/>
          </ac:spMkLst>
        </pc:spChg>
        <pc:spChg chg="del">
          <ac:chgData name="Wencai Zhang" userId="4a86a1d0-2108-4707-8228-1110f3c1be85" providerId="ADAL" clId="{1BBB9177-4005-5540-B885-43DD27640C07}" dt="2022-04-21T00:14:42.662" v="1463" actId="478"/>
          <ac:spMkLst>
            <pc:docMk/>
            <pc:sldMk cId="3998775946" sldId="283"/>
            <ac:spMk id="289" creationId="{E59D94A3-A775-B24F-8FC5-035B9DB0D9FB}"/>
          </ac:spMkLst>
        </pc:spChg>
        <pc:spChg chg="del">
          <ac:chgData name="Wencai Zhang" userId="4a86a1d0-2108-4707-8228-1110f3c1be85" providerId="ADAL" clId="{1BBB9177-4005-5540-B885-43DD27640C07}" dt="2022-04-20T23:52:15.164" v="743" actId="478"/>
          <ac:spMkLst>
            <pc:docMk/>
            <pc:sldMk cId="3998775946" sldId="283"/>
            <ac:spMk id="290" creationId="{B5E20232-D96E-C74F-9D1C-C364E48F8884}"/>
          </ac:spMkLst>
        </pc:spChg>
        <pc:spChg chg="del">
          <ac:chgData name="Wencai Zhang" userId="4a86a1d0-2108-4707-8228-1110f3c1be85" providerId="ADAL" clId="{1BBB9177-4005-5540-B885-43DD27640C07}" dt="2022-04-20T23:51:49.635" v="720" actId="478"/>
          <ac:spMkLst>
            <pc:docMk/>
            <pc:sldMk cId="3998775946" sldId="283"/>
            <ac:spMk id="291" creationId="{94E0EC7B-B24B-8F4A-A482-8E007D3421BE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4" creationId="{037C4275-0158-B648-AD5A-343C7F0CFD76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6" creationId="{C34326C3-DEEF-614A-BC94-D8645503AE4D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7" creationId="{195EBFE9-EA5E-7545-9593-7991C52234DF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299" creationId="{8DA3FE05-31A9-2048-9C98-C3FC0ED79136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0" creationId="{5EFEA7F4-8CCB-9B49-9C0D-DD160F828755}"/>
          </ac:spMkLst>
        </pc:spChg>
        <pc:spChg chg="del">
          <ac:chgData name="Wencai Zhang" userId="4a86a1d0-2108-4707-8228-1110f3c1be85" providerId="ADAL" clId="{1BBB9177-4005-5540-B885-43DD27640C07}" dt="2022-04-21T00:08:13.107" v="1253" actId="478"/>
          <ac:spMkLst>
            <pc:docMk/>
            <pc:sldMk cId="3998775946" sldId="283"/>
            <ac:spMk id="301" creationId="{47AF706E-6473-7D48-9E88-CB4346B5D1C9}"/>
          </ac:spMkLst>
        </pc:spChg>
        <pc:spChg chg="del mod">
          <ac:chgData name="Wencai Zhang" userId="4a86a1d0-2108-4707-8228-1110f3c1be85" providerId="ADAL" clId="{1BBB9177-4005-5540-B885-43DD27640C07}" dt="2022-04-21T00:12:32.327" v="1375" actId="478"/>
          <ac:spMkLst>
            <pc:docMk/>
            <pc:sldMk cId="3998775946" sldId="283"/>
            <ac:spMk id="302" creationId="{86DB98B1-BDFC-0942-8FBA-F054AB42CC42}"/>
          </ac:spMkLst>
        </pc:spChg>
        <pc:spChg chg="del mod topLvl">
          <ac:chgData name="Wencai Zhang" userId="4a86a1d0-2108-4707-8228-1110f3c1be85" providerId="ADAL" clId="{1BBB9177-4005-5540-B885-43DD27640C07}" dt="2022-04-21T00:12:28.202" v="1374" actId="478"/>
          <ac:spMkLst>
            <pc:docMk/>
            <pc:sldMk cId="3998775946" sldId="283"/>
            <ac:spMk id="303" creationId="{7A8A4964-A4E5-8F4B-862F-F928D5BEB80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4" creationId="{A0363A2F-D7BB-5A4D-95EE-8656CE5F0660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05" creationId="{B5D84BCF-4062-5640-8BF4-C47DEFF63F40}"/>
          </ac:spMkLst>
        </pc:spChg>
        <pc:spChg chg="del mod topLvl">
          <ac:chgData name="Wencai Zhang" userId="4a86a1d0-2108-4707-8228-1110f3c1be85" providerId="ADAL" clId="{1BBB9177-4005-5540-B885-43DD27640C07}" dt="2022-04-21T00:12:37.302" v="1376" actId="478"/>
          <ac:spMkLst>
            <pc:docMk/>
            <pc:sldMk cId="3998775946" sldId="283"/>
            <ac:spMk id="306" creationId="{0AC37BEE-9FEE-C748-A708-C96BAD624187}"/>
          </ac:spMkLst>
        </pc:spChg>
        <pc:spChg chg="del">
          <ac:chgData name="Wencai Zhang" userId="4a86a1d0-2108-4707-8228-1110f3c1be85" providerId="ADAL" clId="{1BBB9177-4005-5540-B885-43DD27640C07}" dt="2022-04-21T00:13:48.089" v="1390" actId="478"/>
          <ac:spMkLst>
            <pc:docMk/>
            <pc:sldMk cId="3998775946" sldId="283"/>
            <ac:spMk id="308" creationId="{F6A252C6-8E9F-9A40-81E1-4658575D1D93}"/>
          </ac:spMkLst>
        </pc:spChg>
        <pc:spChg chg="del">
          <ac:chgData name="Wencai Zhang" userId="4a86a1d0-2108-4707-8228-1110f3c1be85" providerId="ADAL" clId="{1BBB9177-4005-5540-B885-43DD27640C07}" dt="2022-04-21T00:14:45.742" v="1464" actId="478"/>
          <ac:spMkLst>
            <pc:docMk/>
            <pc:sldMk cId="3998775946" sldId="283"/>
            <ac:spMk id="309" creationId="{723145C1-38D6-D347-89A4-F6A68BCDA1DE}"/>
          </ac:spMkLst>
        </pc:spChg>
        <pc:spChg chg="del">
          <ac:chgData name="Wencai Zhang" userId="4a86a1d0-2108-4707-8228-1110f3c1be85" providerId="ADAL" clId="{1BBB9177-4005-5540-B885-43DD27640C07}" dt="2022-04-21T00:14:47.915" v="1465" actId="478"/>
          <ac:spMkLst>
            <pc:docMk/>
            <pc:sldMk cId="3998775946" sldId="283"/>
            <ac:spMk id="310" creationId="{3E97819B-7389-414D-8D3D-77FF352CA8A4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1" creationId="{0C676772-4386-A542-B4E3-EAB0ADF2C293}"/>
          </ac:spMkLst>
        </pc:spChg>
        <pc:spChg chg="del">
          <ac:chgData name="Wencai Zhang" userId="4a86a1d0-2108-4707-8228-1110f3c1be85" providerId="ADAL" clId="{1BBB9177-4005-5540-B885-43DD27640C07}" dt="2022-04-21T00:10:03.612" v="1297" actId="478"/>
          <ac:spMkLst>
            <pc:docMk/>
            <pc:sldMk cId="3998775946" sldId="283"/>
            <ac:spMk id="312" creationId="{280D227E-C83A-0441-B8A4-E7F897E7A066}"/>
          </ac:spMkLst>
        </pc:spChg>
        <pc:spChg chg="del mod topLvl">
          <ac:chgData name="Wencai Zhang" userId="4a86a1d0-2108-4707-8228-1110f3c1be85" providerId="ADAL" clId="{1BBB9177-4005-5540-B885-43DD27640C07}" dt="2022-04-21T00:12:40.595" v="1377" actId="478"/>
          <ac:spMkLst>
            <pc:docMk/>
            <pc:sldMk cId="3998775946" sldId="283"/>
            <ac:spMk id="313" creationId="{9E00FB9E-D923-004E-A59E-4406B1183C42}"/>
          </ac:spMkLst>
        </pc:spChg>
        <pc:spChg chg="del">
          <ac:chgData name="Wencai Zhang" userId="4a86a1d0-2108-4707-8228-1110f3c1be85" providerId="ADAL" clId="{1BBB9177-4005-5540-B885-43DD27640C07}" dt="2022-04-21T00:14:49.686" v="1466" actId="478"/>
          <ac:spMkLst>
            <pc:docMk/>
            <pc:sldMk cId="3998775946" sldId="283"/>
            <ac:spMk id="314" creationId="{0412498F-4F4D-8640-BE4A-3E10228E23F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5" creationId="{99F4BB11-D596-1545-8161-A9CF4F97D8EE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16" creationId="{BFDC8C24-2E7C-C54C-B7B1-363556E699D6}"/>
          </ac:spMkLst>
        </pc:spChg>
        <pc:spChg chg="del mod topLvl">
          <ac:chgData name="Wencai Zhang" userId="4a86a1d0-2108-4707-8228-1110f3c1be85" providerId="ADAL" clId="{1BBB9177-4005-5540-B885-43DD27640C07}" dt="2022-04-21T00:12:43.330" v="1378" actId="478"/>
          <ac:spMkLst>
            <pc:docMk/>
            <pc:sldMk cId="3998775946" sldId="283"/>
            <ac:spMk id="317" creationId="{D3CC6593-FC19-284E-8B73-DD53FA2CE544}"/>
          </ac:spMkLst>
        </pc:spChg>
        <pc:spChg chg="del">
          <ac:chgData name="Wencai Zhang" userId="4a86a1d0-2108-4707-8228-1110f3c1be85" providerId="ADAL" clId="{1BBB9177-4005-5540-B885-43DD27640C07}" dt="2022-04-21T00:14:55.572" v="1468" actId="478"/>
          <ac:spMkLst>
            <pc:docMk/>
            <pc:sldMk cId="3998775946" sldId="283"/>
            <ac:spMk id="319" creationId="{3DA8A3D2-6FE0-734F-9FAA-25640EF09677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0" creationId="{6AFAA2A5-BAAD-E44D-AFE9-912EF1817509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1" creationId="{9D8AE43B-7056-2C42-B504-6B4D46E835B9}"/>
          </ac:spMkLst>
        </pc:spChg>
        <pc:spChg chg="del mod topLvl">
          <ac:chgData name="Wencai Zhang" userId="4a86a1d0-2108-4707-8228-1110f3c1be85" providerId="ADAL" clId="{1BBB9177-4005-5540-B885-43DD27640C07}" dt="2022-04-21T00:12:46.141" v="1379" actId="478"/>
          <ac:spMkLst>
            <pc:docMk/>
            <pc:sldMk cId="3998775946" sldId="283"/>
            <ac:spMk id="322" creationId="{DC9E1A87-B772-5B48-B326-C782BC67476E}"/>
          </ac:spMkLst>
        </pc:spChg>
        <pc:spChg chg="del">
          <ac:chgData name="Wencai Zhang" userId="4a86a1d0-2108-4707-8228-1110f3c1be85" providerId="ADAL" clId="{1BBB9177-4005-5540-B885-43DD27640C07}" dt="2022-04-21T00:14:57.787" v="1469" actId="478"/>
          <ac:spMkLst>
            <pc:docMk/>
            <pc:sldMk cId="3998775946" sldId="283"/>
            <ac:spMk id="324" creationId="{90DAC876-2700-F647-98B9-8D9775682A6C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5" creationId="{A52F1DE5-28A6-4549-A26C-4DE511E67175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6" creationId="{E273EACB-801F-434F-900C-C49A4E8B1F2F}"/>
          </ac:spMkLst>
        </pc:spChg>
        <pc:spChg chg="del mod topLvl">
          <ac:chgData name="Wencai Zhang" userId="4a86a1d0-2108-4707-8228-1110f3c1be85" providerId="ADAL" clId="{1BBB9177-4005-5540-B885-43DD27640C07}" dt="2022-04-21T00:12:49.338" v="1380" actId="478"/>
          <ac:spMkLst>
            <pc:docMk/>
            <pc:sldMk cId="3998775946" sldId="283"/>
            <ac:spMk id="327" creationId="{E8C132DF-C4EB-BA44-BD97-1660DCE1A42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29" creationId="{2524425C-E734-6747-B3AF-958A0C7EEAD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30" creationId="{B01E9A44-41C0-0D47-BFB9-8ADD8639BACD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2" creationId="{189A8DC2-A6D2-B143-BD05-31EDF9A512A3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3" creationId="{54BEEB33-7BCB-8846-B5C0-5755DC5535A7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4" creationId="{A37F1550-8D48-3340-A64C-CA1D83170044}"/>
          </ac:spMkLst>
        </pc:spChg>
        <pc:spChg chg="mod">
          <ac:chgData name="Wencai Zhang" userId="4a86a1d0-2108-4707-8228-1110f3c1be85" providerId="ADAL" clId="{1BBB9177-4005-5540-B885-43DD27640C07}" dt="2022-04-20T23:52:03.731" v="740" actId="1036"/>
          <ac:spMkLst>
            <pc:docMk/>
            <pc:sldMk cId="3998775946" sldId="283"/>
            <ac:spMk id="336" creationId="{866597AB-2AC4-FA46-84B1-4853AE187441}"/>
          </ac:spMkLst>
        </pc:spChg>
        <pc:spChg chg="mod">
          <ac:chgData name="Wencai Zhang" userId="4a86a1d0-2108-4707-8228-1110f3c1be85" providerId="ADAL" clId="{1BBB9177-4005-5540-B885-43DD27640C07}" dt="2022-04-20T23:48:21.549" v="701"/>
          <ac:spMkLst>
            <pc:docMk/>
            <pc:sldMk cId="3998775946" sldId="283"/>
            <ac:spMk id="337" creationId="{8B7334BA-97BB-7E4B-A1B3-2146D4EA83AD}"/>
          </ac:spMkLst>
        </pc:spChg>
        <pc:spChg chg="mod">
          <ac:chgData name="Wencai Zhang" userId="4a86a1d0-2108-4707-8228-1110f3c1be85" providerId="ADAL" clId="{1BBB9177-4005-5540-B885-43DD27640C07}" dt="2022-04-20T23:48:53" v="705" actId="20577"/>
          <ac:spMkLst>
            <pc:docMk/>
            <pc:sldMk cId="3998775946" sldId="283"/>
            <ac:spMk id="338" creationId="{DBDF3252-4931-E046-A1A5-DCC409F65863}"/>
          </ac:spMkLst>
        </pc:spChg>
        <pc:spChg chg="add mod">
          <ac:chgData name="Wencai Zhang" userId="4a86a1d0-2108-4707-8228-1110f3c1be85" providerId="ADAL" clId="{1BBB9177-4005-5540-B885-43DD27640C07}" dt="2022-04-20T23:52:21.680" v="744" actId="164"/>
          <ac:spMkLst>
            <pc:docMk/>
            <pc:sldMk cId="3998775946" sldId="283"/>
            <ac:spMk id="339" creationId="{681FB82F-EF01-5F45-A233-B776476E070C}"/>
          </ac:spMkLst>
        </pc:spChg>
        <pc:spChg chg="mod">
          <ac:chgData name="Wencai Zhang" userId="4a86a1d0-2108-4707-8228-1110f3c1be85" providerId="ADAL" clId="{1BBB9177-4005-5540-B885-43DD27640C07}" dt="2022-04-21T00:10:09.240" v="1319" actId="1036"/>
          <ac:spMkLst>
            <pc:docMk/>
            <pc:sldMk cId="3998775946" sldId="283"/>
            <ac:spMk id="342" creationId="{9E11DF43-A89C-BE44-A86C-970241968E49}"/>
          </ac:spMkLst>
        </pc:spChg>
        <pc:spChg chg="mod">
          <ac:chgData name="Wencai Zhang" userId="4a86a1d0-2108-4707-8228-1110f3c1be85" providerId="ADAL" clId="{1BBB9177-4005-5540-B885-43DD27640C07}" dt="2022-04-21T00:13:18.830" v="1383" actId="1036"/>
          <ac:spMkLst>
            <pc:docMk/>
            <pc:sldMk cId="3998775946" sldId="283"/>
            <ac:spMk id="343" creationId="{4AC60818-E44C-5E4A-9F7F-F27F71824C5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4" creationId="{ACDF534F-B8AB-2E44-A505-1238A8CA04D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5" creationId="{F2A9FEDB-97DC-AF40-B771-C906CC82E032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7" creationId="{30CFC702-0E88-854A-BCD2-CFE8AE5FB74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8" creationId="{967F35BF-7516-5740-A76D-154896507CE6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9" creationId="{B5DA68BE-EE92-B34E-A211-CB46276F6138}"/>
          </ac:spMkLst>
        </pc:spChg>
        <pc:spChg chg="mod">
          <ac:chgData name="Wencai Zhang" userId="4a86a1d0-2108-4707-8228-1110f3c1be85" providerId="ADAL" clId="{1BBB9177-4005-5540-B885-43DD27640C07}" dt="2022-04-20T23:42:07.210" v="271" actId="1038"/>
          <ac:spMkLst>
            <pc:docMk/>
            <pc:sldMk cId="3998775946" sldId="283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18:22.705" v="1623" actId="1038"/>
          <ac:spMkLst>
            <pc:docMk/>
            <pc:sldMk cId="3998775946" sldId="283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5" creationId="{A5C27DAF-3031-864C-9C37-112CC070FCC4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6" creationId="{A1D7723D-0C3E-D548-BCC7-B7D44C3588BD}"/>
          </ac:spMkLst>
        </pc:spChg>
        <pc:spChg chg="mod">
          <ac:chgData name="Wencai Zhang" userId="4a86a1d0-2108-4707-8228-1110f3c1be85" providerId="ADAL" clId="{1BBB9177-4005-5540-B885-43DD27640C07}" dt="2022-04-21T00:28:28.027" v="2042" actId="1038"/>
          <ac:spMkLst>
            <pc:docMk/>
            <pc:sldMk cId="3998775946" sldId="283"/>
            <ac:spMk id="357" creationId="{463C2D55-EFCB-1D40-A3BF-EA5D75F7633B}"/>
          </ac:spMkLst>
        </pc:spChg>
        <pc:spChg chg="del">
          <ac:chgData name="Wencai Zhang" userId="4a86a1d0-2108-4707-8228-1110f3c1be85" providerId="ADAL" clId="{1BBB9177-4005-5540-B885-43DD27640C07}" dt="2022-04-21T00:23:58.168" v="1818" actId="478"/>
          <ac:spMkLst>
            <pc:docMk/>
            <pc:sldMk cId="3998775946" sldId="283"/>
            <ac:spMk id="358" creationId="{B1802351-4668-D242-920B-36BE5B67400B}"/>
          </ac:spMkLst>
        </pc:spChg>
        <pc:spChg chg="del">
          <ac:chgData name="Wencai Zhang" userId="4a86a1d0-2108-4707-8228-1110f3c1be85" providerId="ADAL" clId="{1BBB9177-4005-5540-B885-43DD27640C07}" dt="2022-04-21T00:24:01.812" v="1819" actId="478"/>
          <ac:spMkLst>
            <pc:docMk/>
            <pc:sldMk cId="3998775946" sldId="283"/>
            <ac:spMk id="359" creationId="{0429DC9A-7DCC-3E49-87E8-05C7839D2E96}"/>
          </ac:spMkLst>
        </pc:spChg>
        <pc:spChg chg="del">
          <ac:chgData name="Wencai Zhang" userId="4a86a1d0-2108-4707-8228-1110f3c1be85" providerId="ADAL" clId="{1BBB9177-4005-5540-B885-43DD27640C07}" dt="2022-04-21T00:26:47.342" v="1978" actId="478"/>
          <ac:spMkLst>
            <pc:docMk/>
            <pc:sldMk cId="3998775946" sldId="283"/>
            <ac:spMk id="360" creationId="{5D008AD1-3239-394E-9325-5A53B29078DC}"/>
          </ac:spMkLst>
        </pc:spChg>
        <pc:spChg chg="del">
          <ac:chgData name="Wencai Zhang" userId="4a86a1d0-2108-4707-8228-1110f3c1be85" providerId="ADAL" clId="{1BBB9177-4005-5540-B885-43DD27640C07}" dt="2022-04-21T00:26:44.730" v="1977" actId="478"/>
          <ac:spMkLst>
            <pc:docMk/>
            <pc:sldMk cId="3998775946" sldId="283"/>
            <ac:spMk id="361" creationId="{3E021C58-547C-7347-B3CF-ED94F6CFD05E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28:38.766" v="2070" actId="1038"/>
          <ac:spMkLst>
            <pc:docMk/>
            <pc:sldMk cId="3998775946" sldId="283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0T23:57:33.212" v="1067" actId="1038"/>
          <ac:spMkLst>
            <pc:docMk/>
            <pc:sldMk cId="3998775946" sldId="283"/>
            <ac:spMk id="364" creationId="{5032542A-D0F1-7F4B-910B-DCBD1CFA9EEB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5" creationId="{816AEEEA-9B60-4E44-9906-18941B8023FC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8" creationId="{D6F9FF6B-B4AA-2B41-A26E-282B139736E8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9" creationId="{4AC64AEE-C8EE-C348-8CD4-C8565DBA9724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0" creationId="{0CD7D80D-953E-D741-BEC6-D180502F6FC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1" creationId="{F9DAA526-18A2-3841-964C-A13ABDE4693A}"/>
          </ac:spMkLst>
        </pc:spChg>
        <pc:spChg chg="mod">
          <ac:chgData name="Wencai Zhang" userId="4a86a1d0-2108-4707-8228-1110f3c1be85" providerId="ADAL" clId="{1BBB9177-4005-5540-B885-43DD27640C07}" dt="2022-04-21T00:24:11.075" v="1828" actId="20577"/>
          <ac:spMkLst>
            <pc:docMk/>
            <pc:sldMk cId="3998775946" sldId="283"/>
            <ac:spMk id="373" creationId="{FC1244B7-A830-3241-B0B9-B937192ECEFA}"/>
          </ac:spMkLst>
        </pc:spChg>
        <pc:spChg chg="mod">
          <ac:chgData name="Wencai Zhang" userId="4a86a1d0-2108-4707-8228-1110f3c1be85" providerId="ADAL" clId="{1BBB9177-4005-5540-B885-43DD27640C07}" dt="2022-04-21T00:23:43.856" v="1815"/>
          <ac:spMkLst>
            <pc:docMk/>
            <pc:sldMk cId="3998775946" sldId="283"/>
            <ac:spMk id="374" creationId="{D7AD7F8D-B70E-E549-B8B7-2753154914FB}"/>
          </ac:spMkLst>
        </pc:spChg>
        <pc:spChg chg="mod">
          <ac:chgData name="Wencai Zhang" userId="4a86a1d0-2108-4707-8228-1110f3c1be85" providerId="ADAL" clId="{1BBB9177-4005-5540-B885-43DD27640C07}" dt="2022-04-21T00:24:07.170" v="1824" actId="20577"/>
          <ac:spMkLst>
            <pc:docMk/>
            <pc:sldMk cId="3998775946" sldId="283"/>
            <ac:spMk id="375" creationId="{9EDC78FF-5117-2B41-9769-D22BF10E18BF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7" creationId="{39F34578-F0C9-D947-8AC4-4605B6D336FE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8" creationId="{CC859AD5-58C9-C549-81D9-C9BA92944F59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9" creationId="{B1D74497-5BF8-5841-AB96-A4E2E6DA41AA}"/>
          </ac:spMkLst>
        </pc:s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6" creationId="{479C65AD-753B-AB4B-8A57-8241A88BDD23}"/>
          </ac:grpSpMkLst>
        </pc:gr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24:54.564" v="1863" actId="1037"/>
          <ac:grpSpMkLst>
            <pc:docMk/>
            <pc:sldMk cId="3998775946" sldId="283"/>
            <ac:grpSpMk id="16" creationId="{7C1AFE9D-0804-4941-9275-A9799A61F71B}"/>
          </ac:grpSpMkLst>
        </pc:grpChg>
        <pc:grpChg chg="add mod">
          <ac:chgData name="Wencai Zhang" userId="4a86a1d0-2108-4707-8228-1110f3c1be85" providerId="ADAL" clId="{1BBB9177-4005-5540-B885-43DD27640C07}" dt="2022-04-20T23:41:08.519" v="213" actId="1037"/>
          <ac:grpSpMkLst>
            <pc:docMk/>
            <pc:sldMk cId="3998775946" sldId="283"/>
            <ac:grpSpMk id="19" creationId="{FAF5B60B-3F9C-8648-BB2F-55EFA9B87758}"/>
          </ac:grpSpMkLst>
        </pc:grpChg>
        <pc:grpChg chg="add mod">
          <ac:chgData name="Wencai Zhang" userId="4a86a1d0-2108-4707-8228-1110f3c1be85" providerId="ADAL" clId="{1BBB9177-4005-5540-B885-43DD27640C07}" dt="2022-04-20T23:45:10.532" v="394" actId="164"/>
          <ac:grpSpMkLst>
            <pc:docMk/>
            <pc:sldMk cId="3998775946" sldId="283"/>
            <ac:grpSpMk id="20" creationId="{0971CC71-7DAF-7F46-9F1D-3A2E6F5ED523}"/>
          </ac:grpSpMkLst>
        </pc:grpChg>
        <pc:grpChg chg="add 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1" creationId="{B5BE6ED3-887F-094E-8750-EA5C51EB264D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4" creationId="{B1A190EF-8208-214C-AA74-D041DE9849E0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6" creationId="{9BCA6DE1-C6B0-0B48-AF62-64C7CADF9862}"/>
          </ac:grpSpMkLst>
        </pc:grpChg>
        <pc:grpChg chg="del 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37" creationId="{27B8616D-59C5-5349-A558-778965C429EA}"/>
          </ac:grpSpMkLst>
        </pc:grpChg>
        <pc:grpChg chg="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60" creationId="{224B13FA-B34C-854B-BE94-EE22CC7CA3B4}"/>
          </ac:grpSpMkLst>
        </pc:grpChg>
        <pc:grpChg chg="de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70" creationId="{75B0705B-E19E-E34D-B58E-0C1D0C1A2D17}"/>
          </ac:grpSpMkLst>
        </pc:grpChg>
        <pc:grpChg chg="mod">
          <ac:chgData name="Wencai Zhang" userId="4a86a1d0-2108-4707-8228-1110f3c1be85" providerId="ADAL" clId="{1BBB9177-4005-5540-B885-43DD27640C07}" dt="2022-04-20T23:57:05.414" v="1025" actId="14100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18:44.564" v="1636" actId="1037"/>
          <ac:grpSpMkLst>
            <pc:docMk/>
            <pc:sldMk cId="3998775946" sldId="283"/>
            <ac:grpSpMk id="106" creationId="{345CB9A9-5784-A24E-9572-7BEA17A9C6A1}"/>
          </ac:grpSpMkLst>
        </pc:grpChg>
        <pc:grpChg chg="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34" creationId="{AD029D35-69BA-FB48-B155-1E2B6B20040D}"/>
          </ac:grpSpMkLst>
        </pc:grpChg>
        <pc:grpChg chg="add mod">
          <ac:chgData name="Wencai Zhang" userId="4a86a1d0-2108-4707-8228-1110f3c1be85" providerId="ADAL" clId="{1BBB9177-4005-5540-B885-43DD27640C07}" dt="2022-04-20T23:45:40.836" v="495" actId="1037"/>
          <ac:grpSpMkLst>
            <pc:docMk/>
            <pc:sldMk cId="3998775946" sldId="283"/>
            <ac:grpSpMk id="298" creationId="{EC9E9EFA-21FA-5B42-A5CB-6082C05CECC2}"/>
          </ac:grpSpMkLst>
        </pc:grpChg>
        <pc:grpChg chg="add mod">
          <ac:chgData name="Wencai Zhang" userId="4a86a1d0-2108-4707-8228-1110f3c1be85" providerId="ADAL" clId="{1BBB9177-4005-5540-B885-43DD27640C07}" dt="2022-04-20T23:46:18.707" v="638" actId="1038"/>
          <ac:grpSpMkLst>
            <pc:docMk/>
            <pc:sldMk cId="3998775946" sldId="283"/>
            <ac:grpSpMk id="331" creationId="{B17F12F3-C713-4A46-A187-892488048BA5}"/>
          </ac:grpSpMkLst>
        </pc:grpChg>
        <pc:grpChg chg="add mod">
          <ac:chgData name="Wencai Zhang" userId="4a86a1d0-2108-4707-8228-1110f3c1be85" providerId="ADAL" clId="{1BBB9177-4005-5540-B885-43DD27640C07}" dt="2022-04-20T23:52:21.680" v="744" actId="164"/>
          <ac:grpSpMkLst>
            <pc:docMk/>
            <pc:sldMk cId="3998775946" sldId="283"/>
            <ac:grpSpMk id="335" creationId="{451C0D05-2907-FC44-923D-1D40C3097A62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340" creationId="{1EDEA6F9-666B-2B4E-B2AA-893E9879CA09}"/>
          </ac:grpSpMkLst>
        </pc:grpChg>
        <pc:grpChg chg="mod">
          <ac:chgData name="Wencai Zhang" userId="4a86a1d0-2108-4707-8228-1110f3c1be85" providerId="ADAL" clId="{1BBB9177-4005-5540-B885-43DD27640C07}" dt="2022-04-21T00:07:52.528" v="1250"/>
          <ac:grpSpMkLst>
            <pc:docMk/>
            <pc:sldMk cId="3998775946" sldId="283"/>
            <ac:grpSpMk id="341" creationId="{8E87BBED-C980-744A-9EA6-A878D3C413E9}"/>
          </ac:grpSpMkLst>
        </pc:grpChg>
        <pc:grpChg chg="add 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6" creationId="{5E9A97AF-A220-474F-A958-908226242058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7" creationId="{1735AC76-729B-5443-AFDA-9C705A092EDC}"/>
          </ac:grpSpMkLst>
        </pc:grpChg>
        <pc:grpChg chg="add mod">
          <ac:chgData name="Wencai Zhang" userId="4a86a1d0-2108-4707-8228-1110f3c1be85" providerId="ADAL" clId="{1BBB9177-4005-5540-B885-43DD27640C07}" dt="2022-04-21T00:24:50.503" v="1862" actId="1038"/>
          <ac:grpSpMkLst>
            <pc:docMk/>
            <pc:sldMk cId="3998775946" sldId="283"/>
            <ac:grpSpMk id="372" creationId="{F43206F6-1277-3547-92AC-57A9EC9C2761}"/>
          </ac:grpSpMkLst>
        </pc:grpChg>
        <pc:grpChg chg="add 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0T23:47:53.401" v="700" actId="1037"/>
          <ac:picMkLst>
            <pc:docMk/>
            <pc:sldMk cId="3998775946" sldId="283"/>
            <ac:picMk id="7" creationId="{4E9CACB6-C4AB-7740-BBFF-7B28DE099420}"/>
          </ac:picMkLst>
        </pc:picChg>
        <pc:picChg chg="add del mod">
          <ac:chgData name="Wencai Zhang" userId="4a86a1d0-2108-4707-8228-1110f3c1be85" providerId="ADAL" clId="{1BBB9177-4005-5540-B885-43DD27640C07}" dt="2022-04-20T23:34:52.137" v="41" actId="478"/>
          <ac:picMkLst>
            <pc:docMk/>
            <pc:sldMk cId="3998775946" sldId="283"/>
            <ac:picMk id="8" creationId="{5A0BC7B9-D656-9840-93A6-A5C5392CAEE7}"/>
          </ac:picMkLst>
        </pc:picChg>
        <pc:picChg chg="mod">
          <ac:chgData name="Wencai Zhang" userId="4a86a1d0-2108-4707-8228-1110f3c1be85" providerId="ADAL" clId="{1BBB9177-4005-5540-B885-43DD27640C07}" dt="2022-04-20T23:41:52.193" v="250" actId="1038"/>
          <ac:picMkLst>
            <pc:docMk/>
            <pc:sldMk cId="3998775946" sldId="283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0T23:41:58.757" v="268" actId="1038"/>
          <ac:picMkLst>
            <pc:docMk/>
            <pc:sldMk cId="3998775946" sldId="283"/>
            <ac:picMk id="13" creationId="{452AC9C4-7DE6-204F-9E61-8F99B2402C02}"/>
          </ac:picMkLst>
        </pc:picChg>
        <pc:picChg chg="add mod">
          <ac:chgData name="Wencai Zhang" userId="4a86a1d0-2108-4707-8228-1110f3c1be85" providerId="ADAL" clId="{1BBB9177-4005-5540-B885-43DD27640C07}" dt="2022-04-20T23:42:36.502" v="300" actId="1037"/>
          <ac:picMkLst>
            <pc:docMk/>
            <pc:sldMk cId="3998775946" sldId="283"/>
            <ac:picMk id="14" creationId="{31E66149-3790-374B-AB85-5E6EA0D4F5BC}"/>
          </ac:picMkLst>
        </pc:picChg>
        <pc:picChg chg="add mod">
          <ac:chgData name="Wencai Zhang" userId="4a86a1d0-2108-4707-8228-1110f3c1be85" providerId="ADAL" clId="{1BBB9177-4005-5540-B885-43DD27640C07}" dt="2022-04-20T23:42:46.558" v="309" actId="1035"/>
          <ac:picMkLst>
            <pc:docMk/>
            <pc:sldMk cId="3998775946" sldId="283"/>
            <ac:picMk id="18" creationId="{AFE39E17-A795-9B4B-8374-7E95106BA399}"/>
          </ac:picMkLst>
        </pc:picChg>
        <pc:picChg chg="add mod">
          <ac:chgData name="Wencai Zhang" userId="4a86a1d0-2108-4707-8228-1110f3c1be85" providerId="ADAL" clId="{1BBB9177-4005-5540-B885-43DD27640C07}" dt="2022-04-20T23:57:40.815" v="1069" actId="1038"/>
          <ac:picMkLst>
            <pc:docMk/>
            <pc:sldMk cId="3998775946" sldId="283"/>
            <ac:picMk id="25" creationId="{A5C4F04F-FA9F-AF42-B4D9-5C269E3F26E6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7" creationId="{44CA3A87-721D-5442-A423-464DEDDF5537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8" creationId="{013E642C-6C4D-8944-B92B-0ECE4FFE4EE5}"/>
          </ac:picMkLst>
        </pc:picChg>
        <pc:picChg chg="add mod modCrop">
          <ac:chgData name="Wencai Zhang" userId="4a86a1d0-2108-4707-8228-1110f3c1be85" providerId="ADAL" clId="{1BBB9177-4005-5540-B885-43DD27640C07}" dt="2022-04-21T00:00:58.237" v="1100" actId="732"/>
          <ac:picMkLst>
            <pc:docMk/>
            <pc:sldMk cId="3998775946" sldId="283"/>
            <ac:picMk id="31" creationId="{50111CC7-87FC-7B4D-8141-6389F01144DD}"/>
          </ac:picMkLst>
        </pc:picChg>
        <pc:picChg chg="add mod modCrop">
          <ac:chgData name="Wencai Zhang" userId="4a86a1d0-2108-4707-8228-1110f3c1be85" providerId="ADAL" clId="{1BBB9177-4005-5540-B885-43DD27640C07}" dt="2022-04-21T00:02:11.825" v="1124" actId="732"/>
          <ac:picMkLst>
            <pc:docMk/>
            <pc:sldMk cId="3998775946" sldId="283"/>
            <ac:picMk id="48" creationId="{E651FCCF-6774-FD48-815E-D4F8522DA29D}"/>
          </ac:picMkLst>
        </pc:picChg>
        <pc:picChg chg="add mod modCrop">
          <ac:chgData name="Wencai Zhang" userId="4a86a1d0-2108-4707-8228-1110f3c1be85" providerId="ADAL" clId="{1BBB9177-4005-5540-B885-43DD27640C07}" dt="2022-04-21T00:03:25.449" v="1177" actId="732"/>
          <ac:picMkLst>
            <pc:docMk/>
            <pc:sldMk cId="3998775946" sldId="283"/>
            <ac:picMk id="69" creationId="{2334DB1B-418E-B24D-BED9-EF016A0280D4}"/>
          </ac:picMkLst>
        </pc:picChg>
        <pc:picChg chg="add mod modCrop">
          <ac:chgData name="Wencai Zhang" userId="4a86a1d0-2108-4707-8228-1110f3c1be85" providerId="ADAL" clId="{1BBB9177-4005-5540-B885-43DD27640C07}" dt="2022-04-21T00:03:31.812" v="1178" actId="732"/>
          <ac:picMkLst>
            <pc:docMk/>
            <pc:sldMk cId="3998775946" sldId="283"/>
            <ac:picMk id="95" creationId="{05F4FA48-5B24-4346-A01F-7A7802631CF7}"/>
          </ac:picMkLst>
        </pc:picChg>
        <pc:picChg chg="add mod modCrop">
          <ac:chgData name="Wencai Zhang" userId="4a86a1d0-2108-4707-8228-1110f3c1be85" providerId="ADAL" clId="{1BBB9177-4005-5540-B885-43DD27640C07}" dt="2022-04-21T00:05:54.189" v="1228" actId="732"/>
          <ac:picMkLst>
            <pc:docMk/>
            <pc:sldMk cId="3998775946" sldId="283"/>
            <ac:picMk id="96" creationId="{23FCB37B-1A20-DB47-A815-B49D084D2309}"/>
          </ac:picMkLst>
        </pc:picChg>
        <pc:picChg chg="add mod modCrop">
          <ac:chgData name="Wencai Zhang" userId="4a86a1d0-2108-4707-8228-1110f3c1be85" providerId="ADAL" clId="{1BBB9177-4005-5540-B885-43DD27640C07}" dt="2022-04-21T00:05:41.644" v="1227" actId="732"/>
          <ac:picMkLst>
            <pc:docMk/>
            <pc:sldMk cId="3998775946" sldId="283"/>
            <ac:picMk id="102" creationId="{57EDE318-521C-D346-A0AF-758E003AA39B}"/>
          </ac:picMkLst>
        </pc:picChg>
        <pc:picChg chg="add mod">
          <ac:chgData name="Wencai Zhang" userId="4a86a1d0-2108-4707-8228-1110f3c1be85" providerId="ADAL" clId="{1BBB9177-4005-5540-B885-43DD27640C07}" dt="2022-04-21T00:06:30.990" v="1249" actId="1076"/>
          <ac:picMkLst>
            <pc:docMk/>
            <pc:sldMk cId="3998775946" sldId="283"/>
            <ac:picMk id="103" creationId="{F89ED89E-111D-7148-89DF-90BD73DEABCA}"/>
          </ac:picMkLst>
        </pc:picChg>
        <pc:picChg chg="add mod">
          <ac:chgData name="Wencai Zhang" userId="4a86a1d0-2108-4707-8228-1110f3c1be85" providerId="ADAL" clId="{1BBB9177-4005-5540-B885-43DD27640C07}" dt="2022-04-21T00:19:04.626" v="1655" actId="1037"/>
          <ac:picMkLst>
            <pc:docMk/>
            <pc:sldMk cId="3998775946" sldId="283"/>
            <ac:picMk id="107" creationId="{EEDC13A2-9BBB-5344-AEC5-8B95AEFFB5A3}"/>
          </ac:picMkLst>
        </pc:picChg>
        <pc:picChg chg="add mod">
          <ac:chgData name="Wencai Zhang" userId="4a86a1d0-2108-4707-8228-1110f3c1be85" providerId="ADAL" clId="{1BBB9177-4005-5540-B885-43DD27640C07}" dt="2022-04-21T00:17:47.490" v="1583" actId="1076"/>
          <ac:picMkLst>
            <pc:docMk/>
            <pc:sldMk cId="3998775946" sldId="283"/>
            <ac:picMk id="109" creationId="{882A2E9B-2A64-C343-86E4-B2CF4C983127}"/>
          </ac:picMkLst>
        </pc:picChg>
        <pc:picChg chg="add mod">
          <ac:chgData name="Wencai Zhang" userId="4a86a1d0-2108-4707-8228-1110f3c1be85" providerId="ADAL" clId="{1BBB9177-4005-5540-B885-43DD27640C07}" dt="2022-04-21T00:19:40.607" v="1683" actId="1076"/>
          <ac:picMkLst>
            <pc:docMk/>
            <pc:sldMk cId="3998775946" sldId="283"/>
            <ac:picMk id="110" creationId="{88311C2B-AF92-174C-B416-EDE2BEE1EA54}"/>
          </ac:picMkLst>
        </pc:picChg>
        <pc:picChg chg="add mod">
          <ac:chgData name="Wencai Zhang" userId="4a86a1d0-2108-4707-8228-1110f3c1be85" providerId="ADAL" clId="{1BBB9177-4005-5540-B885-43DD27640C07}" dt="2022-04-21T00:20:16.766" v="1704" actId="1076"/>
          <ac:picMkLst>
            <pc:docMk/>
            <pc:sldMk cId="3998775946" sldId="283"/>
            <ac:picMk id="111" creationId="{388B1E29-F01F-4E44-B804-BBD2B20C8EFE}"/>
          </ac:picMkLst>
        </pc:picChg>
        <pc:picChg chg="add mod">
          <ac:chgData name="Wencai Zhang" userId="4a86a1d0-2108-4707-8228-1110f3c1be85" providerId="ADAL" clId="{1BBB9177-4005-5540-B885-43DD27640C07}" dt="2022-04-21T00:20:39.741" v="1725" actId="1076"/>
          <ac:picMkLst>
            <pc:docMk/>
            <pc:sldMk cId="3998775946" sldId="283"/>
            <ac:picMk id="112" creationId="{12437FF6-47D0-3F41-B188-62892B0FDD48}"/>
          </ac:picMkLst>
        </pc:picChg>
        <pc:picChg chg="add mod">
          <ac:chgData name="Wencai Zhang" userId="4a86a1d0-2108-4707-8228-1110f3c1be85" providerId="ADAL" clId="{1BBB9177-4005-5540-B885-43DD27640C07}" dt="2022-04-21T00:21:01.286" v="1746" actId="1076"/>
          <ac:picMkLst>
            <pc:docMk/>
            <pc:sldMk cId="3998775946" sldId="283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15:07.908" v="1471" actId="1037"/>
          <ac:picMkLst>
            <pc:docMk/>
            <pc:sldMk cId="3998775946" sldId="283"/>
            <ac:picMk id="116" creationId="{842C16C1-2569-2B41-9BE7-A76C8801DE2F}"/>
          </ac:picMkLst>
        </pc:picChg>
        <pc:picChg chg="add mod">
          <ac:chgData name="Wencai Zhang" userId="4a86a1d0-2108-4707-8228-1110f3c1be85" providerId="ADAL" clId="{1BBB9177-4005-5540-B885-43DD27640C07}" dt="2022-04-21T00:21:31.943" v="1767" actId="1076"/>
          <ac:picMkLst>
            <pc:docMk/>
            <pc:sldMk cId="3998775946" sldId="283"/>
            <ac:picMk id="117" creationId="{8364684B-4B74-E249-8D48-0D520006B5E4}"/>
          </ac:picMkLst>
        </pc:picChg>
        <pc:picChg chg="add mod">
          <ac:chgData name="Wencai Zhang" userId="4a86a1d0-2108-4707-8228-1110f3c1be85" providerId="ADAL" clId="{1BBB9177-4005-5540-B885-43DD27640C07}" dt="2022-04-21T00:27:18.158" v="1990" actId="1076"/>
          <ac:picMkLst>
            <pc:docMk/>
            <pc:sldMk cId="3998775946" sldId="283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15:13.054" v="1472" actId="1038"/>
          <ac:picMkLst>
            <pc:docMk/>
            <pc:sldMk cId="3998775946" sldId="283"/>
            <ac:picMk id="121" creationId="{3832138C-BC52-E444-98C2-D355BA3C8434}"/>
          </ac:picMkLst>
        </pc:picChg>
        <pc:picChg chg="add mod">
          <ac:chgData name="Wencai Zhang" userId="4a86a1d0-2108-4707-8228-1110f3c1be85" providerId="ADAL" clId="{1BBB9177-4005-5540-B885-43DD27640C07}" dt="2022-04-21T00:27:55.490" v="2012" actId="1076"/>
          <ac:picMkLst>
            <pc:docMk/>
            <pc:sldMk cId="3998775946" sldId="283"/>
            <ac:picMk id="122" creationId="{BE1FF44F-605B-8A45-BD38-A801818982A6}"/>
          </ac:picMkLst>
        </pc:picChg>
        <pc:picChg chg="add mod">
          <ac:chgData name="Wencai Zhang" userId="4a86a1d0-2108-4707-8228-1110f3c1be85" providerId="ADAL" clId="{1BBB9177-4005-5540-B885-43DD27640C07}" dt="2022-04-21T00:29:51.213" v="2099" actId="1076"/>
          <ac:picMkLst>
            <pc:docMk/>
            <pc:sldMk cId="3998775946" sldId="283"/>
            <ac:picMk id="127" creationId="{C7C92599-816F-A74F-B00A-7A037DB6D190}"/>
          </ac:picMkLst>
        </pc:picChg>
        <pc:picChg chg="add mod">
          <ac:chgData name="Wencai Zhang" userId="4a86a1d0-2108-4707-8228-1110f3c1be85" providerId="ADAL" clId="{1BBB9177-4005-5540-B885-43DD27640C07}" dt="2022-04-21T00:30:35.519" v="2131" actId="1035"/>
          <ac:picMkLst>
            <pc:docMk/>
            <pc:sldMk cId="3998775946" sldId="283"/>
            <ac:picMk id="129" creationId="{FABB8195-5A40-B345-9D9E-D7ACDE9CC7A4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66" creationId="{5DE39962-B321-8847-83CF-4797A1FEFE2C}"/>
          </ac:picMkLst>
        </pc:picChg>
        <pc:picChg chg="mod">
          <ac:chgData name="Wencai Zhang" userId="4a86a1d0-2108-4707-8228-1110f3c1be85" providerId="ADAL" clId="{1BBB9177-4005-5540-B885-43DD27640C07}" dt="2022-04-21T00:26:55.304" v="1985" actId="1035"/>
          <ac:picMkLst>
            <pc:docMk/>
            <pc:sldMk cId="3998775946" sldId="283"/>
            <ac:picMk id="192" creationId="{71CCA731-AEC4-324C-B904-1CFC513A08F9}"/>
          </ac:picMkLst>
        </pc:picChg>
        <pc:picChg chg="mod">
          <ac:chgData name="Wencai Zhang" userId="4a86a1d0-2108-4707-8228-1110f3c1be85" providerId="ADAL" clId="{1BBB9177-4005-5540-B885-43DD27640C07}" dt="2022-04-20T23:46:30.206" v="647" actId="1035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0T23:41:17.085" v="231" actId="1038"/>
          <ac:picMkLst>
            <pc:docMk/>
            <pc:sldMk cId="3998775946" sldId="283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14:52.456" v="1467" actId="1037"/>
          <ac:picMkLst>
            <pc:docMk/>
            <pc:sldMk cId="3998775946" sldId="283"/>
            <ac:picMk id="255" creationId="{6C620D77-00EC-B64C-8F91-2C86BE3F5E02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25:45.306" v="1891" actId="1036"/>
          <ac:picMkLst>
            <pc:docMk/>
            <pc:sldMk cId="3998775946" sldId="283"/>
            <ac:picMk id="293" creationId="{87C33A91-41E2-C44B-B229-07B0D51695C9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5" creationId="{251A0F80-8D82-2245-9504-A3FA76583FEC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18" creationId="{37AA4BFA-EF24-B240-B9DD-1675C3688EE3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3" creationId="{EE36942F-7CEC-DD41-BE75-CCDD77DF75DB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8" creationId="{0B58CBAA-3E9F-6140-8558-409BCB7DFAC6}"/>
          </ac:picMkLst>
        </pc:picChg>
      </pc:sldChg>
      <pc:sldChg chg="addSp modSp add mod ord">
        <pc:chgData name="Wencai Zhang" userId="4a86a1d0-2108-4707-8228-1110f3c1be85" providerId="ADAL" clId="{1BBB9177-4005-5540-B885-43DD27640C07}" dt="2022-04-21T00:48:43.328" v="3132" actId="20578"/>
        <pc:sldMkLst>
          <pc:docMk/>
          <pc:sldMk cId="428893665" sldId="289"/>
        </pc:sldMkLst>
        <pc:spChg chg="mod">
          <ac:chgData name="Wencai Zhang" userId="4a86a1d0-2108-4707-8228-1110f3c1be85" providerId="ADAL" clId="{1BBB9177-4005-5540-B885-43DD27640C07}" dt="2022-04-21T00:37:14.673" v="2363" actId="1037"/>
          <ac:spMkLst>
            <pc:docMk/>
            <pc:sldMk cId="428893665" sldId="289"/>
            <ac:spMk id="15" creationId="{73A0757A-AC74-43FC-BBB2-E91DD12F5CD5}"/>
          </ac:spMkLst>
        </pc:spChg>
        <pc:spChg chg="mod">
          <ac:chgData name="Wencai Zhang" userId="4a86a1d0-2108-4707-8228-1110f3c1be85" providerId="ADAL" clId="{1BBB9177-4005-5540-B885-43DD27640C07}" dt="2022-04-21T00:39:49.329" v="2581" actId="1037"/>
          <ac:spMkLst>
            <pc:docMk/>
            <pc:sldMk cId="428893665" sldId="289"/>
            <ac:spMk id="71" creationId="{9B63982C-9423-B641-9499-4AB2C87BF98E}"/>
          </ac:spMkLst>
        </pc:spChg>
        <pc:spChg chg="mod">
          <ac:chgData name="Wencai Zhang" userId="4a86a1d0-2108-4707-8228-1110f3c1be85" providerId="ADAL" clId="{1BBB9177-4005-5540-B885-43DD27640C07}" dt="2022-04-21T00:41:53.246" v="2724" actId="1038"/>
          <ac:spMkLst>
            <pc:docMk/>
            <pc:sldMk cId="428893665" sldId="289"/>
            <ac:spMk id="76" creationId="{9A59F463-DF57-BD49-8378-B4332DE229CE}"/>
          </ac:spMkLst>
        </pc:spChg>
        <pc:spChg chg="mod">
          <ac:chgData name="Wencai Zhang" userId="4a86a1d0-2108-4707-8228-1110f3c1be85" providerId="ADAL" clId="{1BBB9177-4005-5540-B885-43DD27640C07}" dt="2022-04-21T00:35:47.670" v="2209" actId="1036"/>
          <ac:spMkLst>
            <pc:docMk/>
            <pc:sldMk cId="428893665" sldId="289"/>
            <ac:spMk id="79" creationId="{F0A85EFF-8CA7-4595-8ED1-A933E3DC9B9B}"/>
          </ac:spMkLst>
        </pc:spChg>
        <pc:spChg chg="mod">
          <ac:chgData name="Wencai Zhang" userId="4a86a1d0-2108-4707-8228-1110f3c1be85" providerId="ADAL" clId="{1BBB9177-4005-5540-B885-43DD27640C07}" dt="2022-04-21T00:43:15.137" v="2804" actId="1076"/>
          <ac:spMkLst>
            <pc:docMk/>
            <pc:sldMk cId="428893665" sldId="289"/>
            <ac:spMk id="86" creationId="{00000000-0000-0000-0000-00000000000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174" creationId="{772C2F64-D0CB-794D-A688-AE5D87C04FC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42" creationId="{E9026220-977C-2146-91A8-11A5B3F1C28A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51" creationId="{EE3570EE-4F1A-B14B-9A24-77C32DC96AE1}"/>
          </ac:spMkLst>
        </pc:spChg>
        <pc:spChg chg="mod">
          <ac:chgData name="Wencai Zhang" userId="4a86a1d0-2108-4707-8228-1110f3c1be85" providerId="ADAL" clId="{1BBB9177-4005-5540-B885-43DD27640C07}" dt="2022-04-21T00:40:47.242" v="2600" actId="164"/>
          <ac:spMkLst>
            <pc:docMk/>
            <pc:sldMk cId="428893665" sldId="289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1T00:38:24.524" v="2425" actId="1037"/>
          <ac:spMkLst>
            <pc:docMk/>
            <pc:sldMk cId="428893665" sldId="289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1T00:41:13.195" v="2670" actId="1038"/>
          <ac:spMkLst>
            <pc:docMk/>
            <pc:sldMk cId="428893665" sldId="289"/>
            <ac:spMk id="265" creationId="{8D326B54-6FC1-6B43-B24F-103C48CE56A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3" creationId="{B5314342-C516-DC41-BC08-CBFC2A6AEDC5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6" creationId="{5A0F809E-FEC4-1F49-8973-FC476EE7A8CE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8" creationId="{64E9E897-BBC3-954D-9E98-0DB16CD13675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04" creationId="{A0363A2F-D7BB-5A4D-95EE-8656CE5F066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1" creationId="{0C676772-4386-A542-B4E3-EAB0ADF2C293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5" creationId="{99F4BB11-D596-1545-8161-A9CF4F97D8EE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0" creationId="{6AFAA2A5-BAAD-E44D-AFE9-912EF1817509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5" creationId="{A52F1DE5-28A6-4549-A26C-4DE511E67175}"/>
          </ac:spMkLst>
        </pc:spChg>
        <pc:spChg chg="mod">
          <ac:chgData name="Wencai Zhang" userId="4a86a1d0-2108-4707-8228-1110f3c1be85" providerId="ADAL" clId="{1BBB9177-4005-5540-B885-43DD27640C07}" dt="2022-04-21T00:36:43.163" v="2328" actId="1037"/>
          <ac:spMkLst>
            <pc:docMk/>
            <pc:sldMk cId="428893665" sldId="289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47:36.081" v="3086" actId="1076"/>
          <ac:spMkLst>
            <pc:docMk/>
            <pc:sldMk cId="428893665" sldId="289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1T00:42:29.826" v="2731" actId="164"/>
          <ac:spMkLst>
            <pc:docMk/>
            <pc:sldMk cId="428893665" sldId="289"/>
            <ac:spMk id="364" creationId="{5032542A-D0F1-7F4B-910B-DCBD1CFA9EEB}"/>
          </ac:spMkLst>
        </pc:spChg>
        <pc:grpChg chg="mod">
          <ac:chgData name="Wencai Zhang" userId="4a86a1d0-2108-4707-8228-1110f3c1be85" providerId="ADAL" clId="{1BBB9177-4005-5540-B885-43DD27640C07}" dt="2022-04-21T00:34:49.716" v="2133" actId="164"/>
          <ac:grpSpMkLst>
            <pc:docMk/>
            <pc:sldMk cId="428893665" sldId="289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6" creationId="{479C65AD-753B-AB4B-8A57-8241A88BDD23}"/>
          </ac:grpSpMkLst>
        </pc:grpChg>
        <pc:grpChg chg="add 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8" creationId="{A30FAC19-1ADF-F545-B666-5A09F3661E62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" creationId="{7C1AFE9D-0804-4941-9275-A9799A61F71B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19" creationId="{FAF5B60B-3F9C-8648-BB2F-55EFA9B87758}"/>
          </ac:grpSpMkLst>
        </pc:grpChg>
        <pc:grpChg chg="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20" creationId="{0971CC71-7DAF-7F46-9F1D-3A2E6F5ED523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1" creationId="{B5BE6ED3-887F-094E-8750-EA5C51EB264D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" creationId="{B1A190EF-8208-214C-AA74-D041DE9849E0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1BBB9177-4005-5540-B885-43DD27640C07}" dt="2022-04-21T00:38:09.454" v="2412" actId="1037"/>
          <ac:grpSpMkLst>
            <pc:docMk/>
            <pc:sldMk cId="428893665" sldId="289"/>
            <ac:grpSpMk id="37" creationId="{553ECA8C-0525-AE49-B3E5-EB378F57E63F}"/>
          </ac:grpSpMkLst>
        </pc:grpChg>
        <pc:grpChg chg="add mod">
          <ac:chgData name="Wencai Zhang" userId="4a86a1d0-2108-4707-8228-1110f3c1be85" providerId="ADAL" clId="{1BBB9177-4005-5540-B885-43DD27640C07}" dt="2022-04-21T00:40:56.615" v="2630" actId="1037"/>
          <ac:grpSpMkLst>
            <pc:docMk/>
            <pc:sldMk cId="428893665" sldId="289"/>
            <ac:grpSpMk id="59" creationId="{6E30B593-2ED6-9445-9E61-90DFAD978194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60" creationId="{224B13FA-B34C-854B-BE94-EE22CC7CA3B4}"/>
          </ac:grpSpMkLst>
        </pc:grpChg>
        <pc:grpChg chg="add 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61" creationId="{4A4E03B9-C9DC-CD42-A45A-B2AAB611BDD7}"/>
          </ac:grpSpMkLst>
        </pc:grpChg>
        <pc:grpChg chg="add mod">
          <ac:chgData name="Wencai Zhang" userId="4a86a1d0-2108-4707-8228-1110f3c1be85" providerId="ADAL" clId="{1BBB9177-4005-5540-B885-43DD27640C07}" dt="2022-04-21T00:48:14.790" v="3117" actId="1076"/>
          <ac:grpSpMkLst>
            <pc:docMk/>
            <pc:sldMk cId="428893665" sldId="289"/>
            <ac:grpSpMk id="62" creationId="{F6AEAD64-7121-1C4C-B3A8-FC1D8F009073}"/>
          </ac:grpSpMkLst>
        </pc:grpChg>
        <pc:grpChg chg="add mod">
          <ac:chgData name="Wencai Zhang" userId="4a86a1d0-2108-4707-8228-1110f3c1be85" providerId="ADAL" clId="{1BBB9177-4005-5540-B885-43DD27640C07}" dt="2022-04-21T00:47:58.694" v="3116" actId="1038"/>
          <ac:grpSpMkLst>
            <pc:docMk/>
            <pc:sldMk cId="428893665" sldId="289"/>
            <ac:grpSpMk id="65" creationId="{09C8E993-74D7-6A48-9DDD-39BF8D82A747}"/>
          </ac:grpSpMkLst>
        </pc:grpChg>
        <pc:grpChg chg="mod">
          <ac:chgData name="Wencai Zhang" userId="4a86a1d0-2108-4707-8228-1110f3c1be85" providerId="ADAL" clId="{1BBB9177-4005-5540-B885-43DD27640C07}" dt="2022-04-21T00:41:41.760" v="2713" actId="1038"/>
          <ac:grpSpMkLst>
            <pc:docMk/>
            <pc:sldMk cId="428893665" sldId="289"/>
            <ac:grpSpMk id="72" creationId="{AD5D29D9-F224-7442-82B6-47A39739BDE3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6" creationId="{345CB9A9-5784-A24E-9572-7BEA17A9C6A1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34" creationId="{AD029D35-69BA-FB48-B155-1E2B6B20040D}"/>
          </ac:grpSpMkLst>
        </pc:grpChg>
        <pc:grpChg chg="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237" creationId="{1A19A94A-DFF2-1346-BB12-32246C0DCE2E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298" creationId="{EC9E9EFA-21FA-5B42-A5CB-6082C05CECC2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331" creationId="{B17F12F3-C713-4A46-A187-892488048BA5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72" creationId="{F43206F6-1277-3547-92AC-57A9EC9C2761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1T00:38:46.097" v="2435" actId="1036"/>
          <ac:picMkLst>
            <pc:docMk/>
            <pc:sldMk cId="428893665" sldId="289"/>
            <ac:picMk id="7" creationId="{4E9CACB6-C4AB-7740-BBFF-7B28DE099420}"/>
          </ac:picMkLst>
        </pc:picChg>
        <pc:picChg chg="mod">
          <ac:chgData name="Wencai Zhang" userId="4a86a1d0-2108-4707-8228-1110f3c1be85" providerId="ADAL" clId="{1BBB9177-4005-5540-B885-43DD27640C07}" dt="2022-04-21T00:37:35.285" v="2388" actId="1037"/>
          <ac:picMkLst>
            <pc:docMk/>
            <pc:sldMk cId="428893665" sldId="289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1T00:38:19.544" v="2413" actId="167"/>
          <ac:picMkLst>
            <pc:docMk/>
            <pc:sldMk cId="428893665" sldId="289"/>
            <ac:picMk id="13" creationId="{452AC9C4-7DE6-204F-9E61-8F99B2402C02}"/>
          </ac:picMkLst>
        </pc:picChg>
        <pc:picChg chg="mod">
          <ac:chgData name="Wencai Zhang" userId="4a86a1d0-2108-4707-8228-1110f3c1be85" providerId="ADAL" clId="{1BBB9177-4005-5540-B885-43DD27640C07}" dt="2022-04-21T00:40:17.891" v="2599" actId="1037"/>
          <ac:picMkLst>
            <pc:docMk/>
            <pc:sldMk cId="428893665" sldId="289"/>
            <ac:picMk id="14" creationId="{31E66149-3790-374B-AB85-5E6EA0D4F5BC}"/>
          </ac:picMkLst>
        </pc:picChg>
        <pc:picChg chg="mod">
          <ac:chgData name="Wencai Zhang" userId="4a86a1d0-2108-4707-8228-1110f3c1be85" providerId="ADAL" clId="{1BBB9177-4005-5540-B885-43DD27640C07}" dt="2022-04-21T00:41:05.691" v="2663" actId="1038"/>
          <ac:picMkLst>
            <pc:docMk/>
            <pc:sldMk cId="428893665" sldId="289"/>
            <ac:picMk id="18" creationId="{AFE39E17-A795-9B4B-8374-7E95106BA399}"/>
          </ac:picMkLst>
        </pc:picChg>
        <pc:picChg chg="mod">
          <ac:chgData name="Wencai Zhang" userId="4a86a1d0-2108-4707-8228-1110f3c1be85" providerId="ADAL" clId="{1BBB9177-4005-5540-B885-43DD27640C07}" dt="2022-04-21T00:48:30.061" v="3131" actId="1038"/>
          <ac:picMkLst>
            <pc:docMk/>
            <pc:sldMk cId="428893665" sldId="289"/>
            <ac:picMk id="25" creationId="{A5C4F04F-FA9F-AF42-B4D9-5C269E3F26E6}"/>
          </ac:picMkLst>
        </pc:picChg>
        <pc:picChg chg="mod">
          <ac:chgData name="Wencai Zhang" userId="4a86a1d0-2108-4707-8228-1110f3c1be85" providerId="ADAL" clId="{1BBB9177-4005-5540-B885-43DD27640C07}" dt="2022-04-21T00:48:26.444" v="3127" actId="1038"/>
          <ac:picMkLst>
            <pc:docMk/>
            <pc:sldMk cId="428893665" sldId="289"/>
            <ac:picMk id="27" creationId="{44CA3A87-721D-5442-A423-464DEDDF5537}"/>
          </ac:picMkLst>
        </pc:picChg>
        <pc:picChg chg="mod">
          <ac:chgData name="Wencai Zhang" userId="4a86a1d0-2108-4707-8228-1110f3c1be85" providerId="ADAL" clId="{1BBB9177-4005-5540-B885-43DD27640C07}" dt="2022-04-21T00:45:00.898" v="2916" actId="1038"/>
          <ac:picMkLst>
            <pc:docMk/>
            <pc:sldMk cId="428893665" sldId="289"/>
            <ac:picMk id="28" creationId="{013E642C-6C4D-8944-B92B-0ECE4FFE4EE5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" creationId="{50111CC7-87FC-7B4D-8141-6389F01144DD}"/>
          </ac:picMkLst>
        </pc:picChg>
        <pc:picChg chg="mod">
          <ac:chgData name="Wencai Zhang" userId="4a86a1d0-2108-4707-8228-1110f3c1be85" providerId="ADAL" clId="{1BBB9177-4005-5540-B885-43DD27640C07}" dt="2022-04-21T00:37:28.685" v="2384" actId="1038"/>
          <ac:picMkLst>
            <pc:docMk/>
            <pc:sldMk cId="428893665" sldId="289"/>
            <ac:picMk id="40" creationId="{5CFBCABC-16A3-9847-9416-3CD86F952992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48" creationId="{E651FCCF-6774-FD48-815E-D4F8522DA29D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69" creationId="{2334DB1B-418E-B24D-BED9-EF016A0280D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5" creationId="{05F4FA48-5B24-4346-A01F-7A7802631CF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6" creationId="{23FCB37B-1A20-DB47-A815-B49D084D2309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2" creationId="{57EDE318-521C-D346-A0AF-758E003AA39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3" creationId="{F89ED89E-111D-7148-89DF-90BD73DEABCA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7" creationId="{EEDC13A2-9BBB-5344-AEC5-8B95AEFFB5A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9" creationId="{882A2E9B-2A64-C343-86E4-B2CF4C98312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0" creationId="{88311C2B-AF92-174C-B416-EDE2BEE1EA5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1" creationId="{388B1E29-F01F-4E44-B804-BBD2B20C8EFE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2" creationId="{12437FF6-47D0-3F41-B188-62892B0FDD48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7" creationId="{8364684B-4B74-E249-8D48-0D520006B5E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22" creationId="{BE1FF44F-605B-8A45-BD38-A801818982A6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7" creationId="{C7C92599-816F-A74F-B00A-7A037DB6D190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9" creationId="{FABB8195-5A40-B345-9D9E-D7ACDE9CC7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35" creationId="{47FEB488-F486-5846-8381-28967983543B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0" creationId="{4A7F546F-62DF-AF48-848A-59BD64690C56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1" creationId="{FD665C2A-A121-1C45-A171-B24CC954C9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8" creationId="{37AA4BFA-EF24-B240-B9DD-1675C3688EE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3" creationId="{EE36942F-7CEC-DD41-BE75-CCDD77DF75D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8" creationId="{0B58CBAA-3E9F-6140-8558-409BCB7DFAC6}"/>
          </ac:picMkLst>
        </pc:picChg>
      </pc:sldChg>
    </pc:docChg>
  </pc:docChgLst>
  <pc:docChgLst>
    <pc:chgData name="Nicholas Skiados" clId="Web-{40982F2D-B18E-4479-80AC-1D1ECAEEAF1E}"/>
    <pc:docChg chg="addSld delSld">
      <pc:chgData name="Nicholas Skiados" userId="" providerId="" clId="Web-{40982F2D-B18E-4479-80AC-1D1ECAEEAF1E}" dt="2021-06-17T03:11:57.342" v="1"/>
      <pc:docMkLst>
        <pc:docMk/>
      </pc:docMkLst>
      <pc:sldChg chg="add del replId">
        <pc:chgData name="Nicholas Skiados" userId="" providerId="" clId="Web-{40982F2D-B18E-4479-80AC-1D1ECAEEAF1E}" dt="2021-06-17T03:11:57.342" v="1"/>
        <pc:sldMkLst>
          <pc:docMk/>
          <pc:sldMk cId="1258508667" sldId="283"/>
        </pc:sldMkLst>
      </pc:sldChg>
    </pc:docChg>
  </pc:docChgLst>
  <pc:docChgLst>
    <pc:chgData name="Wencai Zhang" userId="4a86a1d0-2108-4707-8228-1110f3c1be85" providerId="ADAL" clId="{D7614370-9963-EF40-966A-B58C4408B08E}"/>
    <pc:docChg chg="modSld">
      <pc:chgData name="Wencai Zhang" userId="4a86a1d0-2108-4707-8228-1110f3c1be85" providerId="ADAL" clId="{D7614370-9963-EF40-966A-B58C4408B08E}" dt="2022-01-10T17:21:13.165" v="5" actId="164"/>
      <pc:docMkLst>
        <pc:docMk/>
      </pc:docMkLst>
      <pc:sldChg chg="addSp delSp modSp">
        <pc:chgData name="Wencai Zhang" userId="4a86a1d0-2108-4707-8228-1110f3c1be85" providerId="ADAL" clId="{D7614370-9963-EF40-966A-B58C4408B08E}" dt="2022-01-10T17:21:13.165" v="5" actId="164"/>
        <pc:sldMkLst>
          <pc:docMk/>
          <pc:sldMk cId="3998775946" sldId="283"/>
        </pc:sldMkLst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3" creationId="{9F3D2978-3FA5-1F46-B7BB-B2A1D2C70654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4" creationId="{FFD005C4-C00B-2949-823A-A186C32EC442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6" creationId="{3D8708BD-48FC-544C-97E2-913EADBF8C8D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7" creationId="{4D7D491B-105C-3644-A0BA-ADE10712D27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8" creationId="{C43F6F12-416D-1945-B6E0-107443CCDF46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9" creationId="{A42F0D0B-74D9-E94C-91E7-AD51A2B55DD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0" creationId="{954D13E6-38B5-734A-A1A7-6C11C73CF015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3" creationId="{70A610C3-9E97-D94F-80DE-3E3920EB3BAA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2" creationId="{092266A2-BC6F-8B42-B1F6-2793B87939A5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3" creationId="{5715180B-47B2-7A40-8448-B41A943EEB93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8" creationId="{B1802351-4668-D242-920B-36BE5B67400B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9" creationId="{0429DC9A-7DCC-3E49-87E8-05C7839D2E96}"/>
          </ac:spMkLst>
        </pc:spChg>
        <pc:grpChg chg="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2" creationId="{97FE748F-63B3-8A46-90B7-DF336B22080D}"/>
          </ac:grpSpMkLst>
        </pc:grpChg>
        <pc:grpChg chg="del">
          <ac:chgData name="Wencai Zhang" userId="4a86a1d0-2108-4707-8228-1110f3c1be85" providerId="ADAL" clId="{D7614370-9963-EF40-966A-B58C4408B08E}" dt="2022-01-10T17:11:05.031" v="0" actId="165"/>
          <ac:grpSpMkLst>
            <pc:docMk/>
            <pc:sldMk cId="3998775946" sldId="283"/>
            <ac:grpSpMk id="7" creationId="{5CEF5AD4-A7C4-F04C-994E-BD0337B0D9F7}"/>
          </ac:grpSpMkLst>
        </pc:grpChg>
        <pc:grpChg chg="add del mod">
          <ac:chgData name="Wencai Zhang" userId="4a86a1d0-2108-4707-8228-1110f3c1be85" providerId="ADAL" clId="{D7614370-9963-EF40-966A-B58C4408B08E}" dt="2022-01-10T17:11:22.264" v="2" actId="165"/>
          <ac:grpSpMkLst>
            <pc:docMk/>
            <pc:sldMk cId="3998775946" sldId="283"/>
            <ac:grpSpMk id="8" creationId="{E4BCDA6E-E03A-D643-BB64-A95EEEB4CACE}"/>
          </ac:grpSpMkLst>
        </pc:grpChg>
        <pc:grpChg chg="add del mod">
          <ac:chgData name="Wencai Zhang" userId="4a86a1d0-2108-4707-8228-1110f3c1be85" providerId="ADAL" clId="{D7614370-9963-EF40-966A-B58C4408B08E}" dt="2022-01-10T17:11:54.506" v="4" actId="165"/>
          <ac:grpSpMkLst>
            <pc:docMk/>
            <pc:sldMk cId="3998775946" sldId="283"/>
            <ac:grpSpMk id="14" creationId="{A4E439EA-E8AA-D84D-87CC-A2C795F48854}"/>
          </ac:grpSpMkLst>
        </pc:grpChg>
        <pc:grpChg chg="add 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16" creationId="{7C1AFE9D-0804-4941-9275-A9799A61F71B}"/>
          </ac:grpSpMkLst>
        </pc:grpChg>
      </pc:sldChg>
    </pc:docChg>
  </pc:docChgLst>
  <pc:docChgLst>
    <pc:chgData name="Nicholas Skiados" clId="Web-{277533C3-9AA5-4F53-A0BA-70EADA089511}"/>
    <pc:docChg chg="mod modSld">
      <pc:chgData name="Nicholas Skiados" userId="" providerId="" clId="Web-{277533C3-9AA5-4F53-A0BA-70EADA089511}" dt="2021-06-17T02:44:39.491" v="163" actId="14100"/>
      <pc:docMkLst>
        <pc:docMk/>
      </pc:docMkLst>
      <pc:sldChg chg="addSp delSp modSp">
        <pc:chgData name="Nicholas Skiados" userId="" providerId="" clId="Web-{277533C3-9AA5-4F53-A0BA-70EADA089511}" dt="2021-06-17T02:44:39.491" v="163" actId="14100"/>
        <pc:sldMkLst>
          <pc:docMk/>
          <pc:sldMk cId="1245431894" sldId="274"/>
        </pc:sldMkLst>
        <pc:spChg chg="add">
          <ac:chgData name="Nicholas Skiados" userId="" providerId="" clId="Web-{277533C3-9AA5-4F53-A0BA-70EADA089511}" dt="2021-06-17T02:39:04.402" v="109"/>
          <ac:spMkLst>
            <pc:docMk/>
            <pc:sldMk cId="1245431894" sldId="274"/>
            <ac:spMk id="7" creationId="{76783D3B-EF98-4635-BD13-F7D92E31EBFE}"/>
          </ac:spMkLst>
        </pc:spChg>
        <pc:spChg chg="add mod">
          <ac:chgData name="Nicholas Skiados" userId="" providerId="" clId="Web-{277533C3-9AA5-4F53-A0BA-70EADA089511}" dt="2021-06-17T02:31:53.311" v="52" actId="20577"/>
          <ac:spMkLst>
            <pc:docMk/>
            <pc:sldMk cId="1245431894" sldId="274"/>
            <ac:spMk id="35" creationId="{DD4DDA71-F6AF-4A52-80F5-CDFE8AB9FD54}"/>
          </ac:spMkLst>
        </pc:spChg>
        <pc:spChg chg="add mod">
          <ac:chgData name="Nicholas Skiados" userId="" providerId="" clId="Web-{277533C3-9AA5-4F53-A0BA-70EADA089511}" dt="2021-06-17T02:31:59.061" v="56" actId="20577"/>
          <ac:spMkLst>
            <pc:docMk/>
            <pc:sldMk cId="1245431894" sldId="274"/>
            <ac:spMk id="36" creationId="{EB28EA73-BDE5-4EA9-ACF3-6A22A9C24232}"/>
          </ac:spMkLst>
        </pc:spChg>
        <pc:spChg chg="mod">
          <ac:chgData name="Nicholas Skiados" userId="" providerId="" clId="Web-{277533C3-9AA5-4F53-A0BA-70EADA089511}" dt="2021-06-17T02:38:48.121" v="105" actId="107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Nicholas Skiados" userId="" providerId="" clId="Web-{277533C3-9AA5-4F53-A0BA-70EADA089511}" dt="2021-06-17T02:38:55.136" v="107" actId="107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Nicholas Skiados" userId="" providerId="" clId="Web-{277533C3-9AA5-4F53-A0BA-70EADA089511}" dt="2021-06-17T02:36:38.007" v="83" actId="107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Nicholas Skiados" userId="" providerId="" clId="Web-{277533C3-9AA5-4F53-A0BA-70EADA089511}" dt="2021-06-17T02:38:58.277" v="108" actId="1076"/>
          <ac:spMkLst>
            <pc:docMk/>
            <pc:sldMk cId="1245431894" sldId="274"/>
            <ac:spMk id="67" creationId="{5A88E887-9896-2742-9FBE-A90372B280F9}"/>
          </ac:spMkLst>
        </pc:spChg>
        <pc:grpChg chg="add del">
          <ac:chgData name="Nicholas Skiados" userId="" providerId="" clId="Web-{277533C3-9AA5-4F53-A0BA-70EADA089511}" dt="2021-06-17T02:23:19.311" v="13"/>
          <ac:grpSpMkLst>
            <pc:docMk/>
            <pc:sldMk cId="1245431894" sldId="274"/>
            <ac:grpSpMk id="2" creationId="{23522517-C292-8C40-8C84-B30913B1168A}"/>
          </ac:grpSpMkLst>
        </pc:grpChg>
        <pc:picChg chg="add mod modCrop">
          <ac:chgData name="Nicholas Skiados" userId="" providerId="" clId="Web-{277533C3-9AA5-4F53-A0BA-70EADA089511}" dt="2021-06-17T02:23:03.232" v="11" actId="1076"/>
          <ac:picMkLst>
            <pc:docMk/>
            <pc:sldMk cId="1245431894" sldId="274"/>
            <ac:picMk id="3" creationId="{687E3D84-6344-4328-9010-DABD465265A4}"/>
          </ac:picMkLst>
        </pc:picChg>
        <pc:picChg chg="add mod modCrop">
          <ac:chgData name="Nicholas Skiados" userId="" providerId="" clId="Web-{277533C3-9AA5-4F53-A0BA-70EADA089511}" dt="2021-06-17T02:26:50.130" v="41" actId="1076"/>
          <ac:picMkLst>
            <pc:docMk/>
            <pc:sldMk cId="1245431894" sldId="274"/>
            <ac:picMk id="4" creationId="{2EEDDA25-1F2E-406D-8861-DFE3770F42DF}"/>
          </ac:picMkLst>
        </pc:picChg>
        <pc:picChg chg="add mod modCrop">
          <ac:chgData name="Nicholas Skiados" userId="" providerId="" clId="Web-{277533C3-9AA5-4F53-A0BA-70EADA089511}" dt="2021-06-17T02:36:29.163" v="82" actId="1076"/>
          <ac:picMkLst>
            <pc:docMk/>
            <pc:sldMk cId="1245431894" sldId="274"/>
            <ac:picMk id="5" creationId="{D552F245-96BD-44EF-962D-5D885EF72528}"/>
          </ac:picMkLst>
        </pc:picChg>
        <pc:picChg chg="add del mod modCrop">
          <ac:chgData name="Nicholas Skiados" userId="" providerId="" clId="Web-{277533C3-9AA5-4F53-A0BA-70EADA089511}" dt="2021-06-17T02:43:41.348" v="152"/>
          <ac:picMkLst>
            <pc:docMk/>
            <pc:sldMk cId="1245431894" sldId="274"/>
            <ac:picMk id="6" creationId="{1DAB7785-2639-433E-8C1A-1936BA36CFB7}"/>
          </ac:picMkLst>
        </pc:picChg>
        <pc:picChg chg="add mod modCrop">
          <ac:chgData name="Nicholas Skiados" userId="" providerId="" clId="Web-{277533C3-9AA5-4F53-A0BA-70EADA089511}" dt="2021-06-17T02:44:39.491" v="163" actId="14100"/>
          <ac:picMkLst>
            <pc:docMk/>
            <pc:sldMk cId="1245431894" sldId="274"/>
            <ac:picMk id="9" creationId="{BE4F643D-BC53-4E47-925A-9949972331C6}"/>
          </ac:picMkLst>
        </pc:picChg>
        <pc:picChg chg="del">
          <ac:chgData name="Nicholas Skiados" userId="" providerId="" clId="Web-{277533C3-9AA5-4F53-A0BA-70EADA089511}" dt="2021-06-17T02:26:46.427" v="40"/>
          <ac:picMkLst>
            <pc:docMk/>
            <pc:sldMk cId="1245431894" sldId="274"/>
            <ac:picMk id="55" creationId="{63F65AE1-44E9-354E-BE26-AA103449E57C}"/>
          </ac:picMkLst>
        </pc:picChg>
        <pc:picChg chg="del">
          <ac:chgData name="Nicholas Skiados" userId="" providerId="" clId="Web-{277533C3-9AA5-4F53-A0BA-70EADA089511}" dt="2021-06-17T02:22:55.216" v="10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Nicholas Skiados" userId="" providerId="" clId="Web-{277533C3-9AA5-4F53-A0BA-70EADA089511}" dt="2021-06-17T02:36:26.163" v="81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Nicholas Skiados" userId="" providerId="" clId="Web-{277533C3-9AA5-4F53-A0BA-70EADA089511}" dt="2021-06-17T02:39:07.856" v="111"/>
          <ac:picMkLst>
            <pc:docMk/>
            <pc:sldMk cId="1245431894" sldId="274"/>
            <ac:picMk id="58" creationId="{35932F72-055A-784A-B589-B30EEFC75F1A}"/>
          </ac:picMkLst>
        </pc:picChg>
      </pc:sldChg>
      <pc:sldChg chg="modSp addCm">
        <pc:chgData name="Nicholas Skiados" userId="" providerId="" clId="Web-{277533C3-9AA5-4F53-A0BA-70EADA089511}" dt="2021-06-17T02:28:34.664" v="43"/>
        <pc:sldMkLst>
          <pc:docMk/>
          <pc:sldMk cId="1904142445" sldId="276"/>
        </pc:sldMkLst>
        <pc:spChg chg="mod">
          <ac:chgData name="Nicholas Skiados" userId="" providerId="" clId="Web-{277533C3-9AA5-4F53-A0BA-70EADA089511}" dt="2021-06-17T02:12:32.947" v="0" actId="1076"/>
          <ac:spMkLst>
            <pc:docMk/>
            <pc:sldMk cId="1904142445" sldId="276"/>
            <ac:spMk id="63" creationId="{C963CAC6-C6D1-CB4C-A32F-6FEF64826360}"/>
          </ac:spMkLst>
        </pc:spChg>
      </pc:sldChg>
    </pc:docChg>
  </pc:docChgLst>
  <pc:docChgLst>
    <pc:chgData name="Wencai Zhang" userId="4a86a1d0-2108-4707-8228-1110f3c1be85" providerId="ADAL" clId="{A812B727-5AF5-A748-A785-197D774968CA}"/>
    <pc:docChg chg="undo custSel delSld modSld">
      <pc:chgData name="Wencai Zhang" userId="4a86a1d0-2108-4707-8228-1110f3c1be85" providerId="ADAL" clId="{A812B727-5AF5-A748-A785-197D774968CA}" dt="2022-04-29T19:28:25.943" v="75" actId="1038"/>
      <pc:docMkLst>
        <pc:docMk/>
      </pc:docMkLst>
      <pc:sldChg chg="addSp modSp">
        <pc:chgData name="Wencai Zhang" userId="4a86a1d0-2108-4707-8228-1110f3c1be85" providerId="ADAL" clId="{A812B727-5AF5-A748-A785-197D774968CA}" dt="2022-04-28T18:20:40.750" v="5" actId="20577"/>
        <pc:sldMkLst>
          <pc:docMk/>
          <pc:sldMk cId="1245431894" sldId="274"/>
        </pc:sldMkLst>
        <pc:spChg chg="add mod">
          <ac:chgData name="Wencai Zhang" userId="4a86a1d0-2108-4707-8228-1110f3c1be85" providerId="ADAL" clId="{A812B727-5AF5-A748-A785-197D774968CA}" dt="2022-04-28T18:20:40.750" v="5" actId="20577"/>
          <ac:spMkLst>
            <pc:docMk/>
            <pc:sldMk cId="1245431894" sldId="274"/>
            <ac:spMk id="75" creationId="{984D3048-D588-A64C-B806-8FCD9BD3A3ED}"/>
          </ac:spMkLst>
        </pc:spChg>
      </pc:sldChg>
      <pc:sldChg chg="del">
        <pc:chgData name="Wencai Zhang" userId="4a86a1d0-2108-4707-8228-1110f3c1be85" providerId="ADAL" clId="{A812B727-5AF5-A748-A785-197D774968CA}" dt="2022-04-28T18:19:47.459" v="2" actId="2696"/>
        <pc:sldMkLst>
          <pc:docMk/>
          <pc:sldMk cId="920392864" sldId="282"/>
        </pc:sldMkLst>
      </pc:sldChg>
      <pc:sldChg chg="del">
        <pc:chgData name="Wencai Zhang" userId="4a86a1d0-2108-4707-8228-1110f3c1be85" providerId="ADAL" clId="{A812B727-5AF5-A748-A785-197D774968CA}" dt="2022-04-28T18:19:47.401" v="1" actId="2696"/>
        <pc:sldMkLst>
          <pc:docMk/>
          <pc:sldMk cId="3998775946" sldId="283"/>
        </pc:sldMkLst>
      </pc:sldChg>
      <pc:sldChg chg="addSp modSp">
        <pc:chgData name="Wencai Zhang" userId="4a86a1d0-2108-4707-8228-1110f3c1be85" providerId="ADAL" clId="{A812B727-5AF5-A748-A785-197D774968CA}" dt="2022-04-28T18:21:09.055" v="17" actId="20577"/>
        <pc:sldMkLst>
          <pc:docMk/>
          <pc:sldMk cId="933386568" sldId="284"/>
        </pc:sldMkLst>
        <pc:spChg chg="add mod">
          <ac:chgData name="Wencai Zhang" userId="4a86a1d0-2108-4707-8228-1110f3c1be85" providerId="ADAL" clId="{A812B727-5AF5-A748-A785-197D774968CA}" dt="2022-04-28T18:21:09.055" v="17" actId="20577"/>
          <ac:spMkLst>
            <pc:docMk/>
            <pc:sldMk cId="933386568" sldId="284"/>
            <ac:spMk id="30" creationId="{1C0380E3-79BE-1446-AEC3-0CB660E7272B}"/>
          </ac:spMkLst>
        </pc:spChg>
      </pc:sldChg>
      <pc:sldChg chg="addSp delSp modSp">
        <pc:chgData name="Wencai Zhang" userId="4a86a1d0-2108-4707-8228-1110f3c1be85" providerId="ADAL" clId="{A812B727-5AF5-A748-A785-197D774968CA}" dt="2022-04-29T19:23:54.570" v="49"/>
        <pc:sldMkLst>
          <pc:docMk/>
          <pc:sldMk cId="1149708096" sldId="285"/>
        </pc:sldMkLst>
        <pc:spChg chg="add mod">
          <ac:chgData name="Wencai Zhang" userId="4a86a1d0-2108-4707-8228-1110f3c1be85" providerId="ADAL" clId="{A812B727-5AF5-A748-A785-197D774968CA}" dt="2022-04-28T18:20:49.391" v="7" actId="20577"/>
          <ac:spMkLst>
            <pc:docMk/>
            <pc:sldMk cId="1149708096" sldId="285"/>
            <ac:spMk id="67" creationId="{AAF7166A-E9B7-7F4B-88D9-37A6AF8189F8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2" creationId="{6BFEB4B0-080D-8B41-A6FC-9830DD816FA1}"/>
          </ac:spMkLst>
        </pc:spChg>
        <pc:picChg chg="add del mod">
          <ac:chgData name="Wencai Zhang" userId="4a86a1d0-2108-4707-8228-1110f3c1be85" providerId="ADAL" clId="{A812B727-5AF5-A748-A785-197D774968CA}" dt="2022-04-29T19:23:54.570" v="49"/>
          <ac:picMkLst>
            <pc:docMk/>
            <pc:sldMk cId="1149708096" sldId="285"/>
            <ac:picMk id="68" creationId="{33967DDA-A6F5-D84C-834B-18C1FD343C93}"/>
          </ac:picMkLst>
        </pc:picChg>
        <pc:picChg chg="mod modCrop">
          <ac:chgData name="Wencai Zhang" userId="4a86a1d0-2108-4707-8228-1110f3c1be85" providerId="ADAL" clId="{A812B727-5AF5-A748-A785-197D774968CA}" dt="2022-04-29T19:23:51.241" v="48" actId="732"/>
          <ac:picMkLst>
            <pc:docMk/>
            <pc:sldMk cId="1149708096" sldId="285"/>
            <ac:picMk id="77" creationId="{044309F2-5B00-714A-91B7-DBDFA966F19F}"/>
          </ac:picMkLst>
        </pc:picChg>
      </pc:sldChg>
      <pc:sldChg chg="addSp delSp modSp">
        <pc:chgData name="Wencai Zhang" userId="4a86a1d0-2108-4707-8228-1110f3c1be85" providerId="ADAL" clId="{A812B727-5AF5-A748-A785-197D774968CA}" dt="2022-04-29T19:28:25.943" v="75" actId="1038"/>
        <pc:sldMkLst>
          <pc:docMk/>
          <pc:sldMk cId="797336377" sldId="287"/>
        </pc:sldMkLst>
        <pc:spChg chg="add mod">
          <ac:chgData name="Wencai Zhang" userId="4a86a1d0-2108-4707-8228-1110f3c1be85" providerId="ADAL" clId="{A812B727-5AF5-A748-A785-197D774968CA}" dt="2022-04-28T18:20:57.086" v="10" actId="20577"/>
          <ac:spMkLst>
            <pc:docMk/>
            <pc:sldMk cId="797336377" sldId="287"/>
            <ac:spMk id="69" creationId="{B921DAB5-1B22-CC4A-8369-874333D17F61}"/>
          </ac:spMkLst>
        </pc:spChg>
        <pc:spChg chg="del topLvl">
          <ac:chgData name="Wencai Zhang" userId="4a86a1d0-2108-4707-8228-1110f3c1be85" providerId="ADAL" clId="{A812B727-5AF5-A748-A785-197D774968CA}" dt="2022-04-29T19:23:05.873" v="44" actId="478"/>
          <ac:spMkLst>
            <pc:docMk/>
            <pc:sldMk cId="797336377" sldId="287"/>
            <ac:spMk id="81" creationId="{B11A44CD-AB09-E540-9980-026812E6FB54}"/>
          </ac:spMkLst>
        </pc:spChg>
        <pc:spChg chg="del topLvl">
          <ac:chgData name="Wencai Zhang" userId="4a86a1d0-2108-4707-8228-1110f3c1be85" providerId="ADAL" clId="{A812B727-5AF5-A748-A785-197D774968CA}" dt="2022-04-29T19:23:02.487" v="43" actId="478"/>
          <ac:spMkLst>
            <pc:docMk/>
            <pc:sldMk cId="797336377" sldId="287"/>
            <ac:spMk id="82" creationId="{6BFEB4B0-080D-8B41-A6FC-9830DD816FA1}"/>
          </ac:spMkLst>
        </pc:spChg>
        <pc:grpChg chg="add del mod">
          <ac:chgData name="Wencai Zhang" userId="4a86a1d0-2108-4707-8228-1110f3c1be85" providerId="ADAL" clId="{A812B727-5AF5-A748-A785-197D774968CA}" dt="2022-04-29T19:25:48.184" v="57"/>
          <ac:grpSpMkLst>
            <pc:docMk/>
            <pc:sldMk cId="797336377" sldId="287"/>
            <ac:grpSpMk id="77" creationId="{4FDD74ED-83C0-8B4E-9243-E1DA491E3001}"/>
          </ac:grpSpMkLst>
        </pc:grpChg>
        <pc:grpChg chg="del">
          <ac:chgData name="Wencai Zhang" userId="4a86a1d0-2108-4707-8228-1110f3c1be85" providerId="ADAL" clId="{A812B727-5AF5-A748-A785-197D774968CA}" dt="2022-04-29T19:23:02.487" v="43" actId="478"/>
          <ac:grpSpMkLst>
            <pc:docMk/>
            <pc:sldMk cId="797336377" sldId="287"/>
            <ac:grpSpMk id="79" creationId="{BCAD6698-7ABF-9143-B78D-400EA289BEFB}"/>
          </ac:grpSpMkLst>
        </pc:grpChg>
        <pc:grpChg chg="mod">
          <ac:chgData name="Wencai Zhang" userId="4a86a1d0-2108-4707-8228-1110f3c1be85" providerId="ADAL" clId="{A812B727-5AF5-A748-A785-197D774968CA}" dt="2022-04-29T19:28:25.943" v="75" actId="1038"/>
          <ac:grpSpMkLst>
            <pc:docMk/>
            <pc:sldMk cId="797336377" sldId="287"/>
            <ac:grpSpMk id="104" creationId="{C7B87BB4-04B4-A84A-9C90-C59A0378B7DD}"/>
          </ac:grpSpMkLst>
        </pc:grpChg>
        <pc:picChg chg="del">
          <ac:chgData name="Wencai Zhang" userId="4a86a1d0-2108-4707-8228-1110f3c1be85" providerId="ADAL" clId="{A812B727-5AF5-A748-A785-197D774968CA}" dt="2022-04-29T19:25:48.184" v="57"/>
          <ac:picMkLst>
            <pc:docMk/>
            <pc:sldMk cId="797336377" sldId="287"/>
            <ac:picMk id="93" creationId="{5C12A139-D81B-F440-B011-260492DD01C6}"/>
          </ac:picMkLst>
        </pc:picChg>
        <pc:picChg chg="add mod modCrop">
          <ac:chgData name="Wencai Zhang" userId="4a86a1d0-2108-4707-8228-1110f3c1be85" providerId="ADAL" clId="{A812B727-5AF5-A748-A785-197D774968CA}" dt="2022-04-29T19:28:15.525" v="61" actId="1076"/>
          <ac:picMkLst>
            <pc:docMk/>
            <pc:sldMk cId="797336377" sldId="287"/>
            <ac:picMk id="112" creationId="{BA3CF924-6C1A-5646-AE18-7EBC385D40DF}"/>
          </ac:picMkLst>
        </pc:picChg>
        <pc:picChg chg="mod">
          <ac:chgData name="Wencai Zhang" userId="4a86a1d0-2108-4707-8228-1110f3c1be85" providerId="ADAL" clId="{A812B727-5AF5-A748-A785-197D774968CA}" dt="2022-04-29T19:27:53.014" v="59" actId="1076"/>
          <ac:picMkLst>
            <pc:docMk/>
            <pc:sldMk cId="797336377" sldId="287"/>
            <ac:picMk id="115" creationId="{F4733671-11E1-514A-9CF9-8A9A9BD1977C}"/>
          </ac:picMkLst>
        </pc:picChg>
      </pc:sldChg>
      <pc:sldChg chg="addSp modSp">
        <pc:chgData name="Wencai Zhang" userId="4a86a1d0-2108-4707-8228-1110f3c1be85" providerId="ADAL" clId="{A812B727-5AF5-A748-A785-197D774968CA}" dt="2022-04-28T18:21:03.375" v="13" actId="20577"/>
        <pc:sldMkLst>
          <pc:docMk/>
          <pc:sldMk cId="1912379916" sldId="288"/>
        </pc:sldMkLst>
        <pc:spChg chg="add mod">
          <ac:chgData name="Wencai Zhang" userId="4a86a1d0-2108-4707-8228-1110f3c1be85" providerId="ADAL" clId="{A812B727-5AF5-A748-A785-197D774968CA}" dt="2022-04-28T18:21:03.375" v="13" actId="20577"/>
          <ac:spMkLst>
            <pc:docMk/>
            <pc:sldMk cId="1912379916" sldId="288"/>
            <ac:spMk id="65" creationId="{D1CDD252-FA40-0D4D-97BD-363D2D8A12A8}"/>
          </ac:spMkLst>
        </pc:spChg>
      </pc:sldChg>
      <pc:sldChg chg="del">
        <pc:chgData name="Wencai Zhang" userId="4a86a1d0-2108-4707-8228-1110f3c1be85" providerId="ADAL" clId="{A812B727-5AF5-A748-A785-197D774968CA}" dt="2022-04-28T18:19:47.319" v="0" actId="2696"/>
        <pc:sldMkLst>
          <pc:docMk/>
          <pc:sldMk cId="428893665" sldId="289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Wencai Zhang" userId="4a86a1d0-2108-4707-8228-1110f3c1be85" providerId="ADAL" clId="{2D60659E-CA34-844E-93CE-5743DAFB12BB}"/>
    <pc:docChg chg="undo redo custSel addSld delSld modSld">
      <pc:chgData name="Wencai Zhang" userId="4a86a1d0-2108-4707-8228-1110f3c1be85" providerId="ADAL" clId="{2D60659E-CA34-844E-93CE-5743DAFB12BB}" dt="2021-06-16T14:16:56.257" v="335"/>
      <pc:docMkLst>
        <pc:docMk/>
      </pc:docMkLst>
      <pc:sldChg chg="addSp delSp modSp">
        <pc:chgData name="Wencai Zhang" userId="4a86a1d0-2108-4707-8228-1110f3c1be85" providerId="ADAL" clId="{2D60659E-CA34-844E-93CE-5743DAFB12BB}" dt="2021-06-15T16:34:29.038" v="330" actId="1076"/>
        <pc:sldMkLst>
          <pc:docMk/>
          <pc:sldMk cId="3242017852" sldId="272"/>
        </pc:sldMkLst>
        <pc:spChg chg="mod">
          <ac:chgData name="Wencai Zhang" userId="4a86a1d0-2108-4707-8228-1110f3c1be85" providerId="ADAL" clId="{2D60659E-CA34-844E-93CE-5743DAFB12BB}" dt="2021-06-15T16:34:23.289" v="329" actId="1038"/>
          <ac:spMkLst>
            <pc:docMk/>
            <pc:sldMk cId="3242017852" sldId="272"/>
            <ac:spMk id="5" creationId="{C9676FCD-1B75-674C-B612-D1EA39A39093}"/>
          </ac:spMkLst>
        </pc:spChg>
        <pc:spChg chg="mod topLvl">
          <ac:chgData name="Wencai Zhang" userId="4a86a1d0-2108-4707-8228-1110f3c1be85" providerId="ADAL" clId="{2D60659E-CA34-844E-93CE-5743DAFB12BB}" dt="2021-06-15T16:34:29.038" v="330" actId="1076"/>
          <ac:spMkLst>
            <pc:docMk/>
            <pc:sldMk cId="3242017852" sldId="272"/>
            <ac:spMk id="86" creationId="{00000000-0000-0000-0000-000000000000}"/>
          </ac:spMkLst>
        </pc:spChg>
        <pc:spChg chg="mod">
          <ac:chgData name="Wencai Zhang" userId="4a86a1d0-2108-4707-8228-1110f3c1be85" providerId="ADAL" clId="{2D60659E-CA34-844E-93CE-5743DAFB12BB}" dt="2021-06-15T16:26:22.223" v="181" actId="20577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2D60659E-CA34-844E-93CE-5743DAFB12BB}" dt="2021-06-15T16:30:17.237" v="228" actId="1076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2D60659E-CA34-844E-93CE-5743DAFB12BB}" dt="2021-06-09T13:36:18.129" v="121" actId="14100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0" creationId="{E9C8D369-5F8D-E54A-AF65-476407FD0AD1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1" creationId="{9FCC0C5D-D6A9-164C-8964-401099D7F9F9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2" creationId="{58BF14D6-FC81-CA47-8833-2926CE44CE61}"/>
          </ac:spMkLst>
        </pc:spChg>
        <pc:spChg chg="add del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9" creationId="{C8230297-1475-3444-AE6A-DA7A58BA0B75}"/>
          </ac:spMkLst>
        </pc:spChg>
        <pc:spChg chg="add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50" creationId="{122C8E5F-0692-274A-A75F-0CF5B51070DC}"/>
          </ac:spMkLst>
        </pc:spChg>
        <pc:spChg chg="add del">
          <ac:chgData name="Wencai Zhang" userId="4a86a1d0-2108-4707-8228-1110f3c1be85" providerId="ADAL" clId="{2D60659E-CA34-844E-93CE-5743DAFB12BB}" dt="2021-06-15T16:24:27.947" v="174" actId="478"/>
          <ac:spMkLst>
            <pc:docMk/>
            <pc:sldMk cId="3242017852" sldId="272"/>
            <ac:spMk id="252" creationId="{80F84604-F358-DF4E-AA99-2E5D9FECD879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3" creationId="{B0FE9530-DB38-CB41-915A-157F7FB3D534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4" creationId="{68010D11-3754-EA45-AFD4-3B036F100A81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6" creationId="{D91C50DB-187A-6642-A64A-CC88CBA82997}"/>
          </ac:spMkLst>
        </pc:s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mod topLvl">
          <ac:chgData name="Wencai Zhang" userId="4a86a1d0-2108-4707-8228-1110f3c1be85" providerId="ADAL" clId="{2D60659E-CA34-844E-93CE-5743DAFB12BB}" dt="2021-06-15T16:32:35.329" v="297" actId="164"/>
          <ac:grpSpMkLst>
            <pc:docMk/>
            <pc:sldMk cId="3242017852" sldId="272"/>
            <ac:grpSpMk id="6" creationId="{581344F7-D56B-B94B-9DB8-92E65EDBA18E}"/>
          </ac:grpSpMkLst>
        </pc:grpChg>
        <pc:grpChg chg="add del mod">
          <ac:chgData name="Wencai Zhang" userId="4a86a1d0-2108-4707-8228-1110f3c1be85" providerId="ADAL" clId="{2D60659E-CA34-844E-93CE-5743DAFB12BB}" dt="2021-06-15T16:32:27.475" v="296" actId="165"/>
          <ac:grpSpMkLst>
            <pc:docMk/>
            <pc:sldMk cId="3242017852" sldId="272"/>
            <ac:grpSpMk id="7" creationId="{F2D8C3AA-A83E-F540-B3EC-67185DC64C31}"/>
          </ac:grpSpMkLst>
        </pc:grpChg>
        <pc:grpChg chg="add mod">
          <ac:chgData name="Wencai Zhang" userId="4a86a1d0-2108-4707-8228-1110f3c1be85" providerId="ADAL" clId="{2D60659E-CA34-844E-93CE-5743DAFB12BB}" dt="2021-06-15T16:34:23.289" v="329" actId="1038"/>
          <ac:grpSpMkLst>
            <pc:docMk/>
            <pc:sldMk cId="3242017852" sldId="272"/>
            <ac:grpSpMk id="9" creationId="{20D61725-C418-9046-9B50-C136B0964C04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13" creationId="{AC403E60-D88B-BB4F-B665-75038169A67A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0" creationId="{321DAD19-E9D0-234C-821C-5E044A313399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1" creationId="{610A4869-03EC-1B41-8D3D-3FB9BFEF5751}"/>
          </ac:grpSpMkLst>
        </pc:grp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2D60659E-CA34-844E-93CE-5743DAFB12BB}" dt="2021-06-15T16:31:31.712" v="268" actId="1035"/>
          <ac:picMkLst>
            <pc:docMk/>
            <pc:sldMk cId="3242017852" sldId="272"/>
            <ac:picMk id="75" creationId="{E62CEEFD-4CA1-864B-8692-4445BAA180CE}"/>
          </ac:picMkLst>
        </pc:picChg>
        <pc:picChg chg="del">
          <ac:chgData name="Wencai Zhang" userId="4a86a1d0-2108-4707-8228-1110f3c1be85" providerId="ADAL" clId="{2D60659E-CA34-844E-93CE-5743DAFB12BB}" dt="2021-06-15T16:29:54.336" v="226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192" creationId="{71CCA731-AEC4-324C-B904-1CFC513A08F9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7" creationId="{69702E48-531B-3148-BF07-B925212EC571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8" creationId="{B98E97CD-7D34-9D42-8BF2-E7E62C9D628D}"/>
          </ac:picMkLst>
        </pc:picChg>
        <pc:picChg chg="add del">
          <ac:chgData name="Wencai Zhang" userId="4a86a1d0-2108-4707-8228-1110f3c1be85" providerId="ADAL" clId="{2D60659E-CA34-844E-93CE-5743DAFB12BB}" dt="2021-06-15T16:24:27.947" v="174" actId="478"/>
          <ac:picMkLst>
            <pc:docMk/>
            <pc:sldMk cId="3242017852" sldId="272"/>
            <ac:picMk id="251" creationId="{CED8E165-2EB1-7A45-9BCE-0FEBCB8A7E22}"/>
          </ac:picMkLst>
        </pc:picChg>
        <pc:picChg chg="add mod topLvl modCrop">
          <ac:chgData name="Wencai Zhang" userId="4a86a1d0-2108-4707-8228-1110f3c1be85" providerId="ADAL" clId="{2D60659E-CA34-844E-93CE-5743DAFB12BB}" dt="2021-06-15T16:32:35.329" v="297" actId="164"/>
          <ac:picMkLst>
            <pc:docMk/>
            <pc:sldMk cId="3242017852" sldId="272"/>
            <ac:picMk id="255" creationId="{6C620D77-00EC-B64C-8F91-2C86BE3F5E02}"/>
          </ac:picMkLst>
        </pc:picChg>
      </pc:sldChg>
      <pc:sldChg chg="del">
        <pc:chgData name="Wencai Zhang" userId="4a86a1d0-2108-4707-8228-1110f3c1be85" providerId="ADAL" clId="{2D60659E-CA34-844E-93CE-5743DAFB12BB}" dt="2021-06-16T14:16:13.373" v="333" actId="2696"/>
        <pc:sldMkLst>
          <pc:docMk/>
          <pc:sldMk cId="3709575207" sldId="273"/>
        </pc:sldMkLst>
      </pc:sldChg>
      <pc:sldChg chg="addSp delSp">
        <pc:chgData name="Wencai Zhang" userId="4a86a1d0-2108-4707-8228-1110f3c1be85" providerId="ADAL" clId="{2D60659E-CA34-844E-93CE-5743DAFB12BB}" dt="2021-06-16T14:16:56.257" v="335"/>
        <pc:sldMkLst>
          <pc:docMk/>
          <pc:sldMk cId="1245431894" sldId="274"/>
        </pc:sldMkLst>
        <pc:spChg chg="del">
          <ac:chgData name="Wencai Zhang" userId="4a86a1d0-2108-4707-8228-1110f3c1be85" providerId="ADAL" clId="{2D60659E-CA34-844E-93CE-5743DAFB12BB}" dt="2021-06-16T14:16:55.723" v="334" actId="478"/>
          <ac:spMkLst>
            <pc:docMk/>
            <pc:sldMk cId="1245431894" sldId="274"/>
            <ac:spMk id="5" creationId="{C9676FCD-1B75-674C-B612-D1EA39A39093}"/>
          </ac:spMkLst>
        </pc:spChg>
        <pc:spChg chg="add">
          <ac:chgData name="Wencai Zhang" userId="4a86a1d0-2108-4707-8228-1110f3c1be85" providerId="ADAL" clId="{2D60659E-CA34-844E-93CE-5743DAFB12BB}" dt="2021-06-16T14:16:56.257" v="335"/>
          <ac:spMkLst>
            <pc:docMk/>
            <pc:sldMk cId="1245431894" sldId="274"/>
            <ac:spMk id="34" creationId="{445C1720-EAE1-B045-A74A-D237858BD8E7}"/>
          </ac:spMkLst>
        </pc:spChg>
      </pc:sldChg>
      <pc:sldChg chg="del">
        <pc:chgData name="Wencai Zhang" userId="4a86a1d0-2108-4707-8228-1110f3c1be85" providerId="ADAL" clId="{2D60659E-CA34-844E-93CE-5743DAFB12BB}" dt="2021-06-16T14:15:59.891" v="332" actId="2696"/>
        <pc:sldMkLst>
          <pc:docMk/>
          <pc:sldMk cId="2222079663" sldId="275"/>
        </pc:sldMkLst>
      </pc:sldChg>
      <pc:sldChg chg="del">
        <pc:chgData name="Wencai Zhang" userId="4a86a1d0-2108-4707-8228-1110f3c1be85" providerId="ADAL" clId="{2D60659E-CA34-844E-93CE-5743DAFB12BB}" dt="2021-06-16T14:15:59.867" v="331" actId="2696"/>
        <pc:sldMkLst>
          <pc:docMk/>
          <pc:sldMk cId="2045228985" sldId="278"/>
        </pc:sldMkLst>
      </pc:sldChg>
      <pc:sldChg chg="add">
        <pc:chgData name="Wencai Zhang" userId="4a86a1d0-2108-4707-8228-1110f3c1be85" providerId="ADAL" clId="{2D60659E-CA34-844E-93CE-5743DAFB12BB}" dt="2021-06-09T20:20:52.984" v="166"/>
        <pc:sldMkLst>
          <pc:docMk/>
          <pc:sldMk cId="920392864" sldId="282"/>
        </pc:sldMkLst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4a86a1d0-2108-4707-8228-1110f3c1be85" providerId="ADAL" clId="{E233410B-50C2-694A-A859-DE61755DB43A}"/>
    <pc:docChg chg="custSel modSld">
      <pc:chgData name="Wencai Zhang" userId="4a86a1d0-2108-4707-8228-1110f3c1be85" providerId="ADAL" clId="{E233410B-50C2-694A-A859-DE61755DB43A}" dt="2022-06-15T19:43:12.276" v="11" actId="478"/>
      <pc:docMkLst>
        <pc:docMk/>
      </pc:docMkLst>
      <pc:sldChg chg="delSp">
        <pc:chgData name="Wencai Zhang" userId="4a86a1d0-2108-4707-8228-1110f3c1be85" providerId="ADAL" clId="{E233410B-50C2-694A-A859-DE61755DB43A}" dt="2022-06-15T19:42:33.767" v="2" actId="478"/>
        <pc:sldMkLst>
          <pc:docMk/>
          <pc:sldMk cId="1245431894" sldId="274"/>
        </pc:sldMkLst>
        <pc:spChg chg="del">
          <ac:chgData name="Wencai Zhang" userId="4a86a1d0-2108-4707-8228-1110f3c1be85" providerId="ADAL" clId="{E233410B-50C2-694A-A859-DE61755DB43A}" dt="2022-06-15T19:42:27.714" v="1" actId="478"/>
          <ac:spMkLst>
            <pc:docMk/>
            <pc:sldMk cId="1245431894" sldId="274"/>
            <ac:spMk id="17" creationId="{A1B94A96-93E3-5A44-AB8A-B4223D0CE1A9}"/>
          </ac:spMkLst>
        </pc:spChg>
        <pc:spChg chg="del">
          <ac:chgData name="Wencai Zhang" userId="4a86a1d0-2108-4707-8228-1110f3c1be85" providerId="ADAL" clId="{E233410B-50C2-694A-A859-DE61755DB43A}" dt="2022-06-15T19:42:26.331" v="0" actId="478"/>
          <ac:spMkLst>
            <pc:docMk/>
            <pc:sldMk cId="1245431894" sldId="274"/>
            <ac:spMk id="34" creationId="{445C1720-EAE1-B045-A74A-D237858BD8E7}"/>
          </ac:spMkLst>
        </pc:spChg>
        <pc:spChg chg="del">
          <ac:chgData name="Wencai Zhang" userId="4a86a1d0-2108-4707-8228-1110f3c1be85" providerId="ADAL" clId="{E233410B-50C2-694A-A859-DE61755DB43A}" dt="2022-06-15T19:42:33.767" v="2" actId="478"/>
          <ac:spMkLst>
            <pc:docMk/>
            <pc:sldMk cId="1245431894" sldId="274"/>
            <ac:spMk id="86" creationId="{00000000-0000-0000-0000-000000000000}"/>
          </ac:spMkLst>
        </pc:spChg>
      </pc:sldChg>
      <pc:sldChg chg="delSp">
        <pc:chgData name="Wencai Zhang" userId="4a86a1d0-2108-4707-8228-1110f3c1be85" providerId="ADAL" clId="{E233410B-50C2-694A-A859-DE61755DB43A}" dt="2022-06-15T19:43:12.276" v="11" actId="478"/>
        <pc:sldMkLst>
          <pc:docMk/>
          <pc:sldMk cId="933386568" sldId="284"/>
        </pc:sldMkLst>
        <pc:spChg chg="del">
          <ac:chgData name="Wencai Zhang" userId="4a86a1d0-2108-4707-8228-1110f3c1be85" providerId="ADAL" clId="{E233410B-50C2-694A-A859-DE61755DB43A}" dt="2022-06-15T19:43:12.276" v="11" actId="478"/>
          <ac:spMkLst>
            <pc:docMk/>
            <pc:sldMk cId="933386568" sldId="284"/>
            <ac:spMk id="3" creationId="{3219B98B-D17F-79CC-201B-392AFE1D677C}"/>
          </ac:spMkLst>
        </pc:spChg>
        <pc:spChg chg="del">
          <ac:chgData name="Wencai Zhang" userId="4a86a1d0-2108-4707-8228-1110f3c1be85" providerId="ADAL" clId="{E233410B-50C2-694A-A859-DE61755DB43A}" dt="2022-06-15T19:43:05.920" v="10" actId="478"/>
          <ac:spMkLst>
            <pc:docMk/>
            <pc:sldMk cId="933386568" sldId="284"/>
            <ac:spMk id="108" creationId="{D7F17C28-EEFC-4046-8657-4171497F3AE9}"/>
          </ac:spMkLst>
        </pc:spChg>
        <pc:picChg chg="del">
          <ac:chgData name="Wencai Zhang" userId="4a86a1d0-2108-4707-8228-1110f3c1be85" providerId="ADAL" clId="{E233410B-50C2-694A-A859-DE61755DB43A}" dt="2022-06-15T19:43:12.276" v="11" actId="478"/>
          <ac:picMkLst>
            <pc:docMk/>
            <pc:sldMk cId="933386568" sldId="284"/>
            <ac:picMk id="62" creationId="{24EA8D65-DF3B-FF43-AAB7-1709AE354ED8}"/>
          </ac:picMkLst>
        </pc:picChg>
      </pc:sldChg>
      <pc:sldChg chg="delSp">
        <pc:chgData name="Wencai Zhang" userId="4a86a1d0-2108-4707-8228-1110f3c1be85" providerId="ADAL" clId="{E233410B-50C2-694A-A859-DE61755DB43A}" dt="2022-06-15T19:42:44.739" v="4" actId="478"/>
        <pc:sldMkLst>
          <pc:docMk/>
          <pc:sldMk cId="1149708096" sldId="285"/>
        </pc:sldMkLst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2.531" v="3" actId="478"/>
          <ac:spMkLst>
            <pc:docMk/>
            <pc:sldMk cId="1149708096" sldId="285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178" creationId="{9B8AA01D-55A8-C748-86FD-9C8CB6ED50E0}"/>
          </ac:spMkLst>
        </pc:spChg>
      </pc:sldChg>
      <pc:sldChg chg="delSp">
        <pc:chgData name="Wencai Zhang" userId="4a86a1d0-2108-4707-8228-1110f3c1be85" providerId="ADAL" clId="{E233410B-50C2-694A-A859-DE61755DB43A}" dt="2022-06-15T19:42:51.970" v="6" actId="478"/>
        <pc:sldMkLst>
          <pc:docMk/>
          <pc:sldMk cId="1407856934" sldId="289"/>
        </pc:sldMkLst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9.371" v="5" actId="478"/>
          <ac:spMkLst>
            <pc:docMk/>
            <pc:sldMk cId="1407856934" sldId="289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190" creationId="{D935C8CE-1EE1-A64F-ACA1-5580D3854AF2}"/>
          </ac:spMkLst>
        </pc:spChg>
      </pc:sldChg>
      <pc:sldChg chg="delSp">
        <pc:chgData name="Wencai Zhang" userId="4a86a1d0-2108-4707-8228-1110f3c1be85" providerId="ADAL" clId="{E233410B-50C2-694A-A859-DE61755DB43A}" dt="2022-06-15T19:43:00.959" v="9" actId="478"/>
        <pc:sldMkLst>
          <pc:docMk/>
          <pc:sldMk cId="3037230208" sldId="290"/>
        </pc:sldMkLst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3:00.959" v="9" actId="478"/>
          <ac:spMkLst>
            <pc:docMk/>
            <pc:sldMk cId="3037230208" sldId="290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198" creationId="{CAAA600C-C9C5-5F44-81A7-2B1615AB35F1}"/>
          </ac:spMkLst>
        </pc:spChg>
        <pc:spChg chg="del">
          <ac:chgData name="Wencai Zhang" userId="4a86a1d0-2108-4707-8228-1110f3c1be85" providerId="ADAL" clId="{E233410B-50C2-694A-A859-DE61755DB43A}" dt="2022-06-15T19:42:57.100" v="7" actId="478"/>
          <ac:spMkLst>
            <pc:docMk/>
            <pc:sldMk cId="3037230208" sldId="290"/>
            <ac:spMk id="200" creationId="{960AA1A2-471B-9643-B356-0D8D28ED6195}"/>
          </ac:spMkLst>
        </pc:spChg>
        <pc:graphicFrameChg chg="del">
          <ac:chgData name="Wencai Zhang" userId="4a86a1d0-2108-4707-8228-1110f3c1be85" providerId="ADAL" clId="{E233410B-50C2-694A-A859-DE61755DB43A}" dt="2022-06-15T19:42:57.100" v="7" actId="478"/>
          <ac:graphicFrameMkLst>
            <pc:docMk/>
            <pc:sldMk cId="3037230208" sldId="290"/>
            <ac:graphicFrameMk id="199" creationId="{C6646175-759A-8245-9096-ED0062CA70F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6586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tif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Group 78">
            <a:extLst>
              <a:ext uri="{FF2B5EF4-FFF2-40B4-BE49-F238E27FC236}">
                <a16:creationId xmlns:a16="http://schemas.microsoft.com/office/drawing/2014/main" id="{BCAD6698-7ABF-9143-B78D-400EA289BEFB}"/>
              </a:ext>
            </a:extLst>
          </p:cNvPr>
          <p:cNvGrpSpPr/>
          <p:nvPr/>
        </p:nvGrpSpPr>
        <p:grpSpPr>
          <a:xfrm>
            <a:off x="131762" y="1892459"/>
            <a:ext cx="1747969" cy="203280"/>
            <a:chOff x="7074439" y="578201"/>
            <a:chExt cx="1747969" cy="203280"/>
          </a:xfrm>
        </p:grpSpPr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11A44CD-AB09-E540-9980-026812E6FB54}"/>
                </a:ext>
              </a:extLst>
            </p:cNvPr>
            <p:cNvSpPr txBox="1"/>
            <p:nvPr/>
          </p:nvSpPr>
          <p:spPr>
            <a:xfrm>
              <a:off x="7074439" y="581426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THFD1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6BFEB4B0-080D-8B41-A6FC-9830DD816FA1}"/>
                </a:ext>
              </a:extLst>
            </p:cNvPr>
            <p:cNvSpPr txBox="1"/>
            <p:nvPr/>
          </p:nvSpPr>
          <p:spPr>
            <a:xfrm>
              <a:off x="8182328" y="578201"/>
              <a:ext cx="6400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102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EEA0505E-A23D-884B-92D7-B239BA911068}"/>
              </a:ext>
            </a:extLst>
          </p:cNvPr>
          <p:cNvGrpSpPr/>
          <p:nvPr/>
        </p:nvGrpSpPr>
        <p:grpSpPr>
          <a:xfrm>
            <a:off x="1926131" y="2679587"/>
            <a:ext cx="1635101" cy="203084"/>
            <a:chOff x="1926131" y="1751193"/>
            <a:chExt cx="1635101" cy="203084"/>
          </a:xfrm>
        </p:grpSpPr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312CA5E9-8EA8-084F-8124-43438F272A9E}"/>
                </a:ext>
              </a:extLst>
            </p:cNvPr>
            <p:cNvSpPr txBox="1"/>
            <p:nvPr/>
          </p:nvSpPr>
          <p:spPr>
            <a:xfrm>
              <a:off x="1926131" y="175422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THFD2</a:t>
              </a: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0FD73DFB-B926-5944-82E8-25E92E6FA2E7}"/>
                </a:ext>
              </a:extLst>
            </p:cNvPr>
            <p:cNvSpPr txBox="1"/>
            <p:nvPr/>
          </p:nvSpPr>
          <p:spPr>
            <a:xfrm>
              <a:off x="3012592" y="175119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38</a:t>
              </a:r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AAF7166A-E9B7-7F4B-88D9-37A6AF8189F8}"/>
              </a:ext>
            </a:extLst>
          </p:cNvPr>
          <p:cNvSpPr txBox="1"/>
          <p:nvPr/>
        </p:nvSpPr>
        <p:spPr>
          <a:xfrm>
            <a:off x="5152510" y="53505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ED9CD213-3DB1-9548-A745-76AB59B7390C}"/>
              </a:ext>
            </a:extLst>
          </p:cNvPr>
          <p:cNvGrpSpPr/>
          <p:nvPr/>
        </p:nvGrpSpPr>
        <p:grpSpPr>
          <a:xfrm>
            <a:off x="-34345" y="618565"/>
            <a:ext cx="1658182" cy="649767"/>
            <a:chOff x="-34345" y="618565"/>
            <a:chExt cx="1658182" cy="649767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266BB3B-480D-2849-9A8F-96232A8FBFA0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A1F87E1B-DDF0-A245-8738-0A761E2F0B0F}"/>
                </a:ext>
              </a:extLst>
            </p:cNvPr>
            <p:cNvGrpSpPr/>
            <p:nvPr/>
          </p:nvGrpSpPr>
          <p:grpSpPr>
            <a:xfrm>
              <a:off x="217604" y="742308"/>
              <a:ext cx="1406233" cy="526024"/>
              <a:chOff x="547784" y="742308"/>
              <a:chExt cx="1406233" cy="526024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3DC60991-BEA3-744D-973E-2EAF742B4731}"/>
                  </a:ext>
                </a:extLst>
              </p:cNvPr>
              <p:cNvSpPr txBox="1"/>
              <p:nvPr/>
            </p:nvSpPr>
            <p:spPr>
              <a:xfrm rot="18995393">
                <a:off x="966464" y="950181"/>
                <a:ext cx="5180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Parental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8A5A0719-1B06-8D4C-B947-C48565B91388}"/>
                  </a:ext>
                </a:extLst>
              </p:cNvPr>
              <p:cNvSpPr txBox="1"/>
              <p:nvPr/>
            </p:nvSpPr>
            <p:spPr>
              <a:xfrm rot="18995393">
                <a:off x="1263161" y="1004399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OTR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CE647874-C091-7946-8080-358C8ADC1A86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4475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1975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71B8DF5E-A3CE-5647-99AE-35FFE2A8FD8E}"/>
                  </a:ext>
                </a:extLst>
              </p:cNvPr>
              <p:cNvSpPr txBox="1"/>
              <p:nvPr/>
            </p:nvSpPr>
            <p:spPr>
              <a:xfrm>
                <a:off x="158825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3A678556-DC02-1C43-9DA7-3F2D30A20CFD}"/>
              </a:ext>
            </a:extLst>
          </p:cNvPr>
          <p:cNvGrpSpPr/>
          <p:nvPr/>
        </p:nvGrpSpPr>
        <p:grpSpPr>
          <a:xfrm>
            <a:off x="1770388" y="618566"/>
            <a:ext cx="1625757" cy="649767"/>
            <a:chOff x="-34345" y="618565"/>
            <a:chExt cx="1625757" cy="649767"/>
          </a:xfrm>
        </p:grpSpPr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93C71A0-423B-AB46-B937-EE0408D5528E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711E2424-9101-BB44-A202-3C522B47FEF5}"/>
                </a:ext>
              </a:extLst>
            </p:cNvPr>
            <p:cNvGrpSpPr/>
            <p:nvPr/>
          </p:nvGrpSpPr>
          <p:grpSpPr>
            <a:xfrm>
              <a:off x="217604" y="742308"/>
              <a:ext cx="1373808" cy="526024"/>
              <a:chOff x="547784" y="742308"/>
              <a:chExt cx="1373808" cy="526024"/>
            </a:xfrm>
          </p:grpSpPr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30DB146F-48BB-224C-8F52-DB6444061CB1}"/>
                  </a:ext>
                </a:extLst>
              </p:cNvPr>
              <p:cNvSpPr txBox="1"/>
              <p:nvPr/>
            </p:nvSpPr>
            <p:spPr>
              <a:xfrm rot="18995393">
                <a:off x="966464" y="950181"/>
                <a:ext cx="51809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Parental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EA9ED9B-225C-3249-8859-60BE10D4574E}"/>
                  </a:ext>
                </a:extLst>
              </p:cNvPr>
              <p:cNvSpPr txBox="1"/>
              <p:nvPr/>
            </p:nvSpPr>
            <p:spPr>
              <a:xfrm rot="18995393">
                <a:off x="1263161" y="1004399"/>
                <a:ext cx="3738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OTR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0C58621E-C652-7241-BADB-38CDFDA4174D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44755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1975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00DF6001-7867-F947-A66D-E906C27A6849}"/>
                  </a:ext>
                </a:extLst>
              </p:cNvPr>
              <p:cNvSpPr txBox="1"/>
              <p:nvPr/>
            </p:nvSpPr>
            <p:spPr>
              <a:xfrm>
                <a:off x="1555832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03" name="Group 102">
            <a:extLst>
              <a:ext uri="{FF2B5EF4-FFF2-40B4-BE49-F238E27FC236}">
                <a16:creationId xmlns:a16="http://schemas.microsoft.com/office/drawing/2014/main" id="{77F3B635-0E98-434D-A139-1A470F830EA4}"/>
              </a:ext>
            </a:extLst>
          </p:cNvPr>
          <p:cNvGrpSpPr/>
          <p:nvPr/>
        </p:nvGrpSpPr>
        <p:grpSpPr>
          <a:xfrm>
            <a:off x="5348982" y="620767"/>
            <a:ext cx="1515512" cy="649767"/>
            <a:chOff x="-34345" y="618565"/>
            <a:chExt cx="1515512" cy="649767"/>
          </a:xfrm>
        </p:grpSpPr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298F8962-F801-A04D-A8F0-6D2B903D7BFB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08" name="Group 107">
              <a:extLst>
                <a:ext uri="{FF2B5EF4-FFF2-40B4-BE49-F238E27FC236}">
                  <a16:creationId xmlns:a16="http://schemas.microsoft.com/office/drawing/2014/main" id="{0E8241FF-5E0B-9C40-97C6-A8A8565FE5C9}"/>
                </a:ext>
              </a:extLst>
            </p:cNvPr>
            <p:cNvGrpSpPr/>
            <p:nvPr/>
          </p:nvGrpSpPr>
          <p:grpSpPr>
            <a:xfrm>
              <a:off x="217604" y="742308"/>
              <a:ext cx="1263563" cy="526024"/>
              <a:chOff x="547784" y="742308"/>
              <a:chExt cx="1263563" cy="526024"/>
            </a:xfrm>
          </p:grpSpPr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653E06BB-652D-CE4F-A75A-F56B1EB7A476}"/>
                  </a:ext>
                </a:extLst>
              </p:cNvPr>
              <p:cNvSpPr txBox="1"/>
              <p:nvPr/>
            </p:nvSpPr>
            <p:spPr>
              <a:xfrm rot="18995393">
                <a:off x="904601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C16836BF-FA7A-3941-A92D-C23AFBE18A95}"/>
                  </a:ext>
                </a:extLst>
              </p:cNvPr>
              <p:cNvSpPr txBox="1"/>
              <p:nvPr/>
            </p:nvSpPr>
            <p:spPr>
              <a:xfrm rot="18995393">
                <a:off x="1171789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01954A24-241C-424E-AB11-04C536F86FE2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F036179A-2126-CC4B-8FE6-BDA22A67C62C}"/>
                  </a:ext>
                </a:extLst>
              </p:cNvPr>
              <p:cNvSpPr txBox="1"/>
              <p:nvPr/>
            </p:nvSpPr>
            <p:spPr>
              <a:xfrm>
                <a:off x="1445587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0FB6D560-63A7-0045-A71F-C5709F18C6FE}"/>
              </a:ext>
            </a:extLst>
          </p:cNvPr>
          <p:cNvGrpSpPr/>
          <p:nvPr/>
        </p:nvGrpSpPr>
        <p:grpSpPr>
          <a:xfrm>
            <a:off x="3545406" y="619665"/>
            <a:ext cx="1612787" cy="649767"/>
            <a:chOff x="-34345" y="618565"/>
            <a:chExt cx="1612787" cy="649767"/>
          </a:xfrm>
        </p:grpSpPr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DE990937-14B8-3247-A320-3923A3115E1A}"/>
                </a:ext>
              </a:extLst>
            </p:cNvPr>
            <p:cNvSpPr txBox="1"/>
            <p:nvPr/>
          </p:nvSpPr>
          <p:spPr>
            <a:xfrm>
              <a:off x="-34345" y="6185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137" name="Group 136">
              <a:extLst>
                <a:ext uri="{FF2B5EF4-FFF2-40B4-BE49-F238E27FC236}">
                  <a16:creationId xmlns:a16="http://schemas.microsoft.com/office/drawing/2014/main" id="{2F6A066E-C8C2-AD45-815B-9D422DA698FF}"/>
                </a:ext>
              </a:extLst>
            </p:cNvPr>
            <p:cNvGrpSpPr/>
            <p:nvPr/>
          </p:nvGrpSpPr>
          <p:grpSpPr>
            <a:xfrm>
              <a:off x="217604" y="742308"/>
              <a:ext cx="1360838" cy="526024"/>
              <a:chOff x="547784" y="742308"/>
              <a:chExt cx="1360838" cy="526024"/>
            </a:xfrm>
          </p:grpSpPr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7DB4CB67-90E2-AD48-BD55-25F9E8C970A2}"/>
                  </a:ext>
                </a:extLst>
              </p:cNvPr>
              <p:cNvSpPr txBox="1"/>
              <p:nvPr/>
            </p:nvSpPr>
            <p:spPr>
              <a:xfrm rot="18995393">
                <a:off x="949996" y="989649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5CCA8D0C-4B0A-184A-8D55-F237FEE5AB39}"/>
                  </a:ext>
                </a:extLst>
              </p:cNvPr>
              <p:cNvSpPr txBox="1"/>
              <p:nvPr/>
            </p:nvSpPr>
            <p:spPr>
              <a:xfrm rot="18995393">
                <a:off x="1204214" y="100439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FAF47AB8-0169-6D49-AD2C-629993CBFE51}"/>
                  </a:ext>
                </a:extLst>
              </p:cNvPr>
              <p:cNvSpPr txBox="1"/>
              <p:nvPr/>
            </p:nvSpPr>
            <p:spPr>
              <a:xfrm>
                <a:off x="547784" y="742308"/>
                <a:ext cx="94128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OTR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4E5429D9-D950-6042-8EE7-90326C8B9F49}"/>
                  </a:ext>
                </a:extLst>
              </p:cNvPr>
              <p:cNvSpPr txBox="1"/>
              <p:nvPr/>
            </p:nvSpPr>
            <p:spPr>
              <a:xfrm>
                <a:off x="1542862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175" name="Picture 174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D336C030-5E72-4D4D-B9FE-8A39C3816C7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293" t="37669" r="65386" b="38949"/>
          <a:stretch/>
        </p:blipFill>
        <p:spPr>
          <a:xfrm>
            <a:off x="628294" y="1249371"/>
            <a:ext cx="679862" cy="2011680"/>
          </a:xfrm>
          <a:prstGeom prst="rect">
            <a:avLst/>
          </a:prstGeom>
        </p:spPr>
      </p:pic>
      <p:pic>
        <p:nvPicPr>
          <p:cNvPr id="176" name="Picture 175" descr="A picture containing wall, indoor, white&#10;&#10;Description automatically generated">
            <a:extLst>
              <a:ext uri="{FF2B5EF4-FFF2-40B4-BE49-F238E27FC236}">
                <a16:creationId xmlns:a16="http://schemas.microsoft.com/office/drawing/2014/main" id="{1EA9737B-972E-5642-889F-75906420EB2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24" t="25850" r="76429" b="42402"/>
          <a:stretch/>
        </p:blipFill>
        <p:spPr>
          <a:xfrm>
            <a:off x="2408892" y="1249371"/>
            <a:ext cx="676917" cy="2011680"/>
          </a:xfrm>
          <a:prstGeom prst="rect">
            <a:avLst/>
          </a:prstGeom>
        </p:spPr>
      </p:pic>
      <p:pic>
        <p:nvPicPr>
          <p:cNvPr id="177" name="Picture 176" descr="A picture containing white, dark&#10;&#10;Description automatically generated">
            <a:extLst>
              <a:ext uri="{FF2B5EF4-FFF2-40B4-BE49-F238E27FC236}">
                <a16:creationId xmlns:a16="http://schemas.microsoft.com/office/drawing/2014/main" id="{20206D92-C081-BE4A-9BAE-C7185327118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051" t="34283" r="61848" b="43148"/>
          <a:stretch/>
        </p:blipFill>
        <p:spPr>
          <a:xfrm>
            <a:off x="4163286" y="1252481"/>
            <a:ext cx="679641" cy="2011680"/>
          </a:xfrm>
          <a:prstGeom prst="rect">
            <a:avLst/>
          </a:prstGeom>
        </p:spPr>
      </p:pic>
      <p:grpSp>
        <p:nvGrpSpPr>
          <p:cNvPr id="179" name="Group 178">
            <a:extLst>
              <a:ext uri="{FF2B5EF4-FFF2-40B4-BE49-F238E27FC236}">
                <a16:creationId xmlns:a16="http://schemas.microsoft.com/office/drawing/2014/main" id="{72BEDB68-3FCD-D642-B29B-8E55B1BBE595}"/>
              </a:ext>
            </a:extLst>
          </p:cNvPr>
          <p:cNvGrpSpPr/>
          <p:nvPr/>
        </p:nvGrpSpPr>
        <p:grpSpPr>
          <a:xfrm>
            <a:off x="3692387" y="1899385"/>
            <a:ext cx="1747969" cy="203280"/>
            <a:chOff x="7074439" y="578201"/>
            <a:chExt cx="1747969" cy="203280"/>
          </a:xfrm>
        </p:grpSpPr>
        <p:sp>
          <p:nvSpPr>
            <p:cNvPr id="180" name="TextBox 179">
              <a:extLst>
                <a:ext uri="{FF2B5EF4-FFF2-40B4-BE49-F238E27FC236}">
                  <a16:creationId xmlns:a16="http://schemas.microsoft.com/office/drawing/2014/main" id="{FDF39AC3-88B1-5D4D-A551-2AEA1A0E018E}"/>
                </a:ext>
              </a:extLst>
            </p:cNvPr>
            <p:cNvSpPr txBox="1"/>
            <p:nvPr/>
          </p:nvSpPr>
          <p:spPr>
            <a:xfrm>
              <a:off x="7074439" y="581426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THFD1</a:t>
              </a:r>
            </a:p>
          </p:txBody>
        </p: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5E3B0886-67A9-8448-BA3E-F496B1677016}"/>
                </a:ext>
              </a:extLst>
            </p:cNvPr>
            <p:cNvSpPr txBox="1"/>
            <p:nvPr/>
          </p:nvSpPr>
          <p:spPr>
            <a:xfrm>
              <a:off x="8182328" y="578201"/>
              <a:ext cx="6400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102</a:t>
              </a:r>
            </a:p>
          </p:txBody>
        </p:sp>
      </p:grpSp>
      <p:pic>
        <p:nvPicPr>
          <p:cNvPr id="182" name="Picture 181" descr="A picture containing white, dark, night sky&#10;&#10;Description automatically generated">
            <a:extLst>
              <a:ext uri="{FF2B5EF4-FFF2-40B4-BE49-F238E27FC236}">
                <a16:creationId xmlns:a16="http://schemas.microsoft.com/office/drawing/2014/main" id="{DE60C6FF-64FE-F845-B344-6D1F65498BD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486" t="37459" r="63617" b="40720"/>
          <a:stretch/>
        </p:blipFill>
        <p:spPr>
          <a:xfrm>
            <a:off x="5889872" y="1252481"/>
            <a:ext cx="679641" cy="2011680"/>
          </a:xfrm>
          <a:prstGeom prst="rect">
            <a:avLst/>
          </a:prstGeom>
        </p:spPr>
      </p:pic>
      <p:grpSp>
        <p:nvGrpSpPr>
          <p:cNvPr id="183" name="Group 182">
            <a:extLst>
              <a:ext uri="{FF2B5EF4-FFF2-40B4-BE49-F238E27FC236}">
                <a16:creationId xmlns:a16="http://schemas.microsoft.com/office/drawing/2014/main" id="{FEA016EC-C43A-C244-9242-564B7A2BA890}"/>
              </a:ext>
            </a:extLst>
          </p:cNvPr>
          <p:cNvGrpSpPr/>
          <p:nvPr/>
        </p:nvGrpSpPr>
        <p:grpSpPr>
          <a:xfrm>
            <a:off x="5408907" y="2676122"/>
            <a:ext cx="1650599" cy="203084"/>
            <a:chOff x="1910633" y="1751193"/>
            <a:chExt cx="1650599" cy="203084"/>
          </a:xfrm>
        </p:grpSpPr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DD136694-6F06-2840-B4AF-E4820016AAE3}"/>
                </a:ext>
              </a:extLst>
            </p:cNvPr>
            <p:cNvSpPr txBox="1"/>
            <p:nvPr/>
          </p:nvSpPr>
          <p:spPr>
            <a:xfrm>
              <a:off x="1910633" y="175422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THFD2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F0F1B4BF-9A83-A14D-B5C4-58B5397FC0F3}"/>
                </a:ext>
              </a:extLst>
            </p:cNvPr>
            <p:cNvSpPr txBox="1"/>
            <p:nvPr/>
          </p:nvSpPr>
          <p:spPr>
            <a:xfrm>
              <a:off x="3012592" y="175119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3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37230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0</TotalTime>
  <Words>40</Words>
  <Application>Microsoft Macintosh PowerPoint</Application>
  <PresentationFormat>Letter Paper (8.5x11 in)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493</cp:revision>
  <cp:lastPrinted>2021-09-14T20:51:29Z</cp:lastPrinted>
  <dcterms:created xsi:type="dcterms:W3CDTF">2016-03-04T20:57:06Z</dcterms:created>
  <dcterms:modified xsi:type="dcterms:W3CDTF">2022-06-23T12:12:10Z</dcterms:modified>
</cp:coreProperties>
</file>